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 id="2147483702" r:id="rId2"/>
  </p:sldMasterIdLst>
  <p:notesMasterIdLst>
    <p:notesMasterId r:id="rId11"/>
  </p:notesMasterIdLst>
  <p:sldIdLst>
    <p:sldId id="256" r:id="rId3"/>
    <p:sldId id="262" r:id="rId4"/>
    <p:sldId id="264" r:id="rId5"/>
    <p:sldId id="263" r:id="rId6"/>
    <p:sldId id="257" r:id="rId7"/>
    <p:sldId id="260" r:id="rId8"/>
    <p:sldId id="261" r:id="rId9"/>
    <p:sldId id="265"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25" autoAdjust="0"/>
    <p:restoredTop sz="71587" autoAdjust="0"/>
  </p:normalViewPr>
  <p:slideViewPr>
    <p:cSldViewPr snapToGrid="0">
      <p:cViewPr varScale="1">
        <p:scale>
          <a:sx n="91" d="100"/>
          <a:sy n="91" d="100"/>
        </p:scale>
        <p:origin x="1098"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viewProps" Target="view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notesMaster" Target="notesMasters/notesMaster1.xml"/><Relationship Id="rId5" Type="http://schemas.openxmlformats.org/officeDocument/2006/relationships/slide" Target="slides/slide3.xml"/><Relationship Id="rId15" Type="http://schemas.openxmlformats.org/officeDocument/2006/relationships/tableStyles" Target="tableStyles.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8718F15-8E17-45AE-BCFE-D238B3058B84}" type="datetimeFigureOut">
              <a:rPr lang="en-US" smtClean="0"/>
              <a:t>4/20/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EABF829-150D-42B8-ADB8-E3B602290832}" type="slidenum">
              <a:rPr lang="en-US" smtClean="0"/>
              <a:t>‹#›</a:t>
            </a:fld>
            <a:endParaRPr lang="en-US"/>
          </a:p>
        </p:txBody>
      </p:sp>
    </p:spTree>
    <p:extLst>
      <p:ext uri="{BB962C8B-B14F-4D97-AF65-F5344CB8AC3E}">
        <p14:creationId xmlns:p14="http://schemas.microsoft.com/office/powerpoint/2010/main" val="25895728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smtClean="0"/>
              <a:t>(This </a:t>
            </a:r>
            <a:r>
              <a:rPr lang="en-US" i="1" dirty="0" err="1" smtClean="0"/>
              <a:t>powerpoint</a:t>
            </a:r>
            <a:r>
              <a:rPr lang="en-US" i="1" dirty="0" smtClean="0"/>
              <a:t> can</a:t>
            </a:r>
            <a:r>
              <a:rPr lang="en-US" i="1" baseline="0" dirty="0" smtClean="0"/>
              <a:t> be displayed to learners to provide instruction on each section of the workshop)</a:t>
            </a:r>
            <a:endParaRPr lang="en-US" i="1" dirty="0" smtClean="0"/>
          </a:p>
          <a:p>
            <a:endParaRPr lang="en-US" dirty="0" smtClean="0"/>
          </a:p>
          <a:p>
            <a:r>
              <a:rPr lang="en-US" dirty="0" smtClean="0"/>
              <a:t>Facilitator</a:t>
            </a:r>
            <a:r>
              <a:rPr lang="en-US" baseline="0" dirty="0" smtClean="0"/>
              <a:t> Script:</a:t>
            </a:r>
          </a:p>
          <a:p>
            <a:endParaRPr lang="en-US" baseline="0" dirty="0" smtClean="0"/>
          </a:p>
          <a:p>
            <a:r>
              <a:rPr lang="en-US" baseline="0" dirty="0" smtClean="0"/>
              <a:t>Welcome everyone. Today you will be participating in a workshop to learn about diagnosis and management of menopause, osteoporosis, abnormal uterine bleeding and urinary incontinence. </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Click to next slide]</a:t>
            </a:r>
          </a:p>
          <a:p>
            <a:endParaRPr lang="en-US" baseline="0" dirty="0" smtClean="0"/>
          </a:p>
        </p:txBody>
      </p:sp>
      <p:sp>
        <p:nvSpPr>
          <p:cNvPr id="4" name="Slide Number Placeholder 3"/>
          <p:cNvSpPr>
            <a:spLocks noGrp="1"/>
          </p:cNvSpPr>
          <p:nvPr>
            <p:ph type="sldNum" sz="quarter" idx="10"/>
          </p:nvPr>
        </p:nvSpPr>
        <p:spPr/>
        <p:txBody>
          <a:bodyPr/>
          <a:lstStyle/>
          <a:p>
            <a:fld id="{CEABF829-150D-42B8-ADB8-E3B602290832}" type="slidenum">
              <a:rPr lang="en-US" smtClean="0"/>
              <a:t>1</a:t>
            </a:fld>
            <a:endParaRPr lang="en-US"/>
          </a:p>
        </p:txBody>
      </p:sp>
    </p:spTree>
    <p:extLst>
      <p:ext uri="{BB962C8B-B14F-4D97-AF65-F5344CB8AC3E}">
        <p14:creationId xmlns:p14="http://schemas.microsoft.com/office/powerpoint/2010/main" val="214424484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acilitator</a:t>
            </a:r>
            <a:r>
              <a:rPr lang="en-US" baseline="0" dirty="0" smtClean="0"/>
              <a:t> Script:</a:t>
            </a:r>
          </a:p>
          <a:p>
            <a:endParaRPr lang="en-US" baseline="0" dirty="0" smtClean="0"/>
          </a:p>
          <a:p>
            <a:r>
              <a:rPr lang="en-US" dirty="0" smtClean="0"/>
              <a:t>In</a:t>
            </a:r>
            <a:r>
              <a:rPr lang="en-US" baseline="0" dirty="0" smtClean="0"/>
              <a:t> today’s workshop, you will be working in teams which we will call “home groups” and each group member is responsible for being an expert in 1 of the 4 topics today. In the next slide we will show you who your home groups are and your assigned topic. </a:t>
            </a:r>
          </a:p>
          <a:p>
            <a:endParaRPr lang="en-US" baseline="0" dirty="0" smtClean="0"/>
          </a:p>
          <a:p>
            <a:r>
              <a:rPr lang="en-US" i="1" baseline="0" dirty="0" smtClean="0"/>
              <a:t>[Click to next animation]</a:t>
            </a:r>
          </a:p>
          <a:p>
            <a:endParaRPr lang="en-US" baseline="0" dirty="0" smtClean="0"/>
          </a:p>
          <a:p>
            <a:r>
              <a:rPr lang="en-US" baseline="0" dirty="0" smtClean="0"/>
              <a:t>In order to become experts, you will break into “expert groups” where you will be working with students from other home groups who were assigned the same topic as you. Together you will be using topic review articles to go through student worksheet.</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Click to next animation]</a:t>
            </a:r>
          </a:p>
          <a:p>
            <a:endParaRPr lang="en-US" baseline="0" dirty="0" smtClean="0"/>
          </a:p>
          <a:p>
            <a:r>
              <a:rPr lang="en-US" baseline="0" dirty="0" smtClean="0"/>
              <a:t>Once you have become experts, you are going to return to your home groups and collectively use your group knowledge to go through 2 patient cases. During the patient case, you will be teaching each other what you learned in the expert group.</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Click to next slide]</a:t>
            </a:r>
          </a:p>
          <a:p>
            <a:endParaRPr lang="en-US" dirty="0"/>
          </a:p>
        </p:txBody>
      </p:sp>
      <p:sp>
        <p:nvSpPr>
          <p:cNvPr id="4" name="Slide Number Placeholder 3"/>
          <p:cNvSpPr>
            <a:spLocks noGrp="1"/>
          </p:cNvSpPr>
          <p:nvPr>
            <p:ph type="sldNum" sz="quarter" idx="10"/>
          </p:nvPr>
        </p:nvSpPr>
        <p:spPr/>
        <p:txBody>
          <a:bodyPr/>
          <a:lstStyle/>
          <a:p>
            <a:pPr>
              <a:defRPr/>
            </a:pPr>
            <a:fld id="{E90EC1EA-07A0-4FA0-85C5-97754687AA71}" type="slidenum">
              <a:rPr lang="en-US" smtClean="0">
                <a:solidFill>
                  <a:prstClr val="black"/>
                </a:solidFill>
              </a:rPr>
              <a:pPr>
                <a:defRPr/>
              </a:pPr>
              <a:t>2</a:t>
            </a:fld>
            <a:endParaRPr lang="en-US">
              <a:solidFill>
                <a:prstClr val="black"/>
              </a:solidFill>
            </a:endParaRPr>
          </a:p>
        </p:txBody>
      </p:sp>
    </p:spTree>
    <p:extLst>
      <p:ext uri="{BB962C8B-B14F-4D97-AF65-F5344CB8AC3E}">
        <p14:creationId xmlns:p14="http://schemas.microsoft.com/office/powerpoint/2010/main" val="39932474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acilitator script:</a:t>
            </a:r>
          </a:p>
          <a:p>
            <a:endParaRPr lang="en-US" dirty="0" smtClean="0"/>
          </a:p>
          <a:p>
            <a:r>
              <a:rPr lang="en-US" dirty="0" smtClean="0"/>
              <a:t>Before</a:t>
            </a:r>
            <a:r>
              <a:rPr lang="en-US" baseline="0" dirty="0" smtClean="0"/>
              <a:t> we start in our learning activity, we would like you to complete a quick pre-test. This should take no more than 5minute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a:t>
            </a:r>
            <a:r>
              <a:rPr lang="en-US" i="1" baseline="0" dirty="0" err="1" smtClean="0"/>
              <a:t>Faciliators</a:t>
            </a:r>
            <a:r>
              <a:rPr lang="en-US" i="1" baseline="0" dirty="0" smtClean="0"/>
              <a:t> can choose to give out pre-test as paper test or electronically- such as with </a:t>
            </a:r>
            <a:r>
              <a:rPr lang="en-US" i="1" baseline="0" dirty="0" err="1" smtClean="0"/>
              <a:t>Qualtrics</a:t>
            </a:r>
            <a:r>
              <a:rPr lang="en-US" i="1" baseline="0" dirty="0" smtClean="0"/>
              <a:t>. This slide can be skipped if educators had learners complete pretest at home prior to session)</a:t>
            </a:r>
          </a:p>
          <a:p>
            <a:endParaRPr lang="en-US" i="1"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Click to next slide</a:t>
            </a:r>
            <a:r>
              <a:rPr lang="en-US" i="1" baseline="0" dirty="0" smtClean="0"/>
              <a:t>]</a:t>
            </a:r>
          </a:p>
          <a:p>
            <a:pPr marL="0" marR="0" indent="0" algn="l" defTabSz="914400" rtl="0" eaLnBrk="1" fontAlgn="auto" latinLnBrk="0" hangingPunct="1">
              <a:lnSpc>
                <a:spcPct val="100000"/>
              </a:lnSpc>
              <a:spcBef>
                <a:spcPts val="0"/>
              </a:spcBef>
              <a:spcAft>
                <a:spcPts val="0"/>
              </a:spcAft>
              <a:buClrTx/>
              <a:buSzTx/>
              <a:buFontTx/>
              <a:buNone/>
              <a:tabLst/>
              <a:defRPr/>
            </a:pPr>
            <a:endParaRPr lang="en-US" i="1" baseline="0" dirty="0" smtClean="0"/>
          </a:p>
        </p:txBody>
      </p:sp>
      <p:sp>
        <p:nvSpPr>
          <p:cNvPr id="4" name="Slide Number Placeholder 3"/>
          <p:cNvSpPr>
            <a:spLocks noGrp="1"/>
          </p:cNvSpPr>
          <p:nvPr>
            <p:ph type="sldNum" sz="quarter" idx="10"/>
          </p:nvPr>
        </p:nvSpPr>
        <p:spPr/>
        <p:txBody>
          <a:bodyPr/>
          <a:lstStyle/>
          <a:p>
            <a:fld id="{CEABF829-150D-42B8-ADB8-E3B602290832}" type="slidenum">
              <a:rPr lang="en-US" smtClean="0"/>
              <a:t>3</a:t>
            </a:fld>
            <a:endParaRPr lang="en-US"/>
          </a:p>
        </p:txBody>
      </p:sp>
    </p:spTree>
    <p:extLst>
      <p:ext uri="{BB962C8B-B14F-4D97-AF65-F5344CB8AC3E}">
        <p14:creationId xmlns:p14="http://schemas.microsoft.com/office/powerpoint/2010/main" val="97763441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acilitator script:</a:t>
            </a:r>
          </a:p>
          <a:p>
            <a:endParaRPr lang="en-US" dirty="0" smtClean="0"/>
          </a:p>
          <a:p>
            <a:r>
              <a:rPr lang="en-US" dirty="0" smtClean="0"/>
              <a:t>Here are your home groups for today. Please take note of your Group</a:t>
            </a:r>
            <a:r>
              <a:rPr lang="en-US" baseline="0" dirty="0" smtClean="0"/>
              <a:t> # and letter you are assigned. </a:t>
            </a:r>
          </a:p>
          <a:p>
            <a:endParaRPr lang="en-US" baseline="0" dirty="0" smtClean="0"/>
          </a:p>
          <a:p>
            <a:r>
              <a:rPr lang="en-US" i="1" baseline="0" dirty="0" smtClean="0"/>
              <a:t>(Facilitators should insert learner names into table.)</a:t>
            </a:r>
          </a:p>
          <a:p>
            <a:endParaRPr lang="en-US" i="1"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Click to next slide]</a:t>
            </a:r>
          </a:p>
          <a:p>
            <a:endParaRPr lang="en-US" i="1" dirty="0"/>
          </a:p>
        </p:txBody>
      </p:sp>
      <p:sp>
        <p:nvSpPr>
          <p:cNvPr id="4" name="Slide Number Placeholder 3"/>
          <p:cNvSpPr>
            <a:spLocks noGrp="1"/>
          </p:cNvSpPr>
          <p:nvPr>
            <p:ph type="sldNum" sz="quarter" idx="5"/>
          </p:nvPr>
        </p:nvSpPr>
        <p:spPr/>
        <p:txBody>
          <a:bodyPr/>
          <a:lstStyle/>
          <a:p>
            <a:fld id="{CEABF829-150D-42B8-ADB8-E3B602290832}" type="slidenum">
              <a:rPr lang="en-US" smtClean="0">
                <a:solidFill>
                  <a:prstClr val="black"/>
                </a:solidFill>
              </a:rPr>
              <a:pPr/>
              <a:t>4</a:t>
            </a:fld>
            <a:endParaRPr lang="en-US">
              <a:solidFill>
                <a:prstClr val="black"/>
              </a:solidFill>
            </a:endParaRPr>
          </a:p>
        </p:txBody>
      </p:sp>
    </p:spTree>
    <p:extLst>
      <p:ext uri="{BB962C8B-B14F-4D97-AF65-F5344CB8AC3E}">
        <p14:creationId xmlns:p14="http://schemas.microsoft.com/office/powerpoint/2010/main" val="7910574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acilitator script:</a:t>
            </a:r>
          </a:p>
          <a:p>
            <a:endParaRPr lang="en-US" dirty="0" smtClean="0"/>
          </a:p>
          <a:p>
            <a:r>
              <a:rPr lang="en-US" dirty="0" smtClean="0"/>
              <a:t>Now that you know your topic letters, please</a:t>
            </a:r>
            <a:r>
              <a:rPr lang="en-US" baseline="0" dirty="0" smtClean="0"/>
              <a:t> move into your letter expert groups. So all the A’s come together, B’s, etc. </a:t>
            </a:r>
          </a:p>
          <a:p>
            <a:endParaRPr lang="en-US" baseline="0" dirty="0" smtClean="0"/>
          </a:p>
          <a:p>
            <a:r>
              <a:rPr lang="en-US" baseline="0" dirty="0" smtClean="0"/>
              <a:t>In your experts groups, each of you should have a topic specific worksheet and a review article that will help you find the answers. </a:t>
            </a:r>
          </a:p>
          <a:p>
            <a:endParaRPr lang="en-US" baseline="0" dirty="0" smtClean="0"/>
          </a:p>
          <a:p>
            <a:r>
              <a:rPr lang="en-US" baseline="0" dirty="0" smtClean="0"/>
              <a:t>As facilitators, we will be circulating the room to answer any question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Facilitators can hand out expert review articles and expert student worksheets. Facilitators should circulate the room to answer questions and give time warnings – i.e. 15min, 10min, etc. Facilitators can give answers during the last 15-10min of this section)</a:t>
            </a:r>
          </a:p>
          <a:p>
            <a:endParaRPr lang="en-US" i="1"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Click to next slide]</a:t>
            </a:r>
          </a:p>
          <a:p>
            <a:endParaRPr lang="en-US" dirty="0"/>
          </a:p>
        </p:txBody>
      </p:sp>
      <p:sp>
        <p:nvSpPr>
          <p:cNvPr id="4" name="Slide Number Placeholder 3"/>
          <p:cNvSpPr>
            <a:spLocks noGrp="1"/>
          </p:cNvSpPr>
          <p:nvPr>
            <p:ph type="sldNum" sz="quarter" idx="10"/>
          </p:nvPr>
        </p:nvSpPr>
        <p:spPr/>
        <p:txBody>
          <a:bodyPr/>
          <a:lstStyle/>
          <a:p>
            <a:fld id="{CEABF829-150D-42B8-ADB8-E3B602290832}" type="slidenum">
              <a:rPr lang="en-US" smtClean="0"/>
              <a:t>5</a:t>
            </a:fld>
            <a:endParaRPr lang="en-US"/>
          </a:p>
        </p:txBody>
      </p:sp>
    </p:spTree>
    <p:extLst>
      <p:ext uri="{BB962C8B-B14F-4D97-AF65-F5344CB8AC3E}">
        <p14:creationId xmlns:p14="http://schemas.microsoft.com/office/powerpoint/2010/main" val="113823201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acilitator script:</a:t>
            </a:r>
          </a:p>
          <a:p>
            <a:endParaRPr lang="en-US" dirty="0" smtClean="0"/>
          </a:p>
          <a:p>
            <a:r>
              <a:rPr lang="en-US" dirty="0" smtClean="0"/>
              <a:t>Now that</a:t>
            </a:r>
            <a:r>
              <a:rPr lang="en-US" baseline="0" dirty="0" smtClean="0"/>
              <a:t> you are all experts, please return to your original home groups and you will be given patient case worksheet to complete together. You have 40 min to complete this section and we will review the answers all together afterwards.</a:t>
            </a:r>
          </a:p>
          <a:p>
            <a:endParaRPr lang="en-US" baseline="0" dirty="0" smtClean="0"/>
          </a:p>
          <a:p>
            <a:r>
              <a:rPr lang="en-US" i="1" baseline="0" dirty="0" smtClean="0"/>
              <a:t>(Facilitators should circulate the room to answer questions and give time warnings – i.e. 15min, 10min, etc.)</a:t>
            </a:r>
          </a:p>
          <a:p>
            <a:endParaRPr lang="en-US" i="1"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Click to next slide]</a:t>
            </a:r>
          </a:p>
          <a:p>
            <a:endParaRPr lang="en-US" dirty="0"/>
          </a:p>
        </p:txBody>
      </p:sp>
      <p:sp>
        <p:nvSpPr>
          <p:cNvPr id="4" name="Slide Number Placeholder 3"/>
          <p:cNvSpPr>
            <a:spLocks noGrp="1"/>
          </p:cNvSpPr>
          <p:nvPr>
            <p:ph type="sldNum" sz="quarter" idx="10"/>
          </p:nvPr>
        </p:nvSpPr>
        <p:spPr/>
        <p:txBody>
          <a:bodyPr/>
          <a:lstStyle/>
          <a:p>
            <a:fld id="{CEABF829-150D-42B8-ADB8-E3B602290832}" type="slidenum">
              <a:rPr lang="en-US" smtClean="0"/>
              <a:t>6</a:t>
            </a:fld>
            <a:endParaRPr lang="en-US"/>
          </a:p>
        </p:txBody>
      </p:sp>
    </p:spTree>
    <p:extLst>
      <p:ext uri="{BB962C8B-B14F-4D97-AF65-F5344CB8AC3E}">
        <p14:creationId xmlns:p14="http://schemas.microsoft.com/office/powerpoint/2010/main" val="11250061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acilitator script:</a:t>
            </a:r>
          </a:p>
          <a:p>
            <a:endParaRPr lang="en-US" dirty="0" smtClean="0"/>
          </a:p>
          <a:p>
            <a:r>
              <a:rPr lang="en-US" i="1" baseline="0" dirty="0" smtClean="0"/>
              <a:t>(If using </a:t>
            </a:r>
            <a:r>
              <a:rPr lang="en-US" i="1" baseline="0" dirty="0" err="1" smtClean="0"/>
              <a:t>Kahoot</a:t>
            </a:r>
            <a:r>
              <a:rPr lang="en-US" i="1" baseline="0" dirty="0" smtClean="0"/>
              <a:t>!, facilitators should log onto the instructor site and start the quiz. Learners will then log onto the game)</a:t>
            </a:r>
          </a:p>
          <a:p>
            <a:endParaRPr lang="en-US" i="1" baseline="0" dirty="0" smtClean="0"/>
          </a:p>
          <a:p>
            <a:r>
              <a:rPr lang="en-US" i="0" baseline="0" dirty="0" smtClean="0"/>
              <a:t>Now we are going to review the patient case answers. Please go to https://kahoot.it on your smart phone/tablet/laptop and plug in the game pin. You will then be prompted to put in your team name (you can be creative!) and then we can start the debrief. </a:t>
            </a:r>
          </a:p>
          <a:p>
            <a:endParaRPr lang="en-US" i="1"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Click to next slide]</a:t>
            </a:r>
          </a:p>
          <a:p>
            <a:endParaRPr lang="en-US" dirty="0"/>
          </a:p>
        </p:txBody>
      </p:sp>
      <p:sp>
        <p:nvSpPr>
          <p:cNvPr id="4" name="Slide Number Placeholder 3"/>
          <p:cNvSpPr>
            <a:spLocks noGrp="1"/>
          </p:cNvSpPr>
          <p:nvPr>
            <p:ph type="sldNum" sz="quarter" idx="10"/>
          </p:nvPr>
        </p:nvSpPr>
        <p:spPr/>
        <p:txBody>
          <a:bodyPr/>
          <a:lstStyle/>
          <a:p>
            <a:fld id="{CEABF829-150D-42B8-ADB8-E3B602290832}" type="slidenum">
              <a:rPr lang="en-US" smtClean="0"/>
              <a:t>7</a:t>
            </a:fld>
            <a:endParaRPr lang="en-US"/>
          </a:p>
        </p:txBody>
      </p:sp>
    </p:spTree>
    <p:extLst>
      <p:ext uri="{BB962C8B-B14F-4D97-AF65-F5344CB8AC3E}">
        <p14:creationId xmlns:p14="http://schemas.microsoft.com/office/powerpoint/2010/main" val="241319098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acilitator</a:t>
            </a:r>
            <a:r>
              <a:rPr lang="en-US" baseline="0" dirty="0" smtClean="0"/>
              <a:t> script:</a:t>
            </a:r>
          </a:p>
          <a:p>
            <a:r>
              <a:rPr lang="en-US" baseline="0" dirty="0" smtClean="0"/>
              <a:t/>
            </a:r>
            <a:br>
              <a:rPr lang="en-US" baseline="0" dirty="0" smtClean="0"/>
            </a:br>
            <a:r>
              <a:rPr lang="en-US" baseline="0" dirty="0" smtClean="0"/>
              <a:t>Thank you for participating in today’s workshop. As a final assessment, please complete our post-test to see how well you learned these topic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i="1" baseline="0" dirty="0" smtClean="0"/>
              <a:t>(</a:t>
            </a:r>
            <a:r>
              <a:rPr lang="en-US" i="1" baseline="0" dirty="0" err="1" smtClean="0"/>
              <a:t>Faciliators</a:t>
            </a:r>
            <a:r>
              <a:rPr lang="en-US" i="1" baseline="0" dirty="0" smtClean="0"/>
              <a:t> can choose to give out post-test as paper test or electronically- such </a:t>
            </a:r>
            <a:r>
              <a:rPr lang="en-US" i="1" baseline="0" smtClean="0"/>
              <a:t>as with Qualtrics</a:t>
            </a:r>
            <a:r>
              <a:rPr lang="en-US" i="1" baseline="0" dirty="0" smtClean="0"/>
              <a:t> or </a:t>
            </a:r>
            <a:r>
              <a:rPr lang="en-US" i="1" baseline="0" dirty="0" err="1" smtClean="0"/>
              <a:t>SurveyMonkey</a:t>
            </a:r>
            <a:r>
              <a:rPr lang="en-US" i="1" baseline="0" dirty="0" smtClean="0"/>
              <a:t>)</a:t>
            </a:r>
          </a:p>
          <a:p>
            <a:endParaRPr lang="en-US" dirty="0"/>
          </a:p>
        </p:txBody>
      </p:sp>
      <p:sp>
        <p:nvSpPr>
          <p:cNvPr id="4" name="Slide Number Placeholder 3"/>
          <p:cNvSpPr>
            <a:spLocks noGrp="1"/>
          </p:cNvSpPr>
          <p:nvPr>
            <p:ph type="sldNum" sz="quarter" idx="10"/>
          </p:nvPr>
        </p:nvSpPr>
        <p:spPr/>
        <p:txBody>
          <a:bodyPr/>
          <a:lstStyle/>
          <a:p>
            <a:fld id="{CEABF829-150D-42B8-ADB8-E3B602290832}" type="slidenum">
              <a:rPr lang="en-US" smtClean="0"/>
              <a:t>8</a:t>
            </a:fld>
            <a:endParaRPr lang="en-US"/>
          </a:p>
        </p:txBody>
      </p:sp>
    </p:spTree>
    <p:extLst>
      <p:ext uri="{BB962C8B-B14F-4D97-AF65-F5344CB8AC3E}">
        <p14:creationId xmlns:p14="http://schemas.microsoft.com/office/powerpoint/2010/main" val="1208586715"/>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g"/><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3.jpg"/><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0" y="0"/>
            <a:ext cx="12192000" cy="6858000"/>
            <a:chOff x="0" y="0"/>
            <a:chExt cx="12192000" cy="6858000"/>
          </a:xfrm>
        </p:grpSpPr>
        <p:sp>
          <p:nvSpPr>
            <p:cNvPr id="9" name="Rectangle 8"/>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ctrTitle"/>
          </p:nvPr>
        </p:nvSpPr>
        <p:spPr>
          <a:xfrm>
            <a:off x="1154955" y="2099733"/>
            <a:ext cx="8825658" cy="2677648"/>
          </a:xfrm>
        </p:spPr>
        <p:txBody>
          <a:bodyPr anchor="b"/>
          <a:lstStyle>
            <a:lvl1pPr>
              <a:defRPr sz="5400"/>
            </a:lvl1pPr>
          </a:lstStyle>
          <a:p>
            <a:r>
              <a:rPr lang="en-US" smtClean="0"/>
              <a:t>Click to edit Master title style</a:t>
            </a:r>
            <a:endParaRPr lang="en-US" dirty="0"/>
          </a:p>
        </p:txBody>
      </p:sp>
      <p:sp>
        <p:nvSpPr>
          <p:cNvPr id="3" name="Subtitle 2"/>
          <p:cNvSpPr>
            <a:spLocks noGrp="1"/>
          </p:cNvSpPr>
          <p:nvPr>
            <p:ph type="subTitle" idx="1"/>
          </p:nvPr>
        </p:nvSpPr>
        <p:spPr bwMode="gray">
          <a:xfrm>
            <a:off x="1154955" y="4777380"/>
            <a:ext cx="8825658" cy="861420"/>
          </a:xfrm>
        </p:spPr>
        <p:txBody>
          <a:bodyPr anchor="t"/>
          <a:lstStyle>
            <a:lvl1pPr marL="0" indent="0" algn="l">
              <a:buNone/>
              <a:defRPr cap="all">
                <a:solidFill>
                  <a:schemeClr val="accent1">
                    <a:lumMod val="60000"/>
                    <a:lumOff val="4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4" name="Date Placeholder 3"/>
          <p:cNvSpPr>
            <a:spLocks noGrp="1"/>
          </p:cNvSpPr>
          <p:nvPr>
            <p:ph type="dt" sz="half" idx="10"/>
          </p:nvPr>
        </p:nvSpPr>
        <p:spPr bwMode="gray">
          <a:xfrm rot="5400000">
            <a:off x="10158984" y="1792224"/>
            <a:ext cx="990599" cy="304799"/>
          </a:xfrm>
        </p:spPr>
        <p:txBody>
          <a:bodyPr anchor="t"/>
          <a:lstStyle>
            <a:lvl1pPr algn="l">
              <a:defRPr b="0" i="0">
                <a:solidFill>
                  <a:schemeClr val="bg1">
                    <a:alpha val="60000"/>
                  </a:schemeClr>
                </a:solidFill>
              </a:defRPr>
            </a:lvl1pPr>
          </a:lstStyle>
          <a:p>
            <a:fld id="{AC3C9A8A-5F74-4945-89C1-6C480A0020A7}" type="datetimeFigureOut">
              <a:rPr lang="en-US" smtClean="0"/>
              <a:t>4/20/2020</a:t>
            </a:fld>
            <a:endParaRPr lang="en-US"/>
          </a:p>
        </p:txBody>
      </p:sp>
      <p:sp>
        <p:nvSpPr>
          <p:cNvPr id="5" name="Footer Placeholder 4"/>
          <p:cNvSpPr>
            <a:spLocks noGrp="1"/>
          </p:cNvSpPr>
          <p:nvPr>
            <p:ph type="ftr" sz="quarter" idx="11"/>
          </p:nvPr>
        </p:nvSpPr>
        <p:spPr bwMode="gray">
          <a:xfrm rot="5400000">
            <a:off x="8951976" y="3227832"/>
            <a:ext cx="3859795" cy="304801"/>
          </a:xfrm>
        </p:spPr>
        <p:txBody>
          <a:bodyPr/>
          <a:lstStyle>
            <a:lvl1pPr>
              <a:defRPr b="0" i="0">
                <a:solidFill>
                  <a:schemeClr val="bg1">
                    <a:alpha val="60000"/>
                  </a:schemeClr>
                </a:solidFill>
              </a:defRPr>
            </a:lvl1pPr>
          </a:lstStyle>
          <a:p>
            <a:endParaRPr lang="en-US"/>
          </a:p>
        </p:txBody>
      </p:sp>
      <p:sp>
        <p:nvSpPr>
          <p:cNvPr id="11" name="Rectangle 10"/>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12" name="Slide Number Placeholder 5"/>
          <p:cNvSpPr>
            <a:spLocks noGrp="1"/>
          </p:cNvSpPr>
          <p:nvPr>
            <p:ph type="sldNum" sz="quarter" idx="12"/>
          </p:nvPr>
        </p:nvSpPr>
        <p:spPr>
          <a:xfrm>
            <a:off x="10352540" y="295729"/>
            <a:ext cx="838199" cy="767687"/>
          </a:xfrm>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2500162854"/>
      </p:ext>
    </p:extLst>
  </p:cSld>
  <p:clrMapOvr>
    <a:masterClrMapping/>
  </p:clrMapOvr>
  <p:extLst>
    <p:ext uri="{DCECCB84-F9BA-43D5-87BE-67443E8EF086}">
      <p15:sldGuideLst xmlns:p15="http://schemas.microsoft.com/office/powerpoint/2012/main"/>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3" name="Rectangle 12"/>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4" name="Freeform 5"/>
            <p:cNvSpPr/>
            <p:nvPr/>
          </p:nvSpPr>
          <p:spPr bwMode="gray">
            <a:xfrm rot="10371525">
              <a:off x="263767" y="443825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1" name="Freeform 5"/>
            <p:cNvSpPr/>
            <p:nvPr/>
          </p:nvSpPr>
          <p:spPr bwMode="gray">
            <a:xfrm rot="10800000">
              <a:off x="459506" y="321130"/>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4969927"/>
            <a:ext cx="8825659" cy="566738"/>
          </a:xfrm>
        </p:spPr>
        <p:txBody>
          <a:bodyPr anchor="b">
            <a:normAutofit/>
          </a:bodyPr>
          <a:lstStyle>
            <a:lvl1pPr algn="l">
              <a:defRPr sz="24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1154954" y="685800"/>
            <a:ext cx="8825659" cy="3429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Click icon to add picture</a:t>
            </a:r>
            <a:endParaRPr lang="en-US" dirty="0"/>
          </a:p>
        </p:txBody>
      </p:sp>
      <p:sp>
        <p:nvSpPr>
          <p:cNvPr id="4" name="Text Placeholder 3"/>
          <p:cNvSpPr>
            <a:spLocks noGrp="1"/>
          </p:cNvSpPr>
          <p:nvPr>
            <p:ph type="body" sz="half" idx="2"/>
          </p:nvPr>
        </p:nvSpPr>
        <p:spPr>
          <a:xfrm>
            <a:off x="1154954" y="5536665"/>
            <a:ext cx="8825658" cy="493712"/>
          </a:xfrm>
        </p:spPr>
        <p:txBody>
          <a:bodyPr>
            <a:normAutofit/>
          </a:bodyPr>
          <a:lstStyle>
            <a:lvl1pPr marL="0" indent="0">
              <a:buNone/>
              <a:defRPr sz="12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C3C9A8A-5F74-4945-89C1-6C480A0020A7}" type="datetimeFigureOut">
              <a:rPr lang="en-US" smtClean="0"/>
              <a:t>4/20/2020</a:t>
            </a:fld>
            <a:endParaRPr lang="en-US"/>
          </a:p>
        </p:txBody>
      </p:sp>
      <p:sp>
        <p:nvSpPr>
          <p:cNvPr id="6" name="Footer Placeholder 5"/>
          <p:cNvSpPr>
            <a:spLocks noGrp="1"/>
          </p:cNvSpPr>
          <p:nvPr>
            <p:ph type="ftr" sz="quarter" idx="11"/>
          </p:nvPr>
        </p:nvSpPr>
        <p:spPr/>
        <p:txBody>
          <a:bodyPr/>
          <a:lstStyle/>
          <a:p>
            <a:endParaRPr lang="en-US"/>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34356878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preserve="1">
  <p:cSld name="Title and Caption">
    <p:spTree>
      <p:nvGrpSpPr>
        <p:cNvPr id="1" name=""/>
        <p:cNvGrpSpPr/>
        <p:nvPr/>
      </p:nvGrpSpPr>
      <p:grpSpPr>
        <a:xfrm>
          <a:off x="0" y="0"/>
          <a:ext cx="0" cy="0"/>
          <a:chOff x="0" y="0"/>
          <a:chExt cx="0" cy="0"/>
        </a:xfrm>
      </p:grpSpPr>
      <p:grpSp>
        <p:nvGrpSpPr>
          <p:cNvPr id="7" name="Group 6"/>
          <p:cNvGrpSpPr/>
          <p:nvPr/>
        </p:nvGrpSpPr>
        <p:grpSpPr>
          <a:xfrm>
            <a:off x="0" y="0"/>
            <a:ext cx="12192000" cy="6858000"/>
            <a:chOff x="0" y="0"/>
            <a:chExt cx="12192000" cy="6858000"/>
          </a:xfrm>
        </p:grpSpPr>
        <p:sp>
          <p:nvSpPr>
            <p:cNvPr id="11" name="Rectangle 10"/>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4" name="Oval 13"/>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5" name="Freeform 5"/>
            <p:cNvSpPr/>
            <p:nvPr/>
          </p:nvSpPr>
          <p:spPr bwMode="gray">
            <a:xfrm rot="21010068">
              <a:off x="8490951" y="271487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7" name="Freeform 5"/>
            <p:cNvSpPr/>
            <p:nvPr/>
          </p:nvSpPr>
          <p:spPr bwMode="gray">
            <a:xfrm>
              <a:off x="455612" y="2801319"/>
              <a:ext cx="11277600" cy="3602637"/>
            </a:xfrm>
            <a:custGeom>
              <a:avLst/>
              <a:gdLst/>
              <a:ahLst/>
              <a:cxnLst/>
              <a:rect l="l" t="t" r="r" b="b"/>
              <a:pathLst>
                <a:path w="10000" h="7946">
                  <a:moveTo>
                    <a:pt x="0" y="0"/>
                  </a:moveTo>
                  <a:lnTo>
                    <a:pt x="0" y="7945"/>
                  </a:lnTo>
                  <a:lnTo>
                    <a:pt x="10000" y="7946"/>
                  </a:lnTo>
                  <a:lnTo>
                    <a:pt x="10000" y="4"/>
                  </a:lnTo>
                  <a:lnTo>
                    <a:pt x="10000" y="4"/>
                  </a:lnTo>
                  <a:lnTo>
                    <a:pt x="9773" y="91"/>
                  </a:lnTo>
                  <a:lnTo>
                    <a:pt x="9547" y="175"/>
                  </a:lnTo>
                  <a:lnTo>
                    <a:pt x="9320" y="256"/>
                  </a:lnTo>
                  <a:lnTo>
                    <a:pt x="9092" y="326"/>
                  </a:lnTo>
                  <a:lnTo>
                    <a:pt x="8865" y="396"/>
                  </a:lnTo>
                  <a:lnTo>
                    <a:pt x="8637" y="462"/>
                  </a:lnTo>
                  <a:lnTo>
                    <a:pt x="8412" y="518"/>
                  </a:lnTo>
                  <a:lnTo>
                    <a:pt x="8184" y="571"/>
                  </a:lnTo>
                  <a:lnTo>
                    <a:pt x="7957" y="620"/>
                  </a:lnTo>
                  <a:lnTo>
                    <a:pt x="7734" y="662"/>
                  </a:lnTo>
                  <a:lnTo>
                    <a:pt x="7508" y="704"/>
                  </a:lnTo>
                  <a:lnTo>
                    <a:pt x="7285" y="739"/>
                  </a:lnTo>
                  <a:lnTo>
                    <a:pt x="7062" y="767"/>
                  </a:lnTo>
                  <a:lnTo>
                    <a:pt x="6840" y="795"/>
                  </a:lnTo>
                  <a:lnTo>
                    <a:pt x="6620" y="819"/>
                  </a:lnTo>
                  <a:lnTo>
                    <a:pt x="6402" y="837"/>
                  </a:lnTo>
                  <a:lnTo>
                    <a:pt x="6184" y="851"/>
                  </a:lnTo>
                  <a:lnTo>
                    <a:pt x="5968" y="865"/>
                  </a:lnTo>
                  <a:lnTo>
                    <a:pt x="5755" y="872"/>
                  </a:lnTo>
                  <a:lnTo>
                    <a:pt x="5542" y="879"/>
                  </a:lnTo>
                  <a:lnTo>
                    <a:pt x="5332" y="882"/>
                  </a:lnTo>
                  <a:lnTo>
                    <a:pt x="5124" y="879"/>
                  </a:lnTo>
                  <a:lnTo>
                    <a:pt x="4918" y="879"/>
                  </a:lnTo>
                  <a:lnTo>
                    <a:pt x="4714" y="872"/>
                  </a:lnTo>
                  <a:lnTo>
                    <a:pt x="4514" y="861"/>
                  </a:lnTo>
                  <a:lnTo>
                    <a:pt x="4316" y="851"/>
                  </a:lnTo>
                  <a:lnTo>
                    <a:pt x="4122" y="840"/>
                  </a:lnTo>
                  <a:lnTo>
                    <a:pt x="3929" y="823"/>
                  </a:lnTo>
                  <a:lnTo>
                    <a:pt x="3739" y="805"/>
                  </a:lnTo>
                  <a:lnTo>
                    <a:pt x="3553" y="788"/>
                  </a:lnTo>
                  <a:lnTo>
                    <a:pt x="3190" y="742"/>
                  </a:lnTo>
                  <a:lnTo>
                    <a:pt x="2842" y="693"/>
                  </a:lnTo>
                  <a:lnTo>
                    <a:pt x="2508" y="641"/>
                  </a:lnTo>
                  <a:lnTo>
                    <a:pt x="2192" y="585"/>
                  </a:lnTo>
                  <a:lnTo>
                    <a:pt x="1890" y="525"/>
                  </a:lnTo>
                  <a:lnTo>
                    <a:pt x="1610" y="462"/>
                  </a:lnTo>
                  <a:lnTo>
                    <a:pt x="1347" y="399"/>
                  </a:lnTo>
                  <a:lnTo>
                    <a:pt x="1105" y="336"/>
                  </a:lnTo>
                  <a:lnTo>
                    <a:pt x="883" y="277"/>
                  </a:lnTo>
                  <a:lnTo>
                    <a:pt x="686" y="221"/>
                  </a:lnTo>
                  <a:lnTo>
                    <a:pt x="508" y="168"/>
                  </a:lnTo>
                  <a:lnTo>
                    <a:pt x="358" y="123"/>
                  </a:lnTo>
                  <a:lnTo>
                    <a:pt x="232" y="81"/>
                  </a:lnTo>
                  <a:lnTo>
                    <a:pt x="59" y="21"/>
                  </a:lnTo>
                  <a:lnTo>
                    <a:pt x="0" y="0"/>
                  </a:lnTo>
                  <a:lnTo>
                    <a:pt x="0" y="0"/>
                  </a:lnTo>
                  <a:close/>
                </a:path>
              </a:pathLst>
            </a:custGeom>
            <a:solidFill>
              <a:schemeClr val="bg1"/>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48798" y="1063417"/>
            <a:ext cx="8831816" cy="1372986"/>
          </a:xfrm>
        </p:spPr>
        <p:txBody>
          <a:bodyPr/>
          <a:lstStyle>
            <a:lvl1pPr>
              <a:defRPr sz="4000"/>
            </a:lvl1pPr>
          </a:lstStyle>
          <a:p>
            <a:r>
              <a:rPr lang="en-US" smtClean="0"/>
              <a:t>Click to edit Master title style</a:t>
            </a:r>
            <a:endParaRPr lang="en-US" dirty="0"/>
          </a:p>
        </p:txBody>
      </p:sp>
      <p:sp>
        <p:nvSpPr>
          <p:cNvPr id="8" name="Text Placeholder 3"/>
          <p:cNvSpPr>
            <a:spLocks noGrp="1"/>
          </p:cNvSpPr>
          <p:nvPr>
            <p:ph type="body" sz="half" idx="2"/>
          </p:nvPr>
        </p:nvSpPr>
        <p:spPr>
          <a:xfrm>
            <a:off x="1154954" y="3543300"/>
            <a:ext cx="8825659" cy="24765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C3C9A8A-5F74-4945-89C1-6C480A0020A7}" type="datetimeFigureOut">
              <a:rPr lang="en-US" smtClean="0"/>
              <a:t>4/20/2020</a:t>
            </a:fld>
            <a:endParaRPr lang="en-US"/>
          </a:p>
        </p:txBody>
      </p:sp>
      <p:sp>
        <p:nvSpPr>
          <p:cNvPr id="5" name="Footer Placeholder 4"/>
          <p:cNvSpPr>
            <a:spLocks noGrp="1"/>
          </p:cNvSpPr>
          <p:nvPr>
            <p:ph type="ftr" sz="quarter" idx="11"/>
          </p:nvPr>
        </p:nvSpPr>
        <p:spPr/>
        <p:txBody>
          <a:bodyPr/>
          <a:lstStyle/>
          <a:p>
            <a:endParaRPr lang="en-US"/>
          </a:p>
        </p:txBody>
      </p:sp>
      <p:sp>
        <p:nvSpPr>
          <p:cNvPr id="13" name="Rectangle 12"/>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326296563"/>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p:cSld name="Quote with Caption">
    <p:spTree>
      <p:nvGrpSpPr>
        <p:cNvPr id="1" name=""/>
        <p:cNvGrpSpPr/>
        <p:nvPr/>
      </p:nvGrpSpPr>
      <p:grpSpPr>
        <a:xfrm>
          <a:off x="0" y="0"/>
          <a:ext cx="0" cy="0"/>
          <a:chOff x="0" y="0"/>
          <a:chExt cx="0" cy="0"/>
        </a:xfrm>
      </p:grpSpPr>
      <p:grpSp>
        <p:nvGrpSpPr>
          <p:cNvPr id="3" name="Group 2"/>
          <p:cNvGrpSpPr/>
          <p:nvPr/>
        </p:nvGrpSpPr>
        <p:grpSpPr>
          <a:xfrm>
            <a:off x="0" y="0"/>
            <a:ext cx="12192000" cy="6858000"/>
            <a:chOff x="0" y="0"/>
            <a:chExt cx="12192000" cy="6858000"/>
          </a:xfrm>
        </p:grpSpPr>
        <p:sp>
          <p:nvSpPr>
            <p:cNvPr id="17" name="Rectangle 16"/>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0" name="Oval 19"/>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2" name="Oval 21"/>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5" name="Oval 24"/>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Freeform 5"/>
            <p:cNvSpPr/>
            <p:nvPr/>
          </p:nvSpPr>
          <p:spPr bwMode="gray">
            <a:xfrm rot="21010068">
              <a:off x="8490951" y="41851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8"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16" name="TextBox 15"/>
          <p:cNvSpPr txBox="1"/>
          <p:nvPr/>
        </p:nvSpPr>
        <p:spPr bwMode="gray">
          <a:xfrm>
            <a:off x="881566" y="607336"/>
            <a:ext cx="801912" cy="1569660"/>
          </a:xfrm>
          <a:prstGeom prst="rect">
            <a:avLst/>
          </a:prstGeom>
          <a:noFill/>
        </p:spPr>
        <p:txBody>
          <a:bodyPr wrap="square" rtlCol="0">
            <a:spAutoFit/>
          </a:bodyPr>
          <a:lstStyle/>
          <a:p>
            <a:pPr algn="r"/>
            <a:r>
              <a:rPr lang="en-US" sz="9600" b="0" i="0" dirty="0">
                <a:solidFill>
                  <a:schemeClr val="accent1">
                    <a:lumMod val="60000"/>
                    <a:lumOff val="40000"/>
                  </a:schemeClr>
                </a:solidFill>
                <a:latin typeface="Arial"/>
                <a:cs typeface="Arial"/>
              </a:rPr>
              <a:t>“</a:t>
            </a:r>
          </a:p>
        </p:txBody>
      </p:sp>
      <p:sp>
        <p:nvSpPr>
          <p:cNvPr id="13" name="TextBox 12"/>
          <p:cNvSpPr txBox="1"/>
          <p:nvPr/>
        </p:nvSpPr>
        <p:spPr bwMode="gray">
          <a:xfrm>
            <a:off x="9884458" y="2613787"/>
            <a:ext cx="652763" cy="1569660"/>
          </a:xfrm>
          <a:prstGeom prst="rect">
            <a:avLst/>
          </a:prstGeom>
          <a:noFill/>
        </p:spPr>
        <p:txBody>
          <a:bodyPr wrap="square" rtlCol="0">
            <a:spAutoFit/>
          </a:bodyPr>
          <a:lstStyle/>
          <a:p>
            <a:pPr algn="r"/>
            <a:r>
              <a:rPr lang="en-US" sz="9600" b="0" i="0" dirty="0">
                <a:solidFill>
                  <a:schemeClr val="accent1">
                    <a:lumMod val="60000"/>
                    <a:lumOff val="40000"/>
                  </a:schemeClr>
                </a:solidFill>
                <a:latin typeface="Arial"/>
                <a:cs typeface="Arial"/>
              </a:rPr>
              <a:t>”</a:t>
            </a:r>
          </a:p>
        </p:txBody>
      </p:sp>
      <p:sp>
        <p:nvSpPr>
          <p:cNvPr id="2" name="Title 1"/>
          <p:cNvSpPr>
            <a:spLocks noGrp="1"/>
          </p:cNvSpPr>
          <p:nvPr>
            <p:ph type="title"/>
          </p:nvPr>
        </p:nvSpPr>
        <p:spPr>
          <a:xfrm>
            <a:off x="1581878" y="982134"/>
            <a:ext cx="8453906" cy="2696632"/>
          </a:xfrm>
        </p:spPr>
        <p:txBody>
          <a:bodyPr/>
          <a:lstStyle>
            <a:lvl1pPr>
              <a:defRPr sz="4000"/>
            </a:lvl1pPr>
          </a:lstStyle>
          <a:p>
            <a:r>
              <a:rPr lang="en-US" smtClean="0"/>
              <a:t>Click to edit Master title style</a:t>
            </a:r>
            <a:endParaRPr lang="en-US" dirty="0"/>
          </a:p>
        </p:txBody>
      </p:sp>
      <p:sp>
        <p:nvSpPr>
          <p:cNvPr id="14" name="Text Placeholder 3"/>
          <p:cNvSpPr>
            <a:spLocks noGrp="1"/>
          </p:cNvSpPr>
          <p:nvPr>
            <p:ph type="body" sz="half" idx="13"/>
          </p:nvPr>
        </p:nvSpPr>
        <p:spPr bwMode="gray">
          <a:xfrm>
            <a:off x="1945945" y="3678766"/>
            <a:ext cx="7731219" cy="342174"/>
          </a:xfrm>
        </p:spPr>
        <p:txBody>
          <a:bodyPr anchor="t">
            <a:normAutofit/>
          </a:bodyPr>
          <a:lstStyle>
            <a:lvl1pPr marL="0" indent="0">
              <a:buNone/>
              <a:defRPr lang="en-US" sz="1400" b="0" i="0" kern="1200" cap="small" dirty="0">
                <a:solidFill>
                  <a:schemeClr val="accent1">
                    <a:lumMod val="60000"/>
                    <a:lumOff val="40000"/>
                  </a:schemeClr>
                </a:solidFill>
                <a:latin typeface="+mn-lt"/>
                <a:ea typeface="+mn-ea"/>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10" name="Text Placeholder 3"/>
          <p:cNvSpPr>
            <a:spLocks noGrp="1"/>
          </p:cNvSpPr>
          <p:nvPr>
            <p:ph type="body" sz="half" idx="2"/>
          </p:nvPr>
        </p:nvSpPr>
        <p:spPr>
          <a:xfrm>
            <a:off x="1154954" y="5029199"/>
            <a:ext cx="9244897" cy="997857"/>
          </a:xfrm>
        </p:spPr>
        <p:txBody>
          <a:bodyPr anchor="ct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C3C9A8A-5F74-4945-89C1-6C480A0020A7}" type="datetimeFigureOut">
              <a:rPr lang="en-US" smtClean="0"/>
              <a:t>4/20/2020</a:t>
            </a:fld>
            <a:endParaRPr lang="en-US"/>
          </a:p>
        </p:txBody>
      </p:sp>
      <p:sp>
        <p:nvSpPr>
          <p:cNvPr id="5" name="Footer Placeholder 4"/>
          <p:cNvSpPr>
            <a:spLocks noGrp="1"/>
          </p:cNvSpPr>
          <p:nvPr>
            <p:ph type="ftr" sz="quarter" idx="11"/>
          </p:nvPr>
        </p:nvSpPr>
        <p:spPr/>
        <p:txBody>
          <a:bodyPr/>
          <a:lstStyle/>
          <a:p>
            <a:endParaRPr lang="en-US"/>
          </a:p>
        </p:txBody>
      </p:sp>
      <p:sp>
        <p:nvSpPr>
          <p:cNvPr id="19" name="Rectangle 18"/>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256953741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p:cSld name="Name Card">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1" name="Rectangle 10"/>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3" name="Freeform 5"/>
            <p:cNvSpPr/>
            <p:nvPr/>
          </p:nvSpPr>
          <p:spPr bwMode="gray">
            <a:xfrm rot="21010068">
              <a:off x="8490951" y="4193583"/>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8"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2370667"/>
            <a:ext cx="8825660" cy="1822514"/>
          </a:xfrm>
        </p:spPr>
        <p:txBody>
          <a:bodyPr anchor="b"/>
          <a:lstStyle>
            <a:lvl1pPr algn="l">
              <a:defRPr sz="40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1154954" y="5024967"/>
            <a:ext cx="8825659" cy="860400"/>
          </a:xfrm>
        </p:spPr>
        <p:txBody>
          <a:bodyPr anchor="t"/>
          <a:lstStyle>
            <a:lvl1pPr marL="0" indent="0" algn="l">
              <a:buNone/>
              <a:defRPr sz="2000" cap="none">
                <a:solidFill>
                  <a:schemeClr val="accent1">
                    <a:lumMod val="60000"/>
                    <a:lumOff val="4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C3C9A8A-5F74-4945-89C1-6C480A0020A7}" type="datetimeFigureOut">
              <a:rPr lang="en-US" smtClean="0"/>
              <a:t>4/20/2020</a:t>
            </a:fld>
            <a:endParaRPr lang="en-US"/>
          </a:p>
        </p:txBody>
      </p:sp>
      <p:sp>
        <p:nvSpPr>
          <p:cNvPr id="5" name="Footer Placeholder 4"/>
          <p:cNvSpPr>
            <a:spLocks noGrp="1"/>
          </p:cNvSpPr>
          <p:nvPr>
            <p:ph type="ftr" sz="quarter" idx="11"/>
          </p:nvPr>
        </p:nvSpPr>
        <p:spPr/>
        <p:txBody>
          <a:bodyPr/>
          <a:lstStyle/>
          <a:p>
            <a:endParaRPr lang="en-US"/>
          </a:p>
        </p:txBody>
      </p:sp>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214633496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lvl1pPr>
              <a:defRPr sz="3600"/>
            </a:lvl1pPr>
          </a:lstStyle>
          <a:p>
            <a:r>
              <a:rPr lang="en-US" smtClean="0"/>
              <a:t>Click to edit Master title style</a:t>
            </a:r>
            <a:endParaRPr lang="en-US" dirty="0"/>
          </a:p>
        </p:txBody>
      </p:sp>
      <p:sp>
        <p:nvSpPr>
          <p:cNvPr id="3" name="Text Placeholder 2"/>
          <p:cNvSpPr>
            <a:spLocks noGrp="1"/>
          </p:cNvSpPr>
          <p:nvPr>
            <p:ph type="body" idx="1"/>
          </p:nvPr>
        </p:nvSpPr>
        <p:spPr>
          <a:xfrm>
            <a:off x="1154954" y="2603502"/>
            <a:ext cx="3141878"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16" name="Text Placeholder 3"/>
          <p:cNvSpPr>
            <a:spLocks noGrp="1"/>
          </p:cNvSpPr>
          <p:nvPr>
            <p:ph type="body" sz="half" idx="15"/>
          </p:nvPr>
        </p:nvSpPr>
        <p:spPr>
          <a:xfrm>
            <a:off x="1154953" y="3179764"/>
            <a:ext cx="3141879"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Text Placeholder 4"/>
          <p:cNvSpPr>
            <a:spLocks noGrp="1"/>
          </p:cNvSpPr>
          <p:nvPr>
            <p:ph type="body" sz="quarter" idx="3"/>
          </p:nvPr>
        </p:nvSpPr>
        <p:spPr>
          <a:xfrm>
            <a:off x="4512721" y="2603500"/>
            <a:ext cx="3147009"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19" name="Text Placeholder 3"/>
          <p:cNvSpPr>
            <a:spLocks noGrp="1"/>
          </p:cNvSpPr>
          <p:nvPr>
            <p:ph type="body" sz="half" idx="16"/>
          </p:nvPr>
        </p:nvSpPr>
        <p:spPr>
          <a:xfrm>
            <a:off x="4512721" y="3179763"/>
            <a:ext cx="3147009"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14" name="Text Placeholder 4"/>
          <p:cNvSpPr>
            <a:spLocks noGrp="1"/>
          </p:cNvSpPr>
          <p:nvPr>
            <p:ph type="body" sz="quarter" idx="13"/>
          </p:nvPr>
        </p:nvSpPr>
        <p:spPr>
          <a:xfrm>
            <a:off x="7888135" y="2603501"/>
            <a:ext cx="3145730"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20" name="Text Placeholder 3"/>
          <p:cNvSpPr>
            <a:spLocks noGrp="1"/>
          </p:cNvSpPr>
          <p:nvPr>
            <p:ph type="body" sz="half" idx="17"/>
          </p:nvPr>
        </p:nvSpPr>
        <p:spPr>
          <a:xfrm>
            <a:off x="7888329" y="3179762"/>
            <a:ext cx="3145536"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cxnSp>
        <p:nvCxnSpPr>
          <p:cNvPr id="17" name="Straight Connector 16"/>
          <p:cNvCxnSpPr/>
          <p:nvPr/>
        </p:nvCxnSpPr>
        <p:spPr>
          <a:xfrm>
            <a:off x="440397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777240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AC3C9A8A-5F74-4945-89C1-6C480A0020A7}" type="datetimeFigureOut">
              <a:rPr lang="en-US" smtClean="0"/>
              <a:t>4/20/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177370413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lvl1pPr>
              <a:defRPr sz="3600"/>
            </a:lvl1pPr>
          </a:lstStyle>
          <a:p>
            <a:r>
              <a:rPr lang="en-US" smtClean="0"/>
              <a:t>Click to edit Master title style</a:t>
            </a:r>
            <a:endParaRPr lang="en-US" dirty="0"/>
          </a:p>
        </p:txBody>
      </p:sp>
      <p:sp>
        <p:nvSpPr>
          <p:cNvPr id="3" name="Text Placeholder 2"/>
          <p:cNvSpPr>
            <a:spLocks noGrp="1"/>
          </p:cNvSpPr>
          <p:nvPr>
            <p:ph type="body" idx="1"/>
          </p:nvPr>
        </p:nvSpPr>
        <p:spPr>
          <a:xfrm>
            <a:off x="1154954" y="4532844"/>
            <a:ext cx="3050438"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19" name="Picture Placeholder 2"/>
          <p:cNvSpPr>
            <a:spLocks noGrp="1" noChangeAspect="1"/>
          </p:cNvSpPr>
          <p:nvPr>
            <p:ph type="pic" idx="15"/>
          </p:nvPr>
        </p:nvSpPr>
        <p:spPr>
          <a:xfrm>
            <a:off x="1334553"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Click icon to add picture</a:t>
            </a:r>
            <a:endParaRPr lang="en-US" dirty="0"/>
          </a:p>
        </p:txBody>
      </p:sp>
      <p:sp>
        <p:nvSpPr>
          <p:cNvPr id="22" name="Text Placeholder 3"/>
          <p:cNvSpPr>
            <a:spLocks noGrp="1"/>
          </p:cNvSpPr>
          <p:nvPr>
            <p:ph type="body" sz="half" idx="18"/>
          </p:nvPr>
        </p:nvSpPr>
        <p:spPr>
          <a:xfrm>
            <a:off x="1154954" y="5109106"/>
            <a:ext cx="3050438"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Text Placeholder 4"/>
          <p:cNvSpPr>
            <a:spLocks noGrp="1"/>
          </p:cNvSpPr>
          <p:nvPr>
            <p:ph type="body" sz="quarter" idx="3"/>
          </p:nvPr>
        </p:nvSpPr>
        <p:spPr>
          <a:xfrm>
            <a:off x="4568865" y="4532844"/>
            <a:ext cx="3050438" cy="576263"/>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1" name="Picture Placeholder 2"/>
          <p:cNvSpPr>
            <a:spLocks noGrp="1" noChangeAspect="1"/>
          </p:cNvSpPr>
          <p:nvPr>
            <p:ph type="pic" idx="21"/>
          </p:nvPr>
        </p:nvSpPr>
        <p:spPr>
          <a:xfrm>
            <a:off x="4748462" y="2603500"/>
            <a:ext cx="2691243"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Click icon to add picture</a:t>
            </a:r>
            <a:endParaRPr lang="en-US" dirty="0"/>
          </a:p>
        </p:txBody>
      </p:sp>
      <p:sp>
        <p:nvSpPr>
          <p:cNvPr id="23" name="Text Placeholder 3"/>
          <p:cNvSpPr>
            <a:spLocks noGrp="1"/>
          </p:cNvSpPr>
          <p:nvPr>
            <p:ph type="body" sz="half" idx="19"/>
          </p:nvPr>
        </p:nvSpPr>
        <p:spPr>
          <a:xfrm>
            <a:off x="4570172" y="5109105"/>
            <a:ext cx="3050438"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14" name="Text Placeholder 4"/>
          <p:cNvSpPr>
            <a:spLocks noGrp="1"/>
          </p:cNvSpPr>
          <p:nvPr>
            <p:ph type="body" sz="quarter" idx="13"/>
          </p:nvPr>
        </p:nvSpPr>
        <p:spPr>
          <a:xfrm>
            <a:off x="7982775" y="4532845"/>
            <a:ext cx="3051095"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2" name="Picture Placeholder 2"/>
          <p:cNvSpPr>
            <a:spLocks noGrp="1" noChangeAspect="1"/>
          </p:cNvSpPr>
          <p:nvPr>
            <p:ph type="pic" idx="22"/>
          </p:nvPr>
        </p:nvSpPr>
        <p:spPr>
          <a:xfrm>
            <a:off x="8163031"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Click icon to add picture</a:t>
            </a:r>
            <a:endParaRPr lang="en-US" dirty="0"/>
          </a:p>
        </p:txBody>
      </p:sp>
      <p:sp>
        <p:nvSpPr>
          <p:cNvPr id="24" name="Text Placeholder 3"/>
          <p:cNvSpPr>
            <a:spLocks noGrp="1"/>
          </p:cNvSpPr>
          <p:nvPr>
            <p:ph type="body" sz="half" idx="20"/>
          </p:nvPr>
        </p:nvSpPr>
        <p:spPr>
          <a:xfrm>
            <a:off x="7982775" y="5109104"/>
            <a:ext cx="3051096"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cxnSp>
        <p:nvCxnSpPr>
          <p:cNvPr id="43" name="Straight Connector 42"/>
          <p:cNvCxnSpPr/>
          <p:nvPr/>
        </p:nvCxnSpPr>
        <p:spPr>
          <a:xfrm>
            <a:off x="440583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44" name="Straight Connector 43"/>
          <p:cNvCxnSpPr/>
          <p:nvPr/>
        </p:nvCxnSpPr>
        <p:spPr>
          <a:xfrm>
            <a:off x="7797802"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AC3C9A8A-5F74-4945-89C1-6C480A0020A7}" type="datetimeFigureOut">
              <a:rPr lang="en-US" smtClean="0"/>
              <a:t>4/20/2020</a:t>
            </a:fld>
            <a:endParaRPr lang="en-US"/>
          </a:p>
        </p:txBody>
      </p:sp>
      <p:sp>
        <p:nvSpPr>
          <p:cNvPr id="8" name="Footer Placeholder 7"/>
          <p:cNvSpPr>
            <a:spLocks noGrp="1"/>
          </p:cNvSpPr>
          <p:nvPr>
            <p:ph type="ftr" sz="quarter" idx="11"/>
          </p:nvPr>
        </p:nvSpPr>
        <p:spPr>
          <a:xfrm>
            <a:off x="561111" y="6391838"/>
            <a:ext cx="3644282" cy="304801"/>
          </a:xfrm>
        </p:spPr>
        <p:txBody>
          <a:bodyPr/>
          <a:lstStyle/>
          <a:p>
            <a:endParaRPr lang="en-US"/>
          </a:p>
        </p:txBody>
      </p:sp>
      <p:sp>
        <p:nvSpPr>
          <p:cNvPr id="9" name="Slide Number Placeholder 8"/>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176322813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1154954" y="2603500"/>
            <a:ext cx="8825659" cy="3416300"/>
          </a:xfrm>
        </p:spPr>
        <p:txBody>
          <a:bodyPr vert="eaVert" anchor="t" anchorCtr="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a:xfrm>
            <a:off x="10695439" y="6391838"/>
            <a:ext cx="990599" cy="304799"/>
          </a:xfrm>
        </p:spPr>
        <p:txBody>
          <a:bodyPr/>
          <a:lstStyle/>
          <a:p>
            <a:fld id="{AC3C9A8A-5F74-4945-89C1-6C480A0020A7}" type="datetimeFigureOut">
              <a:rPr lang="en-US" smtClean="0"/>
              <a:t>4/2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372814652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2" name="Rectangle 11"/>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7" name="Rectangle 6"/>
            <p:cNvSpPr/>
            <p:nvPr/>
          </p:nvSpPr>
          <p:spPr bwMode="gray">
            <a:xfrm>
              <a:off x="414867" y="402165"/>
              <a:ext cx="6510866"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7" name="Freeform 5"/>
            <p:cNvSpPr/>
            <p:nvPr/>
          </p:nvSpPr>
          <p:spPr bwMode="gray">
            <a:xfrm rot="5101749">
              <a:off x="6294738" y="457773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0" name="Freeform 5"/>
            <p:cNvSpPr/>
            <p:nvPr/>
          </p:nvSpPr>
          <p:spPr bwMode="gray">
            <a:xfrm rot="5400000">
              <a:off x="44492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3"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Vertical Title 1"/>
          <p:cNvSpPr>
            <a:spLocks noGrp="1"/>
          </p:cNvSpPr>
          <p:nvPr>
            <p:ph type="title" orient="vert"/>
          </p:nvPr>
        </p:nvSpPr>
        <p:spPr>
          <a:xfrm>
            <a:off x="8585235" y="1278467"/>
            <a:ext cx="1409965" cy="4748590"/>
          </a:xfrm>
        </p:spPr>
        <p:txBody>
          <a:bodyPr vert="eaVert" anchor="b" anchorCtr="0"/>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1154954" y="1278467"/>
            <a:ext cx="6256025" cy="474859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a:xfrm>
            <a:off x="10653104" y="6391838"/>
            <a:ext cx="992135" cy="304799"/>
          </a:xfrm>
        </p:spPr>
        <p:txBody>
          <a:bodyPr/>
          <a:lstStyle/>
          <a:p>
            <a:fld id="{AC3C9A8A-5F74-4945-89C1-6C480A0020A7}" type="datetimeFigureOut">
              <a:rPr lang="en-US" smtClean="0"/>
              <a:t>4/20/2020</a:t>
            </a:fld>
            <a:endParaRPr lang="en-US"/>
          </a:p>
        </p:txBody>
      </p:sp>
      <p:sp>
        <p:nvSpPr>
          <p:cNvPr id="5" name="Footer Placeholder 4"/>
          <p:cNvSpPr>
            <a:spLocks noGrp="1"/>
          </p:cNvSpPr>
          <p:nvPr>
            <p:ph type="ftr" sz="quarter" idx="11"/>
          </p:nvPr>
        </p:nvSpPr>
        <p:spPr/>
        <p:txBody>
          <a:bodyPr/>
          <a:lstStyle/>
          <a:p>
            <a:endParaRPr lang="en-US"/>
          </a:p>
        </p:txBody>
      </p:sp>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3238858231"/>
      </p:ext>
    </p:extLst>
  </p:cSld>
  <p:clrMapOvr>
    <a:masterClrMapping/>
  </p:clrMapOvr>
  <p:extLst>
    <p:ext uri="{DCECCB84-F9BA-43D5-87BE-67443E8EF086}">
      <p15:sldGuideLst xmlns:p15="http://schemas.microsoft.com/office/powerpoint/2012/main"/>
    </p:ext>
  </p:extLst>
</p:sldLayout>
</file>

<file path=ppt/slideLayouts/slideLayout18.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ctrTitle"/>
          </p:nvPr>
        </p:nvSpPr>
        <p:spPr>
          <a:xfrm>
            <a:off x="1002536" y="1905918"/>
            <a:ext cx="10363200" cy="1868450"/>
          </a:xfrm>
          <a:noFill/>
          <a:ln w="28575" cmpd="dbl">
            <a:noFill/>
          </a:ln>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759025" y="4373219"/>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Tree>
    <p:extLst>
      <p:ext uri="{BB962C8B-B14F-4D97-AF65-F5344CB8AC3E}">
        <p14:creationId xmlns:p14="http://schemas.microsoft.com/office/powerpoint/2010/main" val="226422772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pic>
        <p:nvPicPr>
          <p:cNvPr id="4" name="Picture 3"/>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a:xfrm>
            <a:off x="2879075" y="213727"/>
            <a:ext cx="8710669" cy="1325563"/>
          </a:xfrm>
        </p:spPr>
        <p:txBody>
          <a:bodyPr/>
          <a:lstStyle/>
          <a:p>
            <a:r>
              <a:rPr lang="en-US"/>
              <a:t>Click to edit Master title style</a:t>
            </a:r>
            <a:endParaRPr lang="en-US" dirty="0"/>
          </a:p>
        </p:txBody>
      </p:sp>
      <p:sp>
        <p:nvSpPr>
          <p:cNvPr id="3" name="Content Placeholder 2"/>
          <p:cNvSpPr>
            <a:spLocks noGrp="1"/>
          </p:cNvSpPr>
          <p:nvPr>
            <p:ph idx="1"/>
          </p:nvPr>
        </p:nvSpPr>
        <p:spPr>
          <a:xfrm>
            <a:off x="2879075" y="1825625"/>
            <a:ext cx="8710669" cy="4553141"/>
          </a:xfrm>
          <a:ln w="31750" cmpd="dbl">
            <a:noFill/>
          </a:ln>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pic>
        <p:nvPicPr>
          <p:cNvPr id="7" name="Content Placeholder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040280" y="88313"/>
            <a:ext cx="1098929" cy="657130"/>
          </a:xfrm>
          <a:prstGeom prst="rect">
            <a:avLst/>
          </a:prstGeom>
          <a:solidFill>
            <a:schemeClr val="bg1"/>
          </a:solidFill>
        </p:spPr>
      </p:pic>
    </p:spTree>
    <p:extLst>
      <p:ext uri="{BB962C8B-B14F-4D97-AF65-F5344CB8AC3E}">
        <p14:creationId xmlns:p14="http://schemas.microsoft.com/office/powerpoint/2010/main" val="11483654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000" b="1"/>
            </a:lvl1pPr>
          </a:lstStyle>
          <a:p>
            <a:r>
              <a:rPr lang="en-US" dirty="0" smtClean="0"/>
              <a:t>Click to edit Master title style</a:t>
            </a:r>
            <a:endParaRPr lang="en-US" dirty="0"/>
          </a:p>
        </p:txBody>
      </p:sp>
      <p:sp>
        <p:nvSpPr>
          <p:cNvPr id="3" name="Content Placeholder 2"/>
          <p:cNvSpPr>
            <a:spLocks noGrp="1"/>
          </p:cNvSpPr>
          <p:nvPr>
            <p:ph idx="1"/>
          </p:nvPr>
        </p:nvSpPr>
        <p:spPr>
          <a:xfrm>
            <a:off x="561110" y="2603500"/>
            <a:ext cx="11082593" cy="3416300"/>
          </a:xfrm>
        </p:spPr>
        <p:txBody>
          <a:bodyPr>
            <a:normAutofit/>
          </a:bodyPr>
          <a:lstStyle>
            <a:lvl1pPr>
              <a:defRPr sz="2400">
                <a:solidFill>
                  <a:schemeClr val="tx1"/>
                </a:solidFill>
              </a:defRPr>
            </a:lvl1pPr>
            <a:lvl2pPr>
              <a:defRPr sz="2000">
                <a:solidFill>
                  <a:schemeClr val="tx1"/>
                </a:solidFill>
              </a:defRPr>
            </a:lvl2pPr>
            <a:lvl3pPr>
              <a:defRPr sz="1800">
                <a:solidFill>
                  <a:schemeClr val="tx1"/>
                </a:solidFill>
              </a:defRPr>
            </a:lvl3pPr>
            <a:lvl4pPr>
              <a:defRPr sz="1600">
                <a:solidFill>
                  <a:schemeClr val="tx1"/>
                </a:solidFill>
              </a:defRPr>
            </a:lvl4pPr>
            <a:lvl5pPr>
              <a:defRPr sz="1600">
                <a:solidFill>
                  <a:schemeClr val="tx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AC3C9A8A-5F74-4945-89C1-6C480A0020A7}" type="datetimeFigureOut">
              <a:rPr lang="en-US" smtClean="0"/>
              <a:t>4/2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62984551"/>
      </p:ext>
    </p:extLst>
  </p:cSld>
  <p:clrMapOvr>
    <a:masterClrMapping/>
  </p:clrMapOvr>
  <p:timing>
    <p:tnLst>
      <p:par>
        <p:cTn id="1" dur="indefinite" restart="never" nodeType="tmRoot"/>
      </p:par>
    </p:tnLst>
  </p:timing>
</p:sldLayout>
</file>

<file path=ppt/slideLayouts/slideLayout20.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1" y="4589465"/>
            <a:ext cx="105156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solidFill>
                  <a:prstClr val="black">
                    <a:tint val="75000"/>
                  </a:prstClr>
                </a:solidFill>
              </a:rPr>
              <a:pPr/>
              <a:t>4/20/2020</a:t>
            </a:fld>
            <a:endParaRPr lang="en-US" dirty="0">
              <a:solidFill>
                <a:prstClr val="black">
                  <a:tint val="75000"/>
                </a:prstClr>
              </a:solidFill>
            </a:endParaRPr>
          </a:p>
        </p:txBody>
      </p:sp>
      <p:sp>
        <p:nvSpPr>
          <p:cNvPr id="5" name="Footer Placeholder 4"/>
          <p:cNvSpPr>
            <a:spLocks noGrp="1"/>
          </p:cNvSpPr>
          <p:nvPr>
            <p:ph type="ftr" sz="quarter" idx="11"/>
          </p:nvPr>
        </p:nvSpPr>
        <p:spPr/>
        <p:txBody>
          <a:bodyPr/>
          <a:lstStyle/>
          <a:p>
            <a:endParaRPr lang="en-US" dirty="0">
              <a:solidFill>
                <a:prstClr val="black">
                  <a:tint val="75000"/>
                </a:prstClr>
              </a:solidFill>
            </a:endParaRPr>
          </a:p>
        </p:txBody>
      </p:sp>
      <p:sp>
        <p:nvSpPr>
          <p:cNvPr id="6" name="Slide Number Placeholder 5"/>
          <p:cNvSpPr>
            <a:spLocks noGrp="1"/>
          </p:cNvSpPr>
          <p:nvPr>
            <p:ph type="sldNum" sz="quarter" idx="12"/>
          </p:nvPr>
        </p:nvSpPr>
        <p:spPr/>
        <p:txBody>
          <a:bodyPr/>
          <a:lstStyle/>
          <a:p>
            <a:fld id="{D57F1E4F-1CFF-5643-939E-217C01CDF565}" type="slidenum">
              <a:rPr lang="en-US" smtClean="0">
                <a:solidFill>
                  <a:prstClr val="black">
                    <a:tint val="75000"/>
                  </a:prstClr>
                </a:solidFill>
              </a:rPr>
              <a:pPr/>
              <a:t>‹#›</a:t>
            </a:fld>
            <a:endParaRPr lang="en-US" dirty="0">
              <a:solidFill>
                <a:prstClr val="black">
                  <a:tint val="75000"/>
                </a:prstClr>
              </a:solidFill>
            </a:endParaRPr>
          </a:p>
        </p:txBody>
      </p:sp>
      <p:pic>
        <p:nvPicPr>
          <p:cNvPr id="7" name="Content Placeholder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839" y="213727"/>
            <a:ext cx="2105152" cy="1258824"/>
          </a:xfrm>
          <a:prstGeom prst="rect">
            <a:avLst/>
          </a:prstGeom>
          <a:solidFill>
            <a:schemeClr val="bg1"/>
          </a:solidFill>
        </p:spPr>
      </p:pic>
    </p:spTree>
    <p:extLst>
      <p:ext uri="{BB962C8B-B14F-4D97-AF65-F5344CB8AC3E}">
        <p14:creationId xmlns:p14="http://schemas.microsoft.com/office/powerpoint/2010/main" val="3357475306"/>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pic>
        <p:nvPicPr>
          <p:cNvPr id="9" name="Picture 8"/>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12192000" cy="6858000"/>
          </a:xfrm>
          <a:prstGeom prst="rect">
            <a:avLst/>
          </a:prstGeom>
        </p:spPr>
      </p:pic>
      <p:sp>
        <p:nvSpPr>
          <p:cNvPr id="2" name="Title 1"/>
          <p:cNvSpPr>
            <a:spLocks noGrp="1"/>
          </p:cNvSpPr>
          <p:nvPr>
            <p:ph type="title"/>
          </p:nvPr>
        </p:nvSpPr>
        <p:spPr>
          <a:xfrm>
            <a:off x="1819123" y="365127"/>
            <a:ext cx="9534676" cy="1325563"/>
          </a:xfrm>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61BEF0D-F0BB-DE4B-95CE-6DB70DBA9567}" type="datetimeFigureOut">
              <a:rPr lang="en-US" smtClean="0">
                <a:solidFill>
                  <a:prstClr val="black">
                    <a:tint val="75000"/>
                  </a:prstClr>
                </a:solidFill>
              </a:rPr>
              <a:pPr/>
              <a:t>4/20/2020</a:t>
            </a:fld>
            <a:endParaRPr lang="en-US" dirty="0">
              <a:solidFill>
                <a:prstClr val="black">
                  <a:tint val="75000"/>
                </a:prstClr>
              </a:solidFill>
            </a:endParaRPr>
          </a:p>
        </p:txBody>
      </p:sp>
      <p:sp>
        <p:nvSpPr>
          <p:cNvPr id="6" name="Footer Placeholder 5"/>
          <p:cNvSpPr>
            <a:spLocks noGrp="1"/>
          </p:cNvSpPr>
          <p:nvPr>
            <p:ph type="ftr" sz="quarter" idx="11"/>
          </p:nvPr>
        </p:nvSpPr>
        <p:spPr/>
        <p:txBody>
          <a:bodyPr/>
          <a:lstStyle/>
          <a:p>
            <a:endParaRPr lang="en-US" dirty="0">
              <a:solidFill>
                <a:prstClr val="black">
                  <a:tint val="75000"/>
                </a:prstClr>
              </a:solidFill>
            </a:endParaRPr>
          </a:p>
        </p:txBody>
      </p:sp>
      <p:sp>
        <p:nvSpPr>
          <p:cNvPr id="7" name="Slide Number Placeholder 6"/>
          <p:cNvSpPr>
            <a:spLocks noGrp="1"/>
          </p:cNvSpPr>
          <p:nvPr>
            <p:ph type="sldNum" sz="quarter" idx="12"/>
          </p:nvPr>
        </p:nvSpPr>
        <p:spPr/>
        <p:txBody>
          <a:bodyPr/>
          <a:lstStyle/>
          <a:p>
            <a:fld id="{D57F1E4F-1CFF-5643-939E-217C01CDF565}" type="slidenum">
              <a:rPr lang="en-US" smtClean="0">
                <a:solidFill>
                  <a:prstClr val="black">
                    <a:tint val="75000"/>
                  </a:prstClr>
                </a:solidFill>
              </a:rPr>
              <a:pPr/>
              <a:t>‹#›</a:t>
            </a:fld>
            <a:endParaRPr lang="en-US" dirty="0">
              <a:solidFill>
                <a:prstClr val="black">
                  <a:tint val="75000"/>
                </a:prstClr>
              </a:solidFill>
            </a:endParaRPr>
          </a:p>
        </p:txBody>
      </p:sp>
      <p:pic>
        <p:nvPicPr>
          <p:cNvPr id="8" name="Content Placeholder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139424" y="50420"/>
            <a:ext cx="1052576" cy="629412"/>
          </a:xfrm>
          <a:prstGeom prst="rect">
            <a:avLst/>
          </a:prstGeom>
          <a:solidFill>
            <a:schemeClr val="bg1"/>
          </a:solidFill>
        </p:spPr>
      </p:pic>
    </p:spTree>
    <p:extLst>
      <p:ext uri="{BB962C8B-B14F-4D97-AF65-F5344CB8AC3E}">
        <p14:creationId xmlns:p14="http://schemas.microsoft.com/office/powerpoint/2010/main" val="408917944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9"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1"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61BEF0D-F0BB-DE4B-95CE-6DB70DBA9567}" type="datetimeFigureOut">
              <a:rPr lang="en-US" smtClean="0">
                <a:solidFill>
                  <a:prstClr val="black">
                    <a:tint val="75000"/>
                  </a:prstClr>
                </a:solidFill>
              </a:rPr>
              <a:pPr/>
              <a:t>4/20/2020</a:t>
            </a:fld>
            <a:endParaRPr lang="en-US" dirty="0">
              <a:solidFill>
                <a:prstClr val="black">
                  <a:tint val="75000"/>
                </a:prstClr>
              </a:solidFill>
            </a:endParaRPr>
          </a:p>
        </p:txBody>
      </p:sp>
      <p:sp>
        <p:nvSpPr>
          <p:cNvPr id="8" name="Footer Placeholder 7"/>
          <p:cNvSpPr>
            <a:spLocks noGrp="1"/>
          </p:cNvSpPr>
          <p:nvPr>
            <p:ph type="ftr" sz="quarter" idx="11"/>
          </p:nvPr>
        </p:nvSpPr>
        <p:spPr/>
        <p:txBody>
          <a:bodyPr/>
          <a:lstStyle/>
          <a:p>
            <a:endParaRPr lang="en-US" dirty="0">
              <a:solidFill>
                <a:prstClr val="black">
                  <a:tint val="75000"/>
                </a:prstClr>
              </a:solidFill>
            </a:endParaRPr>
          </a:p>
        </p:txBody>
      </p:sp>
      <p:sp>
        <p:nvSpPr>
          <p:cNvPr id="9" name="Slide Number Placeholder 8"/>
          <p:cNvSpPr>
            <a:spLocks noGrp="1"/>
          </p:cNvSpPr>
          <p:nvPr>
            <p:ph type="sldNum" sz="quarter" idx="12"/>
          </p:nvPr>
        </p:nvSpPr>
        <p:spPr/>
        <p:txBody>
          <a:bodyPr/>
          <a:lstStyle/>
          <a:p>
            <a:fld id="{D57F1E4F-1CFF-5643-939E-217C01CDF565}" type="slidenum">
              <a:rPr lang="en-US" smtClean="0">
                <a:solidFill>
                  <a:prstClr val="black">
                    <a:tint val="75000"/>
                  </a:prstClr>
                </a:solidFill>
              </a:rPr>
              <a:pPr/>
              <a:t>‹#›</a:t>
            </a:fld>
            <a:endParaRPr lang="en-US" dirty="0">
              <a:solidFill>
                <a:prstClr val="black">
                  <a:tint val="75000"/>
                </a:prstClr>
              </a:solidFill>
            </a:endParaRPr>
          </a:p>
        </p:txBody>
      </p:sp>
      <p:pic>
        <p:nvPicPr>
          <p:cNvPr id="10" name="Content Placeholder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839" y="213727"/>
            <a:ext cx="2105152" cy="1258824"/>
          </a:xfrm>
          <a:prstGeom prst="rect">
            <a:avLst/>
          </a:prstGeom>
          <a:solidFill>
            <a:schemeClr val="bg1"/>
          </a:solidFill>
        </p:spPr>
      </p:pic>
    </p:spTree>
    <p:extLst>
      <p:ext uri="{BB962C8B-B14F-4D97-AF65-F5344CB8AC3E}">
        <p14:creationId xmlns:p14="http://schemas.microsoft.com/office/powerpoint/2010/main" val="1865964733"/>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61BEF0D-F0BB-DE4B-95CE-6DB70DBA9567}" type="datetimeFigureOut">
              <a:rPr lang="en-US" smtClean="0">
                <a:solidFill>
                  <a:prstClr val="black">
                    <a:tint val="75000"/>
                  </a:prstClr>
                </a:solidFill>
              </a:rPr>
              <a:pPr/>
              <a:t>4/20/2020</a:t>
            </a:fld>
            <a:endParaRPr lang="en-US" dirty="0">
              <a:solidFill>
                <a:prstClr val="black">
                  <a:tint val="75000"/>
                </a:prstClr>
              </a:solidFill>
            </a:endParaRPr>
          </a:p>
        </p:txBody>
      </p:sp>
      <p:sp>
        <p:nvSpPr>
          <p:cNvPr id="4" name="Footer Placeholder 3"/>
          <p:cNvSpPr>
            <a:spLocks noGrp="1"/>
          </p:cNvSpPr>
          <p:nvPr>
            <p:ph type="ftr" sz="quarter" idx="11"/>
          </p:nvPr>
        </p:nvSpPr>
        <p:spPr/>
        <p:txBody>
          <a:bodyPr/>
          <a:lstStyle/>
          <a:p>
            <a:endParaRPr lang="en-US" dirty="0">
              <a:solidFill>
                <a:prstClr val="black">
                  <a:tint val="75000"/>
                </a:prstClr>
              </a:solidFill>
            </a:endParaRPr>
          </a:p>
        </p:txBody>
      </p:sp>
      <p:sp>
        <p:nvSpPr>
          <p:cNvPr id="5" name="Slide Number Placeholder 4"/>
          <p:cNvSpPr>
            <a:spLocks noGrp="1"/>
          </p:cNvSpPr>
          <p:nvPr>
            <p:ph type="sldNum" sz="quarter" idx="12"/>
          </p:nvPr>
        </p:nvSpPr>
        <p:spPr/>
        <p:txBody>
          <a:bodyPr/>
          <a:lstStyle/>
          <a:p>
            <a:fld id="{D57F1E4F-1CFF-5643-939E-217C01CDF565}" type="slidenum">
              <a:rPr lang="en-US" smtClean="0">
                <a:solidFill>
                  <a:prstClr val="black">
                    <a:tint val="75000"/>
                  </a:prstClr>
                </a:solidFill>
              </a:rPr>
              <a:pPr/>
              <a:t>‹#›</a:t>
            </a:fld>
            <a:endParaRPr lang="en-US" dirty="0">
              <a:solidFill>
                <a:prstClr val="black">
                  <a:tint val="75000"/>
                </a:prstClr>
              </a:solidFill>
            </a:endParaRPr>
          </a:p>
        </p:txBody>
      </p:sp>
      <p:pic>
        <p:nvPicPr>
          <p:cNvPr id="6" name="Content Placeholder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839" y="213727"/>
            <a:ext cx="2105152" cy="1258824"/>
          </a:xfrm>
          <a:prstGeom prst="rect">
            <a:avLst/>
          </a:prstGeom>
          <a:solidFill>
            <a:schemeClr val="bg1"/>
          </a:solidFill>
        </p:spPr>
      </p:pic>
    </p:spTree>
    <p:extLst>
      <p:ext uri="{BB962C8B-B14F-4D97-AF65-F5344CB8AC3E}">
        <p14:creationId xmlns:p14="http://schemas.microsoft.com/office/powerpoint/2010/main" val="2867232986"/>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1BEF0D-F0BB-DE4B-95CE-6DB70DBA9567}" type="datetimeFigureOut">
              <a:rPr lang="en-US" smtClean="0">
                <a:solidFill>
                  <a:prstClr val="black">
                    <a:tint val="75000"/>
                  </a:prstClr>
                </a:solidFill>
              </a:rPr>
              <a:pPr/>
              <a:t>4/20/2020</a:t>
            </a:fld>
            <a:endParaRPr lang="en-US" dirty="0">
              <a:solidFill>
                <a:prstClr val="black">
                  <a:tint val="75000"/>
                </a:prstClr>
              </a:solidFill>
            </a:endParaRPr>
          </a:p>
        </p:txBody>
      </p:sp>
      <p:sp>
        <p:nvSpPr>
          <p:cNvPr id="3" name="Footer Placeholder 2"/>
          <p:cNvSpPr>
            <a:spLocks noGrp="1"/>
          </p:cNvSpPr>
          <p:nvPr>
            <p:ph type="ftr" sz="quarter" idx="11"/>
          </p:nvPr>
        </p:nvSpPr>
        <p:spPr/>
        <p:txBody>
          <a:bodyPr/>
          <a:lstStyle/>
          <a:p>
            <a:endParaRPr lang="en-US" dirty="0">
              <a:solidFill>
                <a:prstClr val="black">
                  <a:tint val="75000"/>
                </a:prstClr>
              </a:solidFill>
            </a:endParaRPr>
          </a:p>
        </p:txBody>
      </p:sp>
      <p:sp>
        <p:nvSpPr>
          <p:cNvPr id="4" name="Slide Number Placeholder 3"/>
          <p:cNvSpPr>
            <a:spLocks noGrp="1"/>
          </p:cNvSpPr>
          <p:nvPr>
            <p:ph type="sldNum" sz="quarter" idx="12"/>
          </p:nvPr>
        </p:nvSpPr>
        <p:spPr/>
        <p:txBody>
          <a:bodyPr/>
          <a:lstStyle/>
          <a:p>
            <a:fld id="{D57F1E4F-1CFF-5643-939E-217C01CDF565}" type="slidenum">
              <a:rPr lang="en-US" smtClean="0">
                <a:solidFill>
                  <a:prstClr val="black">
                    <a:tint val="75000"/>
                  </a:prstClr>
                </a:solidFill>
              </a:rPr>
              <a:pPr/>
              <a:t>‹#›</a:t>
            </a:fld>
            <a:endParaRPr lang="en-US" dirty="0">
              <a:solidFill>
                <a:prstClr val="black">
                  <a:tint val="75000"/>
                </a:prstClr>
              </a:solidFill>
            </a:endParaRPr>
          </a:p>
        </p:txBody>
      </p:sp>
      <p:pic>
        <p:nvPicPr>
          <p:cNvPr id="5" name="Content Placeholder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839" y="213727"/>
            <a:ext cx="2105152" cy="1258824"/>
          </a:xfrm>
          <a:prstGeom prst="rect">
            <a:avLst/>
          </a:prstGeom>
          <a:solidFill>
            <a:schemeClr val="bg1"/>
          </a:solidFill>
        </p:spPr>
      </p:pic>
    </p:spTree>
    <p:extLst>
      <p:ext uri="{BB962C8B-B14F-4D97-AF65-F5344CB8AC3E}">
        <p14:creationId xmlns:p14="http://schemas.microsoft.com/office/powerpoint/2010/main" val="378051590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7"/>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solidFill>
                  <a:prstClr val="black">
                    <a:tint val="75000"/>
                  </a:prstClr>
                </a:solidFill>
              </a:rPr>
              <a:pPr/>
              <a:t>4/20/2020</a:t>
            </a:fld>
            <a:endParaRPr lang="en-US" dirty="0">
              <a:solidFill>
                <a:prstClr val="black">
                  <a:tint val="75000"/>
                </a:prstClr>
              </a:solidFill>
            </a:endParaRPr>
          </a:p>
        </p:txBody>
      </p:sp>
      <p:sp>
        <p:nvSpPr>
          <p:cNvPr id="6" name="Footer Placeholder 5"/>
          <p:cNvSpPr>
            <a:spLocks noGrp="1"/>
          </p:cNvSpPr>
          <p:nvPr>
            <p:ph type="ftr" sz="quarter" idx="11"/>
          </p:nvPr>
        </p:nvSpPr>
        <p:spPr/>
        <p:txBody>
          <a:bodyPr/>
          <a:lstStyle/>
          <a:p>
            <a:endParaRPr lang="en-US" dirty="0">
              <a:solidFill>
                <a:prstClr val="black">
                  <a:tint val="75000"/>
                </a:prstClr>
              </a:solidFill>
            </a:endParaRPr>
          </a:p>
        </p:txBody>
      </p:sp>
      <p:sp>
        <p:nvSpPr>
          <p:cNvPr id="7" name="Slide Number Placeholder 6"/>
          <p:cNvSpPr>
            <a:spLocks noGrp="1"/>
          </p:cNvSpPr>
          <p:nvPr>
            <p:ph type="sldNum" sz="quarter" idx="12"/>
          </p:nvPr>
        </p:nvSpPr>
        <p:spPr/>
        <p:txBody>
          <a:bodyPr/>
          <a:lstStyle/>
          <a:p>
            <a:fld id="{D57F1E4F-1CFF-5643-939E-217C01CDF565}" type="slidenum">
              <a:rPr lang="en-US" smtClean="0">
                <a:solidFill>
                  <a:prstClr val="black">
                    <a:tint val="75000"/>
                  </a:prstClr>
                </a:solidFill>
              </a:rPr>
              <a:pPr/>
              <a:t>‹#›</a:t>
            </a:fld>
            <a:endParaRPr lang="en-US" dirty="0">
              <a:solidFill>
                <a:prstClr val="black">
                  <a:tint val="75000"/>
                </a:prstClr>
              </a:solidFill>
            </a:endParaRPr>
          </a:p>
        </p:txBody>
      </p:sp>
      <p:pic>
        <p:nvPicPr>
          <p:cNvPr id="8" name="Content Placeholder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839" y="213727"/>
            <a:ext cx="2105152" cy="1258824"/>
          </a:xfrm>
          <a:prstGeom prst="rect">
            <a:avLst/>
          </a:prstGeom>
          <a:solidFill>
            <a:schemeClr val="bg1"/>
          </a:solidFill>
        </p:spPr>
      </p:pic>
    </p:spTree>
    <p:extLst>
      <p:ext uri="{BB962C8B-B14F-4D97-AF65-F5344CB8AC3E}">
        <p14:creationId xmlns:p14="http://schemas.microsoft.com/office/powerpoint/2010/main" val="379547778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7"/>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solidFill>
                  <a:prstClr val="black">
                    <a:tint val="75000"/>
                  </a:prstClr>
                </a:solidFill>
              </a:rPr>
              <a:pPr/>
              <a:t>4/20/2020</a:t>
            </a:fld>
            <a:endParaRPr lang="en-US" dirty="0">
              <a:solidFill>
                <a:prstClr val="black">
                  <a:tint val="75000"/>
                </a:prstClr>
              </a:solidFill>
            </a:endParaRPr>
          </a:p>
        </p:txBody>
      </p:sp>
      <p:sp>
        <p:nvSpPr>
          <p:cNvPr id="6" name="Footer Placeholder 5"/>
          <p:cNvSpPr>
            <a:spLocks noGrp="1"/>
          </p:cNvSpPr>
          <p:nvPr>
            <p:ph type="ftr" sz="quarter" idx="11"/>
          </p:nvPr>
        </p:nvSpPr>
        <p:spPr/>
        <p:txBody>
          <a:bodyPr/>
          <a:lstStyle/>
          <a:p>
            <a:endParaRPr lang="en-US" dirty="0">
              <a:solidFill>
                <a:prstClr val="black">
                  <a:tint val="75000"/>
                </a:prstClr>
              </a:solidFill>
            </a:endParaRPr>
          </a:p>
        </p:txBody>
      </p:sp>
      <p:sp>
        <p:nvSpPr>
          <p:cNvPr id="7" name="Slide Number Placeholder 6"/>
          <p:cNvSpPr>
            <a:spLocks noGrp="1"/>
          </p:cNvSpPr>
          <p:nvPr>
            <p:ph type="sldNum" sz="quarter" idx="12"/>
          </p:nvPr>
        </p:nvSpPr>
        <p:spPr/>
        <p:txBody>
          <a:bodyPr/>
          <a:lstStyle/>
          <a:p>
            <a:fld id="{D57F1E4F-1CFF-5643-939E-217C01CDF565}" type="slidenum">
              <a:rPr lang="en-US" smtClean="0">
                <a:solidFill>
                  <a:prstClr val="black">
                    <a:tint val="75000"/>
                  </a:prstClr>
                </a:solidFill>
              </a:rPr>
              <a:pPr/>
              <a:t>‹#›</a:t>
            </a:fld>
            <a:endParaRPr lang="en-US" dirty="0">
              <a:solidFill>
                <a:prstClr val="black">
                  <a:tint val="75000"/>
                </a:prstClr>
              </a:solidFill>
            </a:endParaRPr>
          </a:p>
        </p:txBody>
      </p:sp>
      <p:pic>
        <p:nvPicPr>
          <p:cNvPr id="8" name="Content Placeholder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839" y="213727"/>
            <a:ext cx="2105152" cy="1258824"/>
          </a:xfrm>
          <a:prstGeom prst="rect">
            <a:avLst/>
          </a:prstGeom>
          <a:solidFill>
            <a:schemeClr val="bg1"/>
          </a:solidFill>
        </p:spPr>
      </p:pic>
    </p:spTree>
    <p:extLst>
      <p:ext uri="{BB962C8B-B14F-4D97-AF65-F5344CB8AC3E}">
        <p14:creationId xmlns:p14="http://schemas.microsoft.com/office/powerpoint/2010/main" val="2047642452"/>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solidFill>
                  <a:prstClr val="black">
                    <a:tint val="75000"/>
                  </a:prstClr>
                </a:solidFill>
              </a:rPr>
              <a:pPr/>
              <a:t>4/20/2020</a:t>
            </a:fld>
            <a:endParaRPr lang="en-US" dirty="0">
              <a:solidFill>
                <a:prstClr val="black">
                  <a:tint val="75000"/>
                </a:prstClr>
              </a:solidFill>
            </a:endParaRPr>
          </a:p>
        </p:txBody>
      </p:sp>
      <p:sp>
        <p:nvSpPr>
          <p:cNvPr id="5" name="Footer Placeholder 4"/>
          <p:cNvSpPr>
            <a:spLocks noGrp="1"/>
          </p:cNvSpPr>
          <p:nvPr>
            <p:ph type="ftr" sz="quarter" idx="11"/>
          </p:nvPr>
        </p:nvSpPr>
        <p:spPr/>
        <p:txBody>
          <a:bodyPr/>
          <a:lstStyle/>
          <a:p>
            <a:endParaRPr lang="en-US" dirty="0">
              <a:solidFill>
                <a:prstClr val="black">
                  <a:tint val="75000"/>
                </a:prstClr>
              </a:solidFill>
            </a:endParaRPr>
          </a:p>
        </p:txBody>
      </p:sp>
      <p:sp>
        <p:nvSpPr>
          <p:cNvPr id="6" name="Slide Number Placeholder 5"/>
          <p:cNvSpPr>
            <a:spLocks noGrp="1"/>
          </p:cNvSpPr>
          <p:nvPr>
            <p:ph type="sldNum" sz="quarter" idx="12"/>
          </p:nvPr>
        </p:nvSpPr>
        <p:spPr/>
        <p:txBody>
          <a:bodyPr/>
          <a:lstStyle/>
          <a:p>
            <a:fld id="{D57F1E4F-1CFF-5643-939E-217C01CDF565}" type="slidenum">
              <a:rPr lang="en-US" smtClean="0">
                <a:solidFill>
                  <a:prstClr val="black">
                    <a:tint val="75000"/>
                  </a:prstClr>
                </a:solidFill>
              </a:rPr>
              <a:pPr/>
              <a:t>‹#›</a:t>
            </a:fld>
            <a:endParaRPr lang="en-US" dirty="0">
              <a:solidFill>
                <a:prstClr val="black">
                  <a:tint val="75000"/>
                </a:prstClr>
              </a:solidFill>
            </a:endParaRPr>
          </a:p>
        </p:txBody>
      </p:sp>
      <p:pic>
        <p:nvPicPr>
          <p:cNvPr id="8" name="Content Placeholder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839" y="213727"/>
            <a:ext cx="2105152" cy="1258824"/>
          </a:xfrm>
          <a:prstGeom prst="rect">
            <a:avLst/>
          </a:prstGeom>
          <a:solidFill>
            <a:schemeClr val="bg1"/>
          </a:solidFill>
        </p:spPr>
      </p:pic>
    </p:spTree>
    <p:extLst>
      <p:ext uri="{BB962C8B-B14F-4D97-AF65-F5344CB8AC3E}">
        <p14:creationId xmlns:p14="http://schemas.microsoft.com/office/powerpoint/2010/main" val="4205423300"/>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solidFill>
                  <a:prstClr val="black">
                    <a:tint val="75000"/>
                  </a:prstClr>
                </a:solidFill>
              </a:rPr>
              <a:pPr/>
              <a:t>4/20/2020</a:t>
            </a:fld>
            <a:endParaRPr lang="en-US" dirty="0">
              <a:solidFill>
                <a:prstClr val="black">
                  <a:tint val="75000"/>
                </a:prstClr>
              </a:solidFill>
            </a:endParaRPr>
          </a:p>
        </p:txBody>
      </p:sp>
      <p:sp>
        <p:nvSpPr>
          <p:cNvPr id="5" name="Footer Placeholder 4"/>
          <p:cNvSpPr>
            <a:spLocks noGrp="1"/>
          </p:cNvSpPr>
          <p:nvPr>
            <p:ph type="ftr" sz="quarter" idx="11"/>
          </p:nvPr>
        </p:nvSpPr>
        <p:spPr/>
        <p:txBody>
          <a:bodyPr/>
          <a:lstStyle/>
          <a:p>
            <a:endParaRPr lang="en-US" dirty="0">
              <a:solidFill>
                <a:prstClr val="black">
                  <a:tint val="75000"/>
                </a:prstClr>
              </a:solidFill>
            </a:endParaRPr>
          </a:p>
        </p:txBody>
      </p:sp>
      <p:sp>
        <p:nvSpPr>
          <p:cNvPr id="6" name="Slide Number Placeholder 5"/>
          <p:cNvSpPr>
            <a:spLocks noGrp="1"/>
          </p:cNvSpPr>
          <p:nvPr>
            <p:ph type="sldNum" sz="quarter" idx="12"/>
          </p:nvPr>
        </p:nvSpPr>
        <p:spPr/>
        <p:txBody>
          <a:bodyPr/>
          <a:lstStyle/>
          <a:p>
            <a:fld id="{D57F1E4F-1CFF-5643-939E-217C01CDF565}" type="slidenum">
              <a:rPr lang="en-US" smtClean="0">
                <a:solidFill>
                  <a:prstClr val="black">
                    <a:tint val="75000"/>
                  </a:prstClr>
                </a:solidFill>
              </a:rPr>
              <a:pPr/>
              <a:t>‹#›</a:t>
            </a:fld>
            <a:endParaRPr lang="en-US" dirty="0">
              <a:solidFill>
                <a:prstClr val="black">
                  <a:tint val="75000"/>
                </a:prstClr>
              </a:solidFill>
            </a:endParaRPr>
          </a:p>
        </p:txBody>
      </p:sp>
      <p:pic>
        <p:nvPicPr>
          <p:cNvPr id="7" name="Content Placeholder 9"/>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04839" y="213727"/>
            <a:ext cx="2105152" cy="1258824"/>
          </a:xfrm>
          <a:prstGeom prst="rect">
            <a:avLst/>
          </a:prstGeom>
          <a:solidFill>
            <a:schemeClr val="bg1"/>
          </a:solidFill>
        </p:spPr>
      </p:pic>
    </p:spTree>
    <p:extLst>
      <p:ext uri="{BB962C8B-B14F-4D97-AF65-F5344CB8AC3E}">
        <p14:creationId xmlns:p14="http://schemas.microsoft.com/office/powerpoint/2010/main" val="13213373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grpSp>
        <p:nvGrpSpPr>
          <p:cNvPr id="8" name="Group 7"/>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0" name="Rectangle 9"/>
            <p:cNvSpPr/>
            <p:nvPr/>
          </p:nvSpPr>
          <p:spPr bwMode="gray">
            <a:xfrm>
              <a:off x="7289800" y="402165"/>
              <a:ext cx="44788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1" name="Freeform 5"/>
            <p:cNvSpPr/>
            <p:nvPr/>
          </p:nvSpPr>
          <p:spPr bwMode="gray">
            <a:xfrm rot="16200000">
              <a:off x="3787244"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2" name="Freeform 5"/>
            <p:cNvSpPr/>
            <p:nvPr/>
          </p:nvSpPr>
          <p:spPr bwMode="gray">
            <a:xfrm rot="15922489">
              <a:off x="4698352"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2677645"/>
            <a:ext cx="4351025" cy="2283824"/>
          </a:xfrm>
        </p:spPr>
        <p:txBody>
          <a:bodyPr anchor="ctr"/>
          <a:lstStyle>
            <a:lvl1pPr algn="l">
              <a:defRPr sz="40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6895559" y="2677644"/>
            <a:ext cx="3757545" cy="2283824"/>
          </a:xfrm>
        </p:spPr>
        <p:txBody>
          <a:bodyPr anchor="ctr"/>
          <a:lstStyle>
            <a:lvl1pPr marL="0" indent="0" algn="l">
              <a:buNone/>
              <a:defRPr sz="2000" cap="all">
                <a:solidFill>
                  <a:schemeClr val="accent1">
                    <a:lumMod val="60000"/>
                    <a:lumOff val="4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C3C9A8A-5F74-4945-89C1-6C480A0020A7}" type="datetimeFigureOut">
              <a:rPr lang="en-US" smtClean="0"/>
              <a:t>4/20/2020</a:t>
            </a:fld>
            <a:endParaRPr lang="en-US"/>
          </a:p>
        </p:txBody>
      </p:sp>
      <p:sp>
        <p:nvSpPr>
          <p:cNvPr id="5" name="Footer Placeholder 4"/>
          <p:cNvSpPr>
            <a:spLocks noGrp="1"/>
          </p:cNvSpPr>
          <p:nvPr>
            <p:ph type="ftr" sz="quarter" idx="11"/>
          </p:nvPr>
        </p:nvSpPr>
        <p:spPr/>
        <p:txBody>
          <a:bodyPr/>
          <a:lstStyle/>
          <a:p>
            <a:endParaRPr lang="en-US"/>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2391694085"/>
      </p:ext>
    </p:extLst>
  </p:cSld>
  <p:clrMapOvr>
    <a:masterClrMapping/>
  </p:clrMapOvr>
  <p:timing>
    <p:tnLst>
      <p:par>
        <p:cTn id="1" dur="indefinite" restart="never" nodeType="tmRoot"/>
      </p:par>
    </p:tnLst>
  </p:timing>
  <p:extLst>
    <p:ext uri="{DCECCB84-F9BA-43D5-87BE-67443E8EF086}">
      <p15:sldGuideLst xmlns:p15="http://schemas.microsoft.com/office/powerpoint/2012/main"/>
    </p:ext>
  </p:extLst>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1154954" y="2603500"/>
            <a:ext cx="4825158" cy="3416301"/>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6208712" y="2603500"/>
            <a:ext cx="4825159" cy="3416300"/>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AC3C9A8A-5F74-4945-89C1-6C480A0020A7}" type="datetimeFigureOut">
              <a:rPr lang="en-US" smtClean="0"/>
              <a:t>4/2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32417116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dirty="0"/>
          </a:p>
        </p:txBody>
      </p:sp>
      <p:sp>
        <p:nvSpPr>
          <p:cNvPr id="3" name="Text Placeholder 2"/>
          <p:cNvSpPr>
            <a:spLocks noGrp="1"/>
          </p:cNvSpPr>
          <p:nvPr>
            <p:ph type="body" idx="1"/>
          </p:nvPr>
        </p:nvSpPr>
        <p:spPr>
          <a:xfrm>
            <a:off x="1154954" y="2603500"/>
            <a:ext cx="4825157"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1154954" y="3179762"/>
            <a:ext cx="4825158" cy="2840039"/>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6208712" y="2603500"/>
            <a:ext cx="4825159"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208712" y="3179762"/>
            <a:ext cx="4825159" cy="2840039"/>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AC3C9A8A-5F74-4945-89C1-6C480A0020A7}" type="datetimeFigureOut">
              <a:rPr lang="en-US" smtClean="0"/>
              <a:t>4/20/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7464968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Title 1"/>
          <p:cNvSpPr>
            <a:spLocks noGrp="1"/>
          </p:cNvSpPr>
          <p:nvPr>
            <p:ph type="title"/>
          </p:nvPr>
        </p:nvSpPr>
        <p:spPr>
          <a:xfrm>
            <a:off x="1154954" y="973668"/>
            <a:ext cx="8761413" cy="706964"/>
          </a:xfrm>
        </p:spPr>
        <p:txBody>
          <a:bodyPr/>
          <a:lstStyle>
            <a:lvl1pPr>
              <a:defRPr/>
            </a:lvl1p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AC3C9A8A-5F74-4945-89C1-6C480A0020A7}" type="datetimeFigureOut">
              <a:rPr lang="en-US" smtClean="0"/>
              <a:t>4/20/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14846901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C3C9A8A-5F74-4945-89C1-6C480A0020A7}" type="datetimeFigureOut">
              <a:rPr lang="en-US" smtClean="0"/>
              <a:t>4/20/2020</a:t>
            </a:fld>
            <a:endParaRPr lang="en-US"/>
          </a:p>
        </p:txBody>
      </p:sp>
      <p:sp>
        <p:nvSpPr>
          <p:cNvPr id="3" name="Footer Placeholder 2"/>
          <p:cNvSpPr>
            <a:spLocks noGrp="1"/>
          </p:cNvSpPr>
          <p:nvPr>
            <p:ph type="ftr" sz="quarter" idx="11"/>
          </p:nvPr>
        </p:nvSpPr>
        <p:spPr/>
        <p:txBody>
          <a:bodyPr/>
          <a:lstStyle/>
          <a:p>
            <a:endParaRPr lang="en-US"/>
          </a:p>
        </p:txBody>
      </p:sp>
      <p:sp>
        <p:nvSpPr>
          <p:cNvPr id="7" name="Rectangle 6"/>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4" name="Slide Number Placeholder 3"/>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20771669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2" name="Oval 21"/>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bwMode="gray">
            <a:xfrm>
              <a:off x="5713412" y="402165"/>
              <a:ext cx="6055253"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8" name="Freeform 5"/>
            <p:cNvSpPr/>
            <p:nvPr/>
          </p:nvSpPr>
          <p:spPr bwMode="gray">
            <a:xfrm rot="15922489">
              <a:off x="3140485"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rot="16200000">
              <a:off x="2229377"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5" y="1295400"/>
            <a:ext cx="2793158" cy="1600200"/>
          </a:xfrm>
        </p:spPr>
        <p:txBody>
          <a:bodyPr anchor="b"/>
          <a:lstStyle>
            <a:lvl1pPr algn="l">
              <a:defRPr sz="2400" b="0"/>
            </a:lvl1pPr>
          </a:lstStyle>
          <a:p>
            <a:r>
              <a:rPr lang="en-US" smtClean="0"/>
              <a:t>Click to edit Master title style</a:t>
            </a:r>
            <a:endParaRPr lang="en-US" dirty="0"/>
          </a:p>
        </p:txBody>
      </p:sp>
      <p:sp>
        <p:nvSpPr>
          <p:cNvPr id="3" name="Content Placeholder 2"/>
          <p:cNvSpPr>
            <a:spLocks noGrp="1"/>
          </p:cNvSpPr>
          <p:nvPr>
            <p:ph idx="1"/>
          </p:nvPr>
        </p:nvSpPr>
        <p:spPr>
          <a:xfrm>
            <a:off x="5781146" y="1447800"/>
            <a:ext cx="5190066" cy="4572000"/>
          </a:xfrm>
        </p:spPr>
        <p:txBody>
          <a:bodyPr anchor="ct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bwMode="gray">
          <a:xfrm>
            <a:off x="1154954" y="3129280"/>
            <a:ext cx="2793158" cy="2895599"/>
          </a:xfrm>
        </p:spPr>
        <p:txBody>
          <a:bodyPr/>
          <a:lstStyle>
            <a:lvl1pPr marL="0" indent="0">
              <a:buNone/>
              <a:defRPr sz="14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C3C9A8A-5F74-4945-89C1-6C480A0020A7}" type="datetimeFigureOut">
              <a:rPr lang="en-US" smtClean="0"/>
              <a:t>4/20/2020</a:t>
            </a:fld>
            <a:endParaRPr lang="en-US"/>
          </a:p>
        </p:txBody>
      </p:sp>
      <p:sp>
        <p:nvSpPr>
          <p:cNvPr id="6" name="Footer Placeholder 5"/>
          <p:cNvSpPr>
            <a:spLocks noGrp="1"/>
          </p:cNvSpPr>
          <p:nvPr>
            <p:ph type="ftr" sz="quarter" idx="11"/>
          </p:nvPr>
        </p:nvSpPr>
        <p:spPr/>
        <p:txBody>
          <a:bodyPr/>
          <a:lstStyle/>
          <a:p>
            <a:endParaRPr lang="en-US"/>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25421499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bwMode="gray">
            <a:xfrm>
              <a:off x="6172200" y="402165"/>
              <a:ext cx="55964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22" name="Freeform 5"/>
            <p:cNvSpPr/>
            <p:nvPr/>
          </p:nvSpPr>
          <p:spPr bwMode="gray">
            <a:xfrm rot="15922489">
              <a:off x="4203594"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rot="16200000">
              <a:off x="32954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5" y="1693333"/>
            <a:ext cx="3865134" cy="1735667"/>
          </a:xfrm>
        </p:spPr>
        <p:txBody>
          <a:bodyPr anchor="b">
            <a:normAutofit/>
          </a:bodyPr>
          <a:lstStyle>
            <a:lvl1pPr algn="l">
              <a:defRPr sz="36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6547870" y="1143000"/>
            <a:ext cx="3227193"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pPr marL="0" lvl="0" indent="0" algn="ctr">
              <a:buNone/>
            </a:pPr>
            <a:r>
              <a:rPr lang="en-US" smtClean="0"/>
              <a:t>Click icon to add picture</a:t>
            </a:r>
            <a:endParaRPr lang="en-US" dirty="0"/>
          </a:p>
        </p:txBody>
      </p:sp>
      <p:sp>
        <p:nvSpPr>
          <p:cNvPr id="4" name="Text Placeholder 3"/>
          <p:cNvSpPr>
            <a:spLocks noGrp="1"/>
          </p:cNvSpPr>
          <p:nvPr>
            <p:ph type="body" sz="half" idx="2"/>
          </p:nvPr>
        </p:nvSpPr>
        <p:spPr bwMode="gray">
          <a:xfrm>
            <a:off x="1154954" y="3657600"/>
            <a:ext cx="3859212" cy="1371600"/>
          </a:xfrm>
        </p:spPr>
        <p:txBody>
          <a:bodyPr>
            <a:normAutofit/>
          </a:bodyPr>
          <a:lstStyle>
            <a:lvl1pPr marL="0" indent="0">
              <a:buNone/>
              <a:defRPr sz="14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C3C9A8A-5F74-4945-89C1-6C480A0020A7}" type="datetimeFigureOut">
              <a:rPr lang="en-US" smtClean="0"/>
              <a:t>4/20/2020</a:t>
            </a:fld>
            <a:endParaRPr lang="en-US"/>
          </a:p>
        </p:txBody>
      </p:sp>
      <p:sp>
        <p:nvSpPr>
          <p:cNvPr id="6" name="Footer Placeholder 5"/>
          <p:cNvSpPr>
            <a:spLocks noGrp="1"/>
          </p:cNvSpPr>
          <p:nvPr>
            <p:ph type="ftr" sz="quarter" idx="11"/>
          </p:nvPr>
        </p:nvSpPr>
        <p:spPr/>
        <p:txBody>
          <a:bodyPr/>
          <a:lstStyle/>
          <a:p>
            <a:endParaRPr lang="en-US"/>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68B33723-06FC-4A21-9DC8-A0125A30DFFC}" type="slidenum">
              <a:rPr lang="en-US" smtClean="0"/>
              <a:t>‹#›</a:t>
            </a:fld>
            <a:endParaRPr lang="en-US"/>
          </a:p>
        </p:txBody>
      </p:sp>
    </p:spTree>
    <p:extLst>
      <p:ext uri="{BB962C8B-B14F-4D97-AF65-F5344CB8AC3E}">
        <p14:creationId xmlns:p14="http://schemas.microsoft.com/office/powerpoint/2010/main" val="8016988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jpe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5.xml"/><Relationship Id="rId3" Type="http://schemas.openxmlformats.org/officeDocument/2006/relationships/slideLayout" Target="../slideLayouts/slideLayout20.xml"/><Relationship Id="rId7" Type="http://schemas.openxmlformats.org/officeDocument/2006/relationships/slideLayout" Target="../slideLayouts/slideLayout24.xml"/><Relationship Id="rId12" Type="http://schemas.openxmlformats.org/officeDocument/2006/relationships/theme" Target="../theme/theme2.xml"/><Relationship Id="rId2" Type="http://schemas.openxmlformats.org/officeDocument/2006/relationships/slideLayout" Target="../slideLayouts/slideLayout19.xml"/><Relationship Id="rId1" Type="http://schemas.openxmlformats.org/officeDocument/2006/relationships/slideLayout" Target="../slideLayouts/slideLayout18.xml"/><Relationship Id="rId6" Type="http://schemas.openxmlformats.org/officeDocument/2006/relationships/slideLayout" Target="../slideLayouts/slideLayout23.xml"/><Relationship Id="rId11" Type="http://schemas.openxmlformats.org/officeDocument/2006/relationships/slideLayout" Target="../slideLayouts/slideLayout28.xml"/><Relationship Id="rId5" Type="http://schemas.openxmlformats.org/officeDocument/2006/relationships/slideLayout" Target="../slideLayouts/slideLayout22.xml"/><Relationship Id="rId10" Type="http://schemas.openxmlformats.org/officeDocument/2006/relationships/slideLayout" Target="../slideLayouts/slideLayout27.xml"/><Relationship Id="rId4" Type="http://schemas.openxmlformats.org/officeDocument/2006/relationships/slideLayout" Target="../slideLayouts/slideLayout21.xml"/><Relationship Id="rId9" Type="http://schemas.openxmlformats.org/officeDocument/2006/relationships/slideLayout" Target="../slideLayouts/slideLayout26.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8" name="Group 7"/>
          <p:cNvGrpSpPr/>
          <p:nvPr/>
        </p:nvGrpSpPr>
        <p:grpSpPr>
          <a:xfrm>
            <a:off x="0" y="0"/>
            <a:ext cx="12192000" cy="6858000"/>
            <a:chOff x="0" y="0"/>
            <a:chExt cx="12192000" cy="6858000"/>
          </a:xfrm>
        </p:grpSpPr>
        <p:sp>
          <p:nvSpPr>
            <p:cNvPr id="7" name="Rectangle 6"/>
            <p:cNvSpPr/>
            <p:nvPr/>
          </p:nvSpPr>
          <p:spPr>
            <a:xfrm>
              <a:off x="0" y="0"/>
              <a:ext cx="12192000" cy="6858000"/>
            </a:xfrm>
            <a:prstGeom prst="rect">
              <a:avLst/>
            </a:prstGeom>
            <a:blipFill>
              <a:blip r:embed="rId19">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Oval 12"/>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Freeform 5"/>
            <p:cNvSpPr/>
            <p:nvPr/>
          </p:nvSpPr>
          <p:spPr bwMode="gray">
            <a:xfrm rot="21010068">
              <a:off x="8490951" y="17975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9" name="Freeform 5"/>
            <p:cNvSpPr/>
            <p:nvPr/>
          </p:nvSpPr>
          <p:spPr bwMode="gray">
            <a:xfrm>
              <a:off x="459506" y="1866405"/>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14"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Placeholder 1"/>
          <p:cNvSpPr>
            <a:spLocks noGrp="1"/>
          </p:cNvSpPr>
          <p:nvPr>
            <p:ph type="title"/>
          </p:nvPr>
        </p:nvSpPr>
        <p:spPr bwMode="gray">
          <a:xfrm>
            <a:off x="1154954" y="973668"/>
            <a:ext cx="8761413" cy="706964"/>
          </a:xfrm>
          <a:prstGeom prst="rect">
            <a:avLst/>
          </a:prstGeom>
        </p:spPr>
        <p:txBody>
          <a:bodyPr vert="horz" lIns="91440" tIns="45720" rIns="91440" bIns="45720" rtlCol="0" anchor="ctr">
            <a:noAutofit/>
          </a:bodyPr>
          <a:lstStyle/>
          <a:p>
            <a:r>
              <a:rPr lang="en-US" smtClean="0"/>
              <a:t>Click to edit Master title style</a:t>
            </a:r>
            <a:endParaRPr lang="en-US" dirty="0"/>
          </a:p>
        </p:txBody>
      </p:sp>
      <p:sp>
        <p:nvSpPr>
          <p:cNvPr id="3" name="Text Placeholder 2"/>
          <p:cNvSpPr>
            <a:spLocks noGrp="1"/>
          </p:cNvSpPr>
          <p:nvPr>
            <p:ph type="body" idx="1"/>
          </p:nvPr>
        </p:nvSpPr>
        <p:spPr>
          <a:xfrm>
            <a:off x="1154954" y="2603500"/>
            <a:ext cx="8761413" cy="34163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10653104" y="6391838"/>
            <a:ext cx="990599" cy="304799"/>
          </a:xfrm>
          <a:prstGeom prst="rect">
            <a:avLst/>
          </a:prstGeom>
        </p:spPr>
        <p:txBody>
          <a:bodyPr vert="horz" lIns="91440" tIns="45720" rIns="91440" bIns="45720" rtlCol="0" anchor="ctr"/>
          <a:lstStyle>
            <a:lvl1pPr algn="r">
              <a:defRPr sz="1000" b="1" i="0">
                <a:solidFill>
                  <a:schemeClr val="accent1"/>
                </a:solidFill>
              </a:defRPr>
            </a:lvl1pPr>
          </a:lstStyle>
          <a:p>
            <a:fld id="{AC3C9A8A-5F74-4945-89C1-6C480A0020A7}" type="datetimeFigureOut">
              <a:rPr lang="en-US" smtClean="0"/>
              <a:t>4/20/2020</a:t>
            </a:fld>
            <a:endParaRPr lang="en-US"/>
          </a:p>
        </p:txBody>
      </p:sp>
      <p:sp>
        <p:nvSpPr>
          <p:cNvPr id="5" name="Footer Placeholder 4"/>
          <p:cNvSpPr>
            <a:spLocks noGrp="1"/>
          </p:cNvSpPr>
          <p:nvPr>
            <p:ph type="ftr" sz="quarter" idx="3"/>
          </p:nvPr>
        </p:nvSpPr>
        <p:spPr>
          <a:xfrm>
            <a:off x="561110" y="6391838"/>
            <a:ext cx="3859795" cy="304801"/>
          </a:xfrm>
          <a:prstGeom prst="rect">
            <a:avLst/>
          </a:prstGeom>
        </p:spPr>
        <p:txBody>
          <a:bodyPr vert="horz" lIns="91440" tIns="45720" rIns="91440" bIns="45720" rtlCol="0" anchor="ctr"/>
          <a:lstStyle>
            <a:lvl1pPr algn="l">
              <a:defRPr sz="1000" b="1" i="0">
                <a:solidFill>
                  <a:schemeClr val="accent1"/>
                </a:solidFill>
              </a:defRPr>
            </a:lvl1pPr>
          </a:lstStyle>
          <a:p>
            <a:endParaRPr lang="en-US"/>
          </a:p>
        </p:txBody>
      </p:sp>
      <p:sp>
        <p:nvSpPr>
          <p:cNvPr id="21" name="Rectangle 20"/>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bg1"/>
                </a:solidFill>
              </a:defRPr>
            </a:lvl1pPr>
          </a:lstStyle>
          <a:p>
            <a:fld id="{68B33723-06FC-4A21-9DC8-A0125A30DFFC}" type="slidenum">
              <a:rPr lang="en-US" smtClean="0"/>
              <a:t>‹#›</a:t>
            </a:fld>
            <a:endParaRPr lang="en-US"/>
          </a:p>
        </p:txBody>
      </p:sp>
    </p:spTree>
    <p:extLst>
      <p:ext uri="{BB962C8B-B14F-4D97-AF65-F5344CB8AC3E}">
        <p14:creationId xmlns:p14="http://schemas.microsoft.com/office/powerpoint/2010/main" val="21593182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 id="2147483696" r:id="rId12"/>
    <p:sldLayoutId id="2147483697" r:id="rId13"/>
    <p:sldLayoutId id="2147483698" r:id="rId14"/>
    <p:sldLayoutId id="2147483699" r:id="rId15"/>
    <p:sldLayoutId id="2147483700" r:id="rId16"/>
    <p:sldLayoutId id="2147483701" r:id="rId17"/>
  </p:sldLayoutIdLst>
  <p:txStyles>
    <p:titleStyle>
      <a:lvl1pPr algn="l" defTabSz="457200" rtl="0" eaLnBrk="1" latinLnBrk="0" hangingPunct="1">
        <a:spcBef>
          <a:spcPct val="0"/>
        </a:spcBef>
        <a:buNone/>
        <a:defRPr sz="3600" b="0" i="0" kern="1200">
          <a:solidFill>
            <a:schemeClr val="bg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defTabSz="457200"/>
            <a:fld id="{B61BEF0D-F0BB-DE4B-95CE-6DB70DBA9567}" type="datetimeFigureOut">
              <a:rPr lang="en-US" smtClean="0">
                <a:solidFill>
                  <a:prstClr val="black">
                    <a:tint val="75000"/>
                  </a:prstClr>
                </a:solidFill>
              </a:rPr>
              <a:pPr defTabSz="457200"/>
              <a:t>4/20/2020</a:t>
            </a:fld>
            <a:endParaRPr lang="en-US" dirty="0">
              <a:solidFill>
                <a:prstClr val="black">
                  <a:tint val="75000"/>
                </a:prstClr>
              </a:solidFill>
            </a:endParaRPr>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defTabSz="457200"/>
            <a:endParaRPr lang="en-US" dirty="0">
              <a:solidFill>
                <a:prstClr val="black">
                  <a:tint val="75000"/>
                </a:prstClr>
              </a:solidFill>
            </a:endParaRPr>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defTabSz="457200"/>
            <a:fld id="{D57F1E4F-1CFF-5643-939E-217C01CDF565}" type="slidenum">
              <a:rPr lang="en-US" smtClean="0">
                <a:solidFill>
                  <a:prstClr val="black">
                    <a:tint val="75000"/>
                  </a:prstClr>
                </a:solidFill>
              </a:rPr>
              <a:pPr defTabSz="457200"/>
              <a:t>‹#›</a:t>
            </a:fld>
            <a:endParaRPr lang="en-US" dirty="0">
              <a:solidFill>
                <a:prstClr val="black">
                  <a:tint val="75000"/>
                </a:prstClr>
              </a:solidFill>
            </a:endParaRPr>
          </a:p>
        </p:txBody>
      </p:sp>
    </p:spTree>
    <p:extLst>
      <p:ext uri="{BB962C8B-B14F-4D97-AF65-F5344CB8AC3E}">
        <p14:creationId xmlns:p14="http://schemas.microsoft.com/office/powerpoint/2010/main" val="2125311931"/>
      </p:ext>
    </p:extLst>
  </p:cSld>
  <p:clrMap bg1="lt1" tx1="dk1" bg2="lt2" tx2="dk2" accent1="accent1" accent2="accent2" accent3="accent3" accent4="accent4" accent5="accent5" accent6="accent6" hlink="hlink" folHlink="folHlink"/>
  <p:sldLayoutIdLst>
    <p:sldLayoutId id="2147483703" r:id="rId1"/>
    <p:sldLayoutId id="2147483704" r:id="rId2"/>
    <p:sldLayoutId id="2147483705" r:id="rId3"/>
    <p:sldLayoutId id="2147483706" r:id="rId4"/>
    <p:sldLayoutId id="2147483707" r:id="rId5"/>
    <p:sldLayoutId id="2147483708" r:id="rId6"/>
    <p:sldLayoutId id="2147483709" r:id="rId7"/>
    <p:sldLayoutId id="2147483710" r:id="rId8"/>
    <p:sldLayoutId id="2147483711" r:id="rId9"/>
    <p:sldLayoutId id="2147483712" r:id="rId10"/>
    <p:sldLayoutId id="214748371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2.xml"/><Relationship Id="rId1" Type="http://schemas.openxmlformats.org/officeDocument/2006/relationships/slideLayout" Target="../slideLayouts/slideLayout19.xml"/></Relationships>
</file>

<file path=ppt/slides/_rels/slide3.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s://kahoot.it/"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 Id="rId5" Type="http://schemas.openxmlformats.org/officeDocument/2006/relationships/image" Target="../media/image7.jpeg"/><Relationship Id="rId4" Type="http://schemas.openxmlformats.org/officeDocument/2006/relationships/hyperlink" Target="https://create.kahoot.it/login"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sz="4400" b="1" i="1" dirty="0">
                <a:solidFill>
                  <a:srgbClr val="FFFF00"/>
                </a:solidFill>
              </a:rPr>
              <a:t>Geriatrics Women’s </a:t>
            </a:r>
            <a:r>
              <a:rPr lang="en-US" sz="4400" b="1" i="1" dirty="0" smtClean="0">
                <a:solidFill>
                  <a:srgbClr val="FFFF00"/>
                </a:solidFill>
              </a:rPr>
              <a:t>Health for IM Residents</a:t>
            </a:r>
            <a:endParaRPr lang="en-US" sz="4400" dirty="0"/>
          </a:p>
        </p:txBody>
      </p:sp>
      <p:sp>
        <p:nvSpPr>
          <p:cNvPr id="9" name="Subtitle 8"/>
          <p:cNvSpPr>
            <a:spLocks noGrp="1"/>
          </p:cNvSpPr>
          <p:nvPr>
            <p:ph type="subTitle" idx="1"/>
          </p:nvPr>
        </p:nvSpPr>
        <p:spPr/>
        <p:txBody>
          <a:bodyPr>
            <a:normAutofit fontScale="55000" lnSpcReduction="20000"/>
          </a:bodyPr>
          <a:lstStyle/>
          <a:p>
            <a:pPr algn="ctr"/>
            <a:endParaRPr lang="en-US" sz="2800" dirty="0" smtClean="0">
              <a:solidFill>
                <a:srgbClr val="FFFF00"/>
              </a:solidFill>
            </a:endParaRPr>
          </a:p>
          <a:p>
            <a:r>
              <a:rPr lang="en-US" sz="2800" dirty="0" smtClean="0">
                <a:solidFill>
                  <a:schemeClr val="bg1"/>
                </a:solidFill>
              </a:rPr>
              <a:t>Menopause, Osteoporosis, Abnormal uterine bleeding, urinary incontinence</a:t>
            </a:r>
          </a:p>
        </p:txBody>
      </p:sp>
      <p:pic>
        <p:nvPicPr>
          <p:cNvPr id="7" name="Content Placeholder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7518" y="6197686"/>
            <a:ext cx="737278" cy="587830"/>
          </a:xfrm>
          <a:prstGeom prst="rect">
            <a:avLst/>
          </a:prstGeom>
          <a:solidFill>
            <a:schemeClr val="bg1"/>
          </a:solidFill>
        </p:spPr>
      </p:pic>
    </p:spTree>
    <p:extLst>
      <p:ext uri="{BB962C8B-B14F-4D97-AF65-F5344CB8AC3E}">
        <p14:creationId xmlns:p14="http://schemas.microsoft.com/office/powerpoint/2010/main" val="121580056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a:xfrm>
            <a:off x="1971676" y="213728"/>
            <a:ext cx="8244633" cy="1325563"/>
          </a:xfrm>
        </p:spPr>
        <p:txBody>
          <a:bodyPr/>
          <a:lstStyle/>
          <a:p>
            <a:pPr algn="ctr"/>
            <a:r>
              <a:rPr lang="en-US" dirty="0" smtClean="0"/>
              <a:t>Workshop Overview</a:t>
            </a:r>
            <a:endParaRPr lang="en-US" dirty="0"/>
          </a:p>
        </p:txBody>
      </p:sp>
      <p:sp>
        <p:nvSpPr>
          <p:cNvPr id="12" name="Freeform 11">
            <a:extLst>
              <a:ext uri="{FF2B5EF4-FFF2-40B4-BE49-F238E27FC236}">
                <a16:creationId xmlns:a16="http://schemas.microsoft.com/office/drawing/2014/main" xmlns="" id="{4D0EBA06-5BDA-8040-A1DF-F2E04E703B9F}"/>
              </a:ext>
            </a:extLst>
          </p:cNvPr>
          <p:cNvSpPr>
            <a:spLocks/>
          </p:cNvSpPr>
          <p:nvPr/>
        </p:nvSpPr>
        <p:spPr bwMode="auto">
          <a:xfrm>
            <a:off x="1361247" y="2319866"/>
            <a:ext cx="1051952" cy="1401232"/>
          </a:xfrm>
          <a:custGeom>
            <a:avLst/>
            <a:gdLst>
              <a:gd name="T0" fmla="*/ 1956 w 2151"/>
              <a:gd name="T1" fmla="*/ 861 h 2586"/>
              <a:gd name="T2" fmla="*/ 2010 w 2151"/>
              <a:gd name="T3" fmla="*/ 884 h 2586"/>
              <a:gd name="T4" fmla="*/ 2054 w 2151"/>
              <a:gd name="T5" fmla="*/ 931 h 2586"/>
              <a:gd name="T6" fmla="*/ 2075 w 2151"/>
              <a:gd name="T7" fmla="*/ 965 h 2586"/>
              <a:gd name="T8" fmla="*/ 2104 w 2151"/>
              <a:gd name="T9" fmla="*/ 988 h 2586"/>
              <a:gd name="T10" fmla="*/ 2132 w 2151"/>
              <a:gd name="T11" fmla="*/ 983 h 2586"/>
              <a:gd name="T12" fmla="*/ 2148 w 2151"/>
              <a:gd name="T13" fmla="*/ 955 h 2586"/>
              <a:gd name="T14" fmla="*/ 0 w 2151"/>
              <a:gd name="T15" fmla="*/ 0 h 2586"/>
              <a:gd name="T16" fmla="*/ 933 w 2151"/>
              <a:gd name="T17" fmla="*/ 2156 h 2586"/>
              <a:gd name="T18" fmla="*/ 965 w 2151"/>
              <a:gd name="T19" fmla="*/ 2161 h 2586"/>
              <a:gd name="T20" fmla="*/ 988 w 2151"/>
              <a:gd name="T21" fmla="*/ 2182 h 2586"/>
              <a:gd name="T22" fmla="*/ 985 w 2151"/>
              <a:gd name="T23" fmla="*/ 2210 h 2586"/>
              <a:gd name="T24" fmla="*/ 957 w 2151"/>
              <a:gd name="T25" fmla="*/ 2239 h 2586"/>
              <a:gd name="T26" fmla="*/ 918 w 2151"/>
              <a:gd name="T27" fmla="*/ 2264 h 2586"/>
              <a:gd name="T28" fmla="*/ 879 w 2151"/>
              <a:gd name="T29" fmla="*/ 2309 h 2586"/>
              <a:gd name="T30" fmla="*/ 859 w 2151"/>
              <a:gd name="T31" fmla="*/ 2368 h 2586"/>
              <a:gd name="T32" fmla="*/ 863 w 2151"/>
              <a:gd name="T33" fmla="*/ 2426 h 2586"/>
              <a:gd name="T34" fmla="*/ 900 w 2151"/>
              <a:gd name="T35" fmla="*/ 2498 h 2586"/>
              <a:gd name="T36" fmla="*/ 968 w 2151"/>
              <a:gd name="T37" fmla="*/ 2552 h 2586"/>
              <a:gd name="T38" fmla="*/ 1058 w 2151"/>
              <a:gd name="T39" fmla="*/ 2582 h 2586"/>
              <a:gd name="T40" fmla="*/ 1133 w 2151"/>
              <a:gd name="T41" fmla="*/ 2584 h 2586"/>
              <a:gd name="T42" fmla="*/ 1227 w 2151"/>
              <a:gd name="T43" fmla="*/ 2561 h 2586"/>
              <a:gd name="T44" fmla="*/ 1300 w 2151"/>
              <a:gd name="T45" fmla="*/ 2513 h 2586"/>
              <a:gd name="T46" fmla="*/ 1346 w 2151"/>
              <a:gd name="T47" fmla="*/ 2444 h 2586"/>
              <a:gd name="T48" fmla="*/ 1357 w 2151"/>
              <a:gd name="T49" fmla="*/ 2386 h 2586"/>
              <a:gd name="T50" fmla="*/ 1344 w 2151"/>
              <a:gd name="T51" fmla="*/ 2322 h 2586"/>
              <a:gd name="T52" fmla="*/ 1313 w 2151"/>
              <a:gd name="T53" fmla="*/ 2278 h 2586"/>
              <a:gd name="T54" fmla="*/ 1269 w 2151"/>
              <a:gd name="T55" fmla="*/ 2244 h 2586"/>
              <a:gd name="T56" fmla="*/ 1235 w 2151"/>
              <a:gd name="T57" fmla="*/ 2218 h 2586"/>
              <a:gd name="T58" fmla="*/ 1225 w 2151"/>
              <a:gd name="T59" fmla="*/ 2189 h 2586"/>
              <a:gd name="T60" fmla="*/ 1242 w 2151"/>
              <a:gd name="T61" fmla="*/ 2166 h 2586"/>
              <a:gd name="T62" fmla="*/ 1282 w 2151"/>
              <a:gd name="T63" fmla="*/ 2156 h 2586"/>
              <a:gd name="T64" fmla="*/ 2151 w 2151"/>
              <a:gd name="T65" fmla="*/ 1281 h 2586"/>
              <a:gd name="T66" fmla="*/ 2146 w 2151"/>
              <a:gd name="T67" fmla="*/ 1248 h 2586"/>
              <a:gd name="T68" fmla="*/ 2125 w 2151"/>
              <a:gd name="T69" fmla="*/ 1225 h 2586"/>
              <a:gd name="T70" fmla="*/ 2097 w 2151"/>
              <a:gd name="T71" fmla="*/ 1229 h 2586"/>
              <a:gd name="T72" fmla="*/ 2068 w 2151"/>
              <a:gd name="T73" fmla="*/ 1258 h 2586"/>
              <a:gd name="T74" fmla="*/ 2044 w 2151"/>
              <a:gd name="T75" fmla="*/ 1295 h 2586"/>
              <a:gd name="T76" fmla="*/ 1998 w 2151"/>
              <a:gd name="T77" fmla="*/ 1336 h 2586"/>
              <a:gd name="T78" fmla="*/ 1940 w 2151"/>
              <a:gd name="T79" fmla="*/ 1356 h 2586"/>
              <a:gd name="T80" fmla="*/ 1881 w 2151"/>
              <a:gd name="T81" fmla="*/ 1351 h 2586"/>
              <a:gd name="T82" fmla="*/ 1809 w 2151"/>
              <a:gd name="T83" fmla="*/ 1313 h 2586"/>
              <a:gd name="T84" fmla="*/ 1756 w 2151"/>
              <a:gd name="T85" fmla="*/ 1247 h 2586"/>
              <a:gd name="T86" fmla="*/ 1725 w 2151"/>
              <a:gd name="T87" fmla="*/ 1157 h 2586"/>
              <a:gd name="T88" fmla="*/ 1722 w 2151"/>
              <a:gd name="T89" fmla="*/ 1081 h 2586"/>
              <a:gd name="T90" fmla="*/ 1746 w 2151"/>
              <a:gd name="T91" fmla="*/ 988 h 2586"/>
              <a:gd name="T92" fmla="*/ 1795 w 2151"/>
              <a:gd name="T93" fmla="*/ 913 h 2586"/>
              <a:gd name="T94" fmla="*/ 1862 w 2151"/>
              <a:gd name="T95" fmla="*/ 868 h 2586"/>
              <a:gd name="T96" fmla="*/ 1922 w 2151"/>
              <a:gd name="T97" fmla="*/ 856 h 258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151" h="2586">
                <a:moveTo>
                  <a:pt x="1922" y="856"/>
                </a:moveTo>
                <a:lnTo>
                  <a:pt x="1922" y="856"/>
                </a:lnTo>
                <a:lnTo>
                  <a:pt x="1940" y="858"/>
                </a:lnTo>
                <a:lnTo>
                  <a:pt x="1956" y="861"/>
                </a:lnTo>
                <a:lnTo>
                  <a:pt x="1971" y="864"/>
                </a:lnTo>
                <a:lnTo>
                  <a:pt x="1985" y="871"/>
                </a:lnTo>
                <a:lnTo>
                  <a:pt x="1998" y="877"/>
                </a:lnTo>
                <a:lnTo>
                  <a:pt x="2010" y="884"/>
                </a:lnTo>
                <a:lnTo>
                  <a:pt x="2019" y="892"/>
                </a:lnTo>
                <a:lnTo>
                  <a:pt x="2029" y="900"/>
                </a:lnTo>
                <a:lnTo>
                  <a:pt x="2044" y="916"/>
                </a:lnTo>
                <a:lnTo>
                  <a:pt x="2054" y="931"/>
                </a:lnTo>
                <a:lnTo>
                  <a:pt x="2062" y="944"/>
                </a:lnTo>
                <a:lnTo>
                  <a:pt x="2062" y="944"/>
                </a:lnTo>
                <a:lnTo>
                  <a:pt x="2068" y="955"/>
                </a:lnTo>
                <a:lnTo>
                  <a:pt x="2075" y="965"/>
                </a:lnTo>
                <a:lnTo>
                  <a:pt x="2083" y="973"/>
                </a:lnTo>
                <a:lnTo>
                  <a:pt x="2089" y="980"/>
                </a:lnTo>
                <a:lnTo>
                  <a:pt x="2097" y="985"/>
                </a:lnTo>
                <a:lnTo>
                  <a:pt x="2104" y="988"/>
                </a:lnTo>
                <a:lnTo>
                  <a:pt x="2112" y="988"/>
                </a:lnTo>
                <a:lnTo>
                  <a:pt x="2119" y="988"/>
                </a:lnTo>
                <a:lnTo>
                  <a:pt x="2125" y="986"/>
                </a:lnTo>
                <a:lnTo>
                  <a:pt x="2132" y="983"/>
                </a:lnTo>
                <a:lnTo>
                  <a:pt x="2136" y="978"/>
                </a:lnTo>
                <a:lnTo>
                  <a:pt x="2141" y="972"/>
                </a:lnTo>
                <a:lnTo>
                  <a:pt x="2146" y="965"/>
                </a:lnTo>
                <a:lnTo>
                  <a:pt x="2148" y="955"/>
                </a:lnTo>
                <a:lnTo>
                  <a:pt x="2151" y="944"/>
                </a:lnTo>
                <a:lnTo>
                  <a:pt x="2151" y="931"/>
                </a:lnTo>
                <a:lnTo>
                  <a:pt x="2151" y="0"/>
                </a:lnTo>
                <a:lnTo>
                  <a:pt x="0" y="0"/>
                </a:lnTo>
                <a:lnTo>
                  <a:pt x="0" y="2155"/>
                </a:lnTo>
                <a:lnTo>
                  <a:pt x="495" y="2155"/>
                </a:lnTo>
                <a:lnTo>
                  <a:pt x="495" y="2156"/>
                </a:lnTo>
                <a:lnTo>
                  <a:pt x="933" y="2156"/>
                </a:lnTo>
                <a:lnTo>
                  <a:pt x="933" y="2156"/>
                </a:lnTo>
                <a:lnTo>
                  <a:pt x="946" y="2156"/>
                </a:lnTo>
                <a:lnTo>
                  <a:pt x="955" y="2158"/>
                </a:lnTo>
                <a:lnTo>
                  <a:pt x="965" y="2161"/>
                </a:lnTo>
                <a:lnTo>
                  <a:pt x="973" y="2166"/>
                </a:lnTo>
                <a:lnTo>
                  <a:pt x="980" y="2171"/>
                </a:lnTo>
                <a:lnTo>
                  <a:pt x="985" y="2176"/>
                </a:lnTo>
                <a:lnTo>
                  <a:pt x="988" y="2182"/>
                </a:lnTo>
                <a:lnTo>
                  <a:pt x="989" y="2189"/>
                </a:lnTo>
                <a:lnTo>
                  <a:pt x="989" y="2195"/>
                </a:lnTo>
                <a:lnTo>
                  <a:pt x="988" y="2203"/>
                </a:lnTo>
                <a:lnTo>
                  <a:pt x="985" y="2210"/>
                </a:lnTo>
                <a:lnTo>
                  <a:pt x="980" y="2218"/>
                </a:lnTo>
                <a:lnTo>
                  <a:pt x="975" y="2225"/>
                </a:lnTo>
                <a:lnTo>
                  <a:pt x="967" y="2233"/>
                </a:lnTo>
                <a:lnTo>
                  <a:pt x="957" y="2239"/>
                </a:lnTo>
                <a:lnTo>
                  <a:pt x="946" y="2244"/>
                </a:lnTo>
                <a:lnTo>
                  <a:pt x="946" y="2244"/>
                </a:lnTo>
                <a:lnTo>
                  <a:pt x="931" y="2252"/>
                </a:lnTo>
                <a:lnTo>
                  <a:pt x="918" y="2264"/>
                </a:lnTo>
                <a:lnTo>
                  <a:pt x="902" y="2278"/>
                </a:lnTo>
                <a:lnTo>
                  <a:pt x="893" y="2288"/>
                </a:lnTo>
                <a:lnTo>
                  <a:pt x="885" y="2298"/>
                </a:lnTo>
                <a:lnTo>
                  <a:pt x="879" y="2309"/>
                </a:lnTo>
                <a:lnTo>
                  <a:pt x="871" y="2322"/>
                </a:lnTo>
                <a:lnTo>
                  <a:pt x="866" y="2335"/>
                </a:lnTo>
                <a:lnTo>
                  <a:pt x="861" y="2351"/>
                </a:lnTo>
                <a:lnTo>
                  <a:pt x="859" y="2368"/>
                </a:lnTo>
                <a:lnTo>
                  <a:pt x="858" y="2386"/>
                </a:lnTo>
                <a:lnTo>
                  <a:pt x="858" y="2386"/>
                </a:lnTo>
                <a:lnTo>
                  <a:pt x="859" y="2405"/>
                </a:lnTo>
                <a:lnTo>
                  <a:pt x="863" y="2426"/>
                </a:lnTo>
                <a:lnTo>
                  <a:pt x="869" y="2444"/>
                </a:lnTo>
                <a:lnTo>
                  <a:pt x="877" y="2464"/>
                </a:lnTo>
                <a:lnTo>
                  <a:pt x="889" y="2482"/>
                </a:lnTo>
                <a:lnTo>
                  <a:pt x="900" y="2498"/>
                </a:lnTo>
                <a:lnTo>
                  <a:pt x="915" y="2513"/>
                </a:lnTo>
                <a:lnTo>
                  <a:pt x="931" y="2527"/>
                </a:lnTo>
                <a:lnTo>
                  <a:pt x="949" y="2540"/>
                </a:lnTo>
                <a:lnTo>
                  <a:pt x="968" y="2552"/>
                </a:lnTo>
                <a:lnTo>
                  <a:pt x="988" y="2561"/>
                </a:lnTo>
                <a:lnTo>
                  <a:pt x="1011" y="2569"/>
                </a:lnTo>
                <a:lnTo>
                  <a:pt x="1033" y="2578"/>
                </a:lnTo>
                <a:lnTo>
                  <a:pt x="1058" y="2582"/>
                </a:lnTo>
                <a:lnTo>
                  <a:pt x="1082" y="2584"/>
                </a:lnTo>
                <a:lnTo>
                  <a:pt x="1108" y="2586"/>
                </a:lnTo>
                <a:lnTo>
                  <a:pt x="1108" y="2586"/>
                </a:lnTo>
                <a:lnTo>
                  <a:pt x="1133" y="2584"/>
                </a:lnTo>
                <a:lnTo>
                  <a:pt x="1157" y="2582"/>
                </a:lnTo>
                <a:lnTo>
                  <a:pt x="1181" y="2578"/>
                </a:lnTo>
                <a:lnTo>
                  <a:pt x="1204" y="2569"/>
                </a:lnTo>
                <a:lnTo>
                  <a:pt x="1227" y="2561"/>
                </a:lnTo>
                <a:lnTo>
                  <a:pt x="1247" y="2552"/>
                </a:lnTo>
                <a:lnTo>
                  <a:pt x="1266" y="2540"/>
                </a:lnTo>
                <a:lnTo>
                  <a:pt x="1284" y="2527"/>
                </a:lnTo>
                <a:lnTo>
                  <a:pt x="1300" y="2513"/>
                </a:lnTo>
                <a:lnTo>
                  <a:pt x="1315" y="2498"/>
                </a:lnTo>
                <a:lnTo>
                  <a:pt x="1326" y="2482"/>
                </a:lnTo>
                <a:lnTo>
                  <a:pt x="1338" y="2464"/>
                </a:lnTo>
                <a:lnTo>
                  <a:pt x="1346" y="2444"/>
                </a:lnTo>
                <a:lnTo>
                  <a:pt x="1352" y="2426"/>
                </a:lnTo>
                <a:lnTo>
                  <a:pt x="1356" y="2405"/>
                </a:lnTo>
                <a:lnTo>
                  <a:pt x="1357" y="2386"/>
                </a:lnTo>
                <a:lnTo>
                  <a:pt x="1357" y="2386"/>
                </a:lnTo>
                <a:lnTo>
                  <a:pt x="1356" y="2368"/>
                </a:lnTo>
                <a:lnTo>
                  <a:pt x="1354" y="2351"/>
                </a:lnTo>
                <a:lnTo>
                  <a:pt x="1349" y="2335"/>
                </a:lnTo>
                <a:lnTo>
                  <a:pt x="1344" y="2322"/>
                </a:lnTo>
                <a:lnTo>
                  <a:pt x="1338" y="2309"/>
                </a:lnTo>
                <a:lnTo>
                  <a:pt x="1329" y="2298"/>
                </a:lnTo>
                <a:lnTo>
                  <a:pt x="1321" y="2288"/>
                </a:lnTo>
                <a:lnTo>
                  <a:pt x="1313" y="2278"/>
                </a:lnTo>
                <a:lnTo>
                  <a:pt x="1297" y="2264"/>
                </a:lnTo>
                <a:lnTo>
                  <a:pt x="1284" y="2252"/>
                </a:lnTo>
                <a:lnTo>
                  <a:pt x="1269" y="2244"/>
                </a:lnTo>
                <a:lnTo>
                  <a:pt x="1269" y="2244"/>
                </a:lnTo>
                <a:lnTo>
                  <a:pt x="1258" y="2239"/>
                </a:lnTo>
                <a:lnTo>
                  <a:pt x="1248" y="2233"/>
                </a:lnTo>
                <a:lnTo>
                  <a:pt x="1240" y="2225"/>
                </a:lnTo>
                <a:lnTo>
                  <a:pt x="1235" y="2218"/>
                </a:lnTo>
                <a:lnTo>
                  <a:pt x="1230" y="2210"/>
                </a:lnTo>
                <a:lnTo>
                  <a:pt x="1227" y="2203"/>
                </a:lnTo>
                <a:lnTo>
                  <a:pt x="1225" y="2195"/>
                </a:lnTo>
                <a:lnTo>
                  <a:pt x="1225" y="2189"/>
                </a:lnTo>
                <a:lnTo>
                  <a:pt x="1227" y="2182"/>
                </a:lnTo>
                <a:lnTo>
                  <a:pt x="1230" y="2176"/>
                </a:lnTo>
                <a:lnTo>
                  <a:pt x="1235" y="2171"/>
                </a:lnTo>
                <a:lnTo>
                  <a:pt x="1242" y="2166"/>
                </a:lnTo>
                <a:lnTo>
                  <a:pt x="1250" y="2161"/>
                </a:lnTo>
                <a:lnTo>
                  <a:pt x="1260" y="2158"/>
                </a:lnTo>
                <a:lnTo>
                  <a:pt x="1269" y="2156"/>
                </a:lnTo>
                <a:lnTo>
                  <a:pt x="1282" y="2156"/>
                </a:lnTo>
                <a:lnTo>
                  <a:pt x="1556" y="2156"/>
                </a:lnTo>
                <a:lnTo>
                  <a:pt x="1556" y="2155"/>
                </a:lnTo>
                <a:lnTo>
                  <a:pt x="2151" y="2155"/>
                </a:lnTo>
                <a:lnTo>
                  <a:pt x="2151" y="1281"/>
                </a:lnTo>
                <a:lnTo>
                  <a:pt x="2151" y="1281"/>
                </a:lnTo>
                <a:lnTo>
                  <a:pt x="2151" y="1269"/>
                </a:lnTo>
                <a:lnTo>
                  <a:pt x="2148" y="1258"/>
                </a:lnTo>
                <a:lnTo>
                  <a:pt x="2146" y="1248"/>
                </a:lnTo>
                <a:lnTo>
                  <a:pt x="2141" y="1240"/>
                </a:lnTo>
                <a:lnTo>
                  <a:pt x="2136" y="1234"/>
                </a:lnTo>
                <a:lnTo>
                  <a:pt x="2132" y="1229"/>
                </a:lnTo>
                <a:lnTo>
                  <a:pt x="2125" y="1225"/>
                </a:lnTo>
                <a:lnTo>
                  <a:pt x="2119" y="1224"/>
                </a:lnTo>
                <a:lnTo>
                  <a:pt x="2112" y="1224"/>
                </a:lnTo>
                <a:lnTo>
                  <a:pt x="2104" y="1225"/>
                </a:lnTo>
                <a:lnTo>
                  <a:pt x="2097" y="1229"/>
                </a:lnTo>
                <a:lnTo>
                  <a:pt x="2089" y="1234"/>
                </a:lnTo>
                <a:lnTo>
                  <a:pt x="2083" y="1240"/>
                </a:lnTo>
                <a:lnTo>
                  <a:pt x="2075" y="1248"/>
                </a:lnTo>
                <a:lnTo>
                  <a:pt x="2068" y="1258"/>
                </a:lnTo>
                <a:lnTo>
                  <a:pt x="2062" y="1268"/>
                </a:lnTo>
                <a:lnTo>
                  <a:pt x="2062" y="1268"/>
                </a:lnTo>
                <a:lnTo>
                  <a:pt x="2054" y="1282"/>
                </a:lnTo>
                <a:lnTo>
                  <a:pt x="2044" y="1295"/>
                </a:lnTo>
                <a:lnTo>
                  <a:pt x="2029" y="1312"/>
                </a:lnTo>
                <a:lnTo>
                  <a:pt x="2019" y="1320"/>
                </a:lnTo>
                <a:lnTo>
                  <a:pt x="2010" y="1328"/>
                </a:lnTo>
                <a:lnTo>
                  <a:pt x="1998" y="1336"/>
                </a:lnTo>
                <a:lnTo>
                  <a:pt x="1985" y="1343"/>
                </a:lnTo>
                <a:lnTo>
                  <a:pt x="1971" y="1348"/>
                </a:lnTo>
                <a:lnTo>
                  <a:pt x="1956" y="1352"/>
                </a:lnTo>
                <a:lnTo>
                  <a:pt x="1940" y="1356"/>
                </a:lnTo>
                <a:lnTo>
                  <a:pt x="1922" y="1356"/>
                </a:lnTo>
                <a:lnTo>
                  <a:pt x="1922" y="1356"/>
                </a:lnTo>
                <a:lnTo>
                  <a:pt x="1901" y="1354"/>
                </a:lnTo>
                <a:lnTo>
                  <a:pt x="1881" y="1351"/>
                </a:lnTo>
                <a:lnTo>
                  <a:pt x="1862" y="1344"/>
                </a:lnTo>
                <a:lnTo>
                  <a:pt x="1844" y="1336"/>
                </a:lnTo>
                <a:lnTo>
                  <a:pt x="1826" y="1326"/>
                </a:lnTo>
                <a:lnTo>
                  <a:pt x="1809" y="1313"/>
                </a:lnTo>
                <a:lnTo>
                  <a:pt x="1795" y="1299"/>
                </a:lnTo>
                <a:lnTo>
                  <a:pt x="1780" y="1282"/>
                </a:lnTo>
                <a:lnTo>
                  <a:pt x="1767" y="1265"/>
                </a:lnTo>
                <a:lnTo>
                  <a:pt x="1756" y="1247"/>
                </a:lnTo>
                <a:lnTo>
                  <a:pt x="1746" y="1225"/>
                </a:lnTo>
                <a:lnTo>
                  <a:pt x="1736" y="1203"/>
                </a:lnTo>
                <a:lnTo>
                  <a:pt x="1730" y="1180"/>
                </a:lnTo>
                <a:lnTo>
                  <a:pt x="1725" y="1157"/>
                </a:lnTo>
                <a:lnTo>
                  <a:pt x="1722" y="1131"/>
                </a:lnTo>
                <a:lnTo>
                  <a:pt x="1722" y="1107"/>
                </a:lnTo>
                <a:lnTo>
                  <a:pt x="1722" y="1107"/>
                </a:lnTo>
                <a:lnTo>
                  <a:pt x="1722" y="1081"/>
                </a:lnTo>
                <a:lnTo>
                  <a:pt x="1725" y="1056"/>
                </a:lnTo>
                <a:lnTo>
                  <a:pt x="1730" y="1032"/>
                </a:lnTo>
                <a:lnTo>
                  <a:pt x="1736" y="1009"/>
                </a:lnTo>
                <a:lnTo>
                  <a:pt x="1746" y="988"/>
                </a:lnTo>
                <a:lnTo>
                  <a:pt x="1756" y="967"/>
                </a:lnTo>
                <a:lnTo>
                  <a:pt x="1767" y="947"/>
                </a:lnTo>
                <a:lnTo>
                  <a:pt x="1780" y="929"/>
                </a:lnTo>
                <a:lnTo>
                  <a:pt x="1795" y="913"/>
                </a:lnTo>
                <a:lnTo>
                  <a:pt x="1809" y="898"/>
                </a:lnTo>
                <a:lnTo>
                  <a:pt x="1826" y="887"/>
                </a:lnTo>
                <a:lnTo>
                  <a:pt x="1844" y="876"/>
                </a:lnTo>
                <a:lnTo>
                  <a:pt x="1862" y="868"/>
                </a:lnTo>
                <a:lnTo>
                  <a:pt x="1881" y="861"/>
                </a:lnTo>
                <a:lnTo>
                  <a:pt x="1901" y="858"/>
                </a:lnTo>
                <a:lnTo>
                  <a:pt x="1922" y="856"/>
                </a:lnTo>
                <a:lnTo>
                  <a:pt x="1922" y="856"/>
                </a:lnTo>
                <a:close/>
              </a:path>
            </a:pathLst>
          </a:custGeom>
          <a:solidFill>
            <a:srgbClr val="FF0000"/>
          </a:solidFill>
          <a:ln w="28575">
            <a:solidFill>
              <a:schemeClr val="tx1">
                <a:lumMod val="50000"/>
                <a:lumOff val="50000"/>
              </a:schemeClr>
            </a:solidFill>
            <a:prstDash val="solid"/>
            <a:round/>
            <a:headEnd/>
            <a:tailEnd/>
          </a:ln>
        </p:spPr>
        <p:txBody>
          <a:bodyPr bIns="540000" anchor="ctr"/>
          <a:lstStyle/>
          <a:p>
            <a:pPr algn="ctr" defTabSz="457200">
              <a:defRPr/>
            </a:pPr>
            <a:r>
              <a:rPr lang="en-US" sz="4000" dirty="0">
                <a:solidFill>
                  <a:prstClr val="black"/>
                </a:solidFill>
              </a:rPr>
              <a:t>A</a:t>
            </a:r>
            <a:endParaRPr lang="en-GB" sz="4000" dirty="0">
              <a:solidFill>
                <a:prstClr val="black"/>
              </a:solidFill>
              <a:cs typeface="Arial" charset="0"/>
            </a:endParaRPr>
          </a:p>
        </p:txBody>
      </p:sp>
      <p:sp>
        <p:nvSpPr>
          <p:cNvPr id="13" name="Freeform 12">
            <a:extLst>
              <a:ext uri="{FF2B5EF4-FFF2-40B4-BE49-F238E27FC236}">
                <a16:creationId xmlns:a16="http://schemas.microsoft.com/office/drawing/2014/main" xmlns="" id="{DC9B64A7-7B77-B542-99BB-81F85AA9FFF4}"/>
              </a:ext>
            </a:extLst>
          </p:cNvPr>
          <p:cNvSpPr>
            <a:spLocks/>
          </p:cNvSpPr>
          <p:nvPr/>
        </p:nvSpPr>
        <p:spPr bwMode="auto">
          <a:xfrm>
            <a:off x="1357902" y="3491814"/>
            <a:ext cx="1265421" cy="1164853"/>
          </a:xfrm>
          <a:custGeom>
            <a:avLst/>
            <a:gdLst>
              <a:gd name="T0" fmla="*/ 861 w 2587"/>
              <a:gd name="T1" fmla="*/ 195 h 2151"/>
              <a:gd name="T2" fmla="*/ 885 w 2587"/>
              <a:gd name="T3" fmla="*/ 143 h 2151"/>
              <a:gd name="T4" fmla="*/ 931 w 2587"/>
              <a:gd name="T5" fmla="*/ 97 h 2151"/>
              <a:gd name="T6" fmla="*/ 965 w 2587"/>
              <a:gd name="T7" fmla="*/ 76 h 2151"/>
              <a:gd name="T8" fmla="*/ 988 w 2587"/>
              <a:gd name="T9" fmla="*/ 47 h 2151"/>
              <a:gd name="T10" fmla="*/ 985 w 2587"/>
              <a:gd name="T11" fmla="*/ 21 h 2151"/>
              <a:gd name="T12" fmla="*/ 955 w 2587"/>
              <a:gd name="T13" fmla="*/ 3 h 2151"/>
              <a:gd name="T14" fmla="*/ 0 w 2587"/>
              <a:gd name="T15" fmla="*/ 2151 h 2151"/>
              <a:gd name="T16" fmla="*/ 2156 w 2587"/>
              <a:gd name="T17" fmla="*/ 1220 h 2151"/>
              <a:gd name="T18" fmla="*/ 2163 w 2587"/>
              <a:gd name="T19" fmla="*/ 1186 h 2151"/>
              <a:gd name="T20" fmla="*/ 2182 w 2587"/>
              <a:gd name="T21" fmla="*/ 1163 h 2151"/>
              <a:gd name="T22" fmla="*/ 2211 w 2587"/>
              <a:gd name="T23" fmla="*/ 1166 h 2151"/>
              <a:gd name="T24" fmla="*/ 2239 w 2587"/>
              <a:gd name="T25" fmla="*/ 1196 h 2151"/>
              <a:gd name="T26" fmla="*/ 2263 w 2587"/>
              <a:gd name="T27" fmla="*/ 1235 h 2151"/>
              <a:gd name="T28" fmla="*/ 2309 w 2587"/>
              <a:gd name="T29" fmla="*/ 1274 h 2151"/>
              <a:gd name="T30" fmla="*/ 2368 w 2587"/>
              <a:gd name="T31" fmla="*/ 1293 h 2151"/>
              <a:gd name="T32" fmla="*/ 2426 w 2587"/>
              <a:gd name="T33" fmla="*/ 1288 h 2151"/>
              <a:gd name="T34" fmla="*/ 2498 w 2587"/>
              <a:gd name="T35" fmla="*/ 1251 h 2151"/>
              <a:gd name="T36" fmla="*/ 2553 w 2587"/>
              <a:gd name="T37" fmla="*/ 1184 h 2151"/>
              <a:gd name="T38" fmla="*/ 2582 w 2587"/>
              <a:gd name="T39" fmla="*/ 1095 h 2151"/>
              <a:gd name="T40" fmla="*/ 2586 w 2587"/>
              <a:gd name="T41" fmla="*/ 1018 h 2151"/>
              <a:gd name="T42" fmla="*/ 2563 w 2587"/>
              <a:gd name="T43" fmla="*/ 926 h 2151"/>
              <a:gd name="T44" fmla="*/ 2514 w 2587"/>
              <a:gd name="T45" fmla="*/ 852 h 2151"/>
              <a:gd name="T46" fmla="*/ 2446 w 2587"/>
              <a:gd name="T47" fmla="*/ 805 h 2151"/>
              <a:gd name="T48" fmla="*/ 2385 w 2587"/>
              <a:gd name="T49" fmla="*/ 794 h 2151"/>
              <a:gd name="T50" fmla="*/ 2322 w 2587"/>
              <a:gd name="T51" fmla="*/ 808 h 2151"/>
              <a:gd name="T52" fmla="*/ 2278 w 2587"/>
              <a:gd name="T53" fmla="*/ 838 h 2151"/>
              <a:gd name="T54" fmla="*/ 2245 w 2587"/>
              <a:gd name="T55" fmla="*/ 882 h 2151"/>
              <a:gd name="T56" fmla="*/ 2218 w 2587"/>
              <a:gd name="T57" fmla="*/ 917 h 2151"/>
              <a:gd name="T58" fmla="*/ 2189 w 2587"/>
              <a:gd name="T59" fmla="*/ 927 h 2151"/>
              <a:gd name="T60" fmla="*/ 2166 w 2587"/>
              <a:gd name="T61" fmla="*/ 911 h 2151"/>
              <a:gd name="T62" fmla="*/ 2156 w 2587"/>
              <a:gd name="T63" fmla="*/ 869 h 2151"/>
              <a:gd name="T64" fmla="*/ 1282 w 2587"/>
              <a:gd name="T65" fmla="*/ 0 h 2151"/>
              <a:gd name="T66" fmla="*/ 1248 w 2587"/>
              <a:gd name="T67" fmla="*/ 6 h 2151"/>
              <a:gd name="T68" fmla="*/ 1227 w 2587"/>
              <a:gd name="T69" fmla="*/ 27 h 2151"/>
              <a:gd name="T70" fmla="*/ 1229 w 2587"/>
              <a:gd name="T71" fmla="*/ 55 h 2151"/>
              <a:gd name="T72" fmla="*/ 1258 w 2587"/>
              <a:gd name="T73" fmla="*/ 83 h 2151"/>
              <a:gd name="T74" fmla="*/ 1297 w 2587"/>
              <a:gd name="T75" fmla="*/ 107 h 2151"/>
              <a:gd name="T76" fmla="*/ 1336 w 2587"/>
              <a:gd name="T77" fmla="*/ 154 h 2151"/>
              <a:gd name="T78" fmla="*/ 1356 w 2587"/>
              <a:gd name="T79" fmla="*/ 213 h 2151"/>
              <a:gd name="T80" fmla="*/ 1352 w 2587"/>
              <a:gd name="T81" fmla="*/ 270 h 2151"/>
              <a:gd name="T82" fmla="*/ 1313 w 2587"/>
              <a:gd name="T83" fmla="*/ 341 h 2151"/>
              <a:gd name="T84" fmla="*/ 1247 w 2587"/>
              <a:gd name="T85" fmla="*/ 397 h 2151"/>
              <a:gd name="T86" fmla="*/ 1157 w 2587"/>
              <a:gd name="T87" fmla="*/ 426 h 2151"/>
              <a:gd name="T88" fmla="*/ 1082 w 2587"/>
              <a:gd name="T89" fmla="*/ 429 h 2151"/>
              <a:gd name="T90" fmla="*/ 988 w 2587"/>
              <a:gd name="T91" fmla="*/ 406 h 2151"/>
              <a:gd name="T92" fmla="*/ 915 w 2587"/>
              <a:gd name="T93" fmla="*/ 358 h 2151"/>
              <a:gd name="T94" fmla="*/ 869 w 2587"/>
              <a:gd name="T95" fmla="*/ 289 h 2151"/>
              <a:gd name="T96" fmla="*/ 858 w 2587"/>
              <a:gd name="T97" fmla="*/ 231 h 215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587" h="2151">
                <a:moveTo>
                  <a:pt x="858" y="231"/>
                </a:moveTo>
                <a:lnTo>
                  <a:pt x="858" y="231"/>
                </a:lnTo>
                <a:lnTo>
                  <a:pt x="858" y="213"/>
                </a:lnTo>
                <a:lnTo>
                  <a:pt x="861" y="195"/>
                </a:lnTo>
                <a:lnTo>
                  <a:pt x="866" y="180"/>
                </a:lnTo>
                <a:lnTo>
                  <a:pt x="871" y="166"/>
                </a:lnTo>
                <a:lnTo>
                  <a:pt x="877" y="154"/>
                </a:lnTo>
                <a:lnTo>
                  <a:pt x="885" y="143"/>
                </a:lnTo>
                <a:lnTo>
                  <a:pt x="893" y="131"/>
                </a:lnTo>
                <a:lnTo>
                  <a:pt x="902" y="123"/>
                </a:lnTo>
                <a:lnTo>
                  <a:pt x="918" y="107"/>
                </a:lnTo>
                <a:lnTo>
                  <a:pt x="931" y="97"/>
                </a:lnTo>
                <a:lnTo>
                  <a:pt x="946" y="89"/>
                </a:lnTo>
                <a:lnTo>
                  <a:pt x="946" y="89"/>
                </a:lnTo>
                <a:lnTo>
                  <a:pt x="955" y="83"/>
                </a:lnTo>
                <a:lnTo>
                  <a:pt x="965" y="76"/>
                </a:lnTo>
                <a:lnTo>
                  <a:pt x="973" y="70"/>
                </a:lnTo>
                <a:lnTo>
                  <a:pt x="980" y="62"/>
                </a:lnTo>
                <a:lnTo>
                  <a:pt x="985" y="55"/>
                </a:lnTo>
                <a:lnTo>
                  <a:pt x="988" y="47"/>
                </a:lnTo>
                <a:lnTo>
                  <a:pt x="989" y="40"/>
                </a:lnTo>
                <a:lnTo>
                  <a:pt x="989" y="34"/>
                </a:lnTo>
                <a:lnTo>
                  <a:pt x="988" y="27"/>
                </a:lnTo>
                <a:lnTo>
                  <a:pt x="985" y="21"/>
                </a:lnTo>
                <a:lnTo>
                  <a:pt x="980" y="14"/>
                </a:lnTo>
                <a:lnTo>
                  <a:pt x="973" y="9"/>
                </a:lnTo>
                <a:lnTo>
                  <a:pt x="965" y="6"/>
                </a:lnTo>
                <a:lnTo>
                  <a:pt x="955" y="3"/>
                </a:lnTo>
                <a:lnTo>
                  <a:pt x="944" y="1"/>
                </a:lnTo>
                <a:lnTo>
                  <a:pt x="933" y="0"/>
                </a:lnTo>
                <a:lnTo>
                  <a:pt x="0" y="0"/>
                </a:lnTo>
                <a:lnTo>
                  <a:pt x="0" y="2151"/>
                </a:lnTo>
                <a:lnTo>
                  <a:pt x="2154" y="2151"/>
                </a:lnTo>
                <a:lnTo>
                  <a:pt x="2154" y="1656"/>
                </a:lnTo>
                <a:lnTo>
                  <a:pt x="2156" y="1656"/>
                </a:lnTo>
                <a:lnTo>
                  <a:pt x="2156" y="1220"/>
                </a:lnTo>
                <a:lnTo>
                  <a:pt x="2156" y="1220"/>
                </a:lnTo>
                <a:lnTo>
                  <a:pt x="2158" y="1207"/>
                </a:lnTo>
                <a:lnTo>
                  <a:pt x="2159" y="1196"/>
                </a:lnTo>
                <a:lnTo>
                  <a:pt x="2163" y="1186"/>
                </a:lnTo>
                <a:lnTo>
                  <a:pt x="2166" y="1178"/>
                </a:lnTo>
                <a:lnTo>
                  <a:pt x="2171" y="1171"/>
                </a:lnTo>
                <a:lnTo>
                  <a:pt x="2177" y="1166"/>
                </a:lnTo>
                <a:lnTo>
                  <a:pt x="2182" y="1163"/>
                </a:lnTo>
                <a:lnTo>
                  <a:pt x="2189" y="1161"/>
                </a:lnTo>
                <a:lnTo>
                  <a:pt x="2197" y="1161"/>
                </a:lnTo>
                <a:lnTo>
                  <a:pt x="2203" y="1163"/>
                </a:lnTo>
                <a:lnTo>
                  <a:pt x="2211" y="1166"/>
                </a:lnTo>
                <a:lnTo>
                  <a:pt x="2218" y="1171"/>
                </a:lnTo>
                <a:lnTo>
                  <a:pt x="2226" y="1178"/>
                </a:lnTo>
                <a:lnTo>
                  <a:pt x="2232" y="1186"/>
                </a:lnTo>
                <a:lnTo>
                  <a:pt x="2239" y="1196"/>
                </a:lnTo>
                <a:lnTo>
                  <a:pt x="2245" y="1207"/>
                </a:lnTo>
                <a:lnTo>
                  <a:pt x="2245" y="1207"/>
                </a:lnTo>
                <a:lnTo>
                  <a:pt x="2254" y="1220"/>
                </a:lnTo>
                <a:lnTo>
                  <a:pt x="2263" y="1235"/>
                </a:lnTo>
                <a:lnTo>
                  <a:pt x="2278" y="1251"/>
                </a:lnTo>
                <a:lnTo>
                  <a:pt x="2288" y="1259"/>
                </a:lnTo>
                <a:lnTo>
                  <a:pt x="2298" y="1266"/>
                </a:lnTo>
                <a:lnTo>
                  <a:pt x="2309" y="1274"/>
                </a:lnTo>
                <a:lnTo>
                  <a:pt x="2322" y="1280"/>
                </a:lnTo>
                <a:lnTo>
                  <a:pt x="2337" y="1285"/>
                </a:lnTo>
                <a:lnTo>
                  <a:pt x="2351" y="1290"/>
                </a:lnTo>
                <a:lnTo>
                  <a:pt x="2368" y="1293"/>
                </a:lnTo>
                <a:lnTo>
                  <a:pt x="2385" y="1293"/>
                </a:lnTo>
                <a:lnTo>
                  <a:pt x="2385" y="1293"/>
                </a:lnTo>
                <a:lnTo>
                  <a:pt x="2407" y="1293"/>
                </a:lnTo>
                <a:lnTo>
                  <a:pt x="2426" y="1288"/>
                </a:lnTo>
                <a:lnTo>
                  <a:pt x="2446" y="1283"/>
                </a:lnTo>
                <a:lnTo>
                  <a:pt x="2463" y="1274"/>
                </a:lnTo>
                <a:lnTo>
                  <a:pt x="2481" y="1264"/>
                </a:lnTo>
                <a:lnTo>
                  <a:pt x="2498" y="1251"/>
                </a:lnTo>
                <a:lnTo>
                  <a:pt x="2514" y="1236"/>
                </a:lnTo>
                <a:lnTo>
                  <a:pt x="2527" y="1220"/>
                </a:lnTo>
                <a:lnTo>
                  <a:pt x="2540" y="1204"/>
                </a:lnTo>
                <a:lnTo>
                  <a:pt x="2553" y="1184"/>
                </a:lnTo>
                <a:lnTo>
                  <a:pt x="2563" y="1163"/>
                </a:lnTo>
                <a:lnTo>
                  <a:pt x="2571" y="1142"/>
                </a:lnTo>
                <a:lnTo>
                  <a:pt x="2577" y="1119"/>
                </a:lnTo>
                <a:lnTo>
                  <a:pt x="2582" y="1095"/>
                </a:lnTo>
                <a:lnTo>
                  <a:pt x="2586" y="1070"/>
                </a:lnTo>
                <a:lnTo>
                  <a:pt x="2587" y="1044"/>
                </a:lnTo>
                <a:lnTo>
                  <a:pt x="2587" y="1044"/>
                </a:lnTo>
                <a:lnTo>
                  <a:pt x="2586" y="1018"/>
                </a:lnTo>
                <a:lnTo>
                  <a:pt x="2582" y="994"/>
                </a:lnTo>
                <a:lnTo>
                  <a:pt x="2577" y="969"/>
                </a:lnTo>
                <a:lnTo>
                  <a:pt x="2571" y="947"/>
                </a:lnTo>
                <a:lnTo>
                  <a:pt x="2563" y="926"/>
                </a:lnTo>
                <a:lnTo>
                  <a:pt x="2553" y="904"/>
                </a:lnTo>
                <a:lnTo>
                  <a:pt x="2540" y="885"/>
                </a:lnTo>
                <a:lnTo>
                  <a:pt x="2527" y="867"/>
                </a:lnTo>
                <a:lnTo>
                  <a:pt x="2514" y="852"/>
                </a:lnTo>
                <a:lnTo>
                  <a:pt x="2498" y="838"/>
                </a:lnTo>
                <a:lnTo>
                  <a:pt x="2481" y="825"/>
                </a:lnTo>
                <a:lnTo>
                  <a:pt x="2463" y="815"/>
                </a:lnTo>
                <a:lnTo>
                  <a:pt x="2446" y="805"/>
                </a:lnTo>
                <a:lnTo>
                  <a:pt x="2426" y="800"/>
                </a:lnTo>
                <a:lnTo>
                  <a:pt x="2407" y="795"/>
                </a:lnTo>
                <a:lnTo>
                  <a:pt x="2385" y="794"/>
                </a:lnTo>
                <a:lnTo>
                  <a:pt x="2385" y="794"/>
                </a:lnTo>
                <a:lnTo>
                  <a:pt x="2368" y="795"/>
                </a:lnTo>
                <a:lnTo>
                  <a:pt x="2351" y="799"/>
                </a:lnTo>
                <a:lnTo>
                  <a:pt x="2337" y="802"/>
                </a:lnTo>
                <a:lnTo>
                  <a:pt x="2322" y="808"/>
                </a:lnTo>
                <a:lnTo>
                  <a:pt x="2309" y="815"/>
                </a:lnTo>
                <a:lnTo>
                  <a:pt x="2298" y="821"/>
                </a:lnTo>
                <a:lnTo>
                  <a:pt x="2288" y="830"/>
                </a:lnTo>
                <a:lnTo>
                  <a:pt x="2278" y="838"/>
                </a:lnTo>
                <a:lnTo>
                  <a:pt x="2263" y="854"/>
                </a:lnTo>
                <a:lnTo>
                  <a:pt x="2254" y="869"/>
                </a:lnTo>
                <a:lnTo>
                  <a:pt x="2245" y="882"/>
                </a:lnTo>
                <a:lnTo>
                  <a:pt x="2245" y="882"/>
                </a:lnTo>
                <a:lnTo>
                  <a:pt x="2239" y="893"/>
                </a:lnTo>
                <a:lnTo>
                  <a:pt x="2232" y="903"/>
                </a:lnTo>
                <a:lnTo>
                  <a:pt x="2226" y="911"/>
                </a:lnTo>
                <a:lnTo>
                  <a:pt x="2218" y="917"/>
                </a:lnTo>
                <a:lnTo>
                  <a:pt x="2211" y="922"/>
                </a:lnTo>
                <a:lnTo>
                  <a:pt x="2203" y="926"/>
                </a:lnTo>
                <a:lnTo>
                  <a:pt x="2197" y="927"/>
                </a:lnTo>
                <a:lnTo>
                  <a:pt x="2189" y="927"/>
                </a:lnTo>
                <a:lnTo>
                  <a:pt x="2182" y="926"/>
                </a:lnTo>
                <a:lnTo>
                  <a:pt x="2177" y="922"/>
                </a:lnTo>
                <a:lnTo>
                  <a:pt x="2171" y="917"/>
                </a:lnTo>
                <a:lnTo>
                  <a:pt x="2166" y="911"/>
                </a:lnTo>
                <a:lnTo>
                  <a:pt x="2163" y="903"/>
                </a:lnTo>
                <a:lnTo>
                  <a:pt x="2159" y="893"/>
                </a:lnTo>
                <a:lnTo>
                  <a:pt x="2158" y="882"/>
                </a:lnTo>
                <a:lnTo>
                  <a:pt x="2156" y="869"/>
                </a:lnTo>
                <a:lnTo>
                  <a:pt x="2156" y="595"/>
                </a:lnTo>
                <a:lnTo>
                  <a:pt x="2154" y="595"/>
                </a:lnTo>
                <a:lnTo>
                  <a:pt x="2154" y="0"/>
                </a:lnTo>
                <a:lnTo>
                  <a:pt x="1282" y="0"/>
                </a:lnTo>
                <a:lnTo>
                  <a:pt x="1282" y="0"/>
                </a:lnTo>
                <a:lnTo>
                  <a:pt x="1269" y="1"/>
                </a:lnTo>
                <a:lnTo>
                  <a:pt x="1258" y="3"/>
                </a:lnTo>
                <a:lnTo>
                  <a:pt x="1248" y="6"/>
                </a:lnTo>
                <a:lnTo>
                  <a:pt x="1242" y="9"/>
                </a:lnTo>
                <a:lnTo>
                  <a:pt x="1235" y="14"/>
                </a:lnTo>
                <a:lnTo>
                  <a:pt x="1230" y="21"/>
                </a:lnTo>
                <a:lnTo>
                  <a:pt x="1227" y="27"/>
                </a:lnTo>
                <a:lnTo>
                  <a:pt x="1225" y="34"/>
                </a:lnTo>
                <a:lnTo>
                  <a:pt x="1225" y="40"/>
                </a:lnTo>
                <a:lnTo>
                  <a:pt x="1225" y="47"/>
                </a:lnTo>
                <a:lnTo>
                  <a:pt x="1229" y="55"/>
                </a:lnTo>
                <a:lnTo>
                  <a:pt x="1234" y="62"/>
                </a:lnTo>
                <a:lnTo>
                  <a:pt x="1240" y="70"/>
                </a:lnTo>
                <a:lnTo>
                  <a:pt x="1248" y="76"/>
                </a:lnTo>
                <a:lnTo>
                  <a:pt x="1258" y="83"/>
                </a:lnTo>
                <a:lnTo>
                  <a:pt x="1269" y="89"/>
                </a:lnTo>
                <a:lnTo>
                  <a:pt x="1269" y="89"/>
                </a:lnTo>
                <a:lnTo>
                  <a:pt x="1282" y="97"/>
                </a:lnTo>
                <a:lnTo>
                  <a:pt x="1297" y="107"/>
                </a:lnTo>
                <a:lnTo>
                  <a:pt x="1313" y="123"/>
                </a:lnTo>
                <a:lnTo>
                  <a:pt x="1321" y="131"/>
                </a:lnTo>
                <a:lnTo>
                  <a:pt x="1329" y="143"/>
                </a:lnTo>
                <a:lnTo>
                  <a:pt x="1336" y="154"/>
                </a:lnTo>
                <a:lnTo>
                  <a:pt x="1343" y="166"/>
                </a:lnTo>
                <a:lnTo>
                  <a:pt x="1349" y="180"/>
                </a:lnTo>
                <a:lnTo>
                  <a:pt x="1352" y="195"/>
                </a:lnTo>
                <a:lnTo>
                  <a:pt x="1356" y="213"/>
                </a:lnTo>
                <a:lnTo>
                  <a:pt x="1357" y="231"/>
                </a:lnTo>
                <a:lnTo>
                  <a:pt x="1357" y="231"/>
                </a:lnTo>
                <a:lnTo>
                  <a:pt x="1356" y="250"/>
                </a:lnTo>
                <a:lnTo>
                  <a:pt x="1352" y="270"/>
                </a:lnTo>
                <a:lnTo>
                  <a:pt x="1346" y="289"/>
                </a:lnTo>
                <a:lnTo>
                  <a:pt x="1338" y="307"/>
                </a:lnTo>
                <a:lnTo>
                  <a:pt x="1326" y="325"/>
                </a:lnTo>
                <a:lnTo>
                  <a:pt x="1313" y="341"/>
                </a:lnTo>
                <a:lnTo>
                  <a:pt x="1300" y="358"/>
                </a:lnTo>
                <a:lnTo>
                  <a:pt x="1284" y="372"/>
                </a:lnTo>
                <a:lnTo>
                  <a:pt x="1266" y="385"/>
                </a:lnTo>
                <a:lnTo>
                  <a:pt x="1247" y="397"/>
                </a:lnTo>
                <a:lnTo>
                  <a:pt x="1225" y="406"/>
                </a:lnTo>
                <a:lnTo>
                  <a:pt x="1204" y="415"/>
                </a:lnTo>
                <a:lnTo>
                  <a:pt x="1181" y="421"/>
                </a:lnTo>
                <a:lnTo>
                  <a:pt x="1157" y="426"/>
                </a:lnTo>
                <a:lnTo>
                  <a:pt x="1133" y="429"/>
                </a:lnTo>
                <a:lnTo>
                  <a:pt x="1107" y="431"/>
                </a:lnTo>
                <a:lnTo>
                  <a:pt x="1107" y="431"/>
                </a:lnTo>
                <a:lnTo>
                  <a:pt x="1082" y="429"/>
                </a:lnTo>
                <a:lnTo>
                  <a:pt x="1056" y="426"/>
                </a:lnTo>
                <a:lnTo>
                  <a:pt x="1033" y="421"/>
                </a:lnTo>
                <a:lnTo>
                  <a:pt x="1011" y="415"/>
                </a:lnTo>
                <a:lnTo>
                  <a:pt x="988" y="406"/>
                </a:lnTo>
                <a:lnTo>
                  <a:pt x="967" y="397"/>
                </a:lnTo>
                <a:lnTo>
                  <a:pt x="949" y="385"/>
                </a:lnTo>
                <a:lnTo>
                  <a:pt x="931" y="372"/>
                </a:lnTo>
                <a:lnTo>
                  <a:pt x="915" y="358"/>
                </a:lnTo>
                <a:lnTo>
                  <a:pt x="900" y="341"/>
                </a:lnTo>
                <a:lnTo>
                  <a:pt x="887" y="325"/>
                </a:lnTo>
                <a:lnTo>
                  <a:pt x="877" y="307"/>
                </a:lnTo>
                <a:lnTo>
                  <a:pt x="869" y="289"/>
                </a:lnTo>
                <a:lnTo>
                  <a:pt x="863" y="270"/>
                </a:lnTo>
                <a:lnTo>
                  <a:pt x="859" y="250"/>
                </a:lnTo>
                <a:lnTo>
                  <a:pt x="858" y="231"/>
                </a:lnTo>
                <a:lnTo>
                  <a:pt x="858" y="231"/>
                </a:lnTo>
                <a:close/>
              </a:path>
            </a:pathLst>
          </a:custGeom>
          <a:solidFill>
            <a:srgbClr val="FFFF00"/>
          </a:solidFill>
          <a:ln w="28575">
            <a:solidFill>
              <a:schemeClr val="tx1">
                <a:lumMod val="50000"/>
                <a:lumOff val="50000"/>
              </a:schemeClr>
            </a:solidFill>
            <a:prstDash val="solid"/>
            <a:round/>
            <a:headEnd/>
            <a:tailEnd/>
          </a:ln>
        </p:spPr>
        <p:txBody>
          <a:bodyPr rIns="468000" anchor="ctr" anchorCtr="1"/>
          <a:lstStyle/>
          <a:p>
            <a:pPr defTabSz="457200">
              <a:defRPr/>
            </a:pPr>
            <a:r>
              <a:rPr lang="en-US" sz="4000" dirty="0">
                <a:solidFill>
                  <a:prstClr val="black"/>
                </a:solidFill>
              </a:rPr>
              <a:t>C</a:t>
            </a:r>
            <a:endParaRPr lang="en-GB" sz="4000" dirty="0">
              <a:solidFill>
                <a:prstClr val="black"/>
              </a:solidFill>
              <a:cs typeface="Arial" charset="0"/>
            </a:endParaRPr>
          </a:p>
        </p:txBody>
      </p:sp>
      <p:sp>
        <p:nvSpPr>
          <p:cNvPr id="14" name="Freeform 13">
            <a:extLst>
              <a:ext uri="{FF2B5EF4-FFF2-40B4-BE49-F238E27FC236}">
                <a16:creationId xmlns:a16="http://schemas.microsoft.com/office/drawing/2014/main" xmlns="" id="{FD528892-C48F-3142-B2B2-5E064467D3C1}"/>
              </a:ext>
            </a:extLst>
          </p:cNvPr>
          <p:cNvSpPr>
            <a:spLocks/>
          </p:cNvSpPr>
          <p:nvPr/>
        </p:nvSpPr>
        <p:spPr bwMode="auto">
          <a:xfrm>
            <a:off x="2200401" y="2322515"/>
            <a:ext cx="1265421" cy="1164853"/>
          </a:xfrm>
          <a:custGeom>
            <a:avLst/>
            <a:gdLst>
              <a:gd name="T0" fmla="*/ 1726 w 2587"/>
              <a:gd name="T1" fmla="*/ 1956 h 2150"/>
              <a:gd name="T2" fmla="*/ 1702 w 2587"/>
              <a:gd name="T3" fmla="*/ 2008 h 2150"/>
              <a:gd name="T4" fmla="*/ 1656 w 2587"/>
              <a:gd name="T5" fmla="*/ 2054 h 2150"/>
              <a:gd name="T6" fmla="*/ 1620 w 2587"/>
              <a:gd name="T7" fmla="*/ 2075 h 2150"/>
              <a:gd name="T8" fmla="*/ 1599 w 2587"/>
              <a:gd name="T9" fmla="*/ 2104 h 2150"/>
              <a:gd name="T10" fmla="*/ 1602 w 2587"/>
              <a:gd name="T11" fmla="*/ 2130 h 2150"/>
              <a:gd name="T12" fmla="*/ 1632 w 2587"/>
              <a:gd name="T13" fmla="*/ 2148 h 2150"/>
              <a:gd name="T14" fmla="*/ 2587 w 2587"/>
              <a:gd name="T15" fmla="*/ 0 h 2150"/>
              <a:gd name="T16" fmla="*/ 429 w 2587"/>
              <a:gd name="T17" fmla="*/ 931 h 2150"/>
              <a:gd name="T18" fmla="*/ 424 w 2587"/>
              <a:gd name="T19" fmla="*/ 965 h 2150"/>
              <a:gd name="T20" fmla="*/ 403 w 2587"/>
              <a:gd name="T21" fmla="*/ 988 h 2150"/>
              <a:gd name="T22" fmla="*/ 376 w 2587"/>
              <a:gd name="T23" fmla="*/ 985 h 2150"/>
              <a:gd name="T24" fmla="*/ 348 w 2587"/>
              <a:gd name="T25" fmla="*/ 955 h 2150"/>
              <a:gd name="T26" fmla="*/ 324 w 2587"/>
              <a:gd name="T27" fmla="*/ 916 h 2150"/>
              <a:gd name="T28" fmla="*/ 276 w 2587"/>
              <a:gd name="T29" fmla="*/ 877 h 2150"/>
              <a:gd name="T30" fmla="*/ 218 w 2587"/>
              <a:gd name="T31" fmla="*/ 858 h 2150"/>
              <a:gd name="T32" fmla="*/ 161 w 2587"/>
              <a:gd name="T33" fmla="*/ 863 h 2150"/>
              <a:gd name="T34" fmla="*/ 89 w 2587"/>
              <a:gd name="T35" fmla="*/ 900 h 2150"/>
              <a:gd name="T36" fmla="*/ 34 w 2587"/>
              <a:gd name="T37" fmla="*/ 967 h 2150"/>
              <a:gd name="T38" fmla="*/ 5 w 2587"/>
              <a:gd name="T39" fmla="*/ 1056 h 2150"/>
              <a:gd name="T40" fmla="*/ 1 w 2587"/>
              <a:gd name="T41" fmla="*/ 1133 h 2150"/>
              <a:gd name="T42" fmla="*/ 24 w 2587"/>
              <a:gd name="T43" fmla="*/ 1225 h 2150"/>
              <a:gd name="T44" fmla="*/ 73 w 2587"/>
              <a:gd name="T45" fmla="*/ 1299 h 2150"/>
              <a:gd name="T46" fmla="*/ 141 w 2587"/>
              <a:gd name="T47" fmla="*/ 1346 h 2150"/>
              <a:gd name="T48" fmla="*/ 200 w 2587"/>
              <a:gd name="T49" fmla="*/ 1356 h 2150"/>
              <a:gd name="T50" fmla="*/ 263 w 2587"/>
              <a:gd name="T51" fmla="*/ 1343 h 2150"/>
              <a:gd name="T52" fmla="*/ 307 w 2587"/>
              <a:gd name="T53" fmla="*/ 1313 h 2150"/>
              <a:gd name="T54" fmla="*/ 342 w 2587"/>
              <a:gd name="T55" fmla="*/ 1269 h 2150"/>
              <a:gd name="T56" fmla="*/ 369 w 2587"/>
              <a:gd name="T57" fmla="*/ 1234 h 2150"/>
              <a:gd name="T58" fmla="*/ 397 w 2587"/>
              <a:gd name="T59" fmla="*/ 1224 h 2150"/>
              <a:gd name="T60" fmla="*/ 421 w 2587"/>
              <a:gd name="T61" fmla="*/ 1240 h 2150"/>
              <a:gd name="T62" fmla="*/ 429 w 2587"/>
              <a:gd name="T63" fmla="*/ 1282 h 2150"/>
              <a:gd name="T64" fmla="*/ 1305 w 2587"/>
              <a:gd name="T65" fmla="*/ 2150 h 2150"/>
              <a:gd name="T66" fmla="*/ 1337 w 2587"/>
              <a:gd name="T67" fmla="*/ 2145 h 2150"/>
              <a:gd name="T68" fmla="*/ 1360 w 2587"/>
              <a:gd name="T69" fmla="*/ 2124 h 2150"/>
              <a:gd name="T70" fmla="*/ 1357 w 2587"/>
              <a:gd name="T71" fmla="*/ 2096 h 2150"/>
              <a:gd name="T72" fmla="*/ 1329 w 2587"/>
              <a:gd name="T73" fmla="*/ 2068 h 2150"/>
              <a:gd name="T74" fmla="*/ 1290 w 2587"/>
              <a:gd name="T75" fmla="*/ 2044 h 2150"/>
              <a:gd name="T76" fmla="*/ 1251 w 2587"/>
              <a:gd name="T77" fmla="*/ 1997 h 2150"/>
              <a:gd name="T78" fmla="*/ 1231 w 2587"/>
              <a:gd name="T79" fmla="*/ 1938 h 2150"/>
              <a:gd name="T80" fmla="*/ 1235 w 2587"/>
              <a:gd name="T81" fmla="*/ 1881 h 2150"/>
              <a:gd name="T82" fmla="*/ 1272 w 2587"/>
              <a:gd name="T83" fmla="*/ 1810 h 2150"/>
              <a:gd name="T84" fmla="*/ 1340 w 2587"/>
              <a:gd name="T85" fmla="*/ 1754 h 2150"/>
              <a:gd name="T86" fmla="*/ 1430 w 2587"/>
              <a:gd name="T87" fmla="*/ 1725 h 2150"/>
              <a:gd name="T88" fmla="*/ 1505 w 2587"/>
              <a:gd name="T89" fmla="*/ 1722 h 2150"/>
              <a:gd name="T90" fmla="*/ 1599 w 2587"/>
              <a:gd name="T91" fmla="*/ 1745 h 2150"/>
              <a:gd name="T92" fmla="*/ 1672 w 2587"/>
              <a:gd name="T93" fmla="*/ 1793 h 2150"/>
              <a:gd name="T94" fmla="*/ 1718 w 2587"/>
              <a:gd name="T95" fmla="*/ 1862 h 2150"/>
              <a:gd name="T96" fmla="*/ 1729 w 2587"/>
              <a:gd name="T97" fmla="*/ 1920 h 21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587" h="2150">
                <a:moveTo>
                  <a:pt x="1729" y="1920"/>
                </a:moveTo>
                <a:lnTo>
                  <a:pt x="1729" y="1920"/>
                </a:lnTo>
                <a:lnTo>
                  <a:pt x="1728" y="1938"/>
                </a:lnTo>
                <a:lnTo>
                  <a:pt x="1726" y="1956"/>
                </a:lnTo>
                <a:lnTo>
                  <a:pt x="1721" y="1971"/>
                </a:lnTo>
                <a:lnTo>
                  <a:pt x="1716" y="1984"/>
                </a:lnTo>
                <a:lnTo>
                  <a:pt x="1710" y="1997"/>
                </a:lnTo>
                <a:lnTo>
                  <a:pt x="1702" y="2008"/>
                </a:lnTo>
                <a:lnTo>
                  <a:pt x="1694" y="2020"/>
                </a:lnTo>
                <a:lnTo>
                  <a:pt x="1685" y="2028"/>
                </a:lnTo>
                <a:lnTo>
                  <a:pt x="1669" y="2044"/>
                </a:lnTo>
                <a:lnTo>
                  <a:pt x="1656" y="2054"/>
                </a:lnTo>
                <a:lnTo>
                  <a:pt x="1641" y="2062"/>
                </a:lnTo>
                <a:lnTo>
                  <a:pt x="1641" y="2062"/>
                </a:lnTo>
                <a:lnTo>
                  <a:pt x="1630" y="2068"/>
                </a:lnTo>
                <a:lnTo>
                  <a:pt x="1620" y="2075"/>
                </a:lnTo>
                <a:lnTo>
                  <a:pt x="1614" y="2081"/>
                </a:lnTo>
                <a:lnTo>
                  <a:pt x="1607" y="2089"/>
                </a:lnTo>
                <a:lnTo>
                  <a:pt x="1602" y="2096"/>
                </a:lnTo>
                <a:lnTo>
                  <a:pt x="1599" y="2104"/>
                </a:lnTo>
                <a:lnTo>
                  <a:pt x="1598" y="2111"/>
                </a:lnTo>
                <a:lnTo>
                  <a:pt x="1598" y="2117"/>
                </a:lnTo>
                <a:lnTo>
                  <a:pt x="1599" y="2124"/>
                </a:lnTo>
                <a:lnTo>
                  <a:pt x="1602" y="2130"/>
                </a:lnTo>
                <a:lnTo>
                  <a:pt x="1607" y="2137"/>
                </a:lnTo>
                <a:lnTo>
                  <a:pt x="1614" y="2142"/>
                </a:lnTo>
                <a:lnTo>
                  <a:pt x="1622" y="2145"/>
                </a:lnTo>
                <a:lnTo>
                  <a:pt x="1632" y="2148"/>
                </a:lnTo>
                <a:lnTo>
                  <a:pt x="1641" y="2150"/>
                </a:lnTo>
                <a:lnTo>
                  <a:pt x="1654" y="2150"/>
                </a:lnTo>
                <a:lnTo>
                  <a:pt x="2587" y="2150"/>
                </a:lnTo>
                <a:lnTo>
                  <a:pt x="2587" y="0"/>
                </a:lnTo>
                <a:lnTo>
                  <a:pt x="433" y="0"/>
                </a:lnTo>
                <a:lnTo>
                  <a:pt x="433" y="495"/>
                </a:lnTo>
                <a:lnTo>
                  <a:pt x="429" y="495"/>
                </a:lnTo>
                <a:lnTo>
                  <a:pt x="429" y="931"/>
                </a:lnTo>
                <a:lnTo>
                  <a:pt x="429" y="931"/>
                </a:lnTo>
                <a:lnTo>
                  <a:pt x="429" y="944"/>
                </a:lnTo>
                <a:lnTo>
                  <a:pt x="428" y="955"/>
                </a:lnTo>
                <a:lnTo>
                  <a:pt x="424" y="965"/>
                </a:lnTo>
                <a:lnTo>
                  <a:pt x="421" y="973"/>
                </a:lnTo>
                <a:lnTo>
                  <a:pt x="416" y="980"/>
                </a:lnTo>
                <a:lnTo>
                  <a:pt x="410" y="985"/>
                </a:lnTo>
                <a:lnTo>
                  <a:pt x="403" y="988"/>
                </a:lnTo>
                <a:lnTo>
                  <a:pt x="397" y="990"/>
                </a:lnTo>
                <a:lnTo>
                  <a:pt x="390" y="990"/>
                </a:lnTo>
                <a:lnTo>
                  <a:pt x="384" y="988"/>
                </a:lnTo>
                <a:lnTo>
                  <a:pt x="376" y="985"/>
                </a:lnTo>
                <a:lnTo>
                  <a:pt x="369" y="980"/>
                </a:lnTo>
                <a:lnTo>
                  <a:pt x="361" y="973"/>
                </a:lnTo>
                <a:lnTo>
                  <a:pt x="355" y="965"/>
                </a:lnTo>
                <a:lnTo>
                  <a:pt x="348" y="955"/>
                </a:lnTo>
                <a:lnTo>
                  <a:pt x="342" y="944"/>
                </a:lnTo>
                <a:lnTo>
                  <a:pt x="342" y="944"/>
                </a:lnTo>
                <a:lnTo>
                  <a:pt x="333" y="931"/>
                </a:lnTo>
                <a:lnTo>
                  <a:pt x="324" y="916"/>
                </a:lnTo>
                <a:lnTo>
                  <a:pt x="307" y="900"/>
                </a:lnTo>
                <a:lnTo>
                  <a:pt x="299" y="892"/>
                </a:lnTo>
                <a:lnTo>
                  <a:pt x="288" y="885"/>
                </a:lnTo>
                <a:lnTo>
                  <a:pt x="276" y="877"/>
                </a:lnTo>
                <a:lnTo>
                  <a:pt x="263" y="871"/>
                </a:lnTo>
                <a:lnTo>
                  <a:pt x="250" y="866"/>
                </a:lnTo>
                <a:lnTo>
                  <a:pt x="236" y="861"/>
                </a:lnTo>
                <a:lnTo>
                  <a:pt x="218" y="858"/>
                </a:lnTo>
                <a:lnTo>
                  <a:pt x="200" y="858"/>
                </a:lnTo>
                <a:lnTo>
                  <a:pt x="200" y="858"/>
                </a:lnTo>
                <a:lnTo>
                  <a:pt x="180" y="858"/>
                </a:lnTo>
                <a:lnTo>
                  <a:pt x="161" y="863"/>
                </a:lnTo>
                <a:lnTo>
                  <a:pt x="141" y="868"/>
                </a:lnTo>
                <a:lnTo>
                  <a:pt x="122" y="877"/>
                </a:lnTo>
                <a:lnTo>
                  <a:pt x="106" y="887"/>
                </a:lnTo>
                <a:lnTo>
                  <a:pt x="89" y="900"/>
                </a:lnTo>
                <a:lnTo>
                  <a:pt x="73" y="915"/>
                </a:lnTo>
                <a:lnTo>
                  <a:pt x="58" y="931"/>
                </a:lnTo>
                <a:lnTo>
                  <a:pt x="45" y="947"/>
                </a:lnTo>
                <a:lnTo>
                  <a:pt x="34" y="967"/>
                </a:lnTo>
                <a:lnTo>
                  <a:pt x="24" y="988"/>
                </a:lnTo>
                <a:lnTo>
                  <a:pt x="16" y="1009"/>
                </a:lnTo>
                <a:lnTo>
                  <a:pt x="10" y="1032"/>
                </a:lnTo>
                <a:lnTo>
                  <a:pt x="5" y="1056"/>
                </a:lnTo>
                <a:lnTo>
                  <a:pt x="1" y="1081"/>
                </a:lnTo>
                <a:lnTo>
                  <a:pt x="0" y="1107"/>
                </a:lnTo>
                <a:lnTo>
                  <a:pt x="0" y="1107"/>
                </a:lnTo>
                <a:lnTo>
                  <a:pt x="1" y="1133"/>
                </a:lnTo>
                <a:lnTo>
                  <a:pt x="5" y="1157"/>
                </a:lnTo>
                <a:lnTo>
                  <a:pt x="10" y="1182"/>
                </a:lnTo>
                <a:lnTo>
                  <a:pt x="16" y="1204"/>
                </a:lnTo>
                <a:lnTo>
                  <a:pt x="24" y="1225"/>
                </a:lnTo>
                <a:lnTo>
                  <a:pt x="34" y="1247"/>
                </a:lnTo>
                <a:lnTo>
                  <a:pt x="45" y="1266"/>
                </a:lnTo>
                <a:lnTo>
                  <a:pt x="58" y="1284"/>
                </a:lnTo>
                <a:lnTo>
                  <a:pt x="73" y="1299"/>
                </a:lnTo>
                <a:lnTo>
                  <a:pt x="89" y="1313"/>
                </a:lnTo>
                <a:lnTo>
                  <a:pt x="106" y="1326"/>
                </a:lnTo>
                <a:lnTo>
                  <a:pt x="122" y="1336"/>
                </a:lnTo>
                <a:lnTo>
                  <a:pt x="141" y="1346"/>
                </a:lnTo>
                <a:lnTo>
                  <a:pt x="161" y="1351"/>
                </a:lnTo>
                <a:lnTo>
                  <a:pt x="180" y="1356"/>
                </a:lnTo>
                <a:lnTo>
                  <a:pt x="200" y="1356"/>
                </a:lnTo>
                <a:lnTo>
                  <a:pt x="200" y="1356"/>
                </a:lnTo>
                <a:lnTo>
                  <a:pt x="218" y="1356"/>
                </a:lnTo>
                <a:lnTo>
                  <a:pt x="236" y="1352"/>
                </a:lnTo>
                <a:lnTo>
                  <a:pt x="250" y="1349"/>
                </a:lnTo>
                <a:lnTo>
                  <a:pt x="263" y="1343"/>
                </a:lnTo>
                <a:lnTo>
                  <a:pt x="276" y="1336"/>
                </a:lnTo>
                <a:lnTo>
                  <a:pt x="288" y="1328"/>
                </a:lnTo>
                <a:lnTo>
                  <a:pt x="299" y="1321"/>
                </a:lnTo>
                <a:lnTo>
                  <a:pt x="307" y="1313"/>
                </a:lnTo>
                <a:lnTo>
                  <a:pt x="324" y="1297"/>
                </a:lnTo>
                <a:lnTo>
                  <a:pt x="333" y="1282"/>
                </a:lnTo>
                <a:lnTo>
                  <a:pt x="342" y="1269"/>
                </a:lnTo>
                <a:lnTo>
                  <a:pt x="342" y="1269"/>
                </a:lnTo>
                <a:lnTo>
                  <a:pt x="348" y="1258"/>
                </a:lnTo>
                <a:lnTo>
                  <a:pt x="355" y="1248"/>
                </a:lnTo>
                <a:lnTo>
                  <a:pt x="361" y="1240"/>
                </a:lnTo>
                <a:lnTo>
                  <a:pt x="369" y="1234"/>
                </a:lnTo>
                <a:lnTo>
                  <a:pt x="376" y="1229"/>
                </a:lnTo>
                <a:lnTo>
                  <a:pt x="384" y="1225"/>
                </a:lnTo>
                <a:lnTo>
                  <a:pt x="390" y="1224"/>
                </a:lnTo>
                <a:lnTo>
                  <a:pt x="397" y="1224"/>
                </a:lnTo>
                <a:lnTo>
                  <a:pt x="403" y="1225"/>
                </a:lnTo>
                <a:lnTo>
                  <a:pt x="410" y="1229"/>
                </a:lnTo>
                <a:lnTo>
                  <a:pt x="416" y="1234"/>
                </a:lnTo>
                <a:lnTo>
                  <a:pt x="421" y="1240"/>
                </a:lnTo>
                <a:lnTo>
                  <a:pt x="424" y="1248"/>
                </a:lnTo>
                <a:lnTo>
                  <a:pt x="428" y="1258"/>
                </a:lnTo>
                <a:lnTo>
                  <a:pt x="429" y="1269"/>
                </a:lnTo>
                <a:lnTo>
                  <a:pt x="429" y="1282"/>
                </a:lnTo>
                <a:lnTo>
                  <a:pt x="429" y="1556"/>
                </a:lnTo>
                <a:lnTo>
                  <a:pt x="433" y="1556"/>
                </a:lnTo>
                <a:lnTo>
                  <a:pt x="433" y="2150"/>
                </a:lnTo>
                <a:lnTo>
                  <a:pt x="1305" y="2150"/>
                </a:lnTo>
                <a:lnTo>
                  <a:pt x="1305" y="2150"/>
                </a:lnTo>
                <a:lnTo>
                  <a:pt x="1318" y="2150"/>
                </a:lnTo>
                <a:lnTo>
                  <a:pt x="1327" y="2148"/>
                </a:lnTo>
                <a:lnTo>
                  <a:pt x="1337" y="2145"/>
                </a:lnTo>
                <a:lnTo>
                  <a:pt x="1345" y="2142"/>
                </a:lnTo>
                <a:lnTo>
                  <a:pt x="1352" y="2137"/>
                </a:lnTo>
                <a:lnTo>
                  <a:pt x="1357" y="2130"/>
                </a:lnTo>
                <a:lnTo>
                  <a:pt x="1360" y="2124"/>
                </a:lnTo>
                <a:lnTo>
                  <a:pt x="1362" y="2117"/>
                </a:lnTo>
                <a:lnTo>
                  <a:pt x="1362" y="2111"/>
                </a:lnTo>
                <a:lnTo>
                  <a:pt x="1360" y="2104"/>
                </a:lnTo>
                <a:lnTo>
                  <a:pt x="1357" y="2096"/>
                </a:lnTo>
                <a:lnTo>
                  <a:pt x="1352" y="2089"/>
                </a:lnTo>
                <a:lnTo>
                  <a:pt x="1347" y="2081"/>
                </a:lnTo>
                <a:lnTo>
                  <a:pt x="1339" y="2075"/>
                </a:lnTo>
                <a:lnTo>
                  <a:pt x="1329" y="2068"/>
                </a:lnTo>
                <a:lnTo>
                  <a:pt x="1318" y="2062"/>
                </a:lnTo>
                <a:lnTo>
                  <a:pt x="1318" y="2062"/>
                </a:lnTo>
                <a:lnTo>
                  <a:pt x="1303" y="2054"/>
                </a:lnTo>
                <a:lnTo>
                  <a:pt x="1290" y="2044"/>
                </a:lnTo>
                <a:lnTo>
                  <a:pt x="1274" y="2028"/>
                </a:lnTo>
                <a:lnTo>
                  <a:pt x="1266" y="2020"/>
                </a:lnTo>
                <a:lnTo>
                  <a:pt x="1258" y="2008"/>
                </a:lnTo>
                <a:lnTo>
                  <a:pt x="1251" y="1997"/>
                </a:lnTo>
                <a:lnTo>
                  <a:pt x="1243" y="1984"/>
                </a:lnTo>
                <a:lnTo>
                  <a:pt x="1238" y="1971"/>
                </a:lnTo>
                <a:lnTo>
                  <a:pt x="1233" y="1956"/>
                </a:lnTo>
                <a:lnTo>
                  <a:pt x="1231" y="1938"/>
                </a:lnTo>
                <a:lnTo>
                  <a:pt x="1230" y="1920"/>
                </a:lnTo>
                <a:lnTo>
                  <a:pt x="1230" y="1920"/>
                </a:lnTo>
                <a:lnTo>
                  <a:pt x="1231" y="1901"/>
                </a:lnTo>
                <a:lnTo>
                  <a:pt x="1235" y="1881"/>
                </a:lnTo>
                <a:lnTo>
                  <a:pt x="1241" y="1862"/>
                </a:lnTo>
                <a:lnTo>
                  <a:pt x="1249" y="1842"/>
                </a:lnTo>
                <a:lnTo>
                  <a:pt x="1261" y="1826"/>
                </a:lnTo>
                <a:lnTo>
                  <a:pt x="1272" y="1810"/>
                </a:lnTo>
                <a:lnTo>
                  <a:pt x="1287" y="1793"/>
                </a:lnTo>
                <a:lnTo>
                  <a:pt x="1303" y="1779"/>
                </a:lnTo>
                <a:lnTo>
                  <a:pt x="1321" y="1766"/>
                </a:lnTo>
                <a:lnTo>
                  <a:pt x="1340" y="1754"/>
                </a:lnTo>
                <a:lnTo>
                  <a:pt x="1360" y="1745"/>
                </a:lnTo>
                <a:lnTo>
                  <a:pt x="1383" y="1736"/>
                </a:lnTo>
                <a:lnTo>
                  <a:pt x="1406" y="1730"/>
                </a:lnTo>
                <a:lnTo>
                  <a:pt x="1430" y="1725"/>
                </a:lnTo>
                <a:lnTo>
                  <a:pt x="1454" y="1722"/>
                </a:lnTo>
                <a:lnTo>
                  <a:pt x="1480" y="1720"/>
                </a:lnTo>
                <a:lnTo>
                  <a:pt x="1480" y="1720"/>
                </a:lnTo>
                <a:lnTo>
                  <a:pt x="1505" y="1722"/>
                </a:lnTo>
                <a:lnTo>
                  <a:pt x="1529" y="1725"/>
                </a:lnTo>
                <a:lnTo>
                  <a:pt x="1554" y="1730"/>
                </a:lnTo>
                <a:lnTo>
                  <a:pt x="1576" y="1736"/>
                </a:lnTo>
                <a:lnTo>
                  <a:pt x="1599" y="1745"/>
                </a:lnTo>
                <a:lnTo>
                  <a:pt x="1619" y="1754"/>
                </a:lnTo>
                <a:lnTo>
                  <a:pt x="1638" y="1766"/>
                </a:lnTo>
                <a:lnTo>
                  <a:pt x="1656" y="1779"/>
                </a:lnTo>
                <a:lnTo>
                  <a:pt x="1672" y="1793"/>
                </a:lnTo>
                <a:lnTo>
                  <a:pt x="1687" y="1810"/>
                </a:lnTo>
                <a:lnTo>
                  <a:pt x="1698" y="1826"/>
                </a:lnTo>
                <a:lnTo>
                  <a:pt x="1710" y="1842"/>
                </a:lnTo>
                <a:lnTo>
                  <a:pt x="1718" y="1862"/>
                </a:lnTo>
                <a:lnTo>
                  <a:pt x="1724" y="1881"/>
                </a:lnTo>
                <a:lnTo>
                  <a:pt x="1728" y="1901"/>
                </a:lnTo>
                <a:lnTo>
                  <a:pt x="1729" y="1920"/>
                </a:lnTo>
                <a:lnTo>
                  <a:pt x="1729" y="1920"/>
                </a:lnTo>
                <a:close/>
              </a:path>
            </a:pathLst>
          </a:custGeom>
          <a:solidFill>
            <a:srgbClr val="92D050"/>
          </a:solidFill>
          <a:ln w="28575">
            <a:solidFill>
              <a:schemeClr val="tx1">
                <a:lumMod val="50000"/>
                <a:lumOff val="50000"/>
              </a:schemeClr>
            </a:solidFill>
            <a:prstDash val="solid"/>
            <a:round/>
            <a:headEnd/>
            <a:tailEnd/>
          </a:ln>
        </p:spPr>
        <p:txBody>
          <a:bodyPr lIns="468000" anchor="ctr"/>
          <a:lstStyle/>
          <a:p>
            <a:pPr algn="ctr" defTabSz="457200">
              <a:defRPr/>
            </a:pPr>
            <a:r>
              <a:rPr lang="en-US" sz="4000" dirty="0">
                <a:solidFill>
                  <a:prstClr val="black"/>
                </a:solidFill>
              </a:rPr>
              <a:t>B</a:t>
            </a:r>
            <a:endParaRPr lang="en-GB" sz="4000" dirty="0">
              <a:solidFill>
                <a:prstClr val="black"/>
              </a:solidFill>
              <a:cs typeface="Arial" charset="0"/>
            </a:endParaRPr>
          </a:p>
        </p:txBody>
      </p:sp>
      <p:sp>
        <p:nvSpPr>
          <p:cNvPr id="15" name="Freeform 14">
            <a:extLst>
              <a:ext uri="{FF2B5EF4-FFF2-40B4-BE49-F238E27FC236}">
                <a16:creationId xmlns:a16="http://schemas.microsoft.com/office/drawing/2014/main" xmlns="" id="{1DF512A4-BBC0-F843-955D-3026BC772BBE}"/>
              </a:ext>
            </a:extLst>
          </p:cNvPr>
          <p:cNvSpPr>
            <a:spLocks/>
          </p:cNvSpPr>
          <p:nvPr/>
        </p:nvSpPr>
        <p:spPr bwMode="auto">
          <a:xfrm>
            <a:off x="2414539" y="3256176"/>
            <a:ext cx="1052621" cy="1400491"/>
          </a:xfrm>
          <a:custGeom>
            <a:avLst/>
            <a:gdLst>
              <a:gd name="T0" fmla="*/ 195 w 2151"/>
              <a:gd name="T1" fmla="*/ 1725 h 2586"/>
              <a:gd name="T2" fmla="*/ 141 w 2151"/>
              <a:gd name="T3" fmla="*/ 1702 h 2586"/>
              <a:gd name="T4" fmla="*/ 96 w 2151"/>
              <a:gd name="T5" fmla="*/ 1655 h 2586"/>
              <a:gd name="T6" fmla="*/ 76 w 2151"/>
              <a:gd name="T7" fmla="*/ 1621 h 2586"/>
              <a:gd name="T8" fmla="*/ 47 w 2151"/>
              <a:gd name="T9" fmla="*/ 1598 h 2586"/>
              <a:gd name="T10" fmla="*/ 19 w 2151"/>
              <a:gd name="T11" fmla="*/ 1603 h 2586"/>
              <a:gd name="T12" fmla="*/ 2 w 2151"/>
              <a:gd name="T13" fmla="*/ 1631 h 2586"/>
              <a:gd name="T14" fmla="*/ 2151 w 2151"/>
              <a:gd name="T15" fmla="*/ 2586 h 2586"/>
              <a:gd name="T16" fmla="*/ 1218 w 2151"/>
              <a:gd name="T17" fmla="*/ 430 h 2586"/>
              <a:gd name="T18" fmla="*/ 1184 w 2151"/>
              <a:gd name="T19" fmla="*/ 425 h 2586"/>
              <a:gd name="T20" fmla="*/ 1163 w 2151"/>
              <a:gd name="T21" fmla="*/ 404 h 2586"/>
              <a:gd name="T22" fmla="*/ 1165 w 2151"/>
              <a:gd name="T23" fmla="*/ 376 h 2586"/>
              <a:gd name="T24" fmla="*/ 1194 w 2151"/>
              <a:gd name="T25" fmla="*/ 347 h 2586"/>
              <a:gd name="T26" fmla="*/ 1233 w 2151"/>
              <a:gd name="T27" fmla="*/ 322 h 2586"/>
              <a:gd name="T28" fmla="*/ 1272 w 2151"/>
              <a:gd name="T29" fmla="*/ 277 h 2586"/>
              <a:gd name="T30" fmla="*/ 1292 w 2151"/>
              <a:gd name="T31" fmla="*/ 218 h 2586"/>
              <a:gd name="T32" fmla="*/ 1288 w 2151"/>
              <a:gd name="T33" fmla="*/ 160 h 2586"/>
              <a:gd name="T34" fmla="*/ 1251 w 2151"/>
              <a:gd name="T35" fmla="*/ 88 h 2586"/>
              <a:gd name="T36" fmla="*/ 1183 w 2151"/>
              <a:gd name="T37" fmla="*/ 34 h 2586"/>
              <a:gd name="T38" fmla="*/ 1093 w 2151"/>
              <a:gd name="T39" fmla="*/ 4 h 2586"/>
              <a:gd name="T40" fmla="*/ 1018 w 2151"/>
              <a:gd name="T41" fmla="*/ 2 h 2586"/>
              <a:gd name="T42" fmla="*/ 924 w 2151"/>
              <a:gd name="T43" fmla="*/ 25 h 2586"/>
              <a:gd name="T44" fmla="*/ 851 w 2151"/>
              <a:gd name="T45" fmla="*/ 73 h 2586"/>
              <a:gd name="T46" fmla="*/ 805 w 2151"/>
              <a:gd name="T47" fmla="*/ 142 h 2586"/>
              <a:gd name="T48" fmla="*/ 794 w 2151"/>
              <a:gd name="T49" fmla="*/ 200 h 2586"/>
              <a:gd name="T50" fmla="*/ 807 w 2151"/>
              <a:gd name="T51" fmla="*/ 264 h 2586"/>
              <a:gd name="T52" fmla="*/ 838 w 2151"/>
              <a:gd name="T53" fmla="*/ 308 h 2586"/>
              <a:gd name="T54" fmla="*/ 882 w 2151"/>
              <a:gd name="T55" fmla="*/ 342 h 2586"/>
              <a:gd name="T56" fmla="*/ 916 w 2151"/>
              <a:gd name="T57" fmla="*/ 368 h 2586"/>
              <a:gd name="T58" fmla="*/ 926 w 2151"/>
              <a:gd name="T59" fmla="*/ 397 h 2586"/>
              <a:gd name="T60" fmla="*/ 909 w 2151"/>
              <a:gd name="T61" fmla="*/ 420 h 2586"/>
              <a:gd name="T62" fmla="*/ 869 w 2151"/>
              <a:gd name="T63" fmla="*/ 430 h 2586"/>
              <a:gd name="T64" fmla="*/ 0 w 2151"/>
              <a:gd name="T65" fmla="*/ 1305 h 2586"/>
              <a:gd name="T66" fmla="*/ 5 w 2151"/>
              <a:gd name="T67" fmla="*/ 1338 h 2586"/>
              <a:gd name="T68" fmla="*/ 26 w 2151"/>
              <a:gd name="T69" fmla="*/ 1361 h 2586"/>
              <a:gd name="T70" fmla="*/ 54 w 2151"/>
              <a:gd name="T71" fmla="*/ 1357 h 2586"/>
              <a:gd name="T72" fmla="*/ 83 w 2151"/>
              <a:gd name="T73" fmla="*/ 1328 h 2586"/>
              <a:gd name="T74" fmla="*/ 107 w 2151"/>
              <a:gd name="T75" fmla="*/ 1291 h 2586"/>
              <a:gd name="T76" fmla="*/ 153 w 2151"/>
              <a:gd name="T77" fmla="*/ 1250 h 2586"/>
              <a:gd name="T78" fmla="*/ 211 w 2151"/>
              <a:gd name="T79" fmla="*/ 1230 h 2586"/>
              <a:gd name="T80" fmla="*/ 270 w 2151"/>
              <a:gd name="T81" fmla="*/ 1235 h 2586"/>
              <a:gd name="T82" fmla="*/ 342 w 2151"/>
              <a:gd name="T83" fmla="*/ 1273 h 2586"/>
              <a:gd name="T84" fmla="*/ 395 w 2151"/>
              <a:gd name="T85" fmla="*/ 1339 h 2586"/>
              <a:gd name="T86" fmla="*/ 426 w 2151"/>
              <a:gd name="T87" fmla="*/ 1429 h 2586"/>
              <a:gd name="T88" fmla="*/ 428 w 2151"/>
              <a:gd name="T89" fmla="*/ 1505 h 2586"/>
              <a:gd name="T90" fmla="*/ 405 w 2151"/>
              <a:gd name="T91" fmla="*/ 1598 h 2586"/>
              <a:gd name="T92" fmla="*/ 356 w 2151"/>
              <a:gd name="T93" fmla="*/ 1673 h 2586"/>
              <a:gd name="T94" fmla="*/ 288 w 2151"/>
              <a:gd name="T95" fmla="*/ 1718 h 2586"/>
              <a:gd name="T96" fmla="*/ 229 w 2151"/>
              <a:gd name="T97" fmla="*/ 1730 h 258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151" h="2586">
                <a:moveTo>
                  <a:pt x="229" y="1730"/>
                </a:moveTo>
                <a:lnTo>
                  <a:pt x="229" y="1730"/>
                </a:lnTo>
                <a:lnTo>
                  <a:pt x="211" y="1728"/>
                </a:lnTo>
                <a:lnTo>
                  <a:pt x="195" y="1725"/>
                </a:lnTo>
                <a:lnTo>
                  <a:pt x="179" y="1722"/>
                </a:lnTo>
                <a:lnTo>
                  <a:pt x="166" y="1715"/>
                </a:lnTo>
                <a:lnTo>
                  <a:pt x="153" y="1709"/>
                </a:lnTo>
                <a:lnTo>
                  <a:pt x="141" y="1702"/>
                </a:lnTo>
                <a:lnTo>
                  <a:pt x="132" y="1694"/>
                </a:lnTo>
                <a:lnTo>
                  <a:pt x="122" y="1686"/>
                </a:lnTo>
                <a:lnTo>
                  <a:pt x="107" y="1670"/>
                </a:lnTo>
                <a:lnTo>
                  <a:pt x="96" y="1655"/>
                </a:lnTo>
                <a:lnTo>
                  <a:pt x="88" y="1642"/>
                </a:lnTo>
                <a:lnTo>
                  <a:pt x="88" y="1642"/>
                </a:lnTo>
                <a:lnTo>
                  <a:pt x="83" y="1631"/>
                </a:lnTo>
                <a:lnTo>
                  <a:pt x="76" y="1621"/>
                </a:lnTo>
                <a:lnTo>
                  <a:pt x="68" y="1613"/>
                </a:lnTo>
                <a:lnTo>
                  <a:pt x="62" y="1606"/>
                </a:lnTo>
                <a:lnTo>
                  <a:pt x="54" y="1601"/>
                </a:lnTo>
                <a:lnTo>
                  <a:pt x="47" y="1598"/>
                </a:lnTo>
                <a:lnTo>
                  <a:pt x="39" y="1598"/>
                </a:lnTo>
                <a:lnTo>
                  <a:pt x="32" y="1598"/>
                </a:lnTo>
                <a:lnTo>
                  <a:pt x="26" y="1600"/>
                </a:lnTo>
                <a:lnTo>
                  <a:pt x="19" y="1603"/>
                </a:lnTo>
                <a:lnTo>
                  <a:pt x="15" y="1608"/>
                </a:lnTo>
                <a:lnTo>
                  <a:pt x="10" y="1614"/>
                </a:lnTo>
                <a:lnTo>
                  <a:pt x="5" y="1621"/>
                </a:lnTo>
                <a:lnTo>
                  <a:pt x="2" y="1631"/>
                </a:lnTo>
                <a:lnTo>
                  <a:pt x="0" y="1642"/>
                </a:lnTo>
                <a:lnTo>
                  <a:pt x="0" y="1655"/>
                </a:lnTo>
                <a:lnTo>
                  <a:pt x="0" y="2586"/>
                </a:lnTo>
                <a:lnTo>
                  <a:pt x="2151" y="2586"/>
                </a:lnTo>
                <a:lnTo>
                  <a:pt x="2151" y="431"/>
                </a:lnTo>
                <a:lnTo>
                  <a:pt x="1656" y="431"/>
                </a:lnTo>
                <a:lnTo>
                  <a:pt x="1656" y="430"/>
                </a:lnTo>
                <a:lnTo>
                  <a:pt x="1218" y="430"/>
                </a:lnTo>
                <a:lnTo>
                  <a:pt x="1218" y="430"/>
                </a:lnTo>
                <a:lnTo>
                  <a:pt x="1205" y="430"/>
                </a:lnTo>
                <a:lnTo>
                  <a:pt x="1194" y="428"/>
                </a:lnTo>
                <a:lnTo>
                  <a:pt x="1184" y="425"/>
                </a:lnTo>
                <a:lnTo>
                  <a:pt x="1178" y="420"/>
                </a:lnTo>
                <a:lnTo>
                  <a:pt x="1171" y="415"/>
                </a:lnTo>
                <a:lnTo>
                  <a:pt x="1166" y="410"/>
                </a:lnTo>
                <a:lnTo>
                  <a:pt x="1163" y="404"/>
                </a:lnTo>
                <a:lnTo>
                  <a:pt x="1162" y="397"/>
                </a:lnTo>
                <a:lnTo>
                  <a:pt x="1162" y="391"/>
                </a:lnTo>
                <a:lnTo>
                  <a:pt x="1162" y="383"/>
                </a:lnTo>
                <a:lnTo>
                  <a:pt x="1165" y="376"/>
                </a:lnTo>
                <a:lnTo>
                  <a:pt x="1170" y="368"/>
                </a:lnTo>
                <a:lnTo>
                  <a:pt x="1176" y="361"/>
                </a:lnTo>
                <a:lnTo>
                  <a:pt x="1184" y="353"/>
                </a:lnTo>
                <a:lnTo>
                  <a:pt x="1194" y="347"/>
                </a:lnTo>
                <a:lnTo>
                  <a:pt x="1205" y="342"/>
                </a:lnTo>
                <a:lnTo>
                  <a:pt x="1205" y="342"/>
                </a:lnTo>
                <a:lnTo>
                  <a:pt x="1218" y="334"/>
                </a:lnTo>
                <a:lnTo>
                  <a:pt x="1233" y="322"/>
                </a:lnTo>
                <a:lnTo>
                  <a:pt x="1249" y="308"/>
                </a:lnTo>
                <a:lnTo>
                  <a:pt x="1258" y="298"/>
                </a:lnTo>
                <a:lnTo>
                  <a:pt x="1266" y="288"/>
                </a:lnTo>
                <a:lnTo>
                  <a:pt x="1272" y="277"/>
                </a:lnTo>
                <a:lnTo>
                  <a:pt x="1279" y="264"/>
                </a:lnTo>
                <a:lnTo>
                  <a:pt x="1285" y="251"/>
                </a:lnTo>
                <a:lnTo>
                  <a:pt x="1288" y="235"/>
                </a:lnTo>
                <a:lnTo>
                  <a:pt x="1292" y="218"/>
                </a:lnTo>
                <a:lnTo>
                  <a:pt x="1293" y="200"/>
                </a:lnTo>
                <a:lnTo>
                  <a:pt x="1293" y="200"/>
                </a:lnTo>
                <a:lnTo>
                  <a:pt x="1292" y="181"/>
                </a:lnTo>
                <a:lnTo>
                  <a:pt x="1288" y="160"/>
                </a:lnTo>
                <a:lnTo>
                  <a:pt x="1282" y="142"/>
                </a:lnTo>
                <a:lnTo>
                  <a:pt x="1274" y="122"/>
                </a:lnTo>
                <a:lnTo>
                  <a:pt x="1262" y="104"/>
                </a:lnTo>
                <a:lnTo>
                  <a:pt x="1251" y="88"/>
                </a:lnTo>
                <a:lnTo>
                  <a:pt x="1236" y="73"/>
                </a:lnTo>
                <a:lnTo>
                  <a:pt x="1220" y="59"/>
                </a:lnTo>
                <a:lnTo>
                  <a:pt x="1202" y="46"/>
                </a:lnTo>
                <a:lnTo>
                  <a:pt x="1183" y="34"/>
                </a:lnTo>
                <a:lnTo>
                  <a:pt x="1162" y="25"/>
                </a:lnTo>
                <a:lnTo>
                  <a:pt x="1140" y="17"/>
                </a:lnTo>
                <a:lnTo>
                  <a:pt x="1118" y="8"/>
                </a:lnTo>
                <a:lnTo>
                  <a:pt x="1093" y="4"/>
                </a:lnTo>
                <a:lnTo>
                  <a:pt x="1069" y="2"/>
                </a:lnTo>
                <a:lnTo>
                  <a:pt x="1043" y="0"/>
                </a:lnTo>
                <a:lnTo>
                  <a:pt x="1043" y="0"/>
                </a:lnTo>
                <a:lnTo>
                  <a:pt x="1018" y="2"/>
                </a:lnTo>
                <a:lnTo>
                  <a:pt x="992" y="4"/>
                </a:lnTo>
                <a:lnTo>
                  <a:pt x="970" y="8"/>
                </a:lnTo>
                <a:lnTo>
                  <a:pt x="947" y="17"/>
                </a:lnTo>
                <a:lnTo>
                  <a:pt x="924" y="25"/>
                </a:lnTo>
                <a:lnTo>
                  <a:pt x="903" y="34"/>
                </a:lnTo>
                <a:lnTo>
                  <a:pt x="885" y="46"/>
                </a:lnTo>
                <a:lnTo>
                  <a:pt x="867" y="59"/>
                </a:lnTo>
                <a:lnTo>
                  <a:pt x="851" y="73"/>
                </a:lnTo>
                <a:lnTo>
                  <a:pt x="836" y="88"/>
                </a:lnTo>
                <a:lnTo>
                  <a:pt x="823" y="104"/>
                </a:lnTo>
                <a:lnTo>
                  <a:pt x="813" y="122"/>
                </a:lnTo>
                <a:lnTo>
                  <a:pt x="805" y="142"/>
                </a:lnTo>
                <a:lnTo>
                  <a:pt x="799" y="160"/>
                </a:lnTo>
                <a:lnTo>
                  <a:pt x="795" y="181"/>
                </a:lnTo>
                <a:lnTo>
                  <a:pt x="794" y="200"/>
                </a:lnTo>
                <a:lnTo>
                  <a:pt x="794" y="200"/>
                </a:lnTo>
                <a:lnTo>
                  <a:pt x="794" y="218"/>
                </a:lnTo>
                <a:lnTo>
                  <a:pt x="797" y="235"/>
                </a:lnTo>
                <a:lnTo>
                  <a:pt x="802" y="251"/>
                </a:lnTo>
                <a:lnTo>
                  <a:pt x="807" y="264"/>
                </a:lnTo>
                <a:lnTo>
                  <a:pt x="813" y="277"/>
                </a:lnTo>
                <a:lnTo>
                  <a:pt x="822" y="288"/>
                </a:lnTo>
                <a:lnTo>
                  <a:pt x="830" y="298"/>
                </a:lnTo>
                <a:lnTo>
                  <a:pt x="838" y="308"/>
                </a:lnTo>
                <a:lnTo>
                  <a:pt x="854" y="322"/>
                </a:lnTo>
                <a:lnTo>
                  <a:pt x="867" y="334"/>
                </a:lnTo>
                <a:lnTo>
                  <a:pt x="882" y="342"/>
                </a:lnTo>
                <a:lnTo>
                  <a:pt x="882" y="342"/>
                </a:lnTo>
                <a:lnTo>
                  <a:pt x="891" y="347"/>
                </a:lnTo>
                <a:lnTo>
                  <a:pt x="901" y="353"/>
                </a:lnTo>
                <a:lnTo>
                  <a:pt x="909" y="361"/>
                </a:lnTo>
                <a:lnTo>
                  <a:pt x="916" y="368"/>
                </a:lnTo>
                <a:lnTo>
                  <a:pt x="921" y="376"/>
                </a:lnTo>
                <a:lnTo>
                  <a:pt x="924" y="383"/>
                </a:lnTo>
                <a:lnTo>
                  <a:pt x="926" y="391"/>
                </a:lnTo>
                <a:lnTo>
                  <a:pt x="926" y="397"/>
                </a:lnTo>
                <a:lnTo>
                  <a:pt x="924" y="404"/>
                </a:lnTo>
                <a:lnTo>
                  <a:pt x="921" y="410"/>
                </a:lnTo>
                <a:lnTo>
                  <a:pt x="916" y="415"/>
                </a:lnTo>
                <a:lnTo>
                  <a:pt x="909" y="420"/>
                </a:lnTo>
                <a:lnTo>
                  <a:pt x="901" y="425"/>
                </a:lnTo>
                <a:lnTo>
                  <a:pt x="891" y="428"/>
                </a:lnTo>
                <a:lnTo>
                  <a:pt x="880" y="430"/>
                </a:lnTo>
                <a:lnTo>
                  <a:pt x="869" y="430"/>
                </a:lnTo>
                <a:lnTo>
                  <a:pt x="595" y="430"/>
                </a:lnTo>
                <a:lnTo>
                  <a:pt x="595" y="431"/>
                </a:lnTo>
                <a:lnTo>
                  <a:pt x="0" y="431"/>
                </a:lnTo>
                <a:lnTo>
                  <a:pt x="0" y="1305"/>
                </a:lnTo>
                <a:lnTo>
                  <a:pt x="0" y="1305"/>
                </a:lnTo>
                <a:lnTo>
                  <a:pt x="0" y="1317"/>
                </a:lnTo>
                <a:lnTo>
                  <a:pt x="2" y="1328"/>
                </a:lnTo>
                <a:lnTo>
                  <a:pt x="5" y="1338"/>
                </a:lnTo>
                <a:lnTo>
                  <a:pt x="10" y="1346"/>
                </a:lnTo>
                <a:lnTo>
                  <a:pt x="15" y="1352"/>
                </a:lnTo>
                <a:lnTo>
                  <a:pt x="19" y="1357"/>
                </a:lnTo>
                <a:lnTo>
                  <a:pt x="26" y="1361"/>
                </a:lnTo>
                <a:lnTo>
                  <a:pt x="32" y="1362"/>
                </a:lnTo>
                <a:lnTo>
                  <a:pt x="39" y="1362"/>
                </a:lnTo>
                <a:lnTo>
                  <a:pt x="47" y="1361"/>
                </a:lnTo>
                <a:lnTo>
                  <a:pt x="54" y="1357"/>
                </a:lnTo>
                <a:lnTo>
                  <a:pt x="62" y="1352"/>
                </a:lnTo>
                <a:lnTo>
                  <a:pt x="68" y="1346"/>
                </a:lnTo>
                <a:lnTo>
                  <a:pt x="76" y="1338"/>
                </a:lnTo>
                <a:lnTo>
                  <a:pt x="83" y="1328"/>
                </a:lnTo>
                <a:lnTo>
                  <a:pt x="88" y="1318"/>
                </a:lnTo>
                <a:lnTo>
                  <a:pt x="88" y="1318"/>
                </a:lnTo>
                <a:lnTo>
                  <a:pt x="96" y="1304"/>
                </a:lnTo>
                <a:lnTo>
                  <a:pt x="107" y="1291"/>
                </a:lnTo>
                <a:lnTo>
                  <a:pt x="122" y="1274"/>
                </a:lnTo>
                <a:lnTo>
                  <a:pt x="132" y="1266"/>
                </a:lnTo>
                <a:lnTo>
                  <a:pt x="141" y="1258"/>
                </a:lnTo>
                <a:lnTo>
                  <a:pt x="153" y="1250"/>
                </a:lnTo>
                <a:lnTo>
                  <a:pt x="166" y="1243"/>
                </a:lnTo>
                <a:lnTo>
                  <a:pt x="179" y="1238"/>
                </a:lnTo>
                <a:lnTo>
                  <a:pt x="195" y="1234"/>
                </a:lnTo>
                <a:lnTo>
                  <a:pt x="211" y="1230"/>
                </a:lnTo>
                <a:lnTo>
                  <a:pt x="229" y="1230"/>
                </a:lnTo>
                <a:lnTo>
                  <a:pt x="229" y="1230"/>
                </a:lnTo>
                <a:lnTo>
                  <a:pt x="249" y="1232"/>
                </a:lnTo>
                <a:lnTo>
                  <a:pt x="270" y="1235"/>
                </a:lnTo>
                <a:lnTo>
                  <a:pt x="288" y="1242"/>
                </a:lnTo>
                <a:lnTo>
                  <a:pt x="307" y="1250"/>
                </a:lnTo>
                <a:lnTo>
                  <a:pt x="325" y="1260"/>
                </a:lnTo>
                <a:lnTo>
                  <a:pt x="342" y="1273"/>
                </a:lnTo>
                <a:lnTo>
                  <a:pt x="356" y="1287"/>
                </a:lnTo>
                <a:lnTo>
                  <a:pt x="371" y="1304"/>
                </a:lnTo>
                <a:lnTo>
                  <a:pt x="384" y="1321"/>
                </a:lnTo>
                <a:lnTo>
                  <a:pt x="395" y="1339"/>
                </a:lnTo>
                <a:lnTo>
                  <a:pt x="405" y="1361"/>
                </a:lnTo>
                <a:lnTo>
                  <a:pt x="413" y="1383"/>
                </a:lnTo>
                <a:lnTo>
                  <a:pt x="421" y="1406"/>
                </a:lnTo>
                <a:lnTo>
                  <a:pt x="426" y="1429"/>
                </a:lnTo>
                <a:lnTo>
                  <a:pt x="428" y="1455"/>
                </a:lnTo>
                <a:lnTo>
                  <a:pt x="429" y="1479"/>
                </a:lnTo>
                <a:lnTo>
                  <a:pt x="429" y="1479"/>
                </a:lnTo>
                <a:lnTo>
                  <a:pt x="428" y="1505"/>
                </a:lnTo>
                <a:lnTo>
                  <a:pt x="426" y="1530"/>
                </a:lnTo>
                <a:lnTo>
                  <a:pt x="421" y="1554"/>
                </a:lnTo>
                <a:lnTo>
                  <a:pt x="413" y="1577"/>
                </a:lnTo>
                <a:lnTo>
                  <a:pt x="405" y="1598"/>
                </a:lnTo>
                <a:lnTo>
                  <a:pt x="395" y="1619"/>
                </a:lnTo>
                <a:lnTo>
                  <a:pt x="384" y="1639"/>
                </a:lnTo>
                <a:lnTo>
                  <a:pt x="371" y="1657"/>
                </a:lnTo>
                <a:lnTo>
                  <a:pt x="356" y="1673"/>
                </a:lnTo>
                <a:lnTo>
                  <a:pt x="342" y="1686"/>
                </a:lnTo>
                <a:lnTo>
                  <a:pt x="325" y="1699"/>
                </a:lnTo>
                <a:lnTo>
                  <a:pt x="307" y="1710"/>
                </a:lnTo>
                <a:lnTo>
                  <a:pt x="288" y="1718"/>
                </a:lnTo>
                <a:lnTo>
                  <a:pt x="270" y="1725"/>
                </a:lnTo>
                <a:lnTo>
                  <a:pt x="249" y="1728"/>
                </a:lnTo>
                <a:lnTo>
                  <a:pt x="229" y="1730"/>
                </a:lnTo>
                <a:lnTo>
                  <a:pt x="229" y="1730"/>
                </a:lnTo>
                <a:close/>
              </a:path>
            </a:pathLst>
          </a:custGeom>
          <a:solidFill>
            <a:srgbClr val="0096FF"/>
          </a:solidFill>
          <a:ln w="28575">
            <a:solidFill>
              <a:schemeClr val="tx1">
                <a:lumMod val="50000"/>
                <a:lumOff val="50000"/>
              </a:schemeClr>
            </a:solidFill>
            <a:prstDash val="solid"/>
            <a:round/>
            <a:headEnd/>
            <a:tailEnd/>
          </a:ln>
        </p:spPr>
        <p:txBody>
          <a:bodyPr tIns="468000" anchor="ctr" anchorCtr="1"/>
          <a:lstStyle/>
          <a:p>
            <a:pPr defTabSz="457200">
              <a:defRPr/>
            </a:pPr>
            <a:r>
              <a:rPr lang="en-US" sz="4000" dirty="0">
                <a:solidFill>
                  <a:prstClr val="black"/>
                </a:solidFill>
              </a:rPr>
              <a:t>D</a:t>
            </a:r>
            <a:endParaRPr lang="en-GB" sz="4000" dirty="0">
              <a:solidFill>
                <a:prstClr val="black"/>
              </a:solidFill>
              <a:cs typeface="Arial" charset="0"/>
            </a:endParaRPr>
          </a:p>
        </p:txBody>
      </p:sp>
      <p:sp>
        <p:nvSpPr>
          <p:cNvPr id="21" name="TextBox 20">
            <a:extLst>
              <a:ext uri="{FF2B5EF4-FFF2-40B4-BE49-F238E27FC236}">
                <a16:creationId xmlns:a16="http://schemas.microsoft.com/office/drawing/2014/main" xmlns="" id="{B06DC457-9447-DE42-8AB2-96C11E14C49D}"/>
              </a:ext>
            </a:extLst>
          </p:cNvPr>
          <p:cNvSpPr txBox="1"/>
          <p:nvPr/>
        </p:nvSpPr>
        <p:spPr>
          <a:xfrm>
            <a:off x="1621693" y="4872336"/>
            <a:ext cx="1947497" cy="461665"/>
          </a:xfrm>
          <a:prstGeom prst="rect">
            <a:avLst/>
          </a:prstGeom>
          <a:noFill/>
        </p:spPr>
        <p:txBody>
          <a:bodyPr wrap="square" rtlCol="0">
            <a:spAutoFit/>
          </a:bodyPr>
          <a:lstStyle/>
          <a:p>
            <a:pPr defTabSz="457200"/>
            <a:r>
              <a:rPr lang="en-US" sz="2400" dirty="0">
                <a:solidFill>
                  <a:prstClr val="black"/>
                </a:solidFill>
                <a:cs typeface="Calibri" panose="020F0502020204030204" pitchFamily="34" charset="0"/>
              </a:rPr>
              <a:t>Home </a:t>
            </a:r>
            <a:r>
              <a:rPr lang="en-US" sz="2400" dirty="0" smtClean="0">
                <a:solidFill>
                  <a:prstClr val="black"/>
                </a:solidFill>
                <a:cs typeface="Calibri" panose="020F0502020204030204" pitchFamily="34" charset="0"/>
              </a:rPr>
              <a:t>Group</a:t>
            </a:r>
          </a:p>
        </p:txBody>
      </p:sp>
      <p:grpSp>
        <p:nvGrpSpPr>
          <p:cNvPr id="3" name="Group 2"/>
          <p:cNvGrpSpPr/>
          <p:nvPr/>
        </p:nvGrpSpPr>
        <p:grpSpPr>
          <a:xfrm>
            <a:off x="4881083" y="1970169"/>
            <a:ext cx="2633227" cy="3850991"/>
            <a:chOff x="4881083" y="1970169"/>
            <a:chExt cx="2633227" cy="3850991"/>
          </a:xfrm>
        </p:grpSpPr>
        <p:sp>
          <p:nvSpPr>
            <p:cNvPr id="6" name="Freeform 5">
              <a:extLst>
                <a:ext uri="{FF2B5EF4-FFF2-40B4-BE49-F238E27FC236}">
                  <a16:creationId xmlns:a16="http://schemas.microsoft.com/office/drawing/2014/main" xmlns="" id="{8AEF7B62-1D5F-F04E-A194-F9BF4A404EF3}"/>
                </a:ext>
              </a:extLst>
            </p:cNvPr>
            <p:cNvSpPr>
              <a:spLocks/>
            </p:cNvSpPr>
            <p:nvPr/>
          </p:nvSpPr>
          <p:spPr bwMode="auto">
            <a:xfrm>
              <a:off x="4881083" y="1970169"/>
              <a:ext cx="1051952" cy="1401232"/>
            </a:xfrm>
            <a:custGeom>
              <a:avLst/>
              <a:gdLst>
                <a:gd name="T0" fmla="*/ 1956 w 2151"/>
                <a:gd name="T1" fmla="*/ 861 h 2586"/>
                <a:gd name="T2" fmla="*/ 2010 w 2151"/>
                <a:gd name="T3" fmla="*/ 884 h 2586"/>
                <a:gd name="T4" fmla="*/ 2054 w 2151"/>
                <a:gd name="T5" fmla="*/ 931 h 2586"/>
                <a:gd name="T6" fmla="*/ 2075 w 2151"/>
                <a:gd name="T7" fmla="*/ 965 h 2586"/>
                <a:gd name="T8" fmla="*/ 2104 w 2151"/>
                <a:gd name="T9" fmla="*/ 988 h 2586"/>
                <a:gd name="T10" fmla="*/ 2132 w 2151"/>
                <a:gd name="T11" fmla="*/ 983 h 2586"/>
                <a:gd name="T12" fmla="*/ 2148 w 2151"/>
                <a:gd name="T13" fmla="*/ 955 h 2586"/>
                <a:gd name="T14" fmla="*/ 0 w 2151"/>
                <a:gd name="T15" fmla="*/ 0 h 2586"/>
                <a:gd name="T16" fmla="*/ 933 w 2151"/>
                <a:gd name="T17" fmla="*/ 2156 h 2586"/>
                <a:gd name="T18" fmla="*/ 965 w 2151"/>
                <a:gd name="T19" fmla="*/ 2161 h 2586"/>
                <a:gd name="T20" fmla="*/ 988 w 2151"/>
                <a:gd name="T21" fmla="*/ 2182 h 2586"/>
                <a:gd name="T22" fmla="*/ 985 w 2151"/>
                <a:gd name="T23" fmla="*/ 2210 h 2586"/>
                <a:gd name="T24" fmla="*/ 957 w 2151"/>
                <a:gd name="T25" fmla="*/ 2239 h 2586"/>
                <a:gd name="T26" fmla="*/ 918 w 2151"/>
                <a:gd name="T27" fmla="*/ 2264 h 2586"/>
                <a:gd name="T28" fmla="*/ 879 w 2151"/>
                <a:gd name="T29" fmla="*/ 2309 h 2586"/>
                <a:gd name="T30" fmla="*/ 859 w 2151"/>
                <a:gd name="T31" fmla="*/ 2368 h 2586"/>
                <a:gd name="T32" fmla="*/ 863 w 2151"/>
                <a:gd name="T33" fmla="*/ 2426 h 2586"/>
                <a:gd name="T34" fmla="*/ 900 w 2151"/>
                <a:gd name="T35" fmla="*/ 2498 h 2586"/>
                <a:gd name="T36" fmla="*/ 968 w 2151"/>
                <a:gd name="T37" fmla="*/ 2552 h 2586"/>
                <a:gd name="T38" fmla="*/ 1058 w 2151"/>
                <a:gd name="T39" fmla="*/ 2582 h 2586"/>
                <a:gd name="T40" fmla="*/ 1133 w 2151"/>
                <a:gd name="T41" fmla="*/ 2584 h 2586"/>
                <a:gd name="T42" fmla="*/ 1227 w 2151"/>
                <a:gd name="T43" fmla="*/ 2561 h 2586"/>
                <a:gd name="T44" fmla="*/ 1300 w 2151"/>
                <a:gd name="T45" fmla="*/ 2513 h 2586"/>
                <a:gd name="T46" fmla="*/ 1346 w 2151"/>
                <a:gd name="T47" fmla="*/ 2444 h 2586"/>
                <a:gd name="T48" fmla="*/ 1357 w 2151"/>
                <a:gd name="T49" fmla="*/ 2386 h 2586"/>
                <a:gd name="T50" fmla="*/ 1344 w 2151"/>
                <a:gd name="T51" fmla="*/ 2322 h 2586"/>
                <a:gd name="T52" fmla="*/ 1313 w 2151"/>
                <a:gd name="T53" fmla="*/ 2278 h 2586"/>
                <a:gd name="T54" fmla="*/ 1269 w 2151"/>
                <a:gd name="T55" fmla="*/ 2244 h 2586"/>
                <a:gd name="T56" fmla="*/ 1235 w 2151"/>
                <a:gd name="T57" fmla="*/ 2218 h 2586"/>
                <a:gd name="T58" fmla="*/ 1225 w 2151"/>
                <a:gd name="T59" fmla="*/ 2189 h 2586"/>
                <a:gd name="T60" fmla="*/ 1242 w 2151"/>
                <a:gd name="T61" fmla="*/ 2166 h 2586"/>
                <a:gd name="T62" fmla="*/ 1282 w 2151"/>
                <a:gd name="T63" fmla="*/ 2156 h 2586"/>
                <a:gd name="T64" fmla="*/ 2151 w 2151"/>
                <a:gd name="T65" fmla="*/ 1281 h 2586"/>
                <a:gd name="T66" fmla="*/ 2146 w 2151"/>
                <a:gd name="T67" fmla="*/ 1248 h 2586"/>
                <a:gd name="T68" fmla="*/ 2125 w 2151"/>
                <a:gd name="T69" fmla="*/ 1225 h 2586"/>
                <a:gd name="T70" fmla="*/ 2097 w 2151"/>
                <a:gd name="T71" fmla="*/ 1229 h 2586"/>
                <a:gd name="T72" fmla="*/ 2068 w 2151"/>
                <a:gd name="T73" fmla="*/ 1258 h 2586"/>
                <a:gd name="T74" fmla="*/ 2044 w 2151"/>
                <a:gd name="T75" fmla="*/ 1295 h 2586"/>
                <a:gd name="T76" fmla="*/ 1998 w 2151"/>
                <a:gd name="T77" fmla="*/ 1336 h 2586"/>
                <a:gd name="T78" fmla="*/ 1940 w 2151"/>
                <a:gd name="T79" fmla="*/ 1356 h 2586"/>
                <a:gd name="T80" fmla="*/ 1881 w 2151"/>
                <a:gd name="T81" fmla="*/ 1351 h 2586"/>
                <a:gd name="T82" fmla="*/ 1809 w 2151"/>
                <a:gd name="T83" fmla="*/ 1313 h 2586"/>
                <a:gd name="T84" fmla="*/ 1756 w 2151"/>
                <a:gd name="T85" fmla="*/ 1247 h 2586"/>
                <a:gd name="T86" fmla="*/ 1725 w 2151"/>
                <a:gd name="T87" fmla="*/ 1157 h 2586"/>
                <a:gd name="T88" fmla="*/ 1722 w 2151"/>
                <a:gd name="T89" fmla="*/ 1081 h 2586"/>
                <a:gd name="T90" fmla="*/ 1746 w 2151"/>
                <a:gd name="T91" fmla="*/ 988 h 2586"/>
                <a:gd name="T92" fmla="*/ 1795 w 2151"/>
                <a:gd name="T93" fmla="*/ 913 h 2586"/>
                <a:gd name="T94" fmla="*/ 1862 w 2151"/>
                <a:gd name="T95" fmla="*/ 868 h 2586"/>
                <a:gd name="T96" fmla="*/ 1922 w 2151"/>
                <a:gd name="T97" fmla="*/ 856 h 258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151" h="2586">
                  <a:moveTo>
                    <a:pt x="1922" y="856"/>
                  </a:moveTo>
                  <a:lnTo>
                    <a:pt x="1922" y="856"/>
                  </a:lnTo>
                  <a:lnTo>
                    <a:pt x="1940" y="858"/>
                  </a:lnTo>
                  <a:lnTo>
                    <a:pt x="1956" y="861"/>
                  </a:lnTo>
                  <a:lnTo>
                    <a:pt x="1971" y="864"/>
                  </a:lnTo>
                  <a:lnTo>
                    <a:pt x="1985" y="871"/>
                  </a:lnTo>
                  <a:lnTo>
                    <a:pt x="1998" y="877"/>
                  </a:lnTo>
                  <a:lnTo>
                    <a:pt x="2010" y="884"/>
                  </a:lnTo>
                  <a:lnTo>
                    <a:pt x="2019" y="892"/>
                  </a:lnTo>
                  <a:lnTo>
                    <a:pt x="2029" y="900"/>
                  </a:lnTo>
                  <a:lnTo>
                    <a:pt x="2044" y="916"/>
                  </a:lnTo>
                  <a:lnTo>
                    <a:pt x="2054" y="931"/>
                  </a:lnTo>
                  <a:lnTo>
                    <a:pt x="2062" y="944"/>
                  </a:lnTo>
                  <a:lnTo>
                    <a:pt x="2062" y="944"/>
                  </a:lnTo>
                  <a:lnTo>
                    <a:pt x="2068" y="955"/>
                  </a:lnTo>
                  <a:lnTo>
                    <a:pt x="2075" y="965"/>
                  </a:lnTo>
                  <a:lnTo>
                    <a:pt x="2083" y="973"/>
                  </a:lnTo>
                  <a:lnTo>
                    <a:pt x="2089" y="980"/>
                  </a:lnTo>
                  <a:lnTo>
                    <a:pt x="2097" y="985"/>
                  </a:lnTo>
                  <a:lnTo>
                    <a:pt x="2104" y="988"/>
                  </a:lnTo>
                  <a:lnTo>
                    <a:pt x="2112" y="988"/>
                  </a:lnTo>
                  <a:lnTo>
                    <a:pt x="2119" y="988"/>
                  </a:lnTo>
                  <a:lnTo>
                    <a:pt x="2125" y="986"/>
                  </a:lnTo>
                  <a:lnTo>
                    <a:pt x="2132" y="983"/>
                  </a:lnTo>
                  <a:lnTo>
                    <a:pt x="2136" y="978"/>
                  </a:lnTo>
                  <a:lnTo>
                    <a:pt x="2141" y="972"/>
                  </a:lnTo>
                  <a:lnTo>
                    <a:pt x="2146" y="965"/>
                  </a:lnTo>
                  <a:lnTo>
                    <a:pt x="2148" y="955"/>
                  </a:lnTo>
                  <a:lnTo>
                    <a:pt x="2151" y="944"/>
                  </a:lnTo>
                  <a:lnTo>
                    <a:pt x="2151" y="931"/>
                  </a:lnTo>
                  <a:lnTo>
                    <a:pt x="2151" y="0"/>
                  </a:lnTo>
                  <a:lnTo>
                    <a:pt x="0" y="0"/>
                  </a:lnTo>
                  <a:lnTo>
                    <a:pt x="0" y="2155"/>
                  </a:lnTo>
                  <a:lnTo>
                    <a:pt x="495" y="2155"/>
                  </a:lnTo>
                  <a:lnTo>
                    <a:pt x="495" y="2156"/>
                  </a:lnTo>
                  <a:lnTo>
                    <a:pt x="933" y="2156"/>
                  </a:lnTo>
                  <a:lnTo>
                    <a:pt x="933" y="2156"/>
                  </a:lnTo>
                  <a:lnTo>
                    <a:pt x="946" y="2156"/>
                  </a:lnTo>
                  <a:lnTo>
                    <a:pt x="955" y="2158"/>
                  </a:lnTo>
                  <a:lnTo>
                    <a:pt x="965" y="2161"/>
                  </a:lnTo>
                  <a:lnTo>
                    <a:pt x="973" y="2166"/>
                  </a:lnTo>
                  <a:lnTo>
                    <a:pt x="980" y="2171"/>
                  </a:lnTo>
                  <a:lnTo>
                    <a:pt x="985" y="2176"/>
                  </a:lnTo>
                  <a:lnTo>
                    <a:pt x="988" y="2182"/>
                  </a:lnTo>
                  <a:lnTo>
                    <a:pt x="989" y="2189"/>
                  </a:lnTo>
                  <a:lnTo>
                    <a:pt x="989" y="2195"/>
                  </a:lnTo>
                  <a:lnTo>
                    <a:pt x="988" y="2203"/>
                  </a:lnTo>
                  <a:lnTo>
                    <a:pt x="985" y="2210"/>
                  </a:lnTo>
                  <a:lnTo>
                    <a:pt x="980" y="2218"/>
                  </a:lnTo>
                  <a:lnTo>
                    <a:pt x="975" y="2225"/>
                  </a:lnTo>
                  <a:lnTo>
                    <a:pt x="967" y="2233"/>
                  </a:lnTo>
                  <a:lnTo>
                    <a:pt x="957" y="2239"/>
                  </a:lnTo>
                  <a:lnTo>
                    <a:pt x="946" y="2244"/>
                  </a:lnTo>
                  <a:lnTo>
                    <a:pt x="946" y="2244"/>
                  </a:lnTo>
                  <a:lnTo>
                    <a:pt x="931" y="2252"/>
                  </a:lnTo>
                  <a:lnTo>
                    <a:pt x="918" y="2264"/>
                  </a:lnTo>
                  <a:lnTo>
                    <a:pt x="902" y="2278"/>
                  </a:lnTo>
                  <a:lnTo>
                    <a:pt x="893" y="2288"/>
                  </a:lnTo>
                  <a:lnTo>
                    <a:pt x="885" y="2298"/>
                  </a:lnTo>
                  <a:lnTo>
                    <a:pt x="879" y="2309"/>
                  </a:lnTo>
                  <a:lnTo>
                    <a:pt x="871" y="2322"/>
                  </a:lnTo>
                  <a:lnTo>
                    <a:pt x="866" y="2335"/>
                  </a:lnTo>
                  <a:lnTo>
                    <a:pt x="861" y="2351"/>
                  </a:lnTo>
                  <a:lnTo>
                    <a:pt x="859" y="2368"/>
                  </a:lnTo>
                  <a:lnTo>
                    <a:pt x="858" y="2386"/>
                  </a:lnTo>
                  <a:lnTo>
                    <a:pt x="858" y="2386"/>
                  </a:lnTo>
                  <a:lnTo>
                    <a:pt x="859" y="2405"/>
                  </a:lnTo>
                  <a:lnTo>
                    <a:pt x="863" y="2426"/>
                  </a:lnTo>
                  <a:lnTo>
                    <a:pt x="869" y="2444"/>
                  </a:lnTo>
                  <a:lnTo>
                    <a:pt x="877" y="2464"/>
                  </a:lnTo>
                  <a:lnTo>
                    <a:pt x="889" y="2482"/>
                  </a:lnTo>
                  <a:lnTo>
                    <a:pt x="900" y="2498"/>
                  </a:lnTo>
                  <a:lnTo>
                    <a:pt x="915" y="2513"/>
                  </a:lnTo>
                  <a:lnTo>
                    <a:pt x="931" y="2527"/>
                  </a:lnTo>
                  <a:lnTo>
                    <a:pt x="949" y="2540"/>
                  </a:lnTo>
                  <a:lnTo>
                    <a:pt x="968" y="2552"/>
                  </a:lnTo>
                  <a:lnTo>
                    <a:pt x="988" y="2561"/>
                  </a:lnTo>
                  <a:lnTo>
                    <a:pt x="1011" y="2569"/>
                  </a:lnTo>
                  <a:lnTo>
                    <a:pt x="1033" y="2578"/>
                  </a:lnTo>
                  <a:lnTo>
                    <a:pt x="1058" y="2582"/>
                  </a:lnTo>
                  <a:lnTo>
                    <a:pt x="1082" y="2584"/>
                  </a:lnTo>
                  <a:lnTo>
                    <a:pt x="1108" y="2586"/>
                  </a:lnTo>
                  <a:lnTo>
                    <a:pt x="1108" y="2586"/>
                  </a:lnTo>
                  <a:lnTo>
                    <a:pt x="1133" y="2584"/>
                  </a:lnTo>
                  <a:lnTo>
                    <a:pt x="1157" y="2582"/>
                  </a:lnTo>
                  <a:lnTo>
                    <a:pt x="1181" y="2578"/>
                  </a:lnTo>
                  <a:lnTo>
                    <a:pt x="1204" y="2569"/>
                  </a:lnTo>
                  <a:lnTo>
                    <a:pt x="1227" y="2561"/>
                  </a:lnTo>
                  <a:lnTo>
                    <a:pt x="1247" y="2552"/>
                  </a:lnTo>
                  <a:lnTo>
                    <a:pt x="1266" y="2540"/>
                  </a:lnTo>
                  <a:lnTo>
                    <a:pt x="1284" y="2527"/>
                  </a:lnTo>
                  <a:lnTo>
                    <a:pt x="1300" y="2513"/>
                  </a:lnTo>
                  <a:lnTo>
                    <a:pt x="1315" y="2498"/>
                  </a:lnTo>
                  <a:lnTo>
                    <a:pt x="1326" y="2482"/>
                  </a:lnTo>
                  <a:lnTo>
                    <a:pt x="1338" y="2464"/>
                  </a:lnTo>
                  <a:lnTo>
                    <a:pt x="1346" y="2444"/>
                  </a:lnTo>
                  <a:lnTo>
                    <a:pt x="1352" y="2426"/>
                  </a:lnTo>
                  <a:lnTo>
                    <a:pt x="1356" y="2405"/>
                  </a:lnTo>
                  <a:lnTo>
                    <a:pt x="1357" y="2386"/>
                  </a:lnTo>
                  <a:lnTo>
                    <a:pt x="1357" y="2386"/>
                  </a:lnTo>
                  <a:lnTo>
                    <a:pt x="1356" y="2368"/>
                  </a:lnTo>
                  <a:lnTo>
                    <a:pt x="1354" y="2351"/>
                  </a:lnTo>
                  <a:lnTo>
                    <a:pt x="1349" y="2335"/>
                  </a:lnTo>
                  <a:lnTo>
                    <a:pt x="1344" y="2322"/>
                  </a:lnTo>
                  <a:lnTo>
                    <a:pt x="1338" y="2309"/>
                  </a:lnTo>
                  <a:lnTo>
                    <a:pt x="1329" y="2298"/>
                  </a:lnTo>
                  <a:lnTo>
                    <a:pt x="1321" y="2288"/>
                  </a:lnTo>
                  <a:lnTo>
                    <a:pt x="1313" y="2278"/>
                  </a:lnTo>
                  <a:lnTo>
                    <a:pt x="1297" y="2264"/>
                  </a:lnTo>
                  <a:lnTo>
                    <a:pt x="1284" y="2252"/>
                  </a:lnTo>
                  <a:lnTo>
                    <a:pt x="1269" y="2244"/>
                  </a:lnTo>
                  <a:lnTo>
                    <a:pt x="1269" y="2244"/>
                  </a:lnTo>
                  <a:lnTo>
                    <a:pt x="1258" y="2239"/>
                  </a:lnTo>
                  <a:lnTo>
                    <a:pt x="1248" y="2233"/>
                  </a:lnTo>
                  <a:lnTo>
                    <a:pt x="1240" y="2225"/>
                  </a:lnTo>
                  <a:lnTo>
                    <a:pt x="1235" y="2218"/>
                  </a:lnTo>
                  <a:lnTo>
                    <a:pt x="1230" y="2210"/>
                  </a:lnTo>
                  <a:lnTo>
                    <a:pt x="1227" y="2203"/>
                  </a:lnTo>
                  <a:lnTo>
                    <a:pt x="1225" y="2195"/>
                  </a:lnTo>
                  <a:lnTo>
                    <a:pt x="1225" y="2189"/>
                  </a:lnTo>
                  <a:lnTo>
                    <a:pt x="1227" y="2182"/>
                  </a:lnTo>
                  <a:lnTo>
                    <a:pt x="1230" y="2176"/>
                  </a:lnTo>
                  <a:lnTo>
                    <a:pt x="1235" y="2171"/>
                  </a:lnTo>
                  <a:lnTo>
                    <a:pt x="1242" y="2166"/>
                  </a:lnTo>
                  <a:lnTo>
                    <a:pt x="1250" y="2161"/>
                  </a:lnTo>
                  <a:lnTo>
                    <a:pt x="1260" y="2158"/>
                  </a:lnTo>
                  <a:lnTo>
                    <a:pt x="1269" y="2156"/>
                  </a:lnTo>
                  <a:lnTo>
                    <a:pt x="1282" y="2156"/>
                  </a:lnTo>
                  <a:lnTo>
                    <a:pt x="1556" y="2156"/>
                  </a:lnTo>
                  <a:lnTo>
                    <a:pt x="1556" y="2155"/>
                  </a:lnTo>
                  <a:lnTo>
                    <a:pt x="2151" y="2155"/>
                  </a:lnTo>
                  <a:lnTo>
                    <a:pt x="2151" y="1281"/>
                  </a:lnTo>
                  <a:lnTo>
                    <a:pt x="2151" y="1281"/>
                  </a:lnTo>
                  <a:lnTo>
                    <a:pt x="2151" y="1269"/>
                  </a:lnTo>
                  <a:lnTo>
                    <a:pt x="2148" y="1258"/>
                  </a:lnTo>
                  <a:lnTo>
                    <a:pt x="2146" y="1248"/>
                  </a:lnTo>
                  <a:lnTo>
                    <a:pt x="2141" y="1240"/>
                  </a:lnTo>
                  <a:lnTo>
                    <a:pt x="2136" y="1234"/>
                  </a:lnTo>
                  <a:lnTo>
                    <a:pt x="2132" y="1229"/>
                  </a:lnTo>
                  <a:lnTo>
                    <a:pt x="2125" y="1225"/>
                  </a:lnTo>
                  <a:lnTo>
                    <a:pt x="2119" y="1224"/>
                  </a:lnTo>
                  <a:lnTo>
                    <a:pt x="2112" y="1224"/>
                  </a:lnTo>
                  <a:lnTo>
                    <a:pt x="2104" y="1225"/>
                  </a:lnTo>
                  <a:lnTo>
                    <a:pt x="2097" y="1229"/>
                  </a:lnTo>
                  <a:lnTo>
                    <a:pt x="2089" y="1234"/>
                  </a:lnTo>
                  <a:lnTo>
                    <a:pt x="2083" y="1240"/>
                  </a:lnTo>
                  <a:lnTo>
                    <a:pt x="2075" y="1248"/>
                  </a:lnTo>
                  <a:lnTo>
                    <a:pt x="2068" y="1258"/>
                  </a:lnTo>
                  <a:lnTo>
                    <a:pt x="2062" y="1268"/>
                  </a:lnTo>
                  <a:lnTo>
                    <a:pt x="2062" y="1268"/>
                  </a:lnTo>
                  <a:lnTo>
                    <a:pt x="2054" y="1282"/>
                  </a:lnTo>
                  <a:lnTo>
                    <a:pt x="2044" y="1295"/>
                  </a:lnTo>
                  <a:lnTo>
                    <a:pt x="2029" y="1312"/>
                  </a:lnTo>
                  <a:lnTo>
                    <a:pt x="2019" y="1320"/>
                  </a:lnTo>
                  <a:lnTo>
                    <a:pt x="2010" y="1328"/>
                  </a:lnTo>
                  <a:lnTo>
                    <a:pt x="1998" y="1336"/>
                  </a:lnTo>
                  <a:lnTo>
                    <a:pt x="1985" y="1343"/>
                  </a:lnTo>
                  <a:lnTo>
                    <a:pt x="1971" y="1348"/>
                  </a:lnTo>
                  <a:lnTo>
                    <a:pt x="1956" y="1352"/>
                  </a:lnTo>
                  <a:lnTo>
                    <a:pt x="1940" y="1356"/>
                  </a:lnTo>
                  <a:lnTo>
                    <a:pt x="1922" y="1356"/>
                  </a:lnTo>
                  <a:lnTo>
                    <a:pt x="1922" y="1356"/>
                  </a:lnTo>
                  <a:lnTo>
                    <a:pt x="1901" y="1354"/>
                  </a:lnTo>
                  <a:lnTo>
                    <a:pt x="1881" y="1351"/>
                  </a:lnTo>
                  <a:lnTo>
                    <a:pt x="1862" y="1344"/>
                  </a:lnTo>
                  <a:lnTo>
                    <a:pt x="1844" y="1336"/>
                  </a:lnTo>
                  <a:lnTo>
                    <a:pt x="1826" y="1326"/>
                  </a:lnTo>
                  <a:lnTo>
                    <a:pt x="1809" y="1313"/>
                  </a:lnTo>
                  <a:lnTo>
                    <a:pt x="1795" y="1299"/>
                  </a:lnTo>
                  <a:lnTo>
                    <a:pt x="1780" y="1282"/>
                  </a:lnTo>
                  <a:lnTo>
                    <a:pt x="1767" y="1265"/>
                  </a:lnTo>
                  <a:lnTo>
                    <a:pt x="1756" y="1247"/>
                  </a:lnTo>
                  <a:lnTo>
                    <a:pt x="1746" y="1225"/>
                  </a:lnTo>
                  <a:lnTo>
                    <a:pt x="1736" y="1203"/>
                  </a:lnTo>
                  <a:lnTo>
                    <a:pt x="1730" y="1180"/>
                  </a:lnTo>
                  <a:lnTo>
                    <a:pt x="1725" y="1157"/>
                  </a:lnTo>
                  <a:lnTo>
                    <a:pt x="1722" y="1131"/>
                  </a:lnTo>
                  <a:lnTo>
                    <a:pt x="1722" y="1107"/>
                  </a:lnTo>
                  <a:lnTo>
                    <a:pt x="1722" y="1107"/>
                  </a:lnTo>
                  <a:lnTo>
                    <a:pt x="1722" y="1081"/>
                  </a:lnTo>
                  <a:lnTo>
                    <a:pt x="1725" y="1056"/>
                  </a:lnTo>
                  <a:lnTo>
                    <a:pt x="1730" y="1032"/>
                  </a:lnTo>
                  <a:lnTo>
                    <a:pt x="1736" y="1009"/>
                  </a:lnTo>
                  <a:lnTo>
                    <a:pt x="1746" y="988"/>
                  </a:lnTo>
                  <a:lnTo>
                    <a:pt x="1756" y="967"/>
                  </a:lnTo>
                  <a:lnTo>
                    <a:pt x="1767" y="947"/>
                  </a:lnTo>
                  <a:lnTo>
                    <a:pt x="1780" y="929"/>
                  </a:lnTo>
                  <a:lnTo>
                    <a:pt x="1795" y="913"/>
                  </a:lnTo>
                  <a:lnTo>
                    <a:pt x="1809" y="898"/>
                  </a:lnTo>
                  <a:lnTo>
                    <a:pt x="1826" y="887"/>
                  </a:lnTo>
                  <a:lnTo>
                    <a:pt x="1844" y="876"/>
                  </a:lnTo>
                  <a:lnTo>
                    <a:pt x="1862" y="868"/>
                  </a:lnTo>
                  <a:lnTo>
                    <a:pt x="1881" y="861"/>
                  </a:lnTo>
                  <a:lnTo>
                    <a:pt x="1901" y="858"/>
                  </a:lnTo>
                  <a:lnTo>
                    <a:pt x="1922" y="856"/>
                  </a:lnTo>
                  <a:lnTo>
                    <a:pt x="1922" y="856"/>
                  </a:lnTo>
                  <a:close/>
                </a:path>
              </a:pathLst>
            </a:custGeom>
            <a:solidFill>
              <a:srgbClr val="FF0000"/>
            </a:solidFill>
            <a:ln w="28575">
              <a:solidFill>
                <a:schemeClr val="tx1">
                  <a:lumMod val="50000"/>
                  <a:lumOff val="50000"/>
                </a:schemeClr>
              </a:solidFill>
              <a:prstDash val="solid"/>
              <a:round/>
              <a:headEnd/>
              <a:tailEnd/>
            </a:ln>
          </p:spPr>
          <p:txBody>
            <a:bodyPr bIns="540000" anchor="ctr"/>
            <a:lstStyle/>
            <a:p>
              <a:pPr algn="ctr" defTabSz="457200">
                <a:defRPr/>
              </a:pPr>
              <a:r>
                <a:rPr lang="en-US" sz="4000" dirty="0">
                  <a:solidFill>
                    <a:prstClr val="black"/>
                  </a:solidFill>
                </a:rPr>
                <a:t>A</a:t>
              </a:r>
              <a:endParaRPr lang="en-GB" sz="4000" dirty="0">
                <a:solidFill>
                  <a:prstClr val="black"/>
                </a:solidFill>
                <a:cs typeface="Arial" charset="0"/>
              </a:endParaRPr>
            </a:p>
          </p:txBody>
        </p:sp>
        <p:sp>
          <p:nvSpPr>
            <p:cNvPr id="7" name="Freeform 6">
              <a:extLst>
                <a:ext uri="{FF2B5EF4-FFF2-40B4-BE49-F238E27FC236}">
                  <a16:creationId xmlns:a16="http://schemas.microsoft.com/office/drawing/2014/main" xmlns="" id="{971B38E0-EC09-AF42-81F7-ABDBF02597E5}"/>
                </a:ext>
              </a:extLst>
            </p:cNvPr>
            <p:cNvSpPr>
              <a:spLocks/>
            </p:cNvSpPr>
            <p:nvPr/>
          </p:nvSpPr>
          <p:spPr bwMode="auto">
            <a:xfrm>
              <a:off x="4889422" y="3770275"/>
              <a:ext cx="1265421" cy="1164853"/>
            </a:xfrm>
            <a:custGeom>
              <a:avLst/>
              <a:gdLst>
                <a:gd name="T0" fmla="*/ 861 w 2587"/>
                <a:gd name="T1" fmla="*/ 195 h 2151"/>
                <a:gd name="T2" fmla="*/ 885 w 2587"/>
                <a:gd name="T3" fmla="*/ 143 h 2151"/>
                <a:gd name="T4" fmla="*/ 931 w 2587"/>
                <a:gd name="T5" fmla="*/ 97 h 2151"/>
                <a:gd name="T6" fmla="*/ 965 w 2587"/>
                <a:gd name="T7" fmla="*/ 76 h 2151"/>
                <a:gd name="T8" fmla="*/ 988 w 2587"/>
                <a:gd name="T9" fmla="*/ 47 h 2151"/>
                <a:gd name="T10" fmla="*/ 985 w 2587"/>
                <a:gd name="T11" fmla="*/ 21 h 2151"/>
                <a:gd name="T12" fmla="*/ 955 w 2587"/>
                <a:gd name="T13" fmla="*/ 3 h 2151"/>
                <a:gd name="T14" fmla="*/ 0 w 2587"/>
                <a:gd name="T15" fmla="*/ 2151 h 2151"/>
                <a:gd name="T16" fmla="*/ 2156 w 2587"/>
                <a:gd name="T17" fmla="*/ 1220 h 2151"/>
                <a:gd name="T18" fmla="*/ 2163 w 2587"/>
                <a:gd name="T19" fmla="*/ 1186 h 2151"/>
                <a:gd name="T20" fmla="*/ 2182 w 2587"/>
                <a:gd name="T21" fmla="*/ 1163 h 2151"/>
                <a:gd name="T22" fmla="*/ 2211 w 2587"/>
                <a:gd name="T23" fmla="*/ 1166 h 2151"/>
                <a:gd name="T24" fmla="*/ 2239 w 2587"/>
                <a:gd name="T25" fmla="*/ 1196 h 2151"/>
                <a:gd name="T26" fmla="*/ 2263 w 2587"/>
                <a:gd name="T27" fmla="*/ 1235 h 2151"/>
                <a:gd name="T28" fmla="*/ 2309 w 2587"/>
                <a:gd name="T29" fmla="*/ 1274 h 2151"/>
                <a:gd name="T30" fmla="*/ 2368 w 2587"/>
                <a:gd name="T31" fmla="*/ 1293 h 2151"/>
                <a:gd name="T32" fmla="*/ 2426 w 2587"/>
                <a:gd name="T33" fmla="*/ 1288 h 2151"/>
                <a:gd name="T34" fmla="*/ 2498 w 2587"/>
                <a:gd name="T35" fmla="*/ 1251 h 2151"/>
                <a:gd name="T36" fmla="*/ 2553 w 2587"/>
                <a:gd name="T37" fmla="*/ 1184 h 2151"/>
                <a:gd name="T38" fmla="*/ 2582 w 2587"/>
                <a:gd name="T39" fmla="*/ 1095 h 2151"/>
                <a:gd name="T40" fmla="*/ 2586 w 2587"/>
                <a:gd name="T41" fmla="*/ 1018 h 2151"/>
                <a:gd name="T42" fmla="*/ 2563 w 2587"/>
                <a:gd name="T43" fmla="*/ 926 h 2151"/>
                <a:gd name="T44" fmla="*/ 2514 w 2587"/>
                <a:gd name="T45" fmla="*/ 852 h 2151"/>
                <a:gd name="T46" fmla="*/ 2446 w 2587"/>
                <a:gd name="T47" fmla="*/ 805 h 2151"/>
                <a:gd name="T48" fmla="*/ 2385 w 2587"/>
                <a:gd name="T49" fmla="*/ 794 h 2151"/>
                <a:gd name="T50" fmla="*/ 2322 w 2587"/>
                <a:gd name="T51" fmla="*/ 808 h 2151"/>
                <a:gd name="T52" fmla="*/ 2278 w 2587"/>
                <a:gd name="T53" fmla="*/ 838 h 2151"/>
                <a:gd name="T54" fmla="*/ 2245 w 2587"/>
                <a:gd name="T55" fmla="*/ 882 h 2151"/>
                <a:gd name="T56" fmla="*/ 2218 w 2587"/>
                <a:gd name="T57" fmla="*/ 917 h 2151"/>
                <a:gd name="T58" fmla="*/ 2189 w 2587"/>
                <a:gd name="T59" fmla="*/ 927 h 2151"/>
                <a:gd name="T60" fmla="*/ 2166 w 2587"/>
                <a:gd name="T61" fmla="*/ 911 h 2151"/>
                <a:gd name="T62" fmla="*/ 2156 w 2587"/>
                <a:gd name="T63" fmla="*/ 869 h 2151"/>
                <a:gd name="T64" fmla="*/ 1282 w 2587"/>
                <a:gd name="T65" fmla="*/ 0 h 2151"/>
                <a:gd name="T66" fmla="*/ 1248 w 2587"/>
                <a:gd name="T67" fmla="*/ 6 h 2151"/>
                <a:gd name="T68" fmla="*/ 1227 w 2587"/>
                <a:gd name="T69" fmla="*/ 27 h 2151"/>
                <a:gd name="T70" fmla="*/ 1229 w 2587"/>
                <a:gd name="T71" fmla="*/ 55 h 2151"/>
                <a:gd name="T72" fmla="*/ 1258 w 2587"/>
                <a:gd name="T73" fmla="*/ 83 h 2151"/>
                <a:gd name="T74" fmla="*/ 1297 w 2587"/>
                <a:gd name="T75" fmla="*/ 107 h 2151"/>
                <a:gd name="T76" fmla="*/ 1336 w 2587"/>
                <a:gd name="T77" fmla="*/ 154 h 2151"/>
                <a:gd name="T78" fmla="*/ 1356 w 2587"/>
                <a:gd name="T79" fmla="*/ 213 h 2151"/>
                <a:gd name="T80" fmla="*/ 1352 w 2587"/>
                <a:gd name="T81" fmla="*/ 270 h 2151"/>
                <a:gd name="T82" fmla="*/ 1313 w 2587"/>
                <a:gd name="T83" fmla="*/ 341 h 2151"/>
                <a:gd name="T84" fmla="*/ 1247 w 2587"/>
                <a:gd name="T85" fmla="*/ 397 h 2151"/>
                <a:gd name="T86" fmla="*/ 1157 w 2587"/>
                <a:gd name="T87" fmla="*/ 426 h 2151"/>
                <a:gd name="T88" fmla="*/ 1082 w 2587"/>
                <a:gd name="T89" fmla="*/ 429 h 2151"/>
                <a:gd name="T90" fmla="*/ 988 w 2587"/>
                <a:gd name="T91" fmla="*/ 406 h 2151"/>
                <a:gd name="T92" fmla="*/ 915 w 2587"/>
                <a:gd name="T93" fmla="*/ 358 h 2151"/>
                <a:gd name="T94" fmla="*/ 869 w 2587"/>
                <a:gd name="T95" fmla="*/ 289 h 2151"/>
                <a:gd name="T96" fmla="*/ 858 w 2587"/>
                <a:gd name="T97" fmla="*/ 231 h 215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587" h="2151">
                  <a:moveTo>
                    <a:pt x="858" y="231"/>
                  </a:moveTo>
                  <a:lnTo>
                    <a:pt x="858" y="231"/>
                  </a:lnTo>
                  <a:lnTo>
                    <a:pt x="858" y="213"/>
                  </a:lnTo>
                  <a:lnTo>
                    <a:pt x="861" y="195"/>
                  </a:lnTo>
                  <a:lnTo>
                    <a:pt x="866" y="180"/>
                  </a:lnTo>
                  <a:lnTo>
                    <a:pt x="871" y="166"/>
                  </a:lnTo>
                  <a:lnTo>
                    <a:pt x="877" y="154"/>
                  </a:lnTo>
                  <a:lnTo>
                    <a:pt x="885" y="143"/>
                  </a:lnTo>
                  <a:lnTo>
                    <a:pt x="893" y="131"/>
                  </a:lnTo>
                  <a:lnTo>
                    <a:pt x="902" y="123"/>
                  </a:lnTo>
                  <a:lnTo>
                    <a:pt x="918" y="107"/>
                  </a:lnTo>
                  <a:lnTo>
                    <a:pt x="931" y="97"/>
                  </a:lnTo>
                  <a:lnTo>
                    <a:pt x="946" y="89"/>
                  </a:lnTo>
                  <a:lnTo>
                    <a:pt x="946" y="89"/>
                  </a:lnTo>
                  <a:lnTo>
                    <a:pt x="955" y="83"/>
                  </a:lnTo>
                  <a:lnTo>
                    <a:pt x="965" y="76"/>
                  </a:lnTo>
                  <a:lnTo>
                    <a:pt x="973" y="70"/>
                  </a:lnTo>
                  <a:lnTo>
                    <a:pt x="980" y="62"/>
                  </a:lnTo>
                  <a:lnTo>
                    <a:pt x="985" y="55"/>
                  </a:lnTo>
                  <a:lnTo>
                    <a:pt x="988" y="47"/>
                  </a:lnTo>
                  <a:lnTo>
                    <a:pt x="989" y="40"/>
                  </a:lnTo>
                  <a:lnTo>
                    <a:pt x="989" y="34"/>
                  </a:lnTo>
                  <a:lnTo>
                    <a:pt x="988" y="27"/>
                  </a:lnTo>
                  <a:lnTo>
                    <a:pt x="985" y="21"/>
                  </a:lnTo>
                  <a:lnTo>
                    <a:pt x="980" y="14"/>
                  </a:lnTo>
                  <a:lnTo>
                    <a:pt x="973" y="9"/>
                  </a:lnTo>
                  <a:lnTo>
                    <a:pt x="965" y="6"/>
                  </a:lnTo>
                  <a:lnTo>
                    <a:pt x="955" y="3"/>
                  </a:lnTo>
                  <a:lnTo>
                    <a:pt x="944" y="1"/>
                  </a:lnTo>
                  <a:lnTo>
                    <a:pt x="933" y="0"/>
                  </a:lnTo>
                  <a:lnTo>
                    <a:pt x="0" y="0"/>
                  </a:lnTo>
                  <a:lnTo>
                    <a:pt x="0" y="2151"/>
                  </a:lnTo>
                  <a:lnTo>
                    <a:pt x="2154" y="2151"/>
                  </a:lnTo>
                  <a:lnTo>
                    <a:pt x="2154" y="1656"/>
                  </a:lnTo>
                  <a:lnTo>
                    <a:pt x="2156" y="1656"/>
                  </a:lnTo>
                  <a:lnTo>
                    <a:pt x="2156" y="1220"/>
                  </a:lnTo>
                  <a:lnTo>
                    <a:pt x="2156" y="1220"/>
                  </a:lnTo>
                  <a:lnTo>
                    <a:pt x="2158" y="1207"/>
                  </a:lnTo>
                  <a:lnTo>
                    <a:pt x="2159" y="1196"/>
                  </a:lnTo>
                  <a:lnTo>
                    <a:pt x="2163" y="1186"/>
                  </a:lnTo>
                  <a:lnTo>
                    <a:pt x="2166" y="1178"/>
                  </a:lnTo>
                  <a:lnTo>
                    <a:pt x="2171" y="1171"/>
                  </a:lnTo>
                  <a:lnTo>
                    <a:pt x="2177" y="1166"/>
                  </a:lnTo>
                  <a:lnTo>
                    <a:pt x="2182" y="1163"/>
                  </a:lnTo>
                  <a:lnTo>
                    <a:pt x="2189" y="1161"/>
                  </a:lnTo>
                  <a:lnTo>
                    <a:pt x="2197" y="1161"/>
                  </a:lnTo>
                  <a:lnTo>
                    <a:pt x="2203" y="1163"/>
                  </a:lnTo>
                  <a:lnTo>
                    <a:pt x="2211" y="1166"/>
                  </a:lnTo>
                  <a:lnTo>
                    <a:pt x="2218" y="1171"/>
                  </a:lnTo>
                  <a:lnTo>
                    <a:pt x="2226" y="1178"/>
                  </a:lnTo>
                  <a:lnTo>
                    <a:pt x="2232" y="1186"/>
                  </a:lnTo>
                  <a:lnTo>
                    <a:pt x="2239" y="1196"/>
                  </a:lnTo>
                  <a:lnTo>
                    <a:pt x="2245" y="1207"/>
                  </a:lnTo>
                  <a:lnTo>
                    <a:pt x="2245" y="1207"/>
                  </a:lnTo>
                  <a:lnTo>
                    <a:pt x="2254" y="1220"/>
                  </a:lnTo>
                  <a:lnTo>
                    <a:pt x="2263" y="1235"/>
                  </a:lnTo>
                  <a:lnTo>
                    <a:pt x="2278" y="1251"/>
                  </a:lnTo>
                  <a:lnTo>
                    <a:pt x="2288" y="1259"/>
                  </a:lnTo>
                  <a:lnTo>
                    <a:pt x="2298" y="1266"/>
                  </a:lnTo>
                  <a:lnTo>
                    <a:pt x="2309" y="1274"/>
                  </a:lnTo>
                  <a:lnTo>
                    <a:pt x="2322" y="1280"/>
                  </a:lnTo>
                  <a:lnTo>
                    <a:pt x="2337" y="1285"/>
                  </a:lnTo>
                  <a:lnTo>
                    <a:pt x="2351" y="1290"/>
                  </a:lnTo>
                  <a:lnTo>
                    <a:pt x="2368" y="1293"/>
                  </a:lnTo>
                  <a:lnTo>
                    <a:pt x="2385" y="1293"/>
                  </a:lnTo>
                  <a:lnTo>
                    <a:pt x="2385" y="1293"/>
                  </a:lnTo>
                  <a:lnTo>
                    <a:pt x="2407" y="1293"/>
                  </a:lnTo>
                  <a:lnTo>
                    <a:pt x="2426" y="1288"/>
                  </a:lnTo>
                  <a:lnTo>
                    <a:pt x="2446" y="1283"/>
                  </a:lnTo>
                  <a:lnTo>
                    <a:pt x="2463" y="1274"/>
                  </a:lnTo>
                  <a:lnTo>
                    <a:pt x="2481" y="1264"/>
                  </a:lnTo>
                  <a:lnTo>
                    <a:pt x="2498" y="1251"/>
                  </a:lnTo>
                  <a:lnTo>
                    <a:pt x="2514" y="1236"/>
                  </a:lnTo>
                  <a:lnTo>
                    <a:pt x="2527" y="1220"/>
                  </a:lnTo>
                  <a:lnTo>
                    <a:pt x="2540" y="1204"/>
                  </a:lnTo>
                  <a:lnTo>
                    <a:pt x="2553" y="1184"/>
                  </a:lnTo>
                  <a:lnTo>
                    <a:pt x="2563" y="1163"/>
                  </a:lnTo>
                  <a:lnTo>
                    <a:pt x="2571" y="1142"/>
                  </a:lnTo>
                  <a:lnTo>
                    <a:pt x="2577" y="1119"/>
                  </a:lnTo>
                  <a:lnTo>
                    <a:pt x="2582" y="1095"/>
                  </a:lnTo>
                  <a:lnTo>
                    <a:pt x="2586" y="1070"/>
                  </a:lnTo>
                  <a:lnTo>
                    <a:pt x="2587" y="1044"/>
                  </a:lnTo>
                  <a:lnTo>
                    <a:pt x="2587" y="1044"/>
                  </a:lnTo>
                  <a:lnTo>
                    <a:pt x="2586" y="1018"/>
                  </a:lnTo>
                  <a:lnTo>
                    <a:pt x="2582" y="994"/>
                  </a:lnTo>
                  <a:lnTo>
                    <a:pt x="2577" y="969"/>
                  </a:lnTo>
                  <a:lnTo>
                    <a:pt x="2571" y="947"/>
                  </a:lnTo>
                  <a:lnTo>
                    <a:pt x="2563" y="926"/>
                  </a:lnTo>
                  <a:lnTo>
                    <a:pt x="2553" y="904"/>
                  </a:lnTo>
                  <a:lnTo>
                    <a:pt x="2540" y="885"/>
                  </a:lnTo>
                  <a:lnTo>
                    <a:pt x="2527" y="867"/>
                  </a:lnTo>
                  <a:lnTo>
                    <a:pt x="2514" y="852"/>
                  </a:lnTo>
                  <a:lnTo>
                    <a:pt x="2498" y="838"/>
                  </a:lnTo>
                  <a:lnTo>
                    <a:pt x="2481" y="825"/>
                  </a:lnTo>
                  <a:lnTo>
                    <a:pt x="2463" y="815"/>
                  </a:lnTo>
                  <a:lnTo>
                    <a:pt x="2446" y="805"/>
                  </a:lnTo>
                  <a:lnTo>
                    <a:pt x="2426" y="800"/>
                  </a:lnTo>
                  <a:lnTo>
                    <a:pt x="2407" y="795"/>
                  </a:lnTo>
                  <a:lnTo>
                    <a:pt x="2385" y="794"/>
                  </a:lnTo>
                  <a:lnTo>
                    <a:pt x="2385" y="794"/>
                  </a:lnTo>
                  <a:lnTo>
                    <a:pt x="2368" y="795"/>
                  </a:lnTo>
                  <a:lnTo>
                    <a:pt x="2351" y="799"/>
                  </a:lnTo>
                  <a:lnTo>
                    <a:pt x="2337" y="802"/>
                  </a:lnTo>
                  <a:lnTo>
                    <a:pt x="2322" y="808"/>
                  </a:lnTo>
                  <a:lnTo>
                    <a:pt x="2309" y="815"/>
                  </a:lnTo>
                  <a:lnTo>
                    <a:pt x="2298" y="821"/>
                  </a:lnTo>
                  <a:lnTo>
                    <a:pt x="2288" y="830"/>
                  </a:lnTo>
                  <a:lnTo>
                    <a:pt x="2278" y="838"/>
                  </a:lnTo>
                  <a:lnTo>
                    <a:pt x="2263" y="854"/>
                  </a:lnTo>
                  <a:lnTo>
                    <a:pt x="2254" y="869"/>
                  </a:lnTo>
                  <a:lnTo>
                    <a:pt x="2245" y="882"/>
                  </a:lnTo>
                  <a:lnTo>
                    <a:pt x="2245" y="882"/>
                  </a:lnTo>
                  <a:lnTo>
                    <a:pt x="2239" y="893"/>
                  </a:lnTo>
                  <a:lnTo>
                    <a:pt x="2232" y="903"/>
                  </a:lnTo>
                  <a:lnTo>
                    <a:pt x="2226" y="911"/>
                  </a:lnTo>
                  <a:lnTo>
                    <a:pt x="2218" y="917"/>
                  </a:lnTo>
                  <a:lnTo>
                    <a:pt x="2211" y="922"/>
                  </a:lnTo>
                  <a:lnTo>
                    <a:pt x="2203" y="926"/>
                  </a:lnTo>
                  <a:lnTo>
                    <a:pt x="2197" y="927"/>
                  </a:lnTo>
                  <a:lnTo>
                    <a:pt x="2189" y="927"/>
                  </a:lnTo>
                  <a:lnTo>
                    <a:pt x="2182" y="926"/>
                  </a:lnTo>
                  <a:lnTo>
                    <a:pt x="2177" y="922"/>
                  </a:lnTo>
                  <a:lnTo>
                    <a:pt x="2171" y="917"/>
                  </a:lnTo>
                  <a:lnTo>
                    <a:pt x="2166" y="911"/>
                  </a:lnTo>
                  <a:lnTo>
                    <a:pt x="2163" y="903"/>
                  </a:lnTo>
                  <a:lnTo>
                    <a:pt x="2159" y="893"/>
                  </a:lnTo>
                  <a:lnTo>
                    <a:pt x="2158" y="882"/>
                  </a:lnTo>
                  <a:lnTo>
                    <a:pt x="2156" y="869"/>
                  </a:lnTo>
                  <a:lnTo>
                    <a:pt x="2156" y="595"/>
                  </a:lnTo>
                  <a:lnTo>
                    <a:pt x="2154" y="595"/>
                  </a:lnTo>
                  <a:lnTo>
                    <a:pt x="2154" y="0"/>
                  </a:lnTo>
                  <a:lnTo>
                    <a:pt x="1282" y="0"/>
                  </a:lnTo>
                  <a:lnTo>
                    <a:pt x="1282" y="0"/>
                  </a:lnTo>
                  <a:lnTo>
                    <a:pt x="1269" y="1"/>
                  </a:lnTo>
                  <a:lnTo>
                    <a:pt x="1258" y="3"/>
                  </a:lnTo>
                  <a:lnTo>
                    <a:pt x="1248" y="6"/>
                  </a:lnTo>
                  <a:lnTo>
                    <a:pt x="1242" y="9"/>
                  </a:lnTo>
                  <a:lnTo>
                    <a:pt x="1235" y="14"/>
                  </a:lnTo>
                  <a:lnTo>
                    <a:pt x="1230" y="21"/>
                  </a:lnTo>
                  <a:lnTo>
                    <a:pt x="1227" y="27"/>
                  </a:lnTo>
                  <a:lnTo>
                    <a:pt x="1225" y="34"/>
                  </a:lnTo>
                  <a:lnTo>
                    <a:pt x="1225" y="40"/>
                  </a:lnTo>
                  <a:lnTo>
                    <a:pt x="1225" y="47"/>
                  </a:lnTo>
                  <a:lnTo>
                    <a:pt x="1229" y="55"/>
                  </a:lnTo>
                  <a:lnTo>
                    <a:pt x="1234" y="62"/>
                  </a:lnTo>
                  <a:lnTo>
                    <a:pt x="1240" y="70"/>
                  </a:lnTo>
                  <a:lnTo>
                    <a:pt x="1248" y="76"/>
                  </a:lnTo>
                  <a:lnTo>
                    <a:pt x="1258" y="83"/>
                  </a:lnTo>
                  <a:lnTo>
                    <a:pt x="1269" y="89"/>
                  </a:lnTo>
                  <a:lnTo>
                    <a:pt x="1269" y="89"/>
                  </a:lnTo>
                  <a:lnTo>
                    <a:pt x="1282" y="97"/>
                  </a:lnTo>
                  <a:lnTo>
                    <a:pt x="1297" y="107"/>
                  </a:lnTo>
                  <a:lnTo>
                    <a:pt x="1313" y="123"/>
                  </a:lnTo>
                  <a:lnTo>
                    <a:pt x="1321" y="131"/>
                  </a:lnTo>
                  <a:lnTo>
                    <a:pt x="1329" y="143"/>
                  </a:lnTo>
                  <a:lnTo>
                    <a:pt x="1336" y="154"/>
                  </a:lnTo>
                  <a:lnTo>
                    <a:pt x="1343" y="166"/>
                  </a:lnTo>
                  <a:lnTo>
                    <a:pt x="1349" y="180"/>
                  </a:lnTo>
                  <a:lnTo>
                    <a:pt x="1352" y="195"/>
                  </a:lnTo>
                  <a:lnTo>
                    <a:pt x="1356" y="213"/>
                  </a:lnTo>
                  <a:lnTo>
                    <a:pt x="1357" y="231"/>
                  </a:lnTo>
                  <a:lnTo>
                    <a:pt x="1357" y="231"/>
                  </a:lnTo>
                  <a:lnTo>
                    <a:pt x="1356" y="250"/>
                  </a:lnTo>
                  <a:lnTo>
                    <a:pt x="1352" y="270"/>
                  </a:lnTo>
                  <a:lnTo>
                    <a:pt x="1346" y="289"/>
                  </a:lnTo>
                  <a:lnTo>
                    <a:pt x="1338" y="307"/>
                  </a:lnTo>
                  <a:lnTo>
                    <a:pt x="1326" y="325"/>
                  </a:lnTo>
                  <a:lnTo>
                    <a:pt x="1313" y="341"/>
                  </a:lnTo>
                  <a:lnTo>
                    <a:pt x="1300" y="358"/>
                  </a:lnTo>
                  <a:lnTo>
                    <a:pt x="1284" y="372"/>
                  </a:lnTo>
                  <a:lnTo>
                    <a:pt x="1266" y="385"/>
                  </a:lnTo>
                  <a:lnTo>
                    <a:pt x="1247" y="397"/>
                  </a:lnTo>
                  <a:lnTo>
                    <a:pt x="1225" y="406"/>
                  </a:lnTo>
                  <a:lnTo>
                    <a:pt x="1204" y="415"/>
                  </a:lnTo>
                  <a:lnTo>
                    <a:pt x="1181" y="421"/>
                  </a:lnTo>
                  <a:lnTo>
                    <a:pt x="1157" y="426"/>
                  </a:lnTo>
                  <a:lnTo>
                    <a:pt x="1133" y="429"/>
                  </a:lnTo>
                  <a:lnTo>
                    <a:pt x="1107" y="431"/>
                  </a:lnTo>
                  <a:lnTo>
                    <a:pt x="1107" y="431"/>
                  </a:lnTo>
                  <a:lnTo>
                    <a:pt x="1082" y="429"/>
                  </a:lnTo>
                  <a:lnTo>
                    <a:pt x="1056" y="426"/>
                  </a:lnTo>
                  <a:lnTo>
                    <a:pt x="1033" y="421"/>
                  </a:lnTo>
                  <a:lnTo>
                    <a:pt x="1011" y="415"/>
                  </a:lnTo>
                  <a:lnTo>
                    <a:pt x="988" y="406"/>
                  </a:lnTo>
                  <a:lnTo>
                    <a:pt x="967" y="397"/>
                  </a:lnTo>
                  <a:lnTo>
                    <a:pt x="949" y="385"/>
                  </a:lnTo>
                  <a:lnTo>
                    <a:pt x="931" y="372"/>
                  </a:lnTo>
                  <a:lnTo>
                    <a:pt x="915" y="358"/>
                  </a:lnTo>
                  <a:lnTo>
                    <a:pt x="900" y="341"/>
                  </a:lnTo>
                  <a:lnTo>
                    <a:pt x="887" y="325"/>
                  </a:lnTo>
                  <a:lnTo>
                    <a:pt x="877" y="307"/>
                  </a:lnTo>
                  <a:lnTo>
                    <a:pt x="869" y="289"/>
                  </a:lnTo>
                  <a:lnTo>
                    <a:pt x="863" y="270"/>
                  </a:lnTo>
                  <a:lnTo>
                    <a:pt x="859" y="250"/>
                  </a:lnTo>
                  <a:lnTo>
                    <a:pt x="858" y="231"/>
                  </a:lnTo>
                  <a:lnTo>
                    <a:pt x="858" y="231"/>
                  </a:lnTo>
                  <a:close/>
                </a:path>
              </a:pathLst>
            </a:custGeom>
            <a:solidFill>
              <a:srgbClr val="FFFF00"/>
            </a:solidFill>
            <a:ln w="28575">
              <a:solidFill>
                <a:schemeClr val="tx1">
                  <a:lumMod val="50000"/>
                  <a:lumOff val="50000"/>
                </a:schemeClr>
              </a:solidFill>
              <a:prstDash val="solid"/>
              <a:round/>
              <a:headEnd/>
              <a:tailEnd/>
            </a:ln>
          </p:spPr>
          <p:txBody>
            <a:bodyPr rIns="468000" anchor="ctr" anchorCtr="1"/>
            <a:lstStyle/>
            <a:p>
              <a:pPr defTabSz="457200">
                <a:defRPr/>
              </a:pPr>
              <a:r>
                <a:rPr lang="en-US" sz="4000" dirty="0">
                  <a:solidFill>
                    <a:prstClr val="black"/>
                  </a:solidFill>
                </a:rPr>
                <a:t>C</a:t>
              </a:r>
              <a:endParaRPr lang="en-GB" sz="4000" dirty="0">
                <a:solidFill>
                  <a:prstClr val="black"/>
                </a:solidFill>
                <a:cs typeface="Arial" charset="0"/>
              </a:endParaRPr>
            </a:p>
          </p:txBody>
        </p:sp>
        <p:sp>
          <p:nvSpPr>
            <p:cNvPr id="8" name="Freeform 7">
              <a:extLst>
                <a:ext uri="{FF2B5EF4-FFF2-40B4-BE49-F238E27FC236}">
                  <a16:creationId xmlns:a16="http://schemas.microsoft.com/office/drawing/2014/main" xmlns="" id="{637B46C9-37C3-C34B-8FB0-8A48F5C554E9}"/>
                </a:ext>
              </a:extLst>
            </p:cNvPr>
            <p:cNvSpPr>
              <a:spLocks/>
            </p:cNvSpPr>
            <p:nvPr/>
          </p:nvSpPr>
          <p:spPr bwMode="auto">
            <a:xfrm>
              <a:off x="6248889" y="2147578"/>
              <a:ext cx="1265421" cy="1164853"/>
            </a:xfrm>
            <a:custGeom>
              <a:avLst/>
              <a:gdLst>
                <a:gd name="T0" fmla="*/ 1726 w 2587"/>
                <a:gd name="T1" fmla="*/ 1956 h 2150"/>
                <a:gd name="T2" fmla="*/ 1702 w 2587"/>
                <a:gd name="T3" fmla="*/ 2008 h 2150"/>
                <a:gd name="T4" fmla="*/ 1656 w 2587"/>
                <a:gd name="T5" fmla="*/ 2054 h 2150"/>
                <a:gd name="T6" fmla="*/ 1620 w 2587"/>
                <a:gd name="T7" fmla="*/ 2075 h 2150"/>
                <a:gd name="T8" fmla="*/ 1599 w 2587"/>
                <a:gd name="T9" fmla="*/ 2104 h 2150"/>
                <a:gd name="T10" fmla="*/ 1602 w 2587"/>
                <a:gd name="T11" fmla="*/ 2130 h 2150"/>
                <a:gd name="T12" fmla="*/ 1632 w 2587"/>
                <a:gd name="T13" fmla="*/ 2148 h 2150"/>
                <a:gd name="T14" fmla="*/ 2587 w 2587"/>
                <a:gd name="T15" fmla="*/ 0 h 2150"/>
                <a:gd name="T16" fmla="*/ 429 w 2587"/>
                <a:gd name="T17" fmla="*/ 931 h 2150"/>
                <a:gd name="T18" fmla="*/ 424 w 2587"/>
                <a:gd name="T19" fmla="*/ 965 h 2150"/>
                <a:gd name="T20" fmla="*/ 403 w 2587"/>
                <a:gd name="T21" fmla="*/ 988 h 2150"/>
                <a:gd name="T22" fmla="*/ 376 w 2587"/>
                <a:gd name="T23" fmla="*/ 985 h 2150"/>
                <a:gd name="T24" fmla="*/ 348 w 2587"/>
                <a:gd name="T25" fmla="*/ 955 h 2150"/>
                <a:gd name="T26" fmla="*/ 324 w 2587"/>
                <a:gd name="T27" fmla="*/ 916 h 2150"/>
                <a:gd name="T28" fmla="*/ 276 w 2587"/>
                <a:gd name="T29" fmla="*/ 877 h 2150"/>
                <a:gd name="T30" fmla="*/ 218 w 2587"/>
                <a:gd name="T31" fmla="*/ 858 h 2150"/>
                <a:gd name="T32" fmla="*/ 161 w 2587"/>
                <a:gd name="T33" fmla="*/ 863 h 2150"/>
                <a:gd name="T34" fmla="*/ 89 w 2587"/>
                <a:gd name="T35" fmla="*/ 900 h 2150"/>
                <a:gd name="T36" fmla="*/ 34 w 2587"/>
                <a:gd name="T37" fmla="*/ 967 h 2150"/>
                <a:gd name="T38" fmla="*/ 5 w 2587"/>
                <a:gd name="T39" fmla="*/ 1056 h 2150"/>
                <a:gd name="T40" fmla="*/ 1 w 2587"/>
                <a:gd name="T41" fmla="*/ 1133 h 2150"/>
                <a:gd name="T42" fmla="*/ 24 w 2587"/>
                <a:gd name="T43" fmla="*/ 1225 h 2150"/>
                <a:gd name="T44" fmla="*/ 73 w 2587"/>
                <a:gd name="T45" fmla="*/ 1299 h 2150"/>
                <a:gd name="T46" fmla="*/ 141 w 2587"/>
                <a:gd name="T47" fmla="*/ 1346 h 2150"/>
                <a:gd name="T48" fmla="*/ 200 w 2587"/>
                <a:gd name="T49" fmla="*/ 1356 h 2150"/>
                <a:gd name="T50" fmla="*/ 263 w 2587"/>
                <a:gd name="T51" fmla="*/ 1343 h 2150"/>
                <a:gd name="T52" fmla="*/ 307 w 2587"/>
                <a:gd name="T53" fmla="*/ 1313 h 2150"/>
                <a:gd name="T54" fmla="*/ 342 w 2587"/>
                <a:gd name="T55" fmla="*/ 1269 h 2150"/>
                <a:gd name="T56" fmla="*/ 369 w 2587"/>
                <a:gd name="T57" fmla="*/ 1234 h 2150"/>
                <a:gd name="T58" fmla="*/ 397 w 2587"/>
                <a:gd name="T59" fmla="*/ 1224 h 2150"/>
                <a:gd name="T60" fmla="*/ 421 w 2587"/>
                <a:gd name="T61" fmla="*/ 1240 h 2150"/>
                <a:gd name="T62" fmla="*/ 429 w 2587"/>
                <a:gd name="T63" fmla="*/ 1282 h 2150"/>
                <a:gd name="T64" fmla="*/ 1305 w 2587"/>
                <a:gd name="T65" fmla="*/ 2150 h 2150"/>
                <a:gd name="T66" fmla="*/ 1337 w 2587"/>
                <a:gd name="T67" fmla="*/ 2145 h 2150"/>
                <a:gd name="T68" fmla="*/ 1360 w 2587"/>
                <a:gd name="T69" fmla="*/ 2124 h 2150"/>
                <a:gd name="T70" fmla="*/ 1357 w 2587"/>
                <a:gd name="T71" fmla="*/ 2096 h 2150"/>
                <a:gd name="T72" fmla="*/ 1329 w 2587"/>
                <a:gd name="T73" fmla="*/ 2068 h 2150"/>
                <a:gd name="T74" fmla="*/ 1290 w 2587"/>
                <a:gd name="T75" fmla="*/ 2044 h 2150"/>
                <a:gd name="T76" fmla="*/ 1251 w 2587"/>
                <a:gd name="T77" fmla="*/ 1997 h 2150"/>
                <a:gd name="T78" fmla="*/ 1231 w 2587"/>
                <a:gd name="T79" fmla="*/ 1938 h 2150"/>
                <a:gd name="T80" fmla="*/ 1235 w 2587"/>
                <a:gd name="T81" fmla="*/ 1881 h 2150"/>
                <a:gd name="T82" fmla="*/ 1272 w 2587"/>
                <a:gd name="T83" fmla="*/ 1810 h 2150"/>
                <a:gd name="T84" fmla="*/ 1340 w 2587"/>
                <a:gd name="T85" fmla="*/ 1754 h 2150"/>
                <a:gd name="T86" fmla="*/ 1430 w 2587"/>
                <a:gd name="T87" fmla="*/ 1725 h 2150"/>
                <a:gd name="T88" fmla="*/ 1505 w 2587"/>
                <a:gd name="T89" fmla="*/ 1722 h 2150"/>
                <a:gd name="T90" fmla="*/ 1599 w 2587"/>
                <a:gd name="T91" fmla="*/ 1745 h 2150"/>
                <a:gd name="T92" fmla="*/ 1672 w 2587"/>
                <a:gd name="T93" fmla="*/ 1793 h 2150"/>
                <a:gd name="T94" fmla="*/ 1718 w 2587"/>
                <a:gd name="T95" fmla="*/ 1862 h 2150"/>
                <a:gd name="T96" fmla="*/ 1729 w 2587"/>
                <a:gd name="T97" fmla="*/ 1920 h 21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587" h="2150">
                  <a:moveTo>
                    <a:pt x="1729" y="1920"/>
                  </a:moveTo>
                  <a:lnTo>
                    <a:pt x="1729" y="1920"/>
                  </a:lnTo>
                  <a:lnTo>
                    <a:pt x="1728" y="1938"/>
                  </a:lnTo>
                  <a:lnTo>
                    <a:pt x="1726" y="1956"/>
                  </a:lnTo>
                  <a:lnTo>
                    <a:pt x="1721" y="1971"/>
                  </a:lnTo>
                  <a:lnTo>
                    <a:pt x="1716" y="1984"/>
                  </a:lnTo>
                  <a:lnTo>
                    <a:pt x="1710" y="1997"/>
                  </a:lnTo>
                  <a:lnTo>
                    <a:pt x="1702" y="2008"/>
                  </a:lnTo>
                  <a:lnTo>
                    <a:pt x="1694" y="2020"/>
                  </a:lnTo>
                  <a:lnTo>
                    <a:pt x="1685" y="2028"/>
                  </a:lnTo>
                  <a:lnTo>
                    <a:pt x="1669" y="2044"/>
                  </a:lnTo>
                  <a:lnTo>
                    <a:pt x="1656" y="2054"/>
                  </a:lnTo>
                  <a:lnTo>
                    <a:pt x="1641" y="2062"/>
                  </a:lnTo>
                  <a:lnTo>
                    <a:pt x="1641" y="2062"/>
                  </a:lnTo>
                  <a:lnTo>
                    <a:pt x="1630" y="2068"/>
                  </a:lnTo>
                  <a:lnTo>
                    <a:pt x="1620" y="2075"/>
                  </a:lnTo>
                  <a:lnTo>
                    <a:pt x="1614" y="2081"/>
                  </a:lnTo>
                  <a:lnTo>
                    <a:pt x="1607" y="2089"/>
                  </a:lnTo>
                  <a:lnTo>
                    <a:pt x="1602" y="2096"/>
                  </a:lnTo>
                  <a:lnTo>
                    <a:pt x="1599" y="2104"/>
                  </a:lnTo>
                  <a:lnTo>
                    <a:pt x="1598" y="2111"/>
                  </a:lnTo>
                  <a:lnTo>
                    <a:pt x="1598" y="2117"/>
                  </a:lnTo>
                  <a:lnTo>
                    <a:pt x="1599" y="2124"/>
                  </a:lnTo>
                  <a:lnTo>
                    <a:pt x="1602" y="2130"/>
                  </a:lnTo>
                  <a:lnTo>
                    <a:pt x="1607" y="2137"/>
                  </a:lnTo>
                  <a:lnTo>
                    <a:pt x="1614" y="2142"/>
                  </a:lnTo>
                  <a:lnTo>
                    <a:pt x="1622" y="2145"/>
                  </a:lnTo>
                  <a:lnTo>
                    <a:pt x="1632" y="2148"/>
                  </a:lnTo>
                  <a:lnTo>
                    <a:pt x="1641" y="2150"/>
                  </a:lnTo>
                  <a:lnTo>
                    <a:pt x="1654" y="2150"/>
                  </a:lnTo>
                  <a:lnTo>
                    <a:pt x="2587" y="2150"/>
                  </a:lnTo>
                  <a:lnTo>
                    <a:pt x="2587" y="0"/>
                  </a:lnTo>
                  <a:lnTo>
                    <a:pt x="433" y="0"/>
                  </a:lnTo>
                  <a:lnTo>
                    <a:pt x="433" y="495"/>
                  </a:lnTo>
                  <a:lnTo>
                    <a:pt x="429" y="495"/>
                  </a:lnTo>
                  <a:lnTo>
                    <a:pt x="429" y="931"/>
                  </a:lnTo>
                  <a:lnTo>
                    <a:pt x="429" y="931"/>
                  </a:lnTo>
                  <a:lnTo>
                    <a:pt x="429" y="944"/>
                  </a:lnTo>
                  <a:lnTo>
                    <a:pt x="428" y="955"/>
                  </a:lnTo>
                  <a:lnTo>
                    <a:pt x="424" y="965"/>
                  </a:lnTo>
                  <a:lnTo>
                    <a:pt x="421" y="973"/>
                  </a:lnTo>
                  <a:lnTo>
                    <a:pt x="416" y="980"/>
                  </a:lnTo>
                  <a:lnTo>
                    <a:pt x="410" y="985"/>
                  </a:lnTo>
                  <a:lnTo>
                    <a:pt x="403" y="988"/>
                  </a:lnTo>
                  <a:lnTo>
                    <a:pt x="397" y="990"/>
                  </a:lnTo>
                  <a:lnTo>
                    <a:pt x="390" y="990"/>
                  </a:lnTo>
                  <a:lnTo>
                    <a:pt x="384" y="988"/>
                  </a:lnTo>
                  <a:lnTo>
                    <a:pt x="376" y="985"/>
                  </a:lnTo>
                  <a:lnTo>
                    <a:pt x="369" y="980"/>
                  </a:lnTo>
                  <a:lnTo>
                    <a:pt x="361" y="973"/>
                  </a:lnTo>
                  <a:lnTo>
                    <a:pt x="355" y="965"/>
                  </a:lnTo>
                  <a:lnTo>
                    <a:pt x="348" y="955"/>
                  </a:lnTo>
                  <a:lnTo>
                    <a:pt x="342" y="944"/>
                  </a:lnTo>
                  <a:lnTo>
                    <a:pt x="342" y="944"/>
                  </a:lnTo>
                  <a:lnTo>
                    <a:pt x="333" y="931"/>
                  </a:lnTo>
                  <a:lnTo>
                    <a:pt x="324" y="916"/>
                  </a:lnTo>
                  <a:lnTo>
                    <a:pt x="307" y="900"/>
                  </a:lnTo>
                  <a:lnTo>
                    <a:pt x="299" y="892"/>
                  </a:lnTo>
                  <a:lnTo>
                    <a:pt x="288" y="885"/>
                  </a:lnTo>
                  <a:lnTo>
                    <a:pt x="276" y="877"/>
                  </a:lnTo>
                  <a:lnTo>
                    <a:pt x="263" y="871"/>
                  </a:lnTo>
                  <a:lnTo>
                    <a:pt x="250" y="866"/>
                  </a:lnTo>
                  <a:lnTo>
                    <a:pt x="236" y="861"/>
                  </a:lnTo>
                  <a:lnTo>
                    <a:pt x="218" y="858"/>
                  </a:lnTo>
                  <a:lnTo>
                    <a:pt x="200" y="858"/>
                  </a:lnTo>
                  <a:lnTo>
                    <a:pt x="200" y="858"/>
                  </a:lnTo>
                  <a:lnTo>
                    <a:pt x="180" y="858"/>
                  </a:lnTo>
                  <a:lnTo>
                    <a:pt x="161" y="863"/>
                  </a:lnTo>
                  <a:lnTo>
                    <a:pt x="141" y="868"/>
                  </a:lnTo>
                  <a:lnTo>
                    <a:pt x="122" y="877"/>
                  </a:lnTo>
                  <a:lnTo>
                    <a:pt x="106" y="887"/>
                  </a:lnTo>
                  <a:lnTo>
                    <a:pt x="89" y="900"/>
                  </a:lnTo>
                  <a:lnTo>
                    <a:pt x="73" y="915"/>
                  </a:lnTo>
                  <a:lnTo>
                    <a:pt x="58" y="931"/>
                  </a:lnTo>
                  <a:lnTo>
                    <a:pt x="45" y="947"/>
                  </a:lnTo>
                  <a:lnTo>
                    <a:pt x="34" y="967"/>
                  </a:lnTo>
                  <a:lnTo>
                    <a:pt x="24" y="988"/>
                  </a:lnTo>
                  <a:lnTo>
                    <a:pt x="16" y="1009"/>
                  </a:lnTo>
                  <a:lnTo>
                    <a:pt x="10" y="1032"/>
                  </a:lnTo>
                  <a:lnTo>
                    <a:pt x="5" y="1056"/>
                  </a:lnTo>
                  <a:lnTo>
                    <a:pt x="1" y="1081"/>
                  </a:lnTo>
                  <a:lnTo>
                    <a:pt x="0" y="1107"/>
                  </a:lnTo>
                  <a:lnTo>
                    <a:pt x="0" y="1107"/>
                  </a:lnTo>
                  <a:lnTo>
                    <a:pt x="1" y="1133"/>
                  </a:lnTo>
                  <a:lnTo>
                    <a:pt x="5" y="1157"/>
                  </a:lnTo>
                  <a:lnTo>
                    <a:pt x="10" y="1182"/>
                  </a:lnTo>
                  <a:lnTo>
                    <a:pt x="16" y="1204"/>
                  </a:lnTo>
                  <a:lnTo>
                    <a:pt x="24" y="1225"/>
                  </a:lnTo>
                  <a:lnTo>
                    <a:pt x="34" y="1247"/>
                  </a:lnTo>
                  <a:lnTo>
                    <a:pt x="45" y="1266"/>
                  </a:lnTo>
                  <a:lnTo>
                    <a:pt x="58" y="1284"/>
                  </a:lnTo>
                  <a:lnTo>
                    <a:pt x="73" y="1299"/>
                  </a:lnTo>
                  <a:lnTo>
                    <a:pt x="89" y="1313"/>
                  </a:lnTo>
                  <a:lnTo>
                    <a:pt x="106" y="1326"/>
                  </a:lnTo>
                  <a:lnTo>
                    <a:pt x="122" y="1336"/>
                  </a:lnTo>
                  <a:lnTo>
                    <a:pt x="141" y="1346"/>
                  </a:lnTo>
                  <a:lnTo>
                    <a:pt x="161" y="1351"/>
                  </a:lnTo>
                  <a:lnTo>
                    <a:pt x="180" y="1356"/>
                  </a:lnTo>
                  <a:lnTo>
                    <a:pt x="200" y="1356"/>
                  </a:lnTo>
                  <a:lnTo>
                    <a:pt x="200" y="1356"/>
                  </a:lnTo>
                  <a:lnTo>
                    <a:pt x="218" y="1356"/>
                  </a:lnTo>
                  <a:lnTo>
                    <a:pt x="236" y="1352"/>
                  </a:lnTo>
                  <a:lnTo>
                    <a:pt x="250" y="1349"/>
                  </a:lnTo>
                  <a:lnTo>
                    <a:pt x="263" y="1343"/>
                  </a:lnTo>
                  <a:lnTo>
                    <a:pt x="276" y="1336"/>
                  </a:lnTo>
                  <a:lnTo>
                    <a:pt x="288" y="1328"/>
                  </a:lnTo>
                  <a:lnTo>
                    <a:pt x="299" y="1321"/>
                  </a:lnTo>
                  <a:lnTo>
                    <a:pt x="307" y="1313"/>
                  </a:lnTo>
                  <a:lnTo>
                    <a:pt x="324" y="1297"/>
                  </a:lnTo>
                  <a:lnTo>
                    <a:pt x="333" y="1282"/>
                  </a:lnTo>
                  <a:lnTo>
                    <a:pt x="342" y="1269"/>
                  </a:lnTo>
                  <a:lnTo>
                    <a:pt x="342" y="1269"/>
                  </a:lnTo>
                  <a:lnTo>
                    <a:pt x="348" y="1258"/>
                  </a:lnTo>
                  <a:lnTo>
                    <a:pt x="355" y="1248"/>
                  </a:lnTo>
                  <a:lnTo>
                    <a:pt x="361" y="1240"/>
                  </a:lnTo>
                  <a:lnTo>
                    <a:pt x="369" y="1234"/>
                  </a:lnTo>
                  <a:lnTo>
                    <a:pt x="376" y="1229"/>
                  </a:lnTo>
                  <a:lnTo>
                    <a:pt x="384" y="1225"/>
                  </a:lnTo>
                  <a:lnTo>
                    <a:pt x="390" y="1224"/>
                  </a:lnTo>
                  <a:lnTo>
                    <a:pt x="397" y="1224"/>
                  </a:lnTo>
                  <a:lnTo>
                    <a:pt x="403" y="1225"/>
                  </a:lnTo>
                  <a:lnTo>
                    <a:pt x="410" y="1229"/>
                  </a:lnTo>
                  <a:lnTo>
                    <a:pt x="416" y="1234"/>
                  </a:lnTo>
                  <a:lnTo>
                    <a:pt x="421" y="1240"/>
                  </a:lnTo>
                  <a:lnTo>
                    <a:pt x="424" y="1248"/>
                  </a:lnTo>
                  <a:lnTo>
                    <a:pt x="428" y="1258"/>
                  </a:lnTo>
                  <a:lnTo>
                    <a:pt x="429" y="1269"/>
                  </a:lnTo>
                  <a:lnTo>
                    <a:pt x="429" y="1282"/>
                  </a:lnTo>
                  <a:lnTo>
                    <a:pt x="429" y="1556"/>
                  </a:lnTo>
                  <a:lnTo>
                    <a:pt x="433" y="1556"/>
                  </a:lnTo>
                  <a:lnTo>
                    <a:pt x="433" y="2150"/>
                  </a:lnTo>
                  <a:lnTo>
                    <a:pt x="1305" y="2150"/>
                  </a:lnTo>
                  <a:lnTo>
                    <a:pt x="1305" y="2150"/>
                  </a:lnTo>
                  <a:lnTo>
                    <a:pt x="1318" y="2150"/>
                  </a:lnTo>
                  <a:lnTo>
                    <a:pt x="1327" y="2148"/>
                  </a:lnTo>
                  <a:lnTo>
                    <a:pt x="1337" y="2145"/>
                  </a:lnTo>
                  <a:lnTo>
                    <a:pt x="1345" y="2142"/>
                  </a:lnTo>
                  <a:lnTo>
                    <a:pt x="1352" y="2137"/>
                  </a:lnTo>
                  <a:lnTo>
                    <a:pt x="1357" y="2130"/>
                  </a:lnTo>
                  <a:lnTo>
                    <a:pt x="1360" y="2124"/>
                  </a:lnTo>
                  <a:lnTo>
                    <a:pt x="1362" y="2117"/>
                  </a:lnTo>
                  <a:lnTo>
                    <a:pt x="1362" y="2111"/>
                  </a:lnTo>
                  <a:lnTo>
                    <a:pt x="1360" y="2104"/>
                  </a:lnTo>
                  <a:lnTo>
                    <a:pt x="1357" y="2096"/>
                  </a:lnTo>
                  <a:lnTo>
                    <a:pt x="1352" y="2089"/>
                  </a:lnTo>
                  <a:lnTo>
                    <a:pt x="1347" y="2081"/>
                  </a:lnTo>
                  <a:lnTo>
                    <a:pt x="1339" y="2075"/>
                  </a:lnTo>
                  <a:lnTo>
                    <a:pt x="1329" y="2068"/>
                  </a:lnTo>
                  <a:lnTo>
                    <a:pt x="1318" y="2062"/>
                  </a:lnTo>
                  <a:lnTo>
                    <a:pt x="1318" y="2062"/>
                  </a:lnTo>
                  <a:lnTo>
                    <a:pt x="1303" y="2054"/>
                  </a:lnTo>
                  <a:lnTo>
                    <a:pt x="1290" y="2044"/>
                  </a:lnTo>
                  <a:lnTo>
                    <a:pt x="1274" y="2028"/>
                  </a:lnTo>
                  <a:lnTo>
                    <a:pt x="1266" y="2020"/>
                  </a:lnTo>
                  <a:lnTo>
                    <a:pt x="1258" y="2008"/>
                  </a:lnTo>
                  <a:lnTo>
                    <a:pt x="1251" y="1997"/>
                  </a:lnTo>
                  <a:lnTo>
                    <a:pt x="1243" y="1984"/>
                  </a:lnTo>
                  <a:lnTo>
                    <a:pt x="1238" y="1971"/>
                  </a:lnTo>
                  <a:lnTo>
                    <a:pt x="1233" y="1956"/>
                  </a:lnTo>
                  <a:lnTo>
                    <a:pt x="1231" y="1938"/>
                  </a:lnTo>
                  <a:lnTo>
                    <a:pt x="1230" y="1920"/>
                  </a:lnTo>
                  <a:lnTo>
                    <a:pt x="1230" y="1920"/>
                  </a:lnTo>
                  <a:lnTo>
                    <a:pt x="1231" y="1901"/>
                  </a:lnTo>
                  <a:lnTo>
                    <a:pt x="1235" y="1881"/>
                  </a:lnTo>
                  <a:lnTo>
                    <a:pt x="1241" y="1862"/>
                  </a:lnTo>
                  <a:lnTo>
                    <a:pt x="1249" y="1842"/>
                  </a:lnTo>
                  <a:lnTo>
                    <a:pt x="1261" y="1826"/>
                  </a:lnTo>
                  <a:lnTo>
                    <a:pt x="1272" y="1810"/>
                  </a:lnTo>
                  <a:lnTo>
                    <a:pt x="1287" y="1793"/>
                  </a:lnTo>
                  <a:lnTo>
                    <a:pt x="1303" y="1779"/>
                  </a:lnTo>
                  <a:lnTo>
                    <a:pt x="1321" y="1766"/>
                  </a:lnTo>
                  <a:lnTo>
                    <a:pt x="1340" y="1754"/>
                  </a:lnTo>
                  <a:lnTo>
                    <a:pt x="1360" y="1745"/>
                  </a:lnTo>
                  <a:lnTo>
                    <a:pt x="1383" y="1736"/>
                  </a:lnTo>
                  <a:lnTo>
                    <a:pt x="1406" y="1730"/>
                  </a:lnTo>
                  <a:lnTo>
                    <a:pt x="1430" y="1725"/>
                  </a:lnTo>
                  <a:lnTo>
                    <a:pt x="1454" y="1722"/>
                  </a:lnTo>
                  <a:lnTo>
                    <a:pt x="1480" y="1720"/>
                  </a:lnTo>
                  <a:lnTo>
                    <a:pt x="1480" y="1720"/>
                  </a:lnTo>
                  <a:lnTo>
                    <a:pt x="1505" y="1722"/>
                  </a:lnTo>
                  <a:lnTo>
                    <a:pt x="1529" y="1725"/>
                  </a:lnTo>
                  <a:lnTo>
                    <a:pt x="1554" y="1730"/>
                  </a:lnTo>
                  <a:lnTo>
                    <a:pt x="1576" y="1736"/>
                  </a:lnTo>
                  <a:lnTo>
                    <a:pt x="1599" y="1745"/>
                  </a:lnTo>
                  <a:lnTo>
                    <a:pt x="1619" y="1754"/>
                  </a:lnTo>
                  <a:lnTo>
                    <a:pt x="1638" y="1766"/>
                  </a:lnTo>
                  <a:lnTo>
                    <a:pt x="1656" y="1779"/>
                  </a:lnTo>
                  <a:lnTo>
                    <a:pt x="1672" y="1793"/>
                  </a:lnTo>
                  <a:lnTo>
                    <a:pt x="1687" y="1810"/>
                  </a:lnTo>
                  <a:lnTo>
                    <a:pt x="1698" y="1826"/>
                  </a:lnTo>
                  <a:lnTo>
                    <a:pt x="1710" y="1842"/>
                  </a:lnTo>
                  <a:lnTo>
                    <a:pt x="1718" y="1862"/>
                  </a:lnTo>
                  <a:lnTo>
                    <a:pt x="1724" y="1881"/>
                  </a:lnTo>
                  <a:lnTo>
                    <a:pt x="1728" y="1901"/>
                  </a:lnTo>
                  <a:lnTo>
                    <a:pt x="1729" y="1920"/>
                  </a:lnTo>
                  <a:lnTo>
                    <a:pt x="1729" y="1920"/>
                  </a:lnTo>
                  <a:close/>
                </a:path>
              </a:pathLst>
            </a:custGeom>
            <a:solidFill>
              <a:srgbClr val="92D050"/>
            </a:solidFill>
            <a:ln w="28575">
              <a:solidFill>
                <a:schemeClr val="tx1">
                  <a:lumMod val="50000"/>
                  <a:lumOff val="50000"/>
                </a:schemeClr>
              </a:solidFill>
              <a:prstDash val="solid"/>
              <a:round/>
              <a:headEnd/>
              <a:tailEnd/>
            </a:ln>
          </p:spPr>
          <p:txBody>
            <a:bodyPr lIns="468000" anchor="ctr"/>
            <a:lstStyle/>
            <a:p>
              <a:pPr algn="ctr" defTabSz="457200">
                <a:defRPr/>
              </a:pPr>
              <a:r>
                <a:rPr lang="en-US" sz="4000" dirty="0">
                  <a:solidFill>
                    <a:prstClr val="black"/>
                  </a:solidFill>
                </a:rPr>
                <a:t>B</a:t>
              </a:r>
              <a:endParaRPr lang="en-GB" sz="4000" dirty="0">
                <a:solidFill>
                  <a:prstClr val="black"/>
                </a:solidFill>
                <a:cs typeface="Arial" charset="0"/>
              </a:endParaRPr>
            </a:p>
          </p:txBody>
        </p:sp>
        <p:sp>
          <p:nvSpPr>
            <p:cNvPr id="9" name="Freeform 8">
              <a:extLst>
                <a:ext uri="{FF2B5EF4-FFF2-40B4-BE49-F238E27FC236}">
                  <a16:creationId xmlns:a16="http://schemas.microsoft.com/office/drawing/2014/main" xmlns="" id="{221E9700-09EC-6943-ABDA-31D1CE6A6E53}"/>
                </a:ext>
              </a:extLst>
            </p:cNvPr>
            <p:cNvSpPr>
              <a:spLocks/>
            </p:cNvSpPr>
            <p:nvPr/>
          </p:nvSpPr>
          <p:spPr bwMode="auto">
            <a:xfrm>
              <a:off x="6419003" y="3789991"/>
              <a:ext cx="1052621" cy="1400491"/>
            </a:xfrm>
            <a:custGeom>
              <a:avLst/>
              <a:gdLst>
                <a:gd name="T0" fmla="*/ 195 w 2151"/>
                <a:gd name="T1" fmla="*/ 1725 h 2586"/>
                <a:gd name="T2" fmla="*/ 141 w 2151"/>
                <a:gd name="T3" fmla="*/ 1702 h 2586"/>
                <a:gd name="T4" fmla="*/ 96 w 2151"/>
                <a:gd name="T5" fmla="*/ 1655 h 2586"/>
                <a:gd name="T6" fmla="*/ 76 w 2151"/>
                <a:gd name="T7" fmla="*/ 1621 h 2586"/>
                <a:gd name="T8" fmla="*/ 47 w 2151"/>
                <a:gd name="T9" fmla="*/ 1598 h 2586"/>
                <a:gd name="T10" fmla="*/ 19 w 2151"/>
                <a:gd name="T11" fmla="*/ 1603 h 2586"/>
                <a:gd name="T12" fmla="*/ 2 w 2151"/>
                <a:gd name="T13" fmla="*/ 1631 h 2586"/>
                <a:gd name="T14" fmla="*/ 2151 w 2151"/>
                <a:gd name="T15" fmla="*/ 2586 h 2586"/>
                <a:gd name="T16" fmla="*/ 1218 w 2151"/>
                <a:gd name="T17" fmla="*/ 430 h 2586"/>
                <a:gd name="T18" fmla="*/ 1184 w 2151"/>
                <a:gd name="T19" fmla="*/ 425 h 2586"/>
                <a:gd name="T20" fmla="*/ 1163 w 2151"/>
                <a:gd name="T21" fmla="*/ 404 h 2586"/>
                <a:gd name="T22" fmla="*/ 1165 w 2151"/>
                <a:gd name="T23" fmla="*/ 376 h 2586"/>
                <a:gd name="T24" fmla="*/ 1194 w 2151"/>
                <a:gd name="T25" fmla="*/ 347 h 2586"/>
                <a:gd name="T26" fmla="*/ 1233 w 2151"/>
                <a:gd name="T27" fmla="*/ 322 h 2586"/>
                <a:gd name="T28" fmla="*/ 1272 w 2151"/>
                <a:gd name="T29" fmla="*/ 277 h 2586"/>
                <a:gd name="T30" fmla="*/ 1292 w 2151"/>
                <a:gd name="T31" fmla="*/ 218 h 2586"/>
                <a:gd name="T32" fmla="*/ 1288 w 2151"/>
                <a:gd name="T33" fmla="*/ 160 h 2586"/>
                <a:gd name="T34" fmla="*/ 1251 w 2151"/>
                <a:gd name="T35" fmla="*/ 88 h 2586"/>
                <a:gd name="T36" fmla="*/ 1183 w 2151"/>
                <a:gd name="T37" fmla="*/ 34 h 2586"/>
                <a:gd name="T38" fmla="*/ 1093 w 2151"/>
                <a:gd name="T39" fmla="*/ 4 h 2586"/>
                <a:gd name="T40" fmla="*/ 1018 w 2151"/>
                <a:gd name="T41" fmla="*/ 2 h 2586"/>
                <a:gd name="T42" fmla="*/ 924 w 2151"/>
                <a:gd name="T43" fmla="*/ 25 h 2586"/>
                <a:gd name="T44" fmla="*/ 851 w 2151"/>
                <a:gd name="T45" fmla="*/ 73 h 2586"/>
                <a:gd name="T46" fmla="*/ 805 w 2151"/>
                <a:gd name="T47" fmla="*/ 142 h 2586"/>
                <a:gd name="T48" fmla="*/ 794 w 2151"/>
                <a:gd name="T49" fmla="*/ 200 h 2586"/>
                <a:gd name="T50" fmla="*/ 807 w 2151"/>
                <a:gd name="T51" fmla="*/ 264 h 2586"/>
                <a:gd name="T52" fmla="*/ 838 w 2151"/>
                <a:gd name="T53" fmla="*/ 308 h 2586"/>
                <a:gd name="T54" fmla="*/ 882 w 2151"/>
                <a:gd name="T55" fmla="*/ 342 h 2586"/>
                <a:gd name="T56" fmla="*/ 916 w 2151"/>
                <a:gd name="T57" fmla="*/ 368 h 2586"/>
                <a:gd name="T58" fmla="*/ 926 w 2151"/>
                <a:gd name="T59" fmla="*/ 397 h 2586"/>
                <a:gd name="T60" fmla="*/ 909 w 2151"/>
                <a:gd name="T61" fmla="*/ 420 h 2586"/>
                <a:gd name="T62" fmla="*/ 869 w 2151"/>
                <a:gd name="T63" fmla="*/ 430 h 2586"/>
                <a:gd name="T64" fmla="*/ 0 w 2151"/>
                <a:gd name="T65" fmla="*/ 1305 h 2586"/>
                <a:gd name="T66" fmla="*/ 5 w 2151"/>
                <a:gd name="T67" fmla="*/ 1338 h 2586"/>
                <a:gd name="T68" fmla="*/ 26 w 2151"/>
                <a:gd name="T69" fmla="*/ 1361 h 2586"/>
                <a:gd name="T70" fmla="*/ 54 w 2151"/>
                <a:gd name="T71" fmla="*/ 1357 h 2586"/>
                <a:gd name="T72" fmla="*/ 83 w 2151"/>
                <a:gd name="T73" fmla="*/ 1328 h 2586"/>
                <a:gd name="T74" fmla="*/ 107 w 2151"/>
                <a:gd name="T75" fmla="*/ 1291 h 2586"/>
                <a:gd name="T76" fmla="*/ 153 w 2151"/>
                <a:gd name="T77" fmla="*/ 1250 h 2586"/>
                <a:gd name="T78" fmla="*/ 211 w 2151"/>
                <a:gd name="T79" fmla="*/ 1230 h 2586"/>
                <a:gd name="T80" fmla="*/ 270 w 2151"/>
                <a:gd name="T81" fmla="*/ 1235 h 2586"/>
                <a:gd name="T82" fmla="*/ 342 w 2151"/>
                <a:gd name="T83" fmla="*/ 1273 h 2586"/>
                <a:gd name="T84" fmla="*/ 395 w 2151"/>
                <a:gd name="T85" fmla="*/ 1339 h 2586"/>
                <a:gd name="T86" fmla="*/ 426 w 2151"/>
                <a:gd name="T87" fmla="*/ 1429 h 2586"/>
                <a:gd name="T88" fmla="*/ 428 w 2151"/>
                <a:gd name="T89" fmla="*/ 1505 h 2586"/>
                <a:gd name="T90" fmla="*/ 405 w 2151"/>
                <a:gd name="T91" fmla="*/ 1598 h 2586"/>
                <a:gd name="T92" fmla="*/ 356 w 2151"/>
                <a:gd name="T93" fmla="*/ 1673 h 2586"/>
                <a:gd name="T94" fmla="*/ 288 w 2151"/>
                <a:gd name="T95" fmla="*/ 1718 h 2586"/>
                <a:gd name="T96" fmla="*/ 229 w 2151"/>
                <a:gd name="T97" fmla="*/ 1730 h 258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151" h="2586">
                  <a:moveTo>
                    <a:pt x="229" y="1730"/>
                  </a:moveTo>
                  <a:lnTo>
                    <a:pt x="229" y="1730"/>
                  </a:lnTo>
                  <a:lnTo>
                    <a:pt x="211" y="1728"/>
                  </a:lnTo>
                  <a:lnTo>
                    <a:pt x="195" y="1725"/>
                  </a:lnTo>
                  <a:lnTo>
                    <a:pt x="179" y="1722"/>
                  </a:lnTo>
                  <a:lnTo>
                    <a:pt x="166" y="1715"/>
                  </a:lnTo>
                  <a:lnTo>
                    <a:pt x="153" y="1709"/>
                  </a:lnTo>
                  <a:lnTo>
                    <a:pt x="141" y="1702"/>
                  </a:lnTo>
                  <a:lnTo>
                    <a:pt x="132" y="1694"/>
                  </a:lnTo>
                  <a:lnTo>
                    <a:pt x="122" y="1686"/>
                  </a:lnTo>
                  <a:lnTo>
                    <a:pt x="107" y="1670"/>
                  </a:lnTo>
                  <a:lnTo>
                    <a:pt x="96" y="1655"/>
                  </a:lnTo>
                  <a:lnTo>
                    <a:pt x="88" y="1642"/>
                  </a:lnTo>
                  <a:lnTo>
                    <a:pt x="88" y="1642"/>
                  </a:lnTo>
                  <a:lnTo>
                    <a:pt x="83" y="1631"/>
                  </a:lnTo>
                  <a:lnTo>
                    <a:pt x="76" y="1621"/>
                  </a:lnTo>
                  <a:lnTo>
                    <a:pt x="68" y="1613"/>
                  </a:lnTo>
                  <a:lnTo>
                    <a:pt x="62" y="1606"/>
                  </a:lnTo>
                  <a:lnTo>
                    <a:pt x="54" y="1601"/>
                  </a:lnTo>
                  <a:lnTo>
                    <a:pt x="47" y="1598"/>
                  </a:lnTo>
                  <a:lnTo>
                    <a:pt x="39" y="1598"/>
                  </a:lnTo>
                  <a:lnTo>
                    <a:pt x="32" y="1598"/>
                  </a:lnTo>
                  <a:lnTo>
                    <a:pt x="26" y="1600"/>
                  </a:lnTo>
                  <a:lnTo>
                    <a:pt x="19" y="1603"/>
                  </a:lnTo>
                  <a:lnTo>
                    <a:pt x="15" y="1608"/>
                  </a:lnTo>
                  <a:lnTo>
                    <a:pt x="10" y="1614"/>
                  </a:lnTo>
                  <a:lnTo>
                    <a:pt x="5" y="1621"/>
                  </a:lnTo>
                  <a:lnTo>
                    <a:pt x="2" y="1631"/>
                  </a:lnTo>
                  <a:lnTo>
                    <a:pt x="0" y="1642"/>
                  </a:lnTo>
                  <a:lnTo>
                    <a:pt x="0" y="1655"/>
                  </a:lnTo>
                  <a:lnTo>
                    <a:pt x="0" y="2586"/>
                  </a:lnTo>
                  <a:lnTo>
                    <a:pt x="2151" y="2586"/>
                  </a:lnTo>
                  <a:lnTo>
                    <a:pt x="2151" y="431"/>
                  </a:lnTo>
                  <a:lnTo>
                    <a:pt x="1656" y="431"/>
                  </a:lnTo>
                  <a:lnTo>
                    <a:pt x="1656" y="430"/>
                  </a:lnTo>
                  <a:lnTo>
                    <a:pt x="1218" y="430"/>
                  </a:lnTo>
                  <a:lnTo>
                    <a:pt x="1218" y="430"/>
                  </a:lnTo>
                  <a:lnTo>
                    <a:pt x="1205" y="430"/>
                  </a:lnTo>
                  <a:lnTo>
                    <a:pt x="1194" y="428"/>
                  </a:lnTo>
                  <a:lnTo>
                    <a:pt x="1184" y="425"/>
                  </a:lnTo>
                  <a:lnTo>
                    <a:pt x="1178" y="420"/>
                  </a:lnTo>
                  <a:lnTo>
                    <a:pt x="1171" y="415"/>
                  </a:lnTo>
                  <a:lnTo>
                    <a:pt x="1166" y="410"/>
                  </a:lnTo>
                  <a:lnTo>
                    <a:pt x="1163" y="404"/>
                  </a:lnTo>
                  <a:lnTo>
                    <a:pt x="1162" y="397"/>
                  </a:lnTo>
                  <a:lnTo>
                    <a:pt x="1162" y="391"/>
                  </a:lnTo>
                  <a:lnTo>
                    <a:pt x="1162" y="383"/>
                  </a:lnTo>
                  <a:lnTo>
                    <a:pt x="1165" y="376"/>
                  </a:lnTo>
                  <a:lnTo>
                    <a:pt x="1170" y="368"/>
                  </a:lnTo>
                  <a:lnTo>
                    <a:pt x="1176" y="361"/>
                  </a:lnTo>
                  <a:lnTo>
                    <a:pt x="1184" y="353"/>
                  </a:lnTo>
                  <a:lnTo>
                    <a:pt x="1194" y="347"/>
                  </a:lnTo>
                  <a:lnTo>
                    <a:pt x="1205" y="342"/>
                  </a:lnTo>
                  <a:lnTo>
                    <a:pt x="1205" y="342"/>
                  </a:lnTo>
                  <a:lnTo>
                    <a:pt x="1218" y="334"/>
                  </a:lnTo>
                  <a:lnTo>
                    <a:pt x="1233" y="322"/>
                  </a:lnTo>
                  <a:lnTo>
                    <a:pt x="1249" y="308"/>
                  </a:lnTo>
                  <a:lnTo>
                    <a:pt x="1258" y="298"/>
                  </a:lnTo>
                  <a:lnTo>
                    <a:pt x="1266" y="288"/>
                  </a:lnTo>
                  <a:lnTo>
                    <a:pt x="1272" y="277"/>
                  </a:lnTo>
                  <a:lnTo>
                    <a:pt x="1279" y="264"/>
                  </a:lnTo>
                  <a:lnTo>
                    <a:pt x="1285" y="251"/>
                  </a:lnTo>
                  <a:lnTo>
                    <a:pt x="1288" y="235"/>
                  </a:lnTo>
                  <a:lnTo>
                    <a:pt x="1292" y="218"/>
                  </a:lnTo>
                  <a:lnTo>
                    <a:pt x="1293" y="200"/>
                  </a:lnTo>
                  <a:lnTo>
                    <a:pt x="1293" y="200"/>
                  </a:lnTo>
                  <a:lnTo>
                    <a:pt x="1292" y="181"/>
                  </a:lnTo>
                  <a:lnTo>
                    <a:pt x="1288" y="160"/>
                  </a:lnTo>
                  <a:lnTo>
                    <a:pt x="1282" y="142"/>
                  </a:lnTo>
                  <a:lnTo>
                    <a:pt x="1274" y="122"/>
                  </a:lnTo>
                  <a:lnTo>
                    <a:pt x="1262" y="104"/>
                  </a:lnTo>
                  <a:lnTo>
                    <a:pt x="1251" y="88"/>
                  </a:lnTo>
                  <a:lnTo>
                    <a:pt x="1236" y="73"/>
                  </a:lnTo>
                  <a:lnTo>
                    <a:pt x="1220" y="59"/>
                  </a:lnTo>
                  <a:lnTo>
                    <a:pt x="1202" y="46"/>
                  </a:lnTo>
                  <a:lnTo>
                    <a:pt x="1183" y="34"/>
                  </a:lnTo>
                  <a:lnTo>
                    <a:pt x="1162" y="25"/>
                  </a:lnTo>
                  <a:lnTo>
                    <a:pt x="1140" y="17"/>
                  </a:lnTo>
                  <a:lnTo>
                    <a:pt x="1118" y="8"/>
                  </a:lnTo>
                  <a:lnTo>
                    <a:pt x="1093" y="4"/>
                  </a:lnTo>
                  <a:lnTo>
                    <a:pt x="1069" y="2"/>
                  </a:lnTo>
                  <a:lnTo>
                    <a:pt x="1043" y="0"/>
                  </a:lnTo>
                  <a:lnTo>
                    <a:pt x="1043" y="0"/>
                  </a:lnTo>
                  <a:lnTo>
                    <a:pt x="1018" y="2"/>
                  </a:lnTo>
                  <a:lnTo>
                    <a:pt x="992" y="4"/>
                  </a:lnTo>
                  <a:lnTo>
                    <a:pt x="970" y="8"/>
                  </a:lnTo>
                  <a:lnTo>
                    <a:pt x="947" y="17"/>
                  </a:lnTo>
                  <a:lnTo>
                    <a:pt x="924" y="25"/>
                  </a:lnTo>
                  <a:lnTo>
                    <a:pt x="903" y="34"/>
                  </a:lnTo>
                  <a:lnTo>
                    <a:pt x="885" y="46"/>
                  </a:lnTo>
                  <a:lnTo>
                    <a:pt x="867" y="59"/>
                  </a:lnTo>
                  <a:lnTo>
                    <a:pt x="851" y="73"/>
                  </a:lnTo>
                  <a:lnTo>
                    <a:pt x="836" y="88"/>
                  </a:lnTo>
                  <a:lnTo>
                    <a:pt x="823" y="104"/>
                  </a:lnTo>
                  <a:lnTo>
                    <a:pt x="813" y="122"/>
                  </a:lnTo>
                  <a:lnTo>
                    <a:pt x="805" y="142"/>
                  </a:lnTo>
                  <a:lnTo>
                    <a:pt x="799" y="160"/>
                  </a:lnTo>
                  <a:lnTo>
                    <a:pt x="795" y="181"/>
                  </a:lnTo>
                  <a:lnTo>
                    <a:pt x="794" y="200"/>
                  </a:lnTo>
                  <a:lnTo>
                    <a:pt x="794" y="200"/>
                  </a:lnTo>
                  <a:lnTo>
                    <a:pt x="794" y="218"/>
                  </a:lnTo>
                  <a:lnTo>
                    <a:pt x="797" y="235"/>
                  </a:lnTo>
                  <a:lnTo>
                    <a:pt x="802" y="251"/>
                  </a:lnTo>
                  <a:lnTo>
                    <a:pt x="807" y="264"/>
                  </a:lnTo>
                  <a:lnTo>
                    <a:pt x="813" y="277"/>
                  </a:lnTo>
                  <a:lnTo>
                    <a:pt x="822" y="288"/>
                  </a:lnTo>
                  <a:lnTo>
                    <a:pt x="830" y="298"/>
                  </a:lnTo>
                  <a:lnTo>
                    <a:pt x="838" y="308"/>
                  </a:lnTo>
                  <a:lnTo>
                    <a:pt x="854" y="322"/>
                  </a:lnTo>
                  <a:lnTo>
                    <a:pt x="867" y="334"/>
                  </a:lnTo>
                  <a:lnTo>
                    <a:pt x="882" y="342"/>
                  </a:lnTo>
                  <a:lnTo>
                    <a:pt x="882" y="342"/>
                  </a:lnTo>
                  <a:lnTo>
                    <a:pt x="891" y="347"/>
                  </a:lnTo>
                  <a:lnTo>
                    <a:pt x="901" y="353"/>
                  </a:lnTo>
                  <a:lnTo>
                    <a:pt x="909" y="361"/>
                  </a:lnTo>
                  <a:lnTo>
                    <a:pt x="916" y="368"/>
                  </a:lnTo>
                  <a:lnTo>
                    <a:pt x="921" y="376"/>
                  </a:lnTo>
                  <a:lnTo>
                    <a:pt x="924" y="383"/>
                  </a:lnTo>
                  <a:lnTo>
                    <a:pt x="926" y="391"/>
                  </a:lnTo>
                  <a:lnTo>
                    <a:pt x="926" y="397"/>
                  </a:lnTo>
                  <a:lnTo>
                    <a:pt x="924" y="404"/>
                  </a:lnTo>
                  <a:lnTo>
                    <a:pt x="921" y="410"/>
                  </a:lnTo>
                  <a:lnTo>
                    <a:pt x="916" y="415"/>
                  </a:lnTo>
                  <a:lnTo>
                    <a:pt x="909" y="420"/>
                  </a:lnTo>
                  <a:lnTo>
                    <a:pt x="901" y="425"/>
                  </a:lnTo>
                  <a:lnTo>
                    <a:pt x="891" y="428"/>
                  </a:lnTo>
                  <a:lnTo>
                    <a:pt x="880" y="430"/>
                  </a:lnTo>
                  <a:lnTo>
                    <a:pt x="869" y="430"/>
                  </a:lnTo>
                  <a:lnTo>
                    <a:pt x="595" y="430"/>
                  </a:lnTo>
                  <a:lnTo>
                    <a:pt x="595" y="431"/>
                  </a:lnTo>
                  <a:lnTo>
                    <a:pt x="0" y="431"/>
                  </a:lnTo>
                  <a:lnTo>
                    <a:pt x="0" y="1305"/>
                  </a:lnTo>
                  <a:lnTo>
                    <a:pt x="0" y="1305"/>
                  </a:lnTo>
                  <a:lnTo>
                    <a:pt x="0" y="1317"/>
                  </a:lnTo>
                  <a:lnTo>
                    <a:pt x="2" y="1328"/>
                  </a:lnTo>
                  <a:lnTo>
                    <a:pt x="5" y="1338"/>
                  </a:lnTo>
                  <a:lnTo>
                    <a:pt x="10" y="1346"/>
                  </a:lnTo>
                  <a:lnTo>
                    <a:pt x="15" y="1352"/>
                  </a:lnTo>
                  <a:lnTo>
                    <a:pt x="19" y="1357"/>
                  </a:lnTo>
                  <a:lnTo>
                    <a:pt x="26" y="1361"/>
                  </a:lnTo>
                  <a:lnTo>
                    <a:pt x="32" y="1362"/>
                  </a:lnTo>
                  <a:lnTo>
                    <a:pt x="39" y="1362"/>
                  </a:lnTo>
                  <a:lnTo>
                    <a:pt x="47" y="1361"/>
                  </a:lnTo>
                  <a:lnTo>
                    <a:pt x="54" y="1357"/>
                  </a:lnTo>
                  <a:lnTo>
                    <a:pt x="62" y="1352"/>
                  </a:lnTo>
                  <a:lnTo>
                    <a:pt x="68" y="1346"/>
                  </a:lnTo>
                  <a:lnTo>
                    <a:pt x="76" y="1338"/>
                  </a:lnTo>
                  <a:lnTo>
                    <a:pt x="83" y="1328"/>
                  </a:lnTo>
                  <a:lnTo>
                    <a:pt x="88" y="1318"/>
                  </a:lnTo>
                  <a:lnTo>
                    <a:pt x="88" y="1318"/>
                  </a:lnTo>
                  <a:lnTo>
                    <a:pt x="96" y="1304"/>
                  </a:lnTo>
                  <a:lnTo>
                    <a:pt x="107" y="1291"/>
                  </a:lnTo>
                  <a:lnTo>
                    <a:pt x="122" y="1274"/>
                  </a:lnTo>
                  <a:lnTo>
                    <a:pt x="132" y="1266"/>
                  </a:lnTo>
                  <a:lnTo>
                    <a:pt x="141" y="1258"/>
                  </a:lnTo>
                  <a:lnTo>
                    <a:pt x="153" y="1250"/>
                  </a:lnTo>
                  <a:lnTo>
                    <a:pt x="166" y="1243"/>
                  </a:lnTo>
                  <a:lnTo>
                    <a:pt x="179" y="1238"/>
                  </a:lnTo>
                  <a:lnTo>
                    <a:pt x="195" y="1234"/>
                  </a:lnTo>
                  <a:lnTo>
                    <a:pt x="211" y="1230"/>
                  </a:lnTo>
                  <a:lnTo>
                    <a:pt x="229" y="1230"/>
                  </a:lnTo>
                  <a:lnTo>
                    <a:pt x="229" y="1230"/>
                  </a:lnTo>
                  <a:lnTo>
                    <a:pt x="249" y="1232"/>
                  </a:lnTo>
                  <a:lnTo>
                    <a:pt x="270" y="1235"/>
                  </a:lnTo>
                  <a:lnTo>
                    <a:pt x="288" y="1242"/>
                  </a:lnTo>
                  <a:lnTo>
                    <a:pt x="307" y="1250"/>
                  </a:lnTo>
                  <a:lnTo>
                    <a:pt x="325" y="1260"/>
                  </a:lnTo>
                  <a:lnTo>
                    <a:pt x="342" y="1273"/>
                  </a:lnTo>
                  <a:lnTo>
                    <a:pt x="356" y="1287"/>
                  </a:lnTo>
                  <a:lnTo>
                    <a:pt x="371" y="1304"/>
                  </a:lnTo>
                  <a:lnTo>
                    <a:pt x="384" y="1321"/>
                  </a:lnTo>
                  <a:lnTo>
                    <a:pt x="395" y="1339"/>
                  </a:lnTo>
                  <a:lnTo>
                    <a:pt x="405" y="1361"/>
                  </a:lnTo>
                  <a:lnTo>
                    <a:pt x="413" y="1383"/>
                  </a:lnTo>
                  <a:lnTo>
                    <a:pt x="421" y="1406"/>
                  </a:lnTo>
                  <a:lnTo>
                    <a:pt x="426" y="1429"/>
                  </a:lnTo>
                  <a:lnTo>
                    <a:pt x="428" y="1455"/>
                  </a:lnTo>
                  <a:lnTo>
                    <a:pt x="429" y="1479"/>
                  </a:lnTo>
                  <a:lnTo>
                    <a:pt x="429" y="1479"/>
                  </a:lnTo>
                  <a:lnTo>
                    <a:pt x="428" y="1505"/>
                  </a:lnTo>
                  <a:lnTo>
                    <a:pt x="426" y="1530"/>
                  </a:lnTo>
                  <a:lnTo>
                    <a:pt x="421" y="1554"/>
                  </a:lnTo>
                  <a:lnTo>
                    <a:pt x="413" y="1577"/>
                  </a:lnTo>
                  <a:lnTo>
                    <a:pt x="405" y="1598"/>
                  </a:lnTo>
                  <a:lnTo>
                    <a:pt x="395" y="1619"/>
                  </a:lnTo>
                  <a:lnTo>
                    <a:pt x="384" y="1639"/>
                  </a:lnTo>
                  <a:lnTo>
                    <a:pt x="371" y="1657"/>
                  </a:lnTo>
                  <a:lnTo>
                    <a:pt x="356" y="1673"/>
                  </a:lnTo>
                  <a:lnTo>
                    <a:pt x="342" y="1686"/>
                  </a:lnTo>
                  <a:lnTo>
                    <a:pt x="325" y="1699"/>
                  </a:lnTo>
                  <a:lnTo>
                    <a:pt x="307" y="1710"/>
                  </a:lnTo>
                  <a:lnTo>
                    <a:pt x="288" y="1718"/>
                  </a:lnTo>
                  <a:lnTo>
                    <a:pt x="270" y="1725"/>
                  </a:lnTo>
                  <a:lnTo>
                    <a:pt x="249" y="1728"/>
                  </a:lnTo>
                  <a:lnTo>
                    <a:pt x="229" y="1730"/>
                  </a:lnTo>
                  <a:lnTo>
                    <a:pt x="229" y="1730"/>
                  </a:lnTo>
                  <a:close/>
                </a:path>
              </a:pathLst>
            </a:custGeom>
            <a:solidFill>
              <a:srgbClr val="0096FF"/>
            </a:solidFill>
            <a:ln w="28575">
              <a:solidFill>
                <a:schemeClr val="tx1">
                  <a:lumMod val="50000"/>
                  <a:lumOff val="50000"/>
                </a:schemeClr>
              </a:solidFill>
              <a:prstDash val="solid"/>
              <a:round/>
              <a:headEnd/>
              <a:tailEnd/>
            </a:ln>
          </p:spPr>
          <p:txBody>
            <a:bodyPr tIns="468000" anchor="ctr" anchorCtr="1"/>
            <a:lstStyle/>
            <a:p>
              <a:pPr defTabSz="457200">
                <a:defRPr/>
              </a:pPr>
              <a:r>
                <a:rPr lang="en-US" sz="4000" dirty="0">
                  <a:solidFill>
                    <a:prstClr val="black"/>
                  </a:solidFill>
                </a:rPr>
                <a:t>D</a:t>
              </a:r>
              <a:endParaRPr lang="en-GB" sz="4000" dirty="0">
                <a:solidFill>
                  <a:prstClr val="black"/>
                </a:solidFill>
                <a:cs typeface="Arial" charset="0"/>
              </a:endParaRPr>
            </a:p>
          </p:txBody>
        </p:sp>
        <p:sp>
          <p:nvSpPr>
            <p:cNvPr id="22" name="TextBox 21">
              <a:extLst>
                <a:ext uri="{FF2B5EF4-FFF2-40B4-BE49-F238E27FC236}">
                  <a16:creationId xmlns:a16="http://schemas.microsoft.com/office/drawing/2014/main" xmlns="" id="{A61DFA6E-6DAD-354E-8FF0-D29AF086DEA7}"/>
                </a:ext>
              </a:extLst>
            </p:cNvPr>
            <p:cNvSpPr txBox="1"/>
            <p:nvPr/>
          </p:nvSpPr>
          <p:spPr>
            <a:xfrm>
              <a:off x="5194928" y="5359495"/>
              <a:ext cx="2107920" cy="461665"/>
            </a:xfrm>
            <a:prstGeom prst="rect">
              <a:avLst/>
            </a:prstGeom>
            <a:noFill/>
          </p:spPr>
          <p:txBody>
            <a:bodyPr wrap="square" rtlCol="0">
              <a:spAutoFit/>
            </a:bodyPr>
            <a:lstStyle/>
            <a:p>
              <a:pPr defTabSz="457200"/>
              <a:r>
                <a:rPr lang="en-US" sz="2400" dirty="0">
                  <a:solidFill>
                    <a:prstClr val="black"/>
                  </a:solidFill>
                  <a:cs typeface="Calibri" panose="020F0502020204030204" pitchFamily="34" charset="0"/>
                </a:rPr>
                <a:t>Expert </a:t>
              </a:r>
              <a:r>
                <a:rPr lang="en-US" sz="2400" dirty="0" smtClean="0">
                  <a:solidFill>
                    <a:prstClr val="black"/>
                  </a:solidFill>
                  <a:cs typeface="Calibri" panose="020F0502020204030204" pitchFamily="34" charset="0"/>
                </a:rPr>
                <a:t>Groups</a:t>
              </a:r>
              <a:endParaRPr lang="en-US" sz="2400" dirty="0">
                <a:solidFill>
                  <a:prstClr val="black"/>
                </a:solidFill>
                <a:cs typeface="Calibri" panose="020F0502020204030204" pitchFamily="34" charset="0"/>
              </a:endParaRPr>
            </a:p>
          </p:txBody>
        </p:sp>
      </p:grpSp>
      <p:grpSp>
        <p:nvGrpSpPr>
          <p:cNvPr id="4" name="Group 3"/>
          <p:cNvGrpSpPr/>
          <p:nvPr/>
        </p:nvGrpSpPr>
        <p:grpSpPr>
          <a:xfrm>
            <a:off x="8791856" y="2319866"/>
            <a:ext cx="2384490" cy="3614299"/>
            <a:chOff x="8791856" y="2319866"/>
            <a:chExt cx="2384490" cy="3614299"/>
          </a:xfrm>
        </p:grpSpPr>
        <p:sp>
          <p:nvSpPr>
            <p:cNvPr id="17" name="Freeform 16">
              <a:extLst>
                <a:ext uri="{FF2B5EF4-FFF2-40B4-BE49-F238E27FC236}">
                  <a16:creationId xmlns:a16="http://schemas.microsoft.com/office/drawing/2014/main" xmlns="" id="{BFD2A36C-CDE2-F147-837B-9AA09FEB3EA0}"/>
                </a:ext>
              </a:extLst>
            </p:cNvPr>
            <p:cNvSpPr>
              <a:spLocks/>
            </p:cNvSpPr>
            <p:nvPr/>
          </p:nvSpPr>
          <p:spPr bwMode="auto">
            <a:xfrm>
              <a:off x="8892634" y="2319866"/>
              <a:ext cx="1051952" cy="1401232"/>
            </a:xfrm>
            <a:custGeom>
              <a:avLst/>
              <a:gdLst>
                <a:gd name="T0" fmla="*/ 1956 w 2151"/>
                <a:gd name="T1" fmla="*/ 861 h 2586"/>
                <a:gd name="T2" fmla="*/ 2010 w 2151"/>
                <a:gd name="T3" fmla="*/ 884 h 2586"/>
                <a:gd name="T4" fmla="*/ 2054 w 2151"/>
                <a:gd name="T5" fmla="*/ 931 h 2586"/>
                <a:gd name="T6" fmla="*/ 2075 w 2151"/>
                <a:gd name="T7" fmla="*/ 965 h 2586"/>
                <a:gd name="T8" fmla="*/ 2104 w 2151"/>
                <a:gd name="T9" fmla="*/ 988 h 2586"/>
                <a:gd name="T10" fmla="*/ 2132 w 2151"/>
                <a:gd name="T11" fmla="*/ 983 h 2586"/>
                <a:gd name="T12" fmla="*/ 2148 w 2151"/>
                <a:gd name="T13" fmla="*/ 955 h 2586"/>
                <a:gd name="T14" fmla="*/ 0 w 2151"/>
                <a:gd name="T15" fmla="*/ 0 h 2586"/>
                <a:gd name="T16" fmla="*/ 933 w 2151"/>
                <a:gd name="T17" fmla="*/ 2156 h 2586"/>
                <a:gd name="T18" fmla="*/ 965 w 2151"/>
                <a:gd name="T19" fmla="*/ 2161 h 2586"/>
                <a:gd name="T20" fmla="*/ 988 w 2151"/>
                <a:gd name="T21" fmla="*/ 2182 h 2586"/>
                <a:gd name="T22" fmla="*/ 985 w 2151"/>
                <a:gd name="T23" fmla="*/ 2210 h 2586"/>
                <a:gd name="T24" fmla="*/ 957 w 2151"/>
                <a:gd name="T25" fmla="*/ 2239 h 2586"/>
                <a:gd name="T26" fmla="*/ 918 w 2151"/>
                <a:gd name="T27" fmla="*/ 2264 h 2586"/>
                <a:gd name="T28" fmla="*/ 879 w 2151"/>
                <a:gd name="T29" fmla="*/ 2309 h 2586"/>
                <a:gd name="T30" fmla="*/ 859 w 2151"/>
                <a:gd name="T31" fmla="*/ 2368 h 2586"/>
                <a:gd name="T32" fmla="*/ 863 w 2151"/>
                <a:gd name="T33" fmla="*/ 2426 h 2586"/>
                <a:gd name="T34" fmla="*/ 900 w 2151"/>
                <a:gd name="T35" fmla="*/ 2498 h 2586"/>
                <a:gd name="T36" fmla="*/ 968 w 2151"/>
                <a:gd name="T37" fmla="*/ 2552 h 2586"/>
                <a:gd name="T38" fmla="*/ 1058 w 2151"/>
                <a:gd name="T39" fmla="*/ 2582 h 2586"/>
                <a:gd name="T40" fmla="*/ 1133 w 2151"/>
                <a:gd name="T41" fmla="*/ 2584 h 2586"/>
                <a:gd name="T42" fmla="*/ 1227 w 2151"/>
                <a:gd name="T43" fmla="*/ 2561 h 2586"/>
                <a:gd name="T44" fmla="*/ 1300 w 2151"/>
                <a:gd name="T45" fmla="*/ 2513 h 2586"/>
                <a:gd name="T46" fmla="*/ 1346 w 2151"/>
                <a:gd name="T47" fmla="*/ 2444 h 2586"/>
                <a:gd name="T48" fmla="*/ 1357 w 2151"/>
                <a:gd name="T49" fmla="*/ 2386 h 2586"/>
                <a:gd name="T50" fmla="*/ 1344 w 2151"/>
                <a:gd name="T51" fmla="*/ 2322 h 2586"/>
                <a:gd name="T52" fmla="*/ 1313 w 2151"/>
                <a:gd name="T53" fmla="*/ 2278 h 2586"/>
                <a:gd name="T54" fmla="*/ 1269 w 2151"/>
                <a:gd name="T55" fmla="*/ 2244 h 2586"/>
                <a:gd name="T56" fmla="*/ 1235 w 2151"/>
                <a:gd name="T57" fmla="*/ 2218 h 2586"/>
                <a:gd name="T58" fmla="*/ 1225 w 2151"/>
                <a:gd name="T59" fmla="*/ 2189 h 2586"/>
                <a:gd name="T60" fmla="*/ 1242 w 2151"/>
                <a:gd name="T61" fmla="*/ 2166 h 2586"/>
                <a:gd name="T62" fmla="*/ 1282 w 2151"/>
                <a:gd name="T63" fmla="*/ 2156 h 2586"/>
                <a:gd name="T64" fmla="*/ 2151 w 2151"/>
                <a:gd name="T65" fmla="*/ 1281 h 2586"/>
                <a:gd name="T66" fmla="*/ 2146 w 2151"/>
                <a:gd name="T67" fmla="*/ 1248 h 2586"/>
                <a:gd name="T68" fmla="*/ 2125 w 2151"/>
                <a:gd name="T69" fmla="*/ 1225 h 2586"/>
                <a:gd name="T70" fmla="*/ 2097 w 2151"/>
                <a:gd name="T71" fmla="*/ 1229 h 2586"/>
                <a:gd name="T72" fmla="*/ 2068 w 2151"/>
                <a:gd name="T73" fmla="*/ 1258 h 2586"/>
                <a:gd name="T74" fmla="*/ 2044 w 2151"/>
                <a:gd name="T75" fmla="*/ 1295 h 2586"/>
                <a:gd name="T76" fmla="*/ 1998 w 2151"/>
                <a:gd name="T77" fmla="*/ 1336 h 2586"/>
                <a:gd name="T78" fmla="*/ 1940 w 2151"/>
                <a:gd name="T79" fmla="*/ 1356 h 2586"/>
                <a:gd name="T80" fmla="*/ 1881 w 2151"/>
                <a:gd name="T81" fmla="*/ 1351 h 2586"/>
                <a:gd name="T82" fmla="*/ 1809 w 2151"/>
                <a:gd name="T83" fmla="*/ 1313 h 2586"/>
                <a:gd name="T84" fmla="*/ 1756 w 2151"/>
                <a:gd name="T85" fmla="*/ 1247 h 2586"/>
                <a:gd name="T86" fmla="*/ 1725 w 2151"/>
                <a:gd name="T87" fmla="*/ 1157 h 2586"/>
                <a:gd name="T88" fmla="*/ 1722 w 2151"/>
                <a:gd name="T89" fmla="*/ 1081 h 2586"/>
                <a:gd name="T90" fmla="*/ 1746 w 2151"/>
                <a:gd name="T91" fmla="*/ 988 h 2586"/>
                <a:gd name="T92" fmla="*/ 1795 w 2151"/>
                <a:gd name="T93" fmla="*/ 913 h 2586"/>
                <a:gd name="T94" fmla="*/ 1862 w 2151"/>
                <a:gd name="T95" fmla="*/ 868 h 2586"/>
                <a:gd name="T96" fmla="*/ 1922 w 2151"/>
                <a:gd name="T97" fmla="*/ 856 h 258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151" h="2586">
                  <a:moveTo>
                    <a:pt x="1922" y="856"/>
                  </a:moveTo>
                  <a:lnTo>
                    <a:pt x="1922" y="856"/>
                  </a:lnTo>
                  <a:lnTo>
                    <a:pt x="1940" y="858"/>
                  </a:lnTo>
                  <a:lnTo>
                    <a:pt x="1956" y="861"/>
                  </a:lnTo>
                  <a:lnTo>
                    <a:pt x="1971" y="864"/>
                  </a:lnTo>
                  <a:lnTo>
                    <a:pt x="1985" y="871"/>
                  </a:lnTo>
                  <a:lnTo>
                    <a:pt x="1998" y="877"/>
                  </a:lnTo>
                  <a:lnTo>
                    <a:pt x="2010" y="884"/>
                  </a:lnTo>
                  <a:lnTo>
                    <a:pt x="2019" y="892"/>
                  </a:lnTo>
                  <a:lnTo>
                    <a:pt x="2029" y="900"/>
                  </a:lnTo>
                  <a:lnTo>
                    <a:pt x="2044" y="916"/>
                  </a:lnTo>
                  <a:lnTo>
                    <a:pt x="2054" y="931"/>
                  </a:lnTo>
                  <a:lnTo>
                    <a:pt x="2062" y="944"/>
                  </a:lnTo>
                  <a:lnTo>
                    <a:pt x="2062" y="944"/>
                  </a:lnTo>
                  <a:lnTo>
                    <a:pt x="2068" y="955"/>
                  </a:lnTo>
                  <a:lnTo>
                    <a:pt x="2075" y="965"/>
                  </a:lnTo>
                  <a:lnTo>
                    <a:pt x="2083" y="973"/>
                  </a:lnTo>
                  <a:lnTo>
                    <a:pt x="2089" y="980"/>
                  </a:lnTo>
                  <a:lnTo>
                    <a:pt x="2097" y="985"/>
                  </a:lnTo>
                  <a:lnTo>
                    <a:pt x="2104" y="988"/>
                  </a:lnTo>
                  <a:lnTo>
                    <a:pt x="2112" y="988"/>
                  </a:lnTo>
                  <a:lnTo>
                    <a:pt x="2119" y="988"/>
                  </a:lnTo>
                  <a:lnTo>
                    <a:pt x="2125" y="986"/>
                  </a:lnTo>
                  <a:lnTo>
                    <a:pt x="2132" y="983"/>
                  </a:lnTo>
                  <a:lnTo>
                    <a:pt x="2136" y="978"/>
                  </a:lnTo>
                  <a:lnTo>
                    <a:pt x="2141" y="972"/>
                  </a:lnTo>
                  <a:lnTo>
                    <a:pt x="2146" y="965"/>
                  </a:lnTo>
                  <a:lnTo>
                    <a:pt x="2148" y="955"/>
                  </a:lnTo>
                  <a:lnTo>
                    <a:pt x="2151" y="944"/>
                  </a:lnTo>
                  <a:lnTo>
                    <a:pt x="2151" y="931"/>
                  </a:lnTo>
                  <a:lnTo>
                    <a:pt x="2151" y="0"/>
                  </a:lnTo>
                  <a:lnTo>
                    <a:pt x="0" y="0"/>
                  </a:lnTo>
                  <a:lnTo>
                    <a:pt x="0" y="2155"/>
                  </a:lnTo>
                  <a:lnTo>
                    <a:pt x="495" y="2155"/>
                  </a:lnTo>
                  <a:lnTo>
                    <a:pt x="495" y="2156"/>
                  </a:lnTo>
                  <a:lnTo>
                    <a:pt x="933" y="2156"/>
                  </a:lnTo>
                  <a:lnTo>
                    <a:pt x="933" y="2156"/>
                  </a:lnTo>
                  <a:lnTo>
                    <a:pt x="946" y="2156"/>
                  </a:lnTo>
                  <a:lnTo>
                    <a:pt x="955" y="2158"/>
                  </a:lnTo>
                  <a:lnTo>
                    <a:pt x="965" y="2161"/>
                  </a:lnTo>
                  <a:lnTo>
                    <a:pt x="973" y="2166"/>
                  </a:lnTo>
                  <a:lnTo>
                    <a:pt x="980" y="2171"/>
                  </a:lnTo>
                  <a:lnTo>
                    <a:pt x="985" y="2176"/>
                  </a:lnTo>
                  <a:lnTo>
                    <a:pt x="988" y="2182"/>
                  </a:lnTo>
                  <a:lnTo>
                    <a:pt x="989" y="2189"/>
                  </a:lnTo>
                  <a:lnTo>
                    <a:pt x="989" y="2195"/>
                  </a:lnTo>
                  <a:lnTo>
                    <a:pt x="988" y="2203"/>
                  </a:lnTo>
                  <a:lnTo>
                    <a:pt x="985" y="2210"/>
                  </a:lnTo>
                  <a:lnTo>
                    <a:pt x="980" y="2218"/>
                  </a:lnTo>
                  <a:lnTo>
                    <a:pt x="975" y="2225"/>
                  </a:lnTo>
                  <a:lnTo>
                    <a:pt x="967" y="2233"/>
                  </a:lnTo>
                  <a:lnTo>
                    <a:pt x="957" y="2239"/>
                  </a:lnTo>
                  <a:lnTo>
                    <a:pt x="946" y="2244"/>
                  </a:lnTo>
                  <a:lnTo>
                    <a:pt x="946" y="2244"/>
                  </a:lnTo>
                  <a:lnTo>
                    <a:pt x="931" y="2252"/>
                  </a:lnTo>
                  <a:lnTo>
                    <a:pt x="918" y="2264"/>
                  </a:lnTo>
                  <a:lnTo>
                    <a:pt x="902" y="2278"/>
                  </a:lnTo>
                  <a:lnTo>
                    <a:pt x="893" y="2288"/>
                  </a:lnTo>
                  <a:lnTo>
                    <a:pt x="885" y="2298"/>
                  </a:lnTo>
                  <a:lnTo>
                    <a:pt x="879" y="2309"/>
                  </a:lnTo>
                  <a:lnTo>
                    <a:pt x="871" y="2322"/>
                  </a:lnTo>
                  <a:lnTo>
                    <a:pt x="866" y="2335"/>
                  </a:lnTo>
                  <a:lnTo>
                    <a:pt x="861" y="2351"/>
                  </a:lnTo>
                  <a:lnTo>
                    <a:pt x="859" y="2368"/>
                  </a:lnTo>
                  <a:lnTo>
                    <a:pt x="858" y="2386"/>
                  </a:lnTo>
                  <a:lnTo>
                    <a:pt x="858" y="2386"/>
                  </a:lnTo>
                  <a:lnTo>
                    <a:pt x="859" y="2405"/>
                  </a:lnTo>
                  <a:lnTo>
                    <a:pt x="863" y="2426"/>
                  </a:lnTo>
                  <a:lnTo>
                    <a:pt x="869" y="2444"/>
                  </a:lnTo>
                  <a:lnTo>
                    <a:pt x="877" y="2464"/>
                  </a:lnTo>
                  <a:lnTo>
                    <a:pt x="889" y="2482"/>
                  </a:lnTo>
                  <a:lnTo>
                    <a:pt x="900" y="2498"/>
                  </a:lnTo>
                  <a:lnTo>
                    <a:pt x="915" y="2513"/>
                  </a:lnTo>
                  <a:lnTo>
                    <a:pt x="931" y="2527"/>
                  </a:lnTo>
                  <a:lnTo>
                    <a:pt x="949" y="2540"/>
                  </a:lnTo>
                  <a:lnTo>
                    <a:pt x="968" y="2552"/>
                  </a:lnTo>
                  <a:lnTo>
                    <a:pt x="988" y="2561"/>
                  </a:lnTo>
                  <a:lnTo>
                    <a:pt x="1011" y="2569"/>
                  </a:lnTo>
                  <a:lnTo>
                    <a:pt x="1033" y="2578"/>
                  </a:lnTo>
                  <a:lnTo>
                    <a:pt x="1058" y="2582"/>
                  </a:lnTo>
                  <a:lnTo>
                    <a:pt x="1082" y="2584"/>
                  </a:lnTo>
                  <a:lnTo>
                    <a:pt x="1108" y="2586"/>
                  </a:lnTo>
                  <a:lnTo>
                    <a:pt x="1108" y="2586"/>
                  </a:lnTo>
                  <a:lnTo>
                    <a:pt x="1133" y="2584"/>
                  </a:lnTo>
                  <a:lnTo>
                    <a:pt x="1157" y="2582"/>
                  </a:lnTo>
                  <a:lnTo>
                    <a:pt x="1181" y="2578"/>
                  </a:lnTo>
                  <a:lnTo>
                    <a:pt x="1204" y="2569"/>
                  </a:lnTo>
                  <a:lnTo>
                    <a:pt x="1227" y="2561"/>
                  </a:lnTo>
                  <a:lnTo>
                    <a:pt x="1247" y="2552"/>
                  </a:lnTo>
                  <a:lnTo>
                    <a:pt x="1266" y="2540"/>
                  </a:lnTo>
                  <a:lnTo>
                    <a:pt x="1284" y="2527"/>
                  </a:lnTo>
                  <a:lnTo>
                    <a:pt x="1300" y="2513"/>
                  </a:lnTo>
                  <a:lnTo>
                    <a:pt x="1315" y="2498"/>
                  </a:lnTo>
                  <a:lnTo>
                    <a:pt x="1326" y="2482"/>
                  </a:lnTo>
                  <a:lnTo>
                    <a:pt x="1338" y="2464"/>
                  </a:lnTo>
                  <a:lnTo>
                    <a:pt x="1346" y="2444"/>
                  </a:lnTo>
                  <a:lnTo>
                    <a:pt x="1352" y="2426"/>
                  </a:lnTo>
                  <a:lnTo>
                    <a:pt x="1356" y="2405"/>
                  </a:lnTo>
                  <a:lnTo>
                    <a:pt x="1357" y="2386"/>
                  </a:lnTo>
                  <a:lnTo>
                    <a:pt x="1357" y="2386"/>
                  </a:lnTo>
                  <a:lnTo>
                    <a:pt x="1356" y="2368"/>
                  </a:lnTo>
                  <a:lnTo>
                    <a:pt x="1354" y="2351"/>
                  </a:lnTo>
                  <a:lnTo>
                    <a:pt x="1349" y="2335"/>
                  </a:lnTo>
                  <a:lnTo>
                    <a:pt x="1344" y="2322"/>
                  </a:lnTo>
                  <a:lnTo>
                    <a:pt x="1338" y="2309"/>
                  </a:lnTo>
                  <a:lnTo>
                    <a:pt x="1329" y="2298"/>
                  </a:lnTo>
                  <a:lnTo>
                    <a:pt x="1321" y="2288"/>
                  </a:lnTo>
                  <a:lnTo>
                    <a:pt x="1313" y="2278"/>
                  </a:lnTo>
                  <a:lnTo>
                    <a:pt x="1297" y="2264"/>
                  </a:lnTo>
                  <a:lnTo>
                    <a:pt x="1284" y="2252"/>
                  </a:lnTo>
                  <a:lnTo>
                    <a:pt x="1269" y="2244"/>
                  </a:lnTo>
                  <a:lnTo>
                    <a:pt x="1269" y="2244"/>
                  </a:lnTo>
                  <a:lnTo>
                    <a:pt x="1258" y="2239"/>
                  </a:lnTo>
                  <a:lnTo>
                    <a:pt x="1248" y="2233"/>
                  </a:lnTo>
                  <a:lnTo>
                    <a:pt x="1240" y="2225"/>
                  </a:lnTo>
                  <a:lnTo>
                    <a:pt x="1235" y="2218"/>
                  </a:lnTo>
                  <a:lnTo>
                    <a:pt x="1230" y="2210"/>
                  </a:lnTo>
                  <a:lnTo>
                    <a:pt x="1227" y="2203"/>
                  </a:lnTo>
                  <a:lnTo>
                    <a:pt x="1225" y="2195"/>
                  </a:lnTo>
                  <a:lnTo>
                    <a:pt x="1225" y="2189"/>
                  </a:lnTo>
                  <a:lnTo>
                    <a:pt x="1227" y="2182"/>
                  </a:lnTo>
                  <a:lnTo>
                    <a:pt x="1230" y="2176"/>
                  </a:lnTo>
                  <a:lnTo>
                    <a:pt x="1235" y="2171"/>
                  </a:lnTo>
                  <a:lnTo>
                    <a:pt x="1242" y="2166"/>
                  </a:lnTo>
                  <a:lnTo>
                    <a:pt x="1250" y="2161"/>
                  </a:lnTo>
                  <a:lnTo>
                    <a:pt x="1260" y="2158"/>
                  </a:lnTo>
                  <a:lnTo>
                    <a:pt x="1269" y="2156"/>
                  </a:lnTo>
                  <a:lnTo>
                    <a:pt x="1282" y="2156"/>
                  </a:lnTo>
                  <a:lnTo>
                    <a:pt x="1556" y="2156"/>
                  </a:lnTo>
                  <a:lnTo>
                    <a:pt x="1556" y="2155"/>
                  </a:lnTo>
                  <a:lnTo>
                    <a:pt x="2151" y="2155"/>
                  </a:lnTo>
                  <a:lnTo>
                    <a:pt x="2151" y="1281"/>
                  </a:lnTo>
                  <a:lnTo>
                    <a:pt x="2151" y="1281"/>
                  </a:lnTo>
                  <a:lnTo>
                    <a:pt x="2151" y="1269"/>
                  </a:lnTo>
                  <a:lnTo>
                    <a:pt x="2148" y="1258"/>
                  </a:lnTo>
                  <a:lnTo>
                    <a:pt x="2146" y="1248"/>
                  </a:lnTo>
                  <a:lnTo>
                    <a:pt x="2141" y="1240"/>
                  </a:lnTo>
                  <a:lnTo>
                    <a:pt x="2136" y="1234"/>
                  </a:lnTo>
                  <a:lnTo>
                    <a:pt x="2132" y="1229"/>
                  </a:lnTo>
                  <a:lnTo>
                    <a:pt x="2125" y="1225"/>
                  </a:lnTo>
                  <a:lnTo>
                    <a:pt x="2119" y="1224"/>
                  </a:lnTo>
                  <a:lnTo>
                    <a:pt x="2112" y="1224"/>
                  </a:lnTo>
                  <a:lnTo>
                    <a:pt x="2104" y="1225"/>
                  </a:lnTo>
                  <a:lnTo>
                    <a:pt x="2097" y="1229"/>
                  </a:lnTo>
                  <a:lnTo>
                    <a:pt x="2089" y="1234"/>
                  </a:lnTo>
                  <a:lnTo>
                    <a:pt x="2083" y="1240"/>
                  </a:lnTo>
                  <a:lnTo>
                    <a:pt x="2075" y="1248"/>
                  </a:lnTo>
                  <a:lnTo>
                    <a:pt x="2068" y="1258"/>
                  </a:lnTo>
                  <a:lnTo>
                    <a:pt x="2062" y="1268"/>
                  </a:lnTo>
                  <a:lnTo>
                    <a:pt x="2062" y="1268"/>
                  </a:lnTo>
                  <a:lnTo>
                    <a:pt x="2054" y="1282"/>
                  </a:lnTo>
                  <a:lnTo>
                    <a:pt x="2044" y="1295"/>
                  </a:lnTo>
                  <a:lnTo>
                    <a:pt x="2029" y="1312"/>
                  </a:lnTo>
                  <a:lnTo>
                    <a:pt x="2019" y="1320"/>
                  </a:lnTo>
                  <a:lnTo>
                    <a:pt x="2010" y="1328"/>
                  </a:lnTo>
                  <a:lnTo>
                    <a:pt x="1998" y="1336"/>
                  </a:lnTo>
                  <a:lnTo>
                    <a:pt x="1985" y="1343"/>
                  </a:lnTo>
                  <a:lnTo>
                    <a:pt x="1971" y="1348"/>
                  </a:lnTo>
                  <a:lnTo>
                    <a:pt x="1956" y="1352"/>
                  </a:lnTo>
                  <a:lnTo>
                    <a:pt x="1940" y="1356"/>
                  </a:lnTo>
                  <a:lnTo>
                    <a:pt x="1922" y="1356"/>
                  </a:lnTo>
                  <a:lnTo>
                    <a:pt x="1922" y="1356"/>
                  </a:lnTo>
                  <a:lnTo>
                    <a:pt x="1901" y="1354"/>
                  </a:lnTo>
                  <a:lnTo>
                    <a:pt x="1881" y="1351"/>
                  </a:lnTo>
                  <a:lnTo>
                    <a:pt x="1862" y="1344"/>
                  </a:lnTo>
                  <a:lnTo>
                    <a:pt x="1844" y="1336"/>
                  </a:lnTo>
                  <a:lnTo>
                    <a:pt x="1826" y="1326"/>
                  </a:lnTo>
                  <a:lnTo>
                    <a:pt x="1809" y="1313"/>
                  </a:lnTo>
                  <a:lnTo>
                    <a:pt x="1795" y="1299"/>
                  </a:lnTo>
                  <a:lnTo>
                    <a:pt x="1780" y="1282"/>
                  </a:lnTo>
                  <a:lnTo>
                    <a:pt x="1767" y="1265"/>
                  </a:lnTo>
                  <a:lnTo>
                    <a:pt x="1756" y="1247"/>
                  </a:lnTo>
                  <a:lnTo>
                    <a:pt x="1746" y="1225"/>
                  </a:lnTo>
                  <a:lnTo>
                    <a:pt x="1736" y="1203"/>
                  </a:lnTo>
                  <a:lnTo>
                    <a:pt x="1730" y="1180"/>
                  </a:lnTo>
                  <a:lnTo>
                    <a:pt x="1725" y="1157"/>
                  </a:lnTo>
                  <a:lnTo>
                    <a:pt x="1722" y="1131"/>
                  </a:lnTo>
                  <a:lnTo>
                    <a:pt x="1722" y="1107"/>
                  </a:lnTo>
                  <a:lnTo>
                    <a:pt x="1722" y="1107"/>
                  </a:lnTo>
                  <a:lnTo>
                    <a:pt x="1722" y="1081"/>
                  </a:lnTo>
                  <a:lnTo>
                    <a:pt x="1725" y="1056"/>
                  </a:lnTo>
                  <a:lnTo>
                    <a:pt x="1730" y="1032"/>
                  </a:lnTo>
                  <a:lnTo>
                    <a:pt x="1736" y="1009"/>
                  </a:lnTo>
                  <a:lnTo>
                    <a:pt x="1746" y="988"/>
                  </a:lnTo>
                  <a:lnTo>
                    <a:pt x="1756" y="967"/>
                  </a:lnTo>
                  <a:lnTo>
                    <a:pt x="1767" y="947"/>
                  </a:lnTo>
                  <a:lnTo>
                    <a:pt x="1780" y="929"/>
                  </a:lnTo>
                  <a:lnTo>
                    <a:pt x="1795" y="913"/>
                  </a:lnTo>
                  <a:lnTo>
                    <a:pt x="1809" y="898"/>
                  </a:lnTo>
                  <a:lnTo>
                    <a:pt x="1826" y="887"/>
                  </a:lnTo>
                  <a:lnTo>
                    <a:pt x="1844" y="876"/>
                  </a:lnTo>
                  <a:lnTo>
                    <a:pt x="1862" y="868"/>
                  </a:lnTo>
                  <a:lnTo>
                    <a:pt x="1881" y="861"/>
                  </a:lnTo>
                  <a:lnTo>
                    <a:pt x="1901" y="858"/>
                  </a:lnTo>
                  <a:lnTo>
                    <a:pt x="1922" y="856"/>
                  </a:lnTo>
                  <a:lnTo>
                    <a:pt x="1922" y="856"/>
                  </a:lnTo>
                  <a:close/>
                </a:path>
              </a:pathLst>
            </a:custGeom>
            <a:solidFill>
              <a:srgbClr val="FF0000"/>
            </a:solidFill>
            <a:ln w="28575">
              <a:solidFill>
                <a:schemeClr val="tx1">
                  <a:lumMod val="50000"/>
                  <a:lumOff val="50000"/>
                </a:schemeClr>
              </a:solidFill>
              <a:prstDash val="solid"/>
              <a:round/>
              <a:headEnd/>
              <a:tailEnd/>
            </a:ln>
          </p:spPr>
          <p:txBody>
            <a:bodyPr bIns="540000" anchor="ctr"/>
            <a:lstStyle/>
            <a:p>
              <a:pPr algn="ctr" defTabSz="457200">
                <a:defRPr/>
              </a:pPr>
              <a:r>
                <a:rPr lang="en-US" sz="4000" dirty="0">
                  <a:solidFill>
                    <a:prstClr val="black"/>
                  </a:solidFill>
                </a:rPr>
                <a:t>A</a:t>
              </a:r>
              <a:endParaRPr lang="en-GB" sz="4000" dirty="0">
                <a:solidFill>
                  <a:prstClr val="black"/>
                </a:solidFill>
                <a:cs typeface="Arial" charset="0"/>
              </a:endParaRPr>
            </a:p>
          </p:txBody>
        </p:sp>
        <p:sp>
          <p:nvSpPr>
            <p:cNvPr id="18" name="Freeform 17">
              <a:extLst>
                <a:ext uri="{FF2B5EF4-FFF2-40B4-BE49-F238E27FC236}">
                  <a16:creationId xmlns:a16="http://schemas.microsoft.com/office/drawing/2014/main" xmlns="" id="{88570BD5-E40A-174E-9568-86D295C2A13D}"/>
                </a:ext>
              </a:extLst>
            </p:cNvPr>
            <p:cNvSpPr>
              <a:spLocks/>
            </p:cNvSpPr>
            <p:nvPr/>
          </p:nvSpPr>
          <p:spPr bwMode="auto">
            <a:xfrm>
              <a:off x="8889289" y="3491814"/>
              <a:ext cx="1265421" cy="1164853"/>
            </a:xfrm>
            <a:custGeom>
              <a:avLst/>
              <a:gdLst>
                <a:gd name="T0" fmla="*/ 861 w 2587"/>
                <a:gd name="T1" fmla="*/ 195 h 2151"/>
                <a:gd name="T2" fmla="*/ 885 w 2587"/>
                <a:gd name="T3" fmla="*/ 143 h 2151"/>
                <a:gd name="T4" fmla="*/ 931 w 2587"/>
                <a:gd name="T5" fmla="*/ 97 h 2151"/>
                <a:gd name="T6" fmla="*/ 965 w 2587"/>
                <a:gd name="T7" fmla="*/ 76 h 2151"/>
                <a:gd name="T8" fmla="*/ 988 w 2587"/>
                <a:gd name="T9" fmla="*/ 47 h 2151"/>
                <a:gd name="T10" fmla="*/ 985 w 2587"/>
                <a:gd name="T11" fmla="*/ 21 h 2151"/>
                <a:gd name="T12" fmla="*/ 955 w 2587"/>
                <a:gd name="T13" fmla="*/ 3 h 2151"/>
                <a:gd name="T14" fmla="*/ 0 w 2587"/>
                <a:gd name="T15" fmla="*/ 2151 h 2151"/>
                <a:gd name="T16" fmla="*/ 2156 w 2587"/>
                <a:gd name="T17" fmla="*/ 1220 h 2151"/>
                <a:gd name="T18" fmla="*/ 2163 w 2587"/>
                <a:gd name="T19" fmla="*/ 1186 h 2151"/>
                <a:gd name="T20" fmla="*/ 2182 w 2587"/>
                <a:gd name="T21" fmla="*/ 1163 h 2151"/>
                <a:gd name="T22" fmla="*/ 2211 w 2587"/>
                <a:gd name="T23" fmla="*/ 1166 h 2151"/>
                <a:gd name="T24" fmla="*/ 2239 w 2587"/>
                <a:gd name="T25" fmla="*/ 1196 h 2151"/>
                <a:gd name="T26" fmla="*/ 2263 w 2587"/>
                <a:gd name="T27" fmla="*/ 1235 h 2151"/>
                <a:gd name="T28" fmla="*/ 2309 w 2587"/>
                <a:gd name="T29" fmla="*/ 1274 h 2151"/>
                <a:gd name="T30" fmla="*/ 2368 w 2587"/>
                <a:gd name="T31" fmla="*/ 1293 h 2151"/>
                <a:gd name="T32" fmla="*/ 2426 w 2587"/>
                <a:gd name="T33" fmla="*/ 1288 h 2151"/>
                <a:gd name="T34" fmla="*/ 2498 w 2587"/>
                <a:gd name="T35" fmla="*/ 1251 h 2151"/>
                <a:gd name="T36" fmla="*/ 2553 w 2587"/>
                <a:gd name="T37" fmla="*/ 1184 h 2151"/>
                <a:gd name="T38" fmla="*/ 2582 w 2587"/>
                <a:gd name="T39" fmla="*/ 1095 h 2151"/>
                <a:gd name="T40" fmla="*/ 2586 w 2587"/>
                <a:gd name="T41" fmla="*/ 1018 h 2151"/>
                <a:gd name="T42" fmla="*/ 2563 w 2587"/>
                <a:gd name="T43" fmla="*/ 926 h 2151"/>
                <a:gd name="T44" fmla="*/ 2514 w 2587"/>
                <a:gd name="T45" fmla="*/ 852 h 2151"/>
                <a:gd name="T46" fmla="*/ 2446 w 2587"/>
                <a:gd name="T47" fmla="*/ 805 h 2151"/>
                <a:gd name="T48" fmla="*/ 2385 w 2587"/>
                <a:gd name="T49" fmla="*/ 794 h 2151"/>
                <a:gd name="T50" fmla="*/ 2322 w 2587"/>
                <a:gd name="T51" fmla="*/ 808 h 2151"/>
                <a:gd name="T52" fmla="*/ 2278 w 2587"/>
                <a:gd name="T53" fmla="*/ 838 h 2151"/>
                <a:gd name="T54" fmla="*/ 2245 w 2587"/>
                <a:gd name="T55" fmla="*/ 882 h 2151"/>
                <a:gd name="T56" fmla="*/ 2218 w 2587"/>
                <a:gd name="T57" fmla="*/ 917 h 2151"/>
                <a:gd name="T58" fmla="*/ 2189 w 2587"/>
                <a:gd name="T59" fmla="*/ 927 h 2151"/>
                <a:gd name="T60" fmla="*/ 2166 w 2587"/>
                <a:gd name="T61" fmla="*/ 911 h 2151"/>
                <a:gd name="T62" fmla="*/ 2156 w 2587"/>
                <a:gd name="T63" fmla="*/ 869 h 2151"/>
                <a:gd name="T64" fmla="*/ 1282 w 2587"/>
                <a:gd name="T65" fmla="*/ 0 h 2151"/>
                <a:gd name="T66" fmla="*/ 1248 w 2587"/>
                <a:gd name="T67" fmla="*/ 6 h 2151"/>
                <a:gd name="T68" fmla="*/ 1227 w 2587"/>
                <a:gd name="T69" fmla="*/ 27 h 2151"/>
                <a:gd name="T70" fmla="*/ 1229 w 2587"/>
                <a:gd name="T71" fmla="*/ 55 h 2151"/>
                <a:gd name="T72" fmla="*/ 1258 w 2587"/>
                <a:gd name="T73" fmla="*/ 83 h 2151"/>
                <a:gd name="T74" fmla="*/ 1297 w 2587"/>
                <a:gd name="T75" fmla="*/ 107 h 2151"/>
                <a:gd name="T76" fmla="*/ 1336 w 2587"/>
                <a:gd name="T77" fmla="*/ 154 h 2151"/>
                <a:gd name="T78" fmla="*/ 1356 w 2587"/>
                <a:gd name="T79" fmla="*/ 213 h 2151"/>
                <a:gd name="T80" fmla="*/ 1352 w 2587"/>
                <a:gd name="T81" fmla="*/ 270 h 2151"/>
                <a:gd name="T82" fmla="*/ 1313 w 2587"/>
                <a:gd name="T83" fmla="*/ 341 h 2151"/>
                <a:gd name="T84" fmla="*/ 1247 w 2587"/>
                <a:gd name="T85" fmla="*/ 397 h 2151"/>
                <a:gd name="T86" fmla="*/ 1157 w 2587"/>
                <a:gd name="T87" fmla="*/ 426 h 2151"/>
                <a:gd name="T88" fmla="*/ 1082 w 2587"/>
                <a:gd name="T89" fmla="*/ 429 h 2151"/>
                <a:gd name="T90" fmla="*/ 988 w 2587"/>
                <a:gd name="T91" fmla="*/ 406 h 2151"/>
                <a:gd name="T92" fmla="*/ 915 w 2587"/>
                <a:gd name="T93" fmla="*/ 358 h 2151"/>
                <a:gd name="T94" fmla="*/ 869 w 2587"/>
                <a:gd name="T95" fmla="*/ 289 h 2151"/>
                <a:gd name="T96" fmla="*/ 858 w 2587"/>
                <a:gd name="T97" fmla="*/ 231 h 2151"/>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587" h="2151">
                  <a:moveTo>
                    <a:pt x="858" y="231"/>
                  </a:moveTo>
                  <a:lnTo>
                    <a:pt x="858" y="231"/>
                  </a:lnTo>
                  <a:lnTo>
                    <a:pt x="858" y="213"/>
                  </a:lnTo>
                  <a:lnTo>
                    <a:pt x="861" y="195"/>
                  </a:lnTo>
                  <a:lnTo>
                    <a:pt x="866" y="180"/>
                  </a:lnTo>
                  <a:lnTo>
                    <a:pt x="871" y="166"/>
                  </a:lnTo>
                  <a:lnTo>
                    <a:pt x="877" y="154"/>
                  </a:lnTo>
                  <a:lnTo>
                    <a:pt x="885" y="143"/>
                  </a:lnTo>
                  <a:lnTo>
                    <a:pt x="893" y="131"/>
                  </a:lnTo>
                  <a:lnTo>
                    <a:pt x="902" y="123"/>
                  </a:lnTo>
                  <a:lnTo>
                    <a:pt x="918" y="107"/>
                  </a:lnTo>
                  <a:lnTo>
                    <a:pt x="931" y="97"/>
                  </a:lnTo>
                  <a:lnTo>
                    <a:pt x="946" y="89"/>
                  </a:lnTo>
                  <a:lnTo>
                    <a:pt x="946" y="89"/>
                  </a:lnTo>
                  <a:lnTo>
                    <a:pt x="955" y="83"/>
                  </a:lnTo>
                  <a:lnTo>
                    <a:pt x="965" y="76"/>
                  </a:lnTo>
                  <a:lnTo>
                    <a:pt x="973" y="70"/>
                  </a:lnTo>
                  <a:lnTo>
                    <a:pt x="980" y="62"/>
                  </a:lnTo>
                  <a:lnTo>
                    <a:pt x="985" y="55"/>
                  </a:lnTo>
                  <a:lnTo>
                    <a:pt x="988" y="47"/>
                  </a:lnTo>
                  <a:lnTo>
                    <a:pt x="989" y="40"/>
                  </a:lnTo>
                  <a:lnTo>
                    <a:pt x="989" y="34"/>
                  </a:lnTo>
                  <a:lnTo>
                    <a:pt x="988" y="27"/>
                  </a:lnTo>
                  <a:lnTo>
                    <a:pt x="985" y="21"/>
                  </a:lnTo>
                  <a:lnTo>
                    <a:pt x="980" y="14"/>
                  </a:lnTo>
                  <a:lnTo>
                    <a:pt x="973" y="9"/>
                  </a:lnTo>
                  <a:lnTo>
                    <a:pt x="965" y="6"/>
                  </a:lnTo>
                  <a:lnTo>
                    <a:pt x="955" y="3"/>
                  </a:lnTo>
                  <a:lnTo>
                    <a:pt x="944" y="1"/>
                  </a:lnTo>
                  <a:lnTo>
                    <a:pt x="933" y="0"/>
                  </a:lnTo>
                  <a:lnTo>
                    <a:pt x="0" y="0"/>
                  </a:lnTo>
                  <a:lnTo>
                    <a:pt x="0" y="2151"/>
                  </a:lnTo>
                  <a:lnTo>
                    <a:pt x="2154" y="2151"/>
                  </a:lnTo>
                  <a:lnTo>
                    <a:pt x="2154" y="1656"/>
                  </a:lnTo>
                  <a:lnTo>
                    <a:pt x="2156" y="1656"/>
                  </a:lnTo>
                  <a:lnTo>
                    <a:pt x="2156" y="1220"/>
                  </a:lnTo>
                  <a:lnTo>
                    <a:pt x="2156" y="1220"/>
                  </a:lnTo>
                  <a:lnTo>
                    <a:pt x="2158" y="1207"/>
                  </a:lnTo>
                  <a:lnTo>
                    <a:pt x="2159" y="1196"/>
                  </a:lnTo>
                  <a:lnTo>
                    <a:pt x="2163" y="1186"/>
                  </a:lnTo>
                  <a:lnTo>
                    <a:pt x="2166" y="1178"/>
                  </a:lnTo>
                  <a:lnTo>
                    <a:pt x="2171" y="1171"/>
                  </a:lnTo>
                  <a:lnTo>
                    <a:pt x="2177" y="1166"/>
                  </a:lnTo>
                  <a:lnTo>
                    <a:pt x="2182" y="1163"/>
                  </a:lnTo>
                  <a:lnTo>
                    <a:pt x="2189" y="1161"/>
                  </a:lnTo>
                  <a:lnTo>
                    <a:pt x="2197" y="1161"/>
                  </a:lnTo>
                  <a:lnTo>
                    <a:pt x="2203" y="1163"/>
                  </a:lnTo>
                  <a:lnTo>
                    <a:pt x="2211" y="1166"/>
                  </a:lnTo>
                  <a:lnTo>
                    <a:pt x="2218" y="1171"/>
                  </a:lnTo>
                  <a:lnTo>
                    <a:pt x="2226" y="1178"/>
                  </a:lnTo>
                  <a:lnTo>
                    <a:pt x="2232" y="1186"/>
                  </a:lnTo>
                  <a:lnTo>
                    <a:pt x="2239" y="1196"/>
                  </a:lnTo>
                  <a:lnTo>
                    <a:pt x="2245" y="1207"/>
                  </a:lnTo>
                  <a:lnTo>
                    <a:pt x="2245" y="1207"/>
                  </a:lnTo>
                  <a:lnTo>
                    <a:pt x="2254" y="1220"/>
                  </a:lnTo>
                  <a:lnTo>
                    <a:pt x="2263" y="1235"/>
                  </a:lnTo>
                  <a:lnTo>
                    <a:pt x="2278" y="1251"/>
                  </a:lnTo>
                  <a:lnTo>
                    <a:pt x="2288" y="1259"/>
                  </a:lnTo>
                  <a:lnTo>
                    <a:pt x="2298" y="1266"/>
                  </a:lnTo>
                  <a:lnTo>
                    <a:pt x="2309" y="1274"/>
                  </a:lnTo>
                  <a:lnTo>
                    <a:pt x="2322" y="1280"/>
                  </a:lnTo>
                  <a:lnTo>
                    <a:pt x="2337" y="1285"/>
                  </a:lnTo>
                  <a:lnTo>
                    <a:pt x="2351" y="1290"/>
                  </a:lnTo>
                  <a:lnTo>
                    <a:pt x="2368" y="1293"/>
                  </a:lnTo>
                  <a:lnTo>
                    <a:pt x="2385" y="1293"/>
                  </a:lnTo>
                  <a:lnTo>
                    <a:pt x="2385" y="1293"/>
                  </a:lnTo>
                  <a:lnTo>
                    <a:pt x="2407" y="1293"/>
                  </a:lnTo>
                  <a:lnTo>
                    <a:pt x="2426" y="1288"/>
                  </a:lnTo>
                  <a:lnTo>
                    <a:pt x="2446" y="1283"/>
                  </a:lnTo>
                  <a:lnTo>
                    <a:pt x="2463" y="1274"/>
                  </a:lnTo>
                  <a:lnTo>
                    <a:pt x="2481" y="1264"/>
                  </a:lnTo>
                  <a:lnTo>
                    <a:pt x="2498" y="1251"/>
                  </a:lnTo>
                  <a:lnTo>
                    <a:pt x="2514" y="1236"/>
                  </a:lnTo>
                  <a:lnTo>
                    <a:pt x="2527" y="1220"/>
                  </a:lnTo>
                  <a:lnTo>
                    <a:pt x="2540" y="1204"/>
                  </a:lnTo>
                  <a:lnTo>
                    <a:pt x="2553" y="1184"/>
                  </a:lnTo>
                  <a:lnTo>
                    <a:pt x="2563" y="1163"/>
                  </a:lnTo>
                  <a:lnTo>
                    <a:pt x="2571" y="1142"/>
                  </a:lnTo>
                  <a:lnTo>
                    <a:pt x="2577" y="1119"/>
                  </a:lnTo>
                  <a:lnTo>
                    <a:pt x="2582" y="1095"/>
                  </a:lnTo>
                  <a:lnTo>
                    <a:pt x="2586" y="1070"/>
                  </a:lnTo>
                  <a:lnTo>
                    <a:pt x="2587" y="1044"/>
                  </a:lnTo>
                  <a:lnTo>
                    <a:pt x="2587" y="1044"/>
                  </a:lnTo>
                  <a:lnTo>
                    <a:pt x="2586" y="1018"/>
                  </a:lnTo>
                  <a:lnTo>
                    <a:pt x="2582" y="994"/>
                  </a:lnTo>
                  <a:lnTo>
                    <a:pt x="2577" y="969"/>
                  </a:lnTo>
                  <a:lnTo>
                    <a:pt x="2571" y="947"/>
                  </a:lnTo>
                  <a:lnTo>
                    <a:pt x="2563" y="926"/>
                  </a:lnTo>
                  <a:lnTo>
                    <a:pt x="2553" y="904"/>
                  </a:lnTo>
                  <a:lnTo>
                    <a:pt x="2540" y="885"/>
                  </a:lnTo>
                  <a:lnTo>
                    <a:pt x="2527" y="867"/>
                  </a:lnTo>
                  <a:lnTo>
                    <a:pt x="2514" y="852"/>
                  </a:lnTo>
                  <a:lnTo>
                    <a:pt x="2498" y="838"/>
                  </a:lnTo>
                  <a:lnTo>
                    <a:pt x="2481" y="825"/>
                  </a:lnTo>
                  <a:lnTo>
                    <a:pt x="2463" y="815"/>
                  </a:lnTo>
                  <a:lnTo>
                    <a:pt x="2446" y="805"/>
                  </a:lnTo>
                  <a:lnTo>
                    <a:pt x="2426" y="800"/>
                  </a:lnTo>
                  <a:lnTo>
                    <a:pt x="2407" y="795"/>
                  </a:lnTo>
                  <a:lnTo>
                    <a:pt x="2385" y="794"/>
                  </a:lnTo>
                  <a:lnTo>
                    <a:pt x="2385" y="794"/>
                  </a:lnTo>
                  <a:lnTo>
                    <a:pt x="2368" y="795"/>
                  </a:lnTo>
                  <a:lnTo>
                    <a:pt x="2351" y="799"/>
                  </a:lnTo>
                  <a:lnTo>
                    <a:pt x="2337" y="802"/>
                  </a:lnTo>
                  <a:lnTo>
                    <a:pt x="2322" y="808"/>
                  </a:lnTo>
                  <a:lnTo>
                    <a:pt x="2309" y="815"/>
                  </a:lnTo>
                  <a:lnTo>
                    <a:pt x="2298" y="821"/>
                  </a:lnTo>
                  <a:lnTo>
                    <a:pt x="2288" y="830"/>
                  </a:lnTo>
                  <a:lnTo>
                    <a:pt x="2278" y="838"/>
                  </a:lnTo>
                  <a:lnTo>
                    <a:pt x="2263" y="854"/>
                  </a:lnTo>
                  <a:lnTo>
                    <a:pt x="2254" y="869"/>
                  </a:lnTo>
                  <a:lnTo>
                    <a:pt x="2245" y="882"/>
                  </a:lnTo>
                  <a:lnTo>
                    <a:pt x="2245" y="882"/>
                  </a:lnTo>
                  <a:lnTo>
                    <a:pt x="2239" y="893"/>
                  </a:lnTo>
                  <a:lnTo>
                    <a:pt x="2232" y="903"/>
                  </a:lnTo>
                  <a:lnTo>
                    <a:pt x="2226" y="911"/>
                  </a:lnTo>
                  <a:lnTo>
                    <a:pt x="2218" y="917"/>
                  </a:lnTo>
                  <a:lnTo>
                    <a:pt x="2211" y="922"/>
                  </a:lnTo>
                  <a:lnTo>
                    <a:pt x="2203" y="926"/>
                  </a:lnTo>
                  <a:lnTo>
                    <a:pt x="2197" y="927"/>
                  </a:lnTo>
                  <a:lnTo>
                    <a:pt x="2189" y="927"/>
                  </a:lnTo>
                  <a:lnTo>
                    <a:pt x="2182" y="926"/>
                  </a:lnTo>
                  <a:lnTo>
                    <a:pt x="2177" y="922"/>
                  </a:lnTo>
                  <a:lnTo>
                    <a:pt x="2171" y="917"/>
                  </a:lnTo>
                  <a:lnTo>
                    <a:pt x="2166" y="911"/>
                  </a:lnTo>
                  <a:lnTo>
                    <a:pt x="2163" y="903"/>
                  </a:lnTo>
                  <a:lnTo>
                    <a:pt x="2159" y="893"/>
                  </a:lnTo>
                  <a:lnTo>
                    <a:pt x="2158" y="882"/>
                  </a:lnTo>
                  <a:lnTo>
                    <a:pt x="2156" y="869"/>
                  </a:lnTo>
                  <a:lnTo>
                    <a:pt x="2156" y="595"/>
                  </a:lnTo>
                  <a:lnTo>
                    <a:pt x="2154" y="595"/>
                  </a:lnTo>
                  <a:lnTo>
                    <a:pt x="2154" y="0"/>
                  </a:lnTo>
                  <a:lnTo>
                    <a:pt x="1282" y="0"/>
                  </a:lnTo>
                  <a:lnTo>
                    <a:pt x="1282" y="0"/>
                  </a:lnTo>
                  <a:lnTo>
                    <a:pt x="1269" y="1"/>
                  </a:lnTo>
                  <a:lnTo>
                    <a:pt x="1258" y="3"/>
                  </a:lnTo>
                  <a:lnTo>
                    <a:pt x="1248" y="6"/>
                  </a:lnTo>
                  <a:lnTo>
                    <a:pt x="1242" y="9"/>
                  </a:lnTo>
                  <a:lnTo>
                    <a:pt x="1235" y="14"/>
                  </a:lnTo>
                  <a:lnTo>
                    <a:pt x="1230" y="21"/>
                  </a:lnTo>
                  <a:lnTo>
                    <a:pt x="1227" y="27"/>
                  </a:lnTo>
                  <a:lnTo>
                    <a:pt x="1225" y="34"/>
                  </a:lnTo>
                  <a:lnTo>
                    <a:pt x="1225" y="40"/>
                  </a:lnTo>
                  <a:lnTo>
                    <a:pt x="1225" y="47"/>
                  </a:lnTo>
                  <a:lnTo>
                    <a:pt x="1229" y="55"/>
                  </a:lnTo>
                  <a:lnTo>
                    <a:pt x="1234" y="62"/>
                  </a:lnTo>
                  <a:lnTo>
                    <a:pt x="1240" y="70"/>
                  </a:lnTo>
                  <a:lnTo>
                    <a:pt x="1248" y="76"/>
                  </a:lnTo>
                  <a:lnTo>
                    <a:pt x="1258" y="83"/>
                  </a:lnTo>
                  <a:lnTo>
                    <a:pt x="1269" y="89"/>
                  </a:lnTo>
                  <a:lnTo>
                    <a:pt x="1269" y="89"/>
                  </a:lnTo>
                  <a:lnTo>
                    <a:pt x="1282" y="97"/>
                  </a:lnTo>
                  <a:lnTo>
                    <a:pt x="1297" y="107"/>
                  </a:lnTo>
                  <a:lnTo>
                    <a:pt x="1313" y="123"/>
                  </a:lnTo>
                  <a:lnTo>
                    <a:pt x="1321" y="131"/>
                  </a:lnTo>
                  <a:lnTo>
                    <a:pt x="1329" y="143"/>
                  </a:lnTo>
                  <a:lnTo>
                    <a:pt x="1336" y="154"/>
                  </a:lnTo>
                  <a:lnTo>
                    <a:pt x="1343" y="166"/>
                  </a:lnTo>
                  <a:lnTo>
                    <a:pt x="1349" y="180"/>
                  </a:lnTo>
                  <a:lnTo>
                    <a:pt x="1352" y="195"/>
                  </a:lnTo>
                  <a:lnTo>
                    <a:pt x="1356" y="213"/>
                  </a:lnTo>
                  <a:lnTo>
                    <a:pt x="1357" y="231"/>
                  </a:lnTo>
                  <a:lnTo>
                    <a:pt x="1357" y="231"/>
                  </a:lnTo>
                  <a:lnTo>
                    <a:pt x="1356" y="250"/>
                  </a:lnTo>
                  <a:lnTo>
                    <a:pt x="1352" y="270"/>
                  </a:lnTo>
                  <a:lnTo>
                    <a:pt x="1346" y="289"/>
                  </a:lnTo>
                  <a:lnTo>
                    <a:pt x="1338" y="307"/>
                  </a:lnTo>
                  <a:lnTo>
                    <a:pt x="1326" y="325"/>
                  </a:lnTo>
                  <a:lnTo>
                    <a:pt x="1313" y="341"/>
                  </a:lnTo>
                  <a:lnTo>
                    <a:pt x="1300" y="358"/>
                  </a:lnTo>
                  <a:lnTo>
                    <a:pt x="1284" y="372"/>
                  </a:lnTo>
                  <a:lnTo>
                    <a:pt x="1266" y="385"/>
                  </a:lnTo>
                  <a:lnTo>
                    <a:pt x="1247" y="397"/>
                  </a:lnTo>
                  <a:lnTo>
                    <a:pt x="1225" y="406"/>
                  </a:lnTo>
                  <a:lnTo>
                    <a:pt x="1204" y="415"/>
                  </a:lnTo>
                  <a:lnTo>
                    <a:pt x="1181" y="421"/>
                  </a:lnTo>
                  <a:lnTo>
                    <a:pt x="1157" y="426"/>
                  </a:lnTo>
                  <a:lnTo>
                    <a:pt x="1133" y="429"/>
                  </a:lnTo>
                  <a:lnTo>
                    <a:pt x="1107" y="431"/>
                  </a:lnTo>
                  <a:lnTo>
                    <a:pt x="1107" y="431"/>
                  </a:lnTo>
                  <a:lnTo>
                    <a:pt x="1082" y="429"/>
                  </a:lnTo>
                  <a:lnTo>
                    <a:pt x="1056" y="426"/>
                  </a:lnTo>
                  <a:lnTo>
                    <a:pt x="1033" y="421"/>
                  </a:lnTo>
                  <a:lnTo>
                    <a:pt x="1011" y="415"/>
                  </a:lnTo>
                  <a:lnTo>
                    <a:pt x="988" y="406"/>
                  </a:lnTo>
                  <a:lnTo>
                    <a:pt x="967" y="397"/>
                  </a:lnTo>
                  <a:lnTo>
                    <a:pt x="949" y="385"/>
                  </a:lnTo>
                  <a:lnTo>
                    <a:pt x="931" y="372"/>
                  </a:lnTo>
                  <a:lnTo>
                    <a:pt x="915" y="358"/>
                  </a:lnTo>
                  <a:lnTo>
                    <a:pt x="900" y="341"/>
                  </a:lnTo>
                  <a:lnTo>
                    <a:pt x="887" y="325"/>
                  </a:lnTo>
                  <a:lnTo>
                    <a:pt x="877" y="307"/>
                  </a:lnTo>
                  <a:lnTo>
                    <a:pt x="869" y="289"/>
                  </a:lnTo>
                  <a:lnTo>
                    <a:pt x="863" y="270"/>
                  </a:lnTo>
                  <a:lnTo>
                    <a:pt x="859" y="250"/>
                  </a:lnTo>
                  <a:lnTo>
                    <a:pt x="858" y="231"/>
                  </a:lnTo>
                  <a:lnTo>
                    <a:pt x="858" y="231"/>
                  </a:lnTo>
                  <a:close/>
                </a:path>
              </a:pathLst>
            </a:custGeom>
            <a:solidFill>
              <a:srgbClr val="FFFF00"/>
            </a:solidFill>
            <a:ln w="28575">
              <a:solidFill>
                <a:schemeClr val="tx1">
                  <a:lumMod val="50000"/>
                  <a:lumOff val="50000"/>
                </a:schemeClr>
              </a:solidFill>
              <a:prstDash val="solid"/>
              <a:round/>
              <a:headEnd/>
              <a:tailEnd/>
            </a:ln>
          </p:spPr>
          <p:txBody>
            <a:bodyPr rIns="468000" anchor="ctr" anchorCtr="1"/>
            <a:lstStyle/>
            <a:p>
              <a:pPr defTabSz="457200">
                <a:defRPr/>
              </a:pPr>
              <a:r>
                <a:rPr lang="en-US" sz="4000" dirty="0">
                  <a:solidFill>
                    <a:prstClr val="black"/>
                  </a:solidFill>
                </a:rPr>
                <a:t>C</a:t>
              </a:r>
              <a:endParaRPr lang="en-GB" sz="4000" dirty="0">
                <a:solidFill>
                  <a:prstClr val="black"/>
                </a:solidFill>
                <a:cs typeface="Arial" charset="0"/>
              </a:endParaRPr>
            </a:p>
          </p:txBody>
        </p:sp>
        <p:sp>
          <p:nvSpPr>
            <p:cNvPr id="19" name="Freeform 18">
              <a:extLst>
                <a:ext uri="{FF2B5EF4-FFF2-40B4-BE49-F238E27FC236}">
                  <a16:creationId xmlns:a16="http://schemas.microsoft.com/office/drawing/2014/main" xmlns="" id="{47857E53-A86D-EB4B-ACBD-4BCB6D667310}"/>
                </a:ext>
              </a:extLst>
            </p:cNvPr>
            <p:cNvSpPr>
              <a:spLocks/>
            </p:cNvSpPr>
            <p:nvPr/>
          </p:nvSpPr>
          <p:spPr bwMode="auto">
            <a:xfrm>
              <a:off x="9731788" y="2322515"/>
              <a:ext cx="1265421" cy="1164853"/>
            </a:xfrm>
            <a:custGeom>
              <a:avLst/>
              <a:gdLst>
                <a:gd name="T0" fmla="*/ 1726 w 2587"/>
                <a:gd name="T1" fmla="*/ 1956 h 2150"/>
                <a:gd name="T2" fmla="*/ 1702 w 2587"/>
                <a:gd name="T3" fmla="*/ 2008 h 2150"/>
                <a:gd name="T4" fmla="*/ 1656 w 2587"/>
                <a:gd name="T5" fmla="*/ 2054 h 2150"/>
                <a:gd name="T6" fmla="*/ 1620 w 2587"/>
                <a:gd name="T7" fmla="*/ 2075 h 2150"/>
                <a:gd name="T8" fmla="*/ 1599 w 2587"/>
                <a:gd name="T9" fmla="*/ 2104 h 2150"/>
                <a:gd name="T10" fmla="*/ 1602 w 2587"/>
                <a:gd name="T11" fmla="*/ 2130 h 2150"/>
                <a:gd name="T12" fmla="*/ 1632 w 2587"/>
                <a:gd name="T13" fmla="*/ 2148 h 2150"/>
                <a:gd name="T14" fmla="*/ 2587 w 2587"/>
                <a:gd name="T15" fmla="*/ 0 h 2150"/>
                <a:gd name="T16" fmla="*/ 429 w 2587"/>
                <a:gd name="T17" fmla="*/ 931 h 2150"/>
                <a:gd name="T18" fmla="*/ 424 w 2587"/>
                <a:gd name="T19" fmla="*/ 965 h 2150"/>
                <a:gd name="T20" fmla="*/ 403 w 2587"/>
                <a:gd name="T21" fmla="*/ 988 h 2150"/>
                <a:gd name="T22" fmla="*/ 376 w 2587"/>
                <a:gd name="T23" fmla="*/ 985 h 2150"/>
                <a:gd name="T24" fmla="*/ 348 w 2587"/>
                <a:gd name="T25" fmla="*/ 955 h 2150"/>
                <a:gd name="T26" fmla="*/ 324 w 2587"/>
                <a:gd name="T27" fmla="*/ 916 h 2150"/>
                <a:gd name="T28" fmla="*/ 276 w 2587"/>
                <a:gd name="T29" fmla="*/ 877 h 2150"/>
                <a:gd name="T30" fmla="*/ 218 w 2587"/>
                <a:gd name="T31" fmla="*/ 858 h 2150"/>
                <a:gd name="T32" fmla="*/ 161 w 2587"/>
                <a:gd name="T33" fmla="*/ 863 h 2150"/>
                <a:gd name="T34" fmla="*/ 89 w 2587"/>
                <a:gd name="T35" fmla="*/ 900 h 2150"/>
                <a:gd name="T36" fmla="*/ 34 w 2587"/>
                <a:gd name="T37" fmla="*/ 967 h 2150"/>
                <a:gd name="T38" fmla="*/ 5 w 2587"/>
                <a:gd name="T39" fmla="*/ 1056 h 2150"/>
                <a:gd name="T40" fmla="*/ 1 w 2587"/>
                <a:gd name="T41" fmla="*/ 1133 h 2150"/>
                <a:gd name="T42" fmla="*/ 24 w 2587"/>
                <a:gd name="T43" fmla="*/ 1225 h 2150"/>
                <a:gd name="T44" fmla="*/ 73 w 2587"/>
                <a:gd name="T45" fmla="*/ 1299 h 2150"/>
                <a:gd name="T46" fmla="*/ 141 w 2587"/>
                <a:gd name="T47" fmla="*/ 1346 h 2150"/>
                <a:gd name="T48" fmla="*/ 200 w 2587"/>
                <a:gd name="T49" fmla="*/ 1356 h 2150"/>
                <a:gd name="T50" fmla="*/ 263 w 2587"/>
                <a:gd name="T51" fmla="*/ 1343 h 2150"/>
                <a:gd name="T52" fmla="*/ 307 w 2587"/>
                <a:gd name="T53" fmla="*/ 1313 h 2150"/>
                <a:gd name="T54" fmla="*/ 342 w 2587"/>
                <a:gd name="T55" fmla="*/ 1269 h 2150"/>
                <a:gd name="T56" fmla="*/ 369 w 2587"/>
                <a:gd name="T57" fmla="*/ 1234 h 2150"/>
                <a:gd name="T58" fmla="*/ 397 w 2587"/>
                <a:gd name="T59" fmla="*/ 1224 h 2150"/>
                <a:gd name="T60" fmla="*/ 421 w 2587"/>
                <a:gd name="T61" fmla="*/ 1240 h 2150"/>
                <a:gd name="T62" fmla="*/ 429 w 2587"/>
                <a:gd name="T63" fmla="*/ 1282 h 2150"/>
                <a:gd name="T64" fmla="*/ 1305 w 2587"/>
                <a:gd name="T65" fmla="*/ 2150 h 2150"/>
                <a:gd name="T66" fmla="*/ 1337 w 2587"/>
                <a:gd name="T67" fmla="*/ 2145 h 2150"/>
                <a:gd name="T68" fmla="*/ 1360 w 2587"/>
                <a:gd name="T69" fmla="*/ 2124 h 2150"/>
                <a:gd name="T70" fmla="*/ 1357 w 2587"/>
                <a:gd name="T71" fmla="*/ 2096 h 2150"/>
                <a:gd name="T72" fmla="*/ 1329 w 2587"/>
                <a:gd name="T73" fmla="*/ 2068 h 2150"/>
                <a:gd name="T74" fmla="*/ 1290 w 2587"/>
                <a:gd name="T75" fmla="*/ 2044 h 2150"/>
                <a:gd name="T76" fmla="*/ 1251 w 2587"/>
                <a:gd name="T77" fmla="*/ 1997 h 2150"/>
                <a:gd name="T78" fmla="*/ 1231 w 2587"/>
                <a:gd name="T79" fmla="*/ 1938 h 2150"/>
                <a:gd name="T80" fmla="*/ 1235 w 2587"/>
                <a:gd name="T81" fmla="*/ 1881 h 2150"/>
                <a:gd name="T82" fmla="*/ 1272 w 2587"/>
                <a:gd name="T83" fmla="*/ 1810 h 2150"/>
                <a:gd name="T84" fmla="*/ 1340 w 2587"/>
                <a:gd name="T85" fmla="*/ 1754 h 2150"/>
                <a:gd name="T86" fmla="*/ 1430 w 2587"/>
                <a:gd name="T87" fmla="*/ 1725 h 2150"/>
                <a:gd name="T88" fmla="*/ 1505 w 2587"/>
                <a:gd name="T89" fmla="*/ 1722 h 2150"/>
                <a:gd name="T90" fmla="*/ 1599 w 2587"/>
                <a:gd name="T91" fmla="*/ 1745 h 2150"/>
                <a:gd name="T92" fmla="*/ 1672 w 2587"/>
                <a:gd name="T93" fmla="*/ 1793 h 2150"/>
                <a:gd name="T94" fmla="*/ 1718 w 2587"/>
                <a:gd name="T95" fmla="*/ 1862 h 2150"/>
                <a:gd name="T96" fmla="*/ 1729 w 2587"/>
                <a:gd name="T97" fmla="*/ 1920 h 215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587" h="2150">
                  <a:moveTo>
                    <a:pt x="1729" y="1920"/>
                  </a:moveTo>
                  <a:lnTo>
                    <a:pt x="1729" y="1920"/>
                  </a:lnTo>
                  <a:lnTo>
                    <a:pt x="1728" y="1938"/>
                  </a:lnTo>
                  <a:lnTo>
                    <a:pt x="1726" y="1956"/>
                  </a:lnTo>
                  <a:lnTo>
                    <a:pt x="1721" y="1971"/>
                  </a:lnTo>
                  <a:lnTo>
                    <a:pt x="1716" y="1984"/>
                  </a:lnTo>
                  <a:lnTo>
                    <a:pt x="1710" y="1997"/>
                  </a:lnTo>
                  <a:lnTo>
                    <a:pt x="1702" y="2008"/>
                  </a:lnTo>
                  <a:lnTo>
                    <a:pt x="1694" y="2020"/>
                  </a:lnTo>
                  <a:lnTo>
                    <a:pt x="1685" y="2028"/>
                  </a:lnTo>
                  <a:lnTo>
                    <a:pt x="1669" y="2044"/>
                  </a:lnTo>
                  <a:lnTo>
                    <a:pt x="1656" y="2054"/>
                  </a:lnTo>
                  <a:lnTo>
                    <a:pt x="1641" y="2062"/>
                  </a:lnTo>
                  <a:lnTo>
                    <a:pt x="1641" y="2062"/>
                  </a:lnTo>
                  <a:lnTo>
                    <a:pt x="1630" y="2068"/>
                  </a:lnTo>
                  <a:lnTo>
                    <a:pt x="1620" y="2075"/>
                  </a:lnTo>
                  <a:lnTo>
                    <a:pt x="1614" y="2081"/>
                  </a:lnTo>
                  <a:lnTo>
                    <a:pt x="1607" y="2089"/>
                  </a:lnTo>
                  <a:lnTo>
                    <a:pt x="1602" y="2096"/>
                  </a:lnTo>
                  <a:lnTo>
                    <a:pt x="1599" y="2104"/>
                  </a:lnTo>
                  <a:lnTo>
                    <a:pt x="1598" y="2111"/>
                  </a:lnTo>
                  <a:lnTo>
                    <a:pt x="1598" y="2117"/>
                  </a:lnTo>
                  <a:lnTo>
                    <a:pt x="1599" y="2124"/>
                  </a:lnTo>
                  <a:lnTo>
                    <a:pt x="1602" y="2130"/>
                  </a:lnTo>
                  <a:lnTo>
                    <a:pt x="1607" y="2137"/>
                  </a:lnTo>
                  <a:lnTo>
                    <a:pt x="1614" y="2142"/>
                  </a:lnTo>
                  <a:lnTo>
                    <a:pt x="1622" y="2145"/>
                  </a:lnTo>
                  <a:lnTo>
                    <a:pt x="1632" y="2148"/>
                  </a:lnTo>
                  <a:lnTo>
                    <a:pt x="1641" y="2150"/>
                  </a:lnTo>
                  <a:lnTo>
                    <a:pt x="1654" y="2150"/>
                  </a:lnTo>
                  <a:lnTo>
                    <a:pt x="2587" y="2150"/>
                  </a:lnTo>
                  <a:lnTo>
                    <a:pt x="2587" y="0"/>
                  </a:lnTo>
                  <a:lnTo>
                    <a:pt x="433" y="0"/>
                  </a:lnTo>
                  <a:lnTo>
                    <a:pt x="433" y="495"/>
                  </a:lnTo>
                  <a:lnTo>
                    <a:pt x="429" y="495"/>
                  </a:lnTo>
                  <a:lnTo>
                    <a:pt x="429" y="931"/>
                  </a:lnTo>
                  <a:lnTo>
                    <a:pt x="429" y="931"/>
                  </a:lnTo>
                  <a:lnTo>
                    <a:pt x="429" y="944"/>
                  </a:lnTo>
                  <a:lnTo>
                    <a:pt x="428" y="955"/>
                  </a:lnTo>
                  <a:lnTo>
                    <a:pt x="424" y="965"/>
                  </a:lnTo>
                  <a:lnTo>
                    <a:pt x="421" y="973"/>
                  </a:lnTo>
                  <a:lnTo>
                    <a:pt x="416" y="980"/>
                  </a:lnTo>
                  <a:lnTo>
                    <a:pt x="410" y="985"/>
                  </a:lnTo>
                  <a:lnTo>
                    <a:pt x="403" y="988"/>
                  </a:lnTo>
                  <a:lnTo>
                    <a:pt x="397" y="990"/>
                  </a:lnTo>
                  <a:lnTo>
                    <a:pt x="390" y="990"/>
                  </a:lnTo>
                  <a:lnTo>
                    <a:pt x="384" y="988"/>
                  </a:lnTo>
                  <a:lnTo>
                    <a:pt x="376" y="985"/>
                  </a:lnTo>
                  <a:lnTo>
                    <a:pt x="369" y="980"/>
                  </a:lnTo>
                  <a:lnTo>
                    <a:pt x="361" y="973"/>
                  </a:lnTo>
                  <a:lnTo>
                    <a:pt x="355" y="965"/>
                  </a:lnTo>
                  <a:lnTo>
                    <a:pt x="348" y="955"/>
                  </a:lnTo>
                  <a:lnTo>
                    <a:pt x="342" y="944"/>
                  </a:lnTo>
                  <a:lnTo>
                    <a:pt x="342" y="944"/>
                  </a:lnTo>
                  <a:lnTo>
                    <a:pt x="333" y="931"/>
                  </a:lnTo>
                  <a:lnTo>
                    <a:pt x="324" y="916"/>
                  </a:lnTo>
                  <a:lnTo>
                    <a:pt x="307" y="900"/>
                  </a:lnTo>
                  <a:lnTo>
                    <a:pt x="299" y="892"/>
                  </a:lnTo>
                  <a:lnTo>
                    <a:pt x="288" y="885"/>
                  </a:lnTo>
                  <a:lnTo>
                    <a:pt x="276" y="877"/>
                  </a:lnTo>
                  <a:lnTo>
                    <a:pt x="263" y="871"/>
                  </a:lnTo>
                  <a:lnTo>
                    <a:pt x="250" y="866"/>
                  </a:lnTo>
                  <a:lnTo>
                    <a:pt x="236" y="861"/>
                  </a:lnTo>
                  <a:lnTo>
                    <a:pt x="218" y="858"/>
                  </a:lnTo>
                  <a:lnTo>
                    <a:pt x="200" y="858"/>
                  </a:lnTo>
                  <a:lnTo>
                    <a:pt x="200" y="858"/>
                  </a:lnTo>
                  <a:lnTo>
                    <a:pt x="180" y="858"/>
                  </a:lnTo>
                  <a:lnTo>
                    <a:pt x="161" y="863"/>
                  </a:lnTo>
                  <a:lnTo>
                    <a:pt x="141" y="868"/>
                  </a:lnTo>
                  <a:lnTo>
                    <a:pt x="122" y="877"/>
                  </a:lnTo>
                  <a:lnTo>
                    <a:pt x="106" y="887"/>
                  </a:lnTo>
                  <a:lnTo>
                    <a:pt x="89" y="900"/>
                  </a:lnTo>
                  <a:lnTo>
                    <a:pt x="73" y="915"/>
                  </a:lnTo>
                  <a:lnTo>
                    <a:pt x="58" y="931"/>
                  </a:lnTo>
                  <a:lnTo>
                    <a:pt x="45" y="947"/>
                  </a:lnTo>
                  <a:lnTo>
                    <a:pt x="34" y="967"/>
                  </a:lnTo>
                  <a:lnTo>
                    <a:pt x="24" y="988"/>
                  </a:lnTo>
                  <a:lnTo>
                    <a:pt x="16" y="1009"/>
                  </a:lnTo>
                  <a:lnTo>
                    <a:pt x="10" y="1032"/>
                  </a:lnTo>
                  <a:lnTo>
                    <a:pt x="5" y="1056"/>
                  </a:lnTo>
                  <a:lnTo>
                    <a:pt x="1" y="1081"/>
                  </a:lnTo>
                  <a:lnTo>
                    <a:pt x="0" y="1107"/>
                  </a:lnTo>
                  <a:lnTo>
                    <a:pt x="0" y="1107"/>
                  </a:lnTo>
                  <a:lnTo>
                    <a:pt x="1" y="1133"/>
                  </a:lnTo>
                  <a:lnTo>
                    <a:pt x="5" y="1157"/>
                  </a:lnTo>
                  <a:lnTo>
                    <a:pt x="10" y="1182"/>
                  </a:lnTo>
                  <a:lnTo>
                    <a:pt x="16" y="1204"/>
                  </a:lnTo>
                  <a:lnTo>
                    <a:pt x="24" y="1225"/>
                  </a:lnTo>
                  <a:lnTo>
                    <a:pt x="34" y="1247"/>
                  </a:lnTo>
                  <a:lnTo>
                    <a:pt x="45" y="1266"/>
                  </a:lnTo>
                  <a:lnTo>
                    <a:pt x="58" y="1284"/>
                  </a:lnTo>
                  <a:lnTo>
                    <a:pt x="73" y="1299"/>
                  </a:lnTo>
                  <a:lnTo>
                    <a:pt x="89" y="1313"/>
                  </a:lnTo>
                  <a:lnTo>
                    <a:pt x="106" y="1326"/>
                  </a:lnTo>
                  <a:lnTo>
                    <a:pt x="122" y="1336"/>
                  </a:lnTo>
                  <a:lnTo>
                    <a:pt x="141" y="1346"/>
                  </a:lnTo>
                  <a:lnTo>
                    <a:pt x="161" y="1351"/>
                  </a:lnTo>
                  <a:lnTo>
                    <a:pt x="180" y="1356"/>
                  </a:lnTo>
                  <a:lnTo>
                    <a:pt x="200" y="1356"/>
                  </a:lnTo>
                  <a:lnTo>
                    <a:pt x="200" y="1356"/>
                  </a:lnTo>
                  <a:lnTo>
                    <a:pt x="218" y="1356"/>
                  </a:lnTo>
                  <a:lnTo>
                    <a:pt x="236" y="1352"/>
                  </a:lnTo>
                  <a:lnTo>
                    <a:pt x="250" y="1349"/>
                  </a:lnTo>
                  <a:lnTo>
                    <a:pt x="263" y="1343"/>
                  </a:lnTo>
                  <a:lnTo>
                    <a:pt x="276" y="1336"/>
                  </a:lnTo>
                  <a:lnTo>
                    <a:pt x="288" y="1328"/>
                  </a:lnTo>
                  <a:lnTo>
                    <a:pt x="299" y="1321"/>
                  </a:lnTo>
                  <a:lnTo>
                    <a:pt x="307" y="1313"/>
                  </a:lnTo>
                  <a:lnTo>
                    <a:pt x="324" y="1297"/>
                  </a:lnTo>
                  <a:lnTo>
                    <a:pt x="333" y="1282"/>
                  </a:lnTo>
                  <a:lnTo>
                    <a:pt x="342" y="1269"/>
                  </a:lnTo>
                  <a:lnTo>
                    <a:pt x="342" y="1269"/>
                  </a:lnTo>
                  <a:lnTo>
                    <a:pt x="348" y="1258"/>
                  </a:lnTo>
                  <a:lnTo>
                    <a:pt x="355" y="1248"/>
                  </a:lnTo>
                  <a:lnTo>
                    <a:pt x="361" y="1240"/>
                  </a:lnTo>
                  <a:lnTo>
                    <a:pt x="369" y="1234"/>
                  </a:lnTo>
                  <a:lnTo>
                    <a:pt x="376" y="1229"/>
                  </a:lnTo>
                  <a:lnTo>
                    <a:pt x="384" y="1225"/>
                  </a:lnTo>
                  <a:lnTo>
                    <a:pt x="390" y="1224"/>
                  </a:lnTo>
                  <a:lnTo>
                    <a:pt x="397" y="1224"/>
                  </a:lnTo>
                  <a:lnTo>
                    <a:pt x="403" y="1225"/>
                  </a:lnTo>
                  <a:lnTo>
                    <a:pt x="410" y="1229"/>
                  </a:lnTo>
                  <a:lnTo>
                    <a:pt x="416" y="1234"/>
                  </a:lnTo>
                  <a:lnTo>
                    <a:pt x="421" y="1240"/>
                  </a:lnTo>
                  <a:lnTo>
                    <a:pt x="424" y="1248"/>
                  </a:lnTo>
                  <a:lnTo>
                    <a:pt x="428" y="1258"/>
                  </a:lnTo>
                  <a:lnTo>
                    <a:pt x="429" y="1269"/>
                  </a:lnTo>
                  <a:lnTo>
                    <a:pt x="429" y="1282"/>
                  </a:lnTo>
                  <a:lnTo>
                    <a:pt x="429" y="1556"/>
                  </a:lnTo>
                  <a:lnTo>
                    <a:pt x="433" y="1556"/>
                  </a:lnTo>
                  <a:lnTo>
                    <a:pt x="433" y="2150"/>
                  </a:lnTo>
                  <a:lnTo>
                    <a:pt x="1305" y="2150"/>
                  </a:lnTo>
                  <a:lnTo>
                    <a:pt x="1305" y="2150"/>
                  </a:lnTo>
                  <a:lnTo>
                    <a:pt x="1318" y="2150"/>
                  </a:lnTo>
                  <a:lnTo>
                    <a:pt x="1327" y="2148"/>
                  </a:lnTo>
                  <a:lnTo>
                    <a:pt x="1337" y="2145"/>
                  </a:lnTo>
                  <a:lnTo>
                    <a:pt x="1345" y="2142"/>
                  </a:lnTo>
                  <a:lnTo>
                    <a:pt x="1352" y="2137"/>
                  </a:lnTo>
                  <a:lnTo>
                    <a:pt x="1357" y="2130"/>
                  </a:lnTo>
                  <a:lnTo>
                    <a:pt x="1360" y="2124"/>
                  </a:lnTo>
                  <a:lnTo>
                    <a:pt x="1362" y="2117"/>
                  </a:lnTo>
                  <a:lnTo>
                    <a:pt x="1362" y="2111"/>
                  </a:lnTo>
                  <a:lnTo>
                    <a:pt x="1360" y="2104"/>
                  </a:lnTo>
                  <a:lnTo>
                    <a:pt x="1357" y="2096"/>
                  </a:lnTo>
                  <a:lnTo>
                    <a:pt x="1352" y="2089"/>
                  </a:lnTo>
                  <a:lnTo>
                    <a:pt x="1347" y="2081"/>
                  </a:lnTo>
                  <a:lnTo>
                    <a:pt x="1339" y="2075"/>
                  </a:lnTo>
                  <a:lnTo>
                    <a:pt x="1329" y="2068"/>
                  </a:lnTo>
                  <a:lnTo>
                    <a:pt x="1318" y="2062"/>
                  </a:lnTo>
                  <a:lnTo>
                    <a:pt x="1318" y="2062"/>
                  </a:lnTo>
                  <a:lnTo>
                    <a:pt x="1303" y="2054"/>
                  </a:lnTo>
                  <a:lnTo>
                    <a:pt x="1290" y="2044"/>
                  </a:lnTo>
                  <a:lnTo>
                    <a:pt x="1274" y="2028"/>
                  </a:lnTo>
                  <a:lnTo>
                    <a:pt x="1266" y="2020"/>
                  </a:lnTo>
                  <a:lnTo>
                    <a:pt x="1258" y="2008"/>
                  </a:lnTo>
                  <a:lnTo>
                    <a:pt x="1251" y="1997"/>
                  </a:lnTo>
                  <a:lnTo>
                    <a:pt x="1243" y="1984"/>
                  </a:lnTo>
                  <a:lnTo>
                    <a:pt x="1238" y="1971"/>
                  </a:lnTo>
                  <a:lnTo>
                    <a:pt x="1233" y="1956"/>
                  </a:lnTo>
                  <a:lnTo>
                    <a:pt x="1231" y="1938"/>
                  </a:lnTo>
                  <a:lnTo>
                    <a:pt x="1230" y="1920"/>
                  </a:lnTo>
                  <a:lnTo>
                    <a:pt x="1230" y="1920"/>
                  </a:lnTo>
                  <a:lnTo>
                    <a:pt x="1231" y="1901"/>
                  </a:lnTo>
                  <a:lnTo>
                    <a:pt x="1235" y="1881"/>
                  </a:lnTo>
                  <a:lnTo>
                    <a:pt x="1241" y="1862"/>
                  </a:lnTo>
                  <a:lnTo>
                    <a:pt x="1249" y="1842"/>
                  </a:lnTo>
                  <a:lnTo>
                    <a:pt x="1261" y="1826"/>
                  </a:lnTo>
                  <a:lnTo>
                    <a:pt x="1272" y="1810"/>
                  </a:lnTo>
                  <a:lnTo>
                    <a:pt x="1287" y="1793"/>
                  </a:lnTo>
                  <a:lnTo>
                    <a:pt x="1303" y="1779"/>
                  </a:lnTo>
                  <a:lnTo>
                    <a:pt x="1321" y="1766"/>
                  </a:lnTo>
                  <a:lnTo>
                    <a:pt x="1340" y="1754"/>
                  </a:lnTo>
                  <a:lnTo>
                    <a:pt x="1360" y="1745"/>
                  </a:lnTo>
                  <a:lnTo>
                    <a:pt x="1383" y="1736"/>
                  </a:lnTo>
                  <a:lnTo>
                    <a:pt x="1406" y="1730"/>
                  </a:lnTo>
                  <a:lnTo>
                    <a:pt x="1430" y="1725"/>
                  </a:lnTo>
                  <a:lnTo>
                    <a:pt x="1454" y="1722"/>
                  </a:lnTo>
                  <a:lnTo>
                    <a:pt x="1480" y="1720"/>
                  </a:lnTo>
                  <a:lnTo>
                    <a:pt x="1480" y="1720"/>
                  </a:lnTo>
                  <a:lnTo>
                    <a:pt x="1505" y="1722"/>
                  </a:lnTo>
                  <a:lnTo>
                    <a:pt x="1529" y="1725"/>
                  </a:lnTo>
                  <a:lnTo>
                    <a:pt x="1554" y="1730"/>
                  </a:lnTo>
                  <a:lnTo>
                    <a:pt x="1576" y="1736"/>
                  </a:lnTo>
                  <a:lnTo>
                    <a:pt x="1599" y="1745"/>
                  </a:lnTo>
                  <a:lnTo>
                    <a:pt x="1619" y="1754"/>
                  </a:lnTo>
                  <a:lnTo>
                    <a:pt x="1638" y="1766"/>
                  </a:lnTo>
                  <a:lnTo>
                    <a:pt x="1656" y="1779"/>
                  </a:lnTo>
                  <a:lnTo>
                    <a:pt x="1672" y="1793"/>
                  </a:lnTo>
                  <a:lnTo>
                    <a:pt x="1687" y="1810"/>
                  </a:lnTo>
                  <a:lnTo>
                    <a:pt x="1698" y="1826"/>
                  </a:lnTo>
                  <a:lnTo>
                    <a:pt x="1710" y="1842"/>
                  </a:lnTo>
                  <a:lnTo>
                    <a:pt x="1718" y="1862"/>
                  </a:lnTo>
                  <a:lnTo>
                    <a:pt x="1724" y="1881"/>
                  </a:lnTo>
                  <a:lnTo>
                    <a:pt x="1728" y="1901"/>
                  </a:lnTo>
                  <a:lnTo>
                    <a:pt x="1729" y="1920"/>
                  </a:lnTo>
                  <a:lnTo>
                    <a:pt x="1729" y="1920"/>
                  </a:lnTo>
                  <a:close/>
                </a:path>
              </a:pathLst>
            </a:custGeom>
            <a:solidFill>
              <a:srgbClr val="92D050"/>
            </a:solidFill>
            <a:ln w="28575">
              <a:solidFill>
                <a:srgbClr val="009051"/>
              </a:solidFill>
              <a:prstDash val="solid"/>
              <a:round/>
              <a:headEnd/>
              <a:tailEnd/>
            </a:ln>
          </p:spPr>
          <p:txBody>
            <a:bodyPr lIns="468000" anchor="ctr"/>
            <a:lstStyle/>
            <a:p>
              <a:pPr algn="ctr" defTabSz="457200">
                <a:defRPr/>
              </a:pPr>
              <a:r>
                <a:rPr lang="en-US" sz="4000" dirty="0">
                  <a:solidFill>
                    <a:prstClr val="black"/>
                  </a:solidFill>
                </a:rPr>
                <a:t>B</a:t>
              </a:r>
              <a:endParaRPr lang="en-GB" sz="4000" dirty="0">
                <a:solidFill>
                  <a:prstClr val="black"/>
                </a:solidFill>
                <a:cs typeface="Arial" charset="0"/>
              </a:endParaRPr>
            </a:p>
          </p:txBody>
        </p:sp>
        <p:sp>
          <p:nvSpPr>
            <p:cNvPr id="20" name="Freeform 19">
              <a:extLst>
                <a:ext uri="{FF2B5EF4-FFF2-40B4-BE49-F238E27FC236}">
                  <a16:creationId xmlns:a16="http://schemas.microsoft.com/office/drawing/2014/main" xmlns="" id="{723AF5F4-44BF-0F47-BF04-2B15C8044E61}"/>
                </a:ext>
              </a:extLst>
            </p:cNvPr>
            <p:cNvSpPr>
              <a:spLocks/>
            </p:cNvSpPr>
            <p:nvPr/>
          </p:nvSpPr>
          <p:spPr bwMode="auto">
            <a:xfrm>
              <a:off x="9945926" y="3256176"/>
              <a:ext cx="1052621" cy="1400491"/>
            </a:xfrm>
            <a:custGeom>
              <a:avLst/>
              <a:gdLst>
                <a:gd name="T0" fmla="*/ 195 w 2151"/>
                <a:gd name="T1" fmla="*/ 1725 h 2586"/>
                <a:gd name="T2" fmla="*/ 141 w 2151"/>
                <a:gd name="T3" fmla="*/ 1702 h 2586"/>
                <a:gd name="T4" fmla="*/ 96 w 2151"/>
                <a:gd name="T5" fmla="*/ 1655 h 2586"/>
                <a:gd name="T6" fmla="*/ 76 w 2151"/>
                <a:gd name="T7" fmla="*/ 1621 h 2586"/>
                <a:gd name="T8" fmla="*/ 47 w 2151"/>
                <a:gd name="T9" fmla="*/ 1598 h 2586"/>
                <a:gd name="T10" fmla="*/ 19 w 2151"/>
                <a:gd name="T11" fmla="*/ 1603 h 2586"/>
                <a:gd name="T12" fmla="*/ 2 w 2151"/>
                <a:gd name="T13" fmla="*/ 1631 h 2586"/>
                <a:gd name="T14" fmla="*/ 2151 w 2151"/>
                <a:gd name="T15" fmla="*/ 2586 h 2586"/>
                <a:gd name="T16" fmla="*/ 1218 w 2151"/>
                <a:gd name="T17" fmla="*/ 430 h 2586"/>
                <a:gd name="T18" fmla="*/ 1184 w 2151"/>
                <a:gd name="T19" fmla="*/ 425 h 2586"/>
                <a:gd name="T20" fmla="*/ 1163 w 2151"/>
                <a:gd name="T21" fmla="*/ 404 h 2586"/>
                <a:gd name="T22" fmla="*/ 1165 w 2151"/>
                <a:gd name="T23" fmla="*/ 376 h 2586"/>
                <a:gd name="T24" fmla="*/ 1194 w 2151"/>
                <a:gd name="T25" fmla="*/ 347 h 2586"/>
                <a:gd name="T26" fmla="*/ 1233 w 2151"/>
                <a:gd name="T27" fmla="*/ 322 h 2586"/>
                <a:gd name="T28" fmla="*/ 1272 w 2151"/>
                <a:gd name="T29" fmla="*/ 277 h 2586"/>
                <a:gd name="T30" fmla="*/ 1292 w 2151"/>
                <a:gd name="T31" fmla="*/ 218 h 2586"/>
                <a:gd name="T32" fmla="*/ 1288 w 2151"/>
                <a:gd name="T33" fmla="*/ 160 h 2586"/>
                <a:gd name="T34" fmla="*/ 1251 w 2151"/>
                <a:gd name="T35" fmla="*/ 88 h 2586"/>
                <a:gd name="T36" fmla="*/ 1183 w 2151"/>
                <a:gd name="T37" fmla="*/ 34 h 2586"/>
                <a:gd name="T38" fmla="*/ 1093 w 2151"/>
                <a:gd name="T39" fmla="*/ 4 h 2586"/>
                <a:gd name="T40" fmla="*/ 1018 w 2151"/>
                <a:gd name="T41" fmla="*/ 2 h 2586"/>
                <a:gd name="T42" fmla="*/ 924 w 2151"/>
                <a:gd name="T43" fmla="*/ 25 h 2586"/>
                <a:gd name="T44" fmla="*/ 851 w 2151"/>
                <a:gd name="T45" fmla="*/ 73 h 2586"/>
                <a:gd name="T46" fmla="*/ 805 w 2151"/>
                <a:gd name="T47" fmla="*/ 142 h 2586"/>
                <a:gd name="T48" fmla="*/ 794 w 2151"/>
                <a:gd name="T49" fmla="*/ 200 h 2586"/>
                <a:gd name="T50" fmla="*/ 807 w 2151"/>
                <a:gd name="T51" fmla="*/ 264 h 2586"/>
                <a:gd name="T52" fmla="*/ 838 w 2151"/>
                <a:gd name="T53" fmla="*/ 308 h 2586"/>
                <a:gd name="T54" fmla="*/ 882 w 2151"/>
                <a:gd name="T55" fmla="*/ 342 h 2586"/>
                <a:gd name="T56" fmla="*/ 916 w 2151"/>
                <a:gd name="T57" fmla="*/ 368 h 2586"/>
                <a:gd name="T58" fmla="*/ 926 w 2151"/>
                <a:gd name="T59" fmla="*/ 397 h 2586"/>
                <a:gd name="T60" fmla="*/ 909 w 2151"/>
                <a:gd name="T61" fmla="*/ 420 h 2586"/>
                <a:gd name="T62" fmla="*/ 869 w 2151"/>
                <a:gd name="T63" fmla="*/ 430 h 2586"/>
                <a:gd name="T64" fmla="*/ 0 w 2151"/>
                <a:gd name="T65" fmla="*/ 1305 h 2586"/>
                <a:gd name="T66" fmla="*/ 5 w 2151"/>
                <a:gd name="T67" fmla="*/ 1338 h 2586"/>
                <a:gd name="T68" fmla="*/ 26 w 2151"/>
                <a:gd name="T69" fmla="*/ 1361 h 2586"/>
                <a:gd name="T70" fmla="*/ 54 w 2151"/>
                <a:gd name="T71" fmla="*/ 1357 h 2586"/>
                <a:gd name="T72" fmla="*/ 83 w 2151"/>
                <a:gd name="T73" fmla="*/ 1328 h 2586"/>
                <a:gd name="T74" fmla="*/ 107 w 2151"/>
                <a:gd name="T75" fmla="*/ 1291 h 2586"/>
                <a:gd name="T76" fmla="*/ 153 w 2151"/>
                <a:gd name="T77" fmla="*/ 1250 h 2586"/>
                <a:gd name="T78" fmla="*/ 211 w 2151"/>
                <a:gd name="T79" fmla="*/ 1230 h 2586"/>
                <a:gd name="T80" fmla="*/ 270 w 2151"/>
                <a:gd name="T81" fmla="*/ 1235 h 2586"/>
                <a:gd name="T82" fmla="*/ 342 w 2151"/>
                <a:gd name="T83" fmla="*/ 1273 h 2586"/>
                <a:gd name="T84" fmla="*/ 395 w 2151"/>
                <a:gd name="T85" fmla="*/ 1339 h 2586"/>
                <a:gd name="T86" fmla="*/ 426 w 2151"/>
                <a:gd name="T87" fmla="*/ 1429 h 2586"/>
                <a:gd name="T88" fmla="*/ 428 w 2151"/>
                <a:gd name="T89" fmla="*/ 1505 h 2586"/>
                <a:gd name="T90" fmla="*/ 405 w 2151"/>
                <a:gd name="T91" fmla="*/ 1598 h 2586"/>
                <a:gd name="T92" fmla="*/ 356 w 2151"/>
                <a:gd name="T93" fmla="*/ 1673 h 2586"/>
                <a:gd name="T94" fmla="*/ 288 w 2151"/>
                <a:gd name="T95" fmla="*/ 1718 h 2586"/>
                <a:gd name="T96" fmla="*/ 229 w 2151"/>
                <a:gd name="T97" fmla="*/ 1730 h 258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Lst>
              <a:rect l="0" t="0" r="r" b="b"/>
              <a:pathLst>
                <a:path w="2151" h="2586">
                  <a:moveTo>
                    <a:pt x="229" y="1730"/>
                  </a:moveTo>
                  <a:lnTo>
                    <a:pt x="229" y="1730"/>
                  </a:lnTo>
                  <a:lnTo>
                    <a:pt x="211" y="1728"/>
                  </a:lnTo>
                  <a:lnTo>
                    <a:pt x="195" y="1725"/>
                  </a:lnTo>
                  <a:lnTo>
                    <a:pt x="179" y="1722"/>
                  </a:lnTo>
                  <a:lnTo>
                    <a:pt x="166" y="1715"/>
                  </a:lnTo>
                  <a:lnTo>
                    <a:pt x="153" y="1709"/>
                  </a:lnTo>
                  <a:lnTo>
                    <a:pt x="141" y="1702"/>
                  </a:lnTo>
                  <a:lnTo>
                    <a:pt x="132" y="1694"/>
                  </a:lnTo>
                  <a:lnTo>
                    <a:pt x="122" y="1686"/>
                  </a:lnTo>
                  <a:lnTo>
                    <a:pt x="107" y="1670"/>
                  </a:lnTo>
                  <a:lnTo>
                    <a:pt x="96" y="1655"/>
                  </a:lnTo>
                  <a:lnTo>
                    <a:pt x="88" y="1642"/>
                  </a:lnTo>
                  <a:lnTo>
                    <a:pt x="88" y="1642"/>
                  </a:lnTo>
                  <a:lnTo>
                    <a:pt x="83" y="1631"/>
                  </a:lnTo>
                  <a:lnTo>
                    <a:pt x="76" y="1621"/>
                  </a:lnTo>
                  <a:lnTo>
                    <a:pt x="68" y="1613"/>
                  </a:lnTo>
                  <a:lnTo>
                    <a:pt x="62" y="1606"/>
                  </a:lnTo>
                  <a:lnTo>
                    <a:pt x="54" y="1601"/>
                  </a:lnTo>
                  <a:lnTo>
                    <a:pt x="47" y="1598"/>
                  </a:lnTo>
                  <a:lnTo>
                    <a:pt x="39" y="1598"/>
                  </a:lnTo>
                  <a:lnTo>
                    <a:pt x="32" y="1598"/>
                  </a:lnTo>
                  <a:lnTo>
                    <a:pt x="26" y="1600"/>
                  </a:lnTo>
                  <a:lnTo>
                    <a:pt x="19" y="1603"/>
                  </a:lnTo>
                  <a:lnTo>
                    <a:pt x="15" y="1608"/>
                  </a:lnTo>
                  <a:lnTo>
                    <a:pt x="10" y="1614"/>
                  </a:lnTo>
                  <a:lnTo>
                    <a:pt x="5" y="1621"/>
                  </a:lnTo>
                  <a:lnTo>
                    <a:pt x="2" y="1631"/>
                  </a:lnTo>
                  <a:lnTo>
                    <a:pt x="0" y="1642"/>
                  </a:lnTo>
                  <a:lnTo>
                    <a:pt x="0" y="1655"/>
                  </a:lnTo>
                  <a:lnTo>
                    <a:pt x="0" y="2586"/>
                  </a:lnTo>
                  <a:lnTo>
                    <a:pt x="2151" y="2586"/>
                  </a:lnTo>
                  <a:lnTo>
                    <a:pt x="2151" y="431"/>
                  </a:lnTo>
                  <a:lnTo>
                    <a:pt x="1656" y="431"/>
                  </a:lnTo>
                  <a:lnTo>
                    <a:pt x="1656" y="430"/>
                  </a:lnTo>
                  <a:lnTo>
                    <a:pt x="1218" y="430"/>
                  </a:lnTo>
                  <a:lnTo>
                    <a:pt x="1218" y="430"/>
                  </a:lnTo>
                  <a:lnTo>
                    <a:pt x="1205" y="430"/>
                  </a:lnTo>
                  <a:lnTo>
                    <a:pt x="1194" y="428"/>
                  </a:lnTo>
                  <a:lnTo>
                    <a:pt x="1184" y="425"/>
                  </a:lnTo>
                  <a:lnTo>
                    <a:pt x="1178" y="420"/>
                  </a:lnTo>
                  <a:lnTo>
                    <a:pt x="1171" y="415"/>
                  </a:lnTo>
                  <a:lnTo>
                    <a:pt x="1166" y="410"/>
                  </a:lnTo>
                  <a:lnTo>
                    <a:pt x="1163" y="404"/>
                  </a:lnTo>
                  <a:lnTo>
                    <a:pt x="1162" y="397"/>
                  </a:lnTo>
                  <a:lnTo>
                    <a:pt x="1162" y="391"/>
                  </a:lnTo>
                  <a:lnTo>
                    <a:pt x="1162" y="383"/>
                  </a:lnTo>
                  <a:lnTo>
                    <a:pt x="1165" y="376"/>
                  </a:lnTo>
                  <a:lnTo>
                    <a:pt x="1170" y="368"/>
                  </a:lnTo>
                  <a:lnTo>
                    <a:pt x="1176" y="361"/>
                  </a:lnTo>
                  <a:lnTo>
                    <a:pt x="1184" y="353"/>
                  </a:lnTo>
                  <a:lnTo>
                    <a:pt x="1194" y="347"/>
                  </a:lnTo>
                  <a:lnTo>
                    <a:pt x="1205" y="342"/>
                  </a:lnTo>
                  <a:lnTo>
                    <a:pt x="1205" y="342"/>
                  </a:lnTo>
                  <a:lnTo>
                    <a:pt x="1218" y="334"/>
                  </a:lnTo>
                  <a:lnTo>
                    <a:pt x="1233" y="322"/>
                  </a:lnTo>
                  <a:lnTo>
                    <a:pt x="1249" y="308"/>
                  </a:lnTo>
                  <a:lnTo>
                    <a:pt x="1258" y="298"/>
                  </a:lnTo>
                  <a:lnTo>
                    <a:pt x="1266" y="288"/>
                  </a:lnTo>
                  <a:lnTo>
                    <a:pt x="1272" y="277"/>
                  </a:lnTo>
                  <a:lnTo>
                    <a:pt x="1279" y="264"/>
                  </a:lnTo>
                  <a:lnTo>
                    <a:pt x="1285" y="251"/>
                  </a:lnTo>
                  <a:lnTo>
                    <a:pt x="1288" y="235"/>
                  </a:lnTo>
                  <a:lnTo>
                    <a:pt x="1292" y="218"/>
                  </a:lnTo>
                  <a:lnTo>
                    <a:pt x="1293" y="200"/>
                  </a:lnTo>
                  <a:lnTo>
                    <a:pt x="1293" y="200"/>
                  </a:lnTo>
                  <a:lnTo>
                    <a:pt x="1292" y="181"/>
                  </a:lnTo>
                  <a:lnTo>
                    <a:pt x="1288" y="160"/>
                  </a:lnTo>
                  <a:lnTo>
                    <a:pt x="1282" y="142"/>
                  </a:lnTo>
                  <a:lnTo>
                    <a:pt x="1274" y="122"/>
                  </a:lnTo>
                  <a:lnTo>
                    <a:pt x="1262" y="104"/>
                  </a:lnTo>
                  <a:lnTo>
                    <a:pt x="1251" y="88"/>
                  </a:lnTo>
                  <a:lnTo>
                    <a:pt x="1236" y="73"/>
                  </a:lnTo>
                  <a:lnTo>
                    <a:pt x="1220" y="59"/>
                  </a:lnTo>
                  <a:lnTo>
                    <a:pt x="1202" y="46"/>
                  </a:lnTo>
                  <a:lnTo>
                    <a:pt x="1183" y="34"/>
                  </a:lnTo>
                  <a:lnTo>
                    <a:pt x="1162" y="25"/>
                  </a:lnTo>
                  <a:lnTo>
                    <a:pt x="1140" y="17"/>
                  </a:lnTo>
                  <a:lnTo>
                    <a:pt x="1118" y="8"/>
                  </a:lnTo>
                  <a:lnTo>
                    <a:pt x="1093" y="4"/>
                  </a:lnTo>
                  <a:lnTo>
                    <a:pt x="1069" y="2"/>
                  </a:lnTo>
                  <a:lnTo>
                    <a:pt x="1043" y="0"/>
                  </a:lnTo>
                  <a:lnTo>
                    <a:pt x="1043" y="0"/>
                  </a:lnTo>
                  <a:lnTo>
                    <a:pt x="1018" y="2"/>
                  </a:lnTo>
                  <a:lnTo>
                    <a:pt x="992" y="4"/>
                  </a:lnTo>
                  <a:lnTo>
                    <a:pt x="970" y="8"/>
                  </a:lnTo>
                  <a:lnTo>
                    <a:pt x="947" y="17"/>
                  </a:lnTo>
                  <a:lnTo>
                    <a:pt x="924" y="25"/>
                  </a:lnTo>
                  <a:lnTo>
                    <a:pt x="903" y="34"/>
                  </a:lnTo>
                  <a:lnTo>
                    <a:pt x="885" y="46"/>
                  </a:lnTo>
                  <a:lnTo>
                    <a:pt x="867" y="59"/>
                  </a:lnTo>
                  <a:lnTo>
                    <a:pt x="851" y="73"/>
                  </a:lnTo>
                  <a:lnTo>
                    <a:pt x="836" y="88"/>
                  </a:lnTo>
                  <a:lnTo>
                    <a:pt x="823" y="104"/>
                  </a:lnTo>
                  <a:lnTo>
                    <a:pt x="813" y="122"/>
                  </a:lnTo>
                  <a:lnTo>
                    <a:pt x="805" y="142"/>
                  </a:lnTo>
                  <a:lnTo>
                    <a:pt x="799" y="160"/>
                  </a:lnTo>
                  <a:lnTo>
                    <a:pt x="795" y="181"/>
                  </a:lnTo>
                  <a:lnTo>
                    <a:pt x="794" y="200"/>
                  </a:lnTo>
                  <a:lnTo>
                    <a:pt x="794" y="200"/>
                  </a:lnTo>
                  <a:lnTo>
                    <a:pt x="794" y="218"/>
                  </a:lnTo>
                  <a:lnTo>
                    <a:pt x="797" y="235"/>
                  </a:lnTo>
                  <a:lnTo>
                    <a:pt x="802" y="251"/>
                  </a:lnTo>
                  <a:lnTo>
                    <a:pt x="807" y="264"/>
                  </a:lnTo>
                  <a:lnTo>
                    <a:pt x="813" y="277"/>
                  </a:lnTo>
                  <a:lnTo>
                    <a:pt x="822" y="288"/>
                  </a:lnTo>
                  <a:lnTo>
                    <a:pt x="830" y="298"/>
                  </a:lnTo>
                  <a:lnTo>
                    <a:pt x="838" y="308"/>
                  </a:lnTo>
                  <a:lnTo>
                    <a:pt x="854" y="322"/>
                  </a:lnTo>
                  <a:lnTo>
                    <a:pt x="867" y="334"/>
                  </a:lnTo>
                  <a:lnTo>
                    <a:pt x="882" y="342"/>
                  </a:lnTo>
                  <a:lnTo>
                    <a:pt x="882" y="342"/>
                  </a:lnTo>
                  <a:lnTo>
                    <a:pt x="891" y="347"/>
                  </a:lnTo>
                  <a:lnTo>
                    <a:pt x="901" y="353"/>
                  </a:lnTo>
                  <a:lnTo>
                    <a:pt x="909" y="361"/>
                  </a:lnTo>
                  <a:lnTo>
                    <a:pt x="916" y="368"/>
                  </a:lnTo>
                  <a:lnTo>
                    <a:pt x="921" y="376"/>
                  </a:lnTo>
                  <a:lnTo>
                    <a:pt x="924" y="383"/>
                  </a:lnTo>
                  <a:lnTo>
                    <a:pt x="926" y="391"/>
                  </a:lnTo>
                  <a:lnTo>
                    <a:pt x="926" y="397"/>
                  </a:lnTo>
                  <a:lnTo>
                    <a:pt x="924" y="404"/>
                  </a:lnTo>
                  <a:lnTo>
                    <a:pt x="921" y="410"/>
                  </a:lnTo>
                  <a:lnTo>
                    <a:pt x="916" y="415"/>
                  </a:lnTo>
                  <a:lnTo>
                    <a:pt x="909" y="420"/>
                  </a:lnTo>
                  <a:lnTo>
                    <a:pt x="901" y="425"/>
                  </a:lnTo>
                  <a:lnTo>
                    <a:pt x="891" y="428"/>
                  </a:lnTo>
                  <a:lnTo>
                    <a:pt x="880" y="430"/>
                  </a:lnTo>
                  <a:lnTo>
                    <a:pt x="869" y="430"/>
                  </a:lnTo>
                  <a:lnTo>
                    <a:pt x="595" y="430"/>
                  </a:lnTo>
                  <a:lnTo>
                    <a:pt x="595" y="431"/>
                  </a:lnTo>
                  <a:lnTo>
                    <a:pt x="0" y="431"/>
                  </a:lnTo>
                  <a:lnTo>
                    <a:pt x="0" y="1305"/>
                  </a:lnTo>
                  <a:lnTo>
                    <a:pt x="0" y="1305"/>
                  </a:lnTo>
                  <a:lnTo>
                    <a:pt x="0" y="1317"/>
                  </a:lnTo>
                  <a:lnTo>
                    <a:pt x="2" y="1328"/>
                  </a:lnTo>
                  <a:lnTo>
                    <a:pt x="5" y="1338"/>
                  </a:lnTo>
                  <a:lnTo>
                    <a:pt x="10" y="1346"/>
                  </a:lnTo>
                  <a:lnTo>
                    <a:pt x="15" y="1352"/>
                  </a:lnTo>
                  <a:lnTo>
                    <a:pt x="19" y="1357"/>
                  </a:lnTo>
                  <a:lnTo>
                    <a:pt x="26" y="1361"/>
                  </a:lnTo>
                  <a:lnTo>
                    <a:pt x="32" y="1362"/>
                  </a:lnTo>
                  <a:lnTo>
                    <a:pt x="39" y="1362"/>
                  </a:lnTo>
                  <a:lnTo>
                    <a:pt x="47" y="1361"/>
                  </a:lnTo>
                  <a:lnTo>
                    <a:pt x="54" y="1357"/>
                  </a:lnTo>
                  <a:lnTo>
                    <a:pt x="62" y="1352"/>
                  </a:lnTo>
                  <a:lnTo>
                    <a:pt x="68" y="1346"/>
                  </a:lnTo>
                  <a:lnTo>
                    <a:pt x="76" y="1338"/>
                  </a:lnTo>
                  <a:lnTo>
                    <a:pt x="83" y="1328"/>
                  </a:lnTo>
                  <a:lnTo>
                    <a:pt x="88" y="1318"/>
                  </a:lnTo>
                  <a:lnTo>
                    <a:pt x="88" y="1318"/>
                  </a:lnTo>
                  <a:lnTo>
                    <a:pt x="96" y="1304"/>
                  </a:lnTo>
                  <a:lnTo>
                    <a:pt x="107" y="1291"/>
                  </a:lnTo>
                  <a:lnTo>
                    <a:pt x="122" y="1274"/>
                  </a:lnTo>
                  <a:lnTo>
                    <a:pt x="132" y="1266"/>
                  </a:lnTo>
                  <a:lnTo>
                    <a:pt x="141" y="1258"/>
                  </a:lnTo>
                  <a:lnTo>
                    <a:pt x="153" y="1250"/>
                  </a:lnTo>
                  <a:lnTo>
                    <a:pt x="166" y="1243"/>
                  </a:lnTo>
                  <a:lnTo>
                    <a:pt x="179" y="1238"/>
                  </a:lnTo>
                  <a:lnTo>
                    <a:pt x="195" y="1234"/>
                  </a:lnTo>
                  <a:lnTo>
                    <a:pt x="211" y="1230"/>
                  </a:lnTo>
                  <a:lnTo>
                    <a:pt x="229" y="1230"/>
                  </a:lnTo>
                  <a:lnTo>
                    <a:pt x="229" y="1230"/>
                  </a:lnTo>
                  <a:lnTo>
                    <a:pt x="249" y="1232"/>
                  </a:lnTo>
                  <a:lnTo>
                    <a:pt x="270" y="1235"/>
                  </a:lnTo>
                  <a:lnTo>
                    <a:pt x="288" y="1242"/>
                  </a:lnTo>
                  <a:lnTo>
                    <a:pt x="307" y="1250"/>
                  </a:lnTo>
                  <a:lnTo>
                    <a:pt x="325" y="1260"/>
                  </a:lnTo>
                  <a:lnTo>
                    <a:pt x="342" y="1273"/>
                  </a:lnTo>
                  <a:lnTo>
                    <a:pt x="356" y="1287"/>
                  </a:lnTo>
                  <a:lnTo>
                    <a:pt x="371" y="1304"/>
                  </a:lnTo>
                  <a:lnTo>
                    <a:pt x="384" y="1321"/>
                  </a:lnTo>
                  <a:lnTo>
                    <a:pt x="395" y="1339"/>
                  </a:lnTo>
                  <a:lnTo>
                    <a:pt x="405" y="1361"/>
                  </a:lnTo>
                  <a:lnTo>
                    <a:pt x="413" y="1383"/>
                  </a:lnTo>
                  <a:lnTo>
                    <a:pt x="421" y="1406"/>
                  </a:lnTo>
                  <a:lnTo>
                    <a:pt x="426" y="1429"/>
                  </a:lnTo>
                  <a:lnTo>
                    <a:pt x="428" y="1455"/>
                  </a:lnTo>
                  <a:lnTo>
                    <a:pt x="429" y="1479"/>
                  </a:lnTo>
                  <a:lnTo>
                    <a:pt x="429" y="1479"/>
                  </a:lnTo>
                  <a:lnTo>
                    <a:pt x="428" y="1505"/>
                  </a:lnTo>
                  <a:lnTo>
                    <a:pt x="426" y="1530"/>
                  </a:lnTo>
                  <a:lnTo>
                    <a:pt x="421" y="1554"/>
                  </a:lnTo>
                  <a:lnTo>
                    <a:pt x="413" y="1577"/>
                  </a:lnTo>
                  <a:lnTo>
                    <a:pt x="405" y="1598"/>
                  </a:lnTo>
                  <a:lnTo>
                    <a:pt x="395" y="1619"/>
                  </a:lnTo>
                  <a:lnTo>
                    <a:pt x="384" y="1639"/>
                  </a:lnTo>
                  <a:lnTo>
                    <a:pt x="371" y="1657"/>
                  </a:lnTo>
                  <a:lnTo>
                    <a:pt x="356" y="1673"/>
                  </a:lnTo>
                  <a:lnTo>
                    <a:pt x="342" y="1686"/>
                  </a:lnTo>
                  <a:lnTo>
                    <a:pt x="325" y="1699"/>
                  </a:lnTo>
                  <a:lnTo>
                    <a:pt x="307" y="1710"/>
                  </a:lnTo>
                  <a:lnTo>
                    <a:pt x="288" y="1718"/>
                  </a:lnTo>
                  <a:lnTo>
                    <a:pt x="270" y="1725"/>
                  </a:lnTo>
                  <a:lnTo>
                    <a:pt x="249" y="1728"/>
                  </a:lnTo>
                  <a:lnTo>
                    <a:pt x="229" y="1730"/>
                  </a:lnTo>
                  <a:lnTo>
                    <a:pt x="229" y="1730"/>
                  </a:lnTo>
                  <a:close/>
                </a:path>
              </a:pathLst>
            </a:custGeom>
            <a:solidFill>
              <a:srgbClr val="0096FF"/>
            </a:solidFill>
            <a:ln w="28575">
              <a:solidFill>
                <a:schemeClr val="tx1">
                  <a:lumMod val="50000"/>
                  <a:lumOff val="50000"/>
                </a:schemeClr>
              </a:solidFill>
              <a:prstDash val="solid"/>
              <a:round/>
              <a:headEnd/>
              <a:tailEnd/>
            </a:ln>
          </p:spPr>
          <p:txBody>
            <a:bodyPr tIns="468000" anchor="ctr" anchorCtr="1"/>
            <a:lstStyle/>
            <a:p>
              <a:pPr defTabSz="457200">
                <a:defRPr/>
              </a:pPr>
              <a:r>
                <a:rPr lang="en-US" sz="4000" dirty="0">
                  <a:solidFill>
                    <a:prstClr val="black"/>
                  </a:solidFill>
                </a:rPr>
                <a:t>D</a:t>
              </a:r>
              <a:endParaRPr lang="en-GB" sz="4000" dirty="0">
                <a:solidFill>
                  <a:prstClr val="black"/>
                </a:solidFill>
                <a:cs typeface="Arial" charset="0"/>
              </a:endParaRPr>
            </a:p>
          </p:txBody>
        </p:sp>
        <p:sp>
          <p:nvSpPr>
            <p:cNvPr id="23" name="TextBox 22">
              <a:extLst>
                <a:ext uri="{FF2B5EF4-FFF2-40B4-BE49-F238E27FC236}">
                  <a16:creationId xmlns:a16="http://schemas.microsoft.com/office/drawing/2014/main" xmlns="" id="{2ADE2B27-A91F-914F-AF04-D9935FB547F6}"/>
                </a:ext>
              </a:extLst>
            </p:cNvPr>
            <p:cNvSpPr txBox="1"/>
            <p:nvPr/>
          </p:nvSpPr>
          <p:spPr>
            <a:xfrm>
              <a:off x="8791856" y="4733836"/>
              <a:ext cx="2384490" cy="1200329"/>
            </a:xfrm>
            <a:prstGeom prst="rect">
              <a:avLst/>
            </a:prstGeom>
            <a:noFill/>
          </p:spPr>
          <p:txBody>
            <a:bodyPr wrap="square" rtlCol="0">
              <a:spAutoFit/>
            </a:bodyPr>
            <a:lstStyle/>
            <a:p>
              <a:pPr algn="ctr" defTabSz="457200"/>
              <a:r>
                <a:rPr lang="en-US" sz="2400" dirty="0">
                  <a:solidFill>
                    <a:prstClr val="black"/>
                  </a:solidFill>
                  <a:cs typeface="Calibri" panose="020F0502020204030204" pitchFamily="34" charset="0"/>
                </a:rPr>
                <a:t>Back to Home group to piece together the </a:t>
              </a:r>
              <a:r>
                <a:rPr lang="en-US" sz="2400" dirty="0" smtClean="0">
                  <a:solidFill>
                    <a:prstClr val="black"/>
                  </a:solidFill>
                  <a:cs typeface="Calibri" panose="020F0502020204030204" pitchFamily="34" charset="0"/>
                </a:rPr>
                <a:t>case</a:t>
              </a:r>
              <a:endParaRPr lang="en-US" sz="2400" dirty="0">
                <a:solidFill>
                  <a:prstClr val="black"/>
                </a:solidFill>
                <a:cs typeface="Calibri" panose="020F0502020204030204" pitchFamily="34" charset="0"/>
              </a:endParaRPr>
            </a:p>
          </p:txBody>
        </p:sp>
      </p:grpSp>
      <p:pic>
        <p:nvPicPr>
          <p:cNvPr id="24" name="Content Placeholder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331607" y="6050840"/>
            <a:ext cx="714257" cy="569475"/>
          </a:xfrm>
          <a:prstGeom prst="rect">
            <a:avLst/>
          </a:prstGeom>
          <a:solidFill>
            <a:schemeClr val="bg1"/>
          </a:solidFill>
        </p:spPr>
      </p:pic>
    </p:spTree>
    <p:extLst>
      <p:ext uri="{BB962C8B-B14F-4D97-AF65-F5344CB8AC3E}">
        <p14:creationId xmlns:p14="http://schemas.microsoft.com/office/powerpoint/2010/main" val="10550402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6" presetClass="entr" presetSubtype="16" fill="hold" nodeType="clickEffect">
                                  <p:stCondLst>
                                    <p:cond delay="0"/>
                                  </p:stCondLst>
                                  <p:childTnLst>
                                    <p:set>
                                      <p:cBhvr>
                                        <p:cTn id="6" dur="1" fill="hold">
                                          <p:stCondLst>
                                            <p:cond delay="0"/>
                                          </p:stCondLst>
                                        </p:cTn>
                                        <p:tgtEl>
                                          <p:spTgt spid="3"/>
                                        </p:tgtEl>
                                        <p:attrNameLst>
                                          <p:attrName>style.visibility</p:attrName>
                                        </p:attrNameLst>
                                      </p:cBhvr>
                                      <p:to>
                                        <p:strVal val="visible"/>
                                      </p:to>
                                    </p:set>
                                    <p:animEffect transition="in" filter="circle(in)">
                                      <p:cBhvr>
                                        <p:cTn id="7" dur="2000"/>
                                        <p:tgtEl>
                                          <p:spTgt spid="3"/>
                                        </p:tgtEl>
                                      </p:cBhvr>
                                    </p:animEffect>
                                  </p:childTnLst>
                                </p:cTn>
                              </p:par>
                            </p:childTnLst>
                          </p:cTn>
                        </p:par>
                      </p:childTnLst>
                    </p:cTn>
                  </p:par>
                  <p:par>
                    <p:cTn id="8" fill="hold">
                      <p:stCondLst>
                        <p:cond delay="indefinite"/>
                      </p:stCondLst>
                      <p:childTnLst>
                        <p:par>
                          <p:cTn id="9" fill="hold">
                            <p:stCondLst>
                              <p:cond delay="0"/>
                            </p:stCondLst>
                            <p:childTnLst>
                              <p:par>
                                <p:cTn id="10" presetID="6" presetClass="entr" presetSubtype="16" fill="hold" nodeType="clickEffect">
                                  <p:stCondLst>
                                    <p:cond delay="0"/>
                                  </p:stCondLst>
                                  <p:childTnLst>
                                    <p:set>
                                      <p:cBhvr>
                                        <p:cTn id="11" dur="1" fill="hold">
                                          <p:stCondLst>
                                            <p:cond delay="0"/>
                                          </p:stCondLst>
                                        </p:cTn>
                                        <p:tgtEl>
                                          <p:spTgt spid="4"/>
                                        </p:tgtEl>
                                        <p:attrNameLst>
                                          <p:attrName>style.visibility</p:attrName>
                                        </p:attrNameLst>
                                      </p:cBhvr>
                                      <p:to>
                                        <p:strVal val="visible"/>
                                      </p:to>
                                    </p:set>
                                    <p:animEffect transition="in" filter="circle(in)">
                                      <p:cBhvr>
                                        <p:cTn id="12" dur="20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034813" y="5887254"/>
            <a:ext cx="1119558" cy="892621"/>
          </a:xfrm>
          <a:prstGeom prst="rect">
            <a:avLst/>
          </a:prstGeom>
          <a:solidFill>
            <a:schemeClr val="bg1"/>
          </a:solidFill>
        </p:spPr>
      </p:pic>
      <p:sp>
        <p:nvSpPr>
          <p:cNvPr id="3" name="Title 2"/>
          <p:cNvSpPr>
            <a:spLocks noGrp="1"/>
          </p:cNvSpPr>
          <p:nvPr>
            <p:ph type="title"/>
          </p:nvPr>
        </p:nvSpPr>
        <p:spPr>
          <a:xfrm>
            <a:off x="1260058" y="2488459"/>
            <a:ext cx="4351025" cy="2283824"/>
          </a:xfrm>
        </p:spPr>
        <p:txBody>
          <a:bodyPr/>
          <a:lstStyle/>
          <a:p>
            <a:r>
              <a:rPr lang="en-US" dirty="0" smtClean="0"/>
              <a:t>Start Pre-Test</a:t>
            </a:r>
            <a:endParaRPr lang="en-US" dirty="0"/>
          </a:p>
        </p:txBody>
      </p:sp>
    </p:spTree>
    <p:extLst>
      <p:ext uri="{BB962C8B-B14F-4D97-AF65-F5344CB8AC3E}">
        <p14:creationId xmlns:p14="http://schemas.microsoft.com/office/powerpoint/2010/main" val="159797603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t>Home Groups</a:t>
            </a:r>
            <a:endParaRPr lang="en-US" b="1" dirty="0"/>
          </a:p>
        </p:txBody>
      </p:sp>
      <p:graphicFrame>
        <p:nvGraphicFramePr>
          <p:cNvPr id="3" name="Table 2">
            <a:extLst>
              <a:ext uri="{FF2B5EF4-FFF2-40B4-BE49-F238E27FC236}">
                <a16:creationId xmlns:a16="http://schemas.microsoft.com/office/drawing/2014/main" xmlns="" id="{14A73B6C-953E-43D8-B8A3-EF1E54F1AEB7}"/>
              </a:ext>
            </a:extLst>
          </p:cNvPr>
          <p:cNvGraphicFramePr>
            <a:graphicFrameLocks noGrp="1"/>
          </p:cNvGraphicFramePr>
          <p:nvPr>
            <p:extLst>
              <p:ext uri="{D42A27DB-BD31-4B8C-83A1-F6EECF244321}">
                <p14:modId xmlns:p14="http://schemas.microsoft.com/office/powerpoint/2010/main" val="1601600835"/>
              </p:ext>
            </p:extLst>
          </p:nvPr>
        </p:nvGraphicFramePr>
        <p:xfrm>
          <a:off x="133584" y="2468881"/>
          <a:ext cx="11777472" cy="3566158"/>
        </p:xfrm>
        <a:graphic>
          <a:graphicData uri="http://schemas.openxmlformats.org/drawingml/2006/table">
            <a:tbl>
              <a:tblPr>
                <a:tableStyleId>{5C22544A-7EE6-4342-B048-85BDC9FD1C3A}</a:tableStyleId>
              </a:tblPr>
              <a:tblGrid>
                <a:gridCol w="3584448">
                  <a:extLst>
                    <a:ext uri="{9D8B030D-6E8A-4147-A177-3AD203B41FA5}">
                      <a16:colId xmlns:a16="http://schemas.microsoft.com/office/drawing/2014/main" xmlns="" val="3228466428"/>
                    </a:ext>
                  </a:extLst>
                </a:gridCol>
                <a:gridCol w="548640">
                  <a:extLst>
                    <a:ext uri="{9D8B030D-6E8A-4147-A177-3AD203B41FA5}">
                      <a16:colId xmlns:a16="http://schemas.microsoft.com/office/drawing/2014/main" xmlns="" val="2954561652"/>
                    </a:ext>
                  </a:extLst>
                </a:gridCol>
                <a:gridCol w="3785616">
                  <a:extLst>
                    <a:ext uri="{9D8B030D-6E8A-4147-A177-3AD203B41FA5}">
                      <a16:colId xmlns:a16="http://schemas.microsoft.com/office/drawing/2014/main" xmlns="" val="608924300"/>
                    </a:ext>
                  </a:extLst>
                </a:gridCol>
                <a:gridCol w="466840">
                  <a:extLst>
                    <a:ext uri="{9D8B030D-6E8A-4147-A177-3AD203B41FA5}">
                      <a16:colId xmlns:a16="http://schemas.microsoft.com/office/drawing/2014/main" xmlns="" val="1722893616"/>
                    </a:ext>
                  </a:extLst>
                </a:gridCol>
                <a:gridCol w="2953016">
                  <a:extLst>
                    <a:ext uri="{9D8B030D-6E8A-4147-A177-3AD203B41FA5}">
                      <a16:colId xmlns:a16="http://schemas.microsoft.com/office/drawing/2014/main" xmlns="" val="1747081117"/>
                    </a:ext>
                  </a:extLst>
                </a:gridCol>
                <a:gridCol w="438912">
                  <a:extLst>
                    <a:ext uri="{9D8B030D-6E8A-4147-A177-3AD203B41FA5}">
                      <a16:colId xmlns:a16="http://schemas.microsoft.com/office/drawing/2014/main" xmlns="" val="2046204891"/>
                    </a:ext>
                  </a:extLst>
                </a:gridCol>
              </a:tblGrid>
              <a:tr h="601386">
                <a:tc gridSpan="2">
                  <a:txBody>
                    <a:bodyPr/>
                    <a:lstStyle/>
                    <a:p>
                      <a:pPr algn="ctr" fontAlgn="b"/>
                      <a:r>
                        <a:rPr lang="en-US" sz="2800" b="1" u="none" strike="noStrike" dirty="0" smtClean="0">
                          <a:effectLst/>
                        </a:rPr>
                        <a:t>Group</a:t>
                      </a:r>
                      <a:r>
                        <a:rPr lang="en-US" sz="2800" b="1" u="none" strike="noStrike" baseline="0" dirty="0" smtClean="0">
                          <a:effectLst/>
                        </a:rPr>
                        <a:t> </a:t>
                      </a:r>
                      <a:r>
                        <a:rPr lang="en-US" sz="2800" b="1" u="none" strike="noStrike" dirty="0" smtClean="0">
                          <a:effectLst/>
                        </a:rPr>
                        <a:t>1</a:t>
                      </a:r>
                      <a:endParaRPr lang="en-US" sz="2800" b="1" i="0" u="none" strike="noStrike" dirty="0">
                        <a:solidFill>
                          <a:srgbClr val="000000"/>
                        </a:solidFill>
                        <a:effectLst/>
                        <a:latin typeface="Calibri" panose="020F0502020204030204" pitchFamily="34" charset="0"/>
                      </a:endParaRPr>
                    </a:p>
                  </a:txBody>
                  <a:tcPr marL="4763" marR="4763" marT="4763" marB="0" anchor="b"/>
                </a:tc>
                <a:tc hMerge="1">
                  <a:txBody>
                    <a:bodyPr/>
                    <a:lstStyle/>
                    <a:p>
                      <a:endParaRPr lang="en-US"/>
                    </a:p>
                  </a:txBody>
                  <a:tcPr/>
                </a:tc>
                <a:tc gridSpan="2">
                  <a:txBody>
                    <a:bodyPr/>
                    <a:lstStyle/>
                    <a:p>
                      <a:pPr algn="ctr" fontAlgn="b"/>
                      <a:r>
                        <a:rPr lang="en-US" sz="2800" b="1" u="none" strike="noStrike" dirty="0" smtClean="0">
                          <a:effectLst/>
                        </a:rPr>
                        <a:t>Grou</a:t>
                      </a:r>
                      <a:r>
                        <a:rPr lang="en-US" sz="2800" b="1" u="none" strike="noStrike" baseline="0" dirty="0" smtClean="0">
                          <a:effectLst/>
                        </a:rPr>
                        <a:t>p </a:t>
                      </a:r>
                      <a:r>
                        <a:rPr lang="en-US" sz="2800" b="1" u="none" strike="noStrike" dirty="0" smtClean="0">
                          <a:effectLst/>
                        </a:rPr>
                        <a:t>2</a:t>
                      </a:r>
                      <a:endParaRPr lang="en-US" sz="2800" b="1" i="0" u="none" strike="noStrike" dirty="0">
                        <a:solidFill>
                          <a:srgbClr val="000000"/>
                        </a:solidFill>
                        <a:effectLst/>
                        <a:latin typeface="Calibri" panose="020F0502020204030204" pitchFamily="34" charset="0"/>
                      </a:endParaRPr>
                    </a:p>
                  </a:txBody>
                  <a:tcPr marL="4763" marR="4763" marT="4763" marB="0" anchor="b">
                    <a:solidFill>
                      <a:schemeClr val="accent5">
                        <a:lumMod val="40000"/>
                        <a:lumOff val="60000"/>
                      </a:schemeClr>
                    </a:solidFill>
                  </a:tcPr>
                </a:tc>
                <a:tc hMerge="1">
                  <a:txBody>
                    <a:bodyPr/>
                    <a:lstStyle/>
                    <a:p>
                      <a:endParaRPr lang="en-US"/>
                    </a:p>
                  </a:txBody>
                  <a:tcPr/>
                </a:tc>
                <a:tc gridSpan="2">
                  <a:txBody>
                    <a:bodyPr/>
                    <a:lstStyle/>
                    <a:p>
                      <a:pPr algn="ctr" fontAlgn="b"/>
                      <a:r>
                        <a:rPr lang="en-US" sz="2800" b="1" u="none" strike="noStrike" dirty="0" smtClean="0">
                          <a:effectLst/>
                        </a:rPr>
                        <a:t>Group</a:t>
                      </a:r>
                      <a:r>
                        <a:rPr lang="en-US" sz="2800" b="1" u="none" strike="noStrike" baseline="0" dirty="0" smtClean="0">
                          <a:effectLst/>
                        </a:rPr>
                        <a:t> </a:t>
                      </a:r>
                      <a:r>
                        <a:rPr lang="en-US" sz="2800" b="1" u="none" strike="noStrike" dirty="0" smtClean="0">
                          <a:effectLst/>
                        </a:rPr>
                        <a:t>3</a:t>
                      </a:r>
                      <a:endParaRPr lang="en-US" sz="2800" b="1" i="0" u="none" strike="noStrike" dirty="0">
                        <a:solidFill>
                          <a:srgbClr val="000000"/>
                        </a:solidFill>
                        <a:effectLst/>
                        <a:latin typeface="Calibri" panose="020F0502020204030204" pitchFamily="34" charset="0"/>
                      </a:endParaRPr>
                    </a:p>
                  </a:txBody>
                  <a:tcPr marL="4763" marR="4763" marT="4763" marB="0" anchor="b">
                    <a:solidFill>
                      <a:schemeClr val="accent3">
                        <a:lumMod val="40000"/>
                        <a:lumOff val="60000"/>
                      </a:schemeClr>
                    </a:solidFill>
                  </a:tcPr>
                </a:tc>
                <a:tc hMerge="1">
                  <a:txBody>
                    <a:bodyPr/>
                    <a:lstStyle/>
                    <a:p>
                      <a:endParaRPr lang="en-US"/>
                    </a:p>
                  </a:txBody>
                  <a:tcPr/>
                </a:tc>
                <a:extLst>
                  <a:ext uri="{0D108BD9-81ED-4DB2-BD59-A6C34878D82A}">
                    <a16:rowId xmlns:a16="http://schemas.microsoft.com/office/drawing/2014/main" xmlns="" val="96309061"/>
                  </a:ext>
                </a:extLst>
              </a:tr>
              <a:tr h="741193">
                <a:tc>
                  <a:txBody>
                    <a:bodyPr/>
                    <a:lstStyle/>
                    <a:p>
                      <a:pPr algn="ctr" fontAlgn="b"/>
                      <a:r>
                        <a:rPr lang="en-US" sz="2800" b="0" i="0" u="none" strike="noStrike" dirty="0" smtClean="0">
                          <a:solidFill>
                            <a:srgbClr val="000000"/>
                          </a:solidFill>
                          <a:effectLst/>
                          <a:latin typeface="Calibri" panose="020F0502020204030204" pitchFamily="34" charset="0"/>
                        </a:rPr>
                        <a:t>Learner</a:t>
                      </a:r>
                      <a:r>
                        <a:rPr lang="en-US" sz="2800" b="0" i="0" u="none" strike="noStrike" baseline="0" dirty="0" smtClean="0">
                          <a:solidFill>
                            <a:srgbClr val="000000"/>
                          </a:solidFill>
                          <a:effectLst/>
                          <a:latin typeface="Calibri" panose="020F0502020204030204" pitchFamily="34" charset="0"/>
                        </a:rPr>
                        <a:t>1A Name</a:t>
                      </a:r>
                      <a:endParaRPr lang="en-US" sz="28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US" sz="2800" b="1" i="1" u="none" strike="noStrike" dirty="0">
                          <a:solidFill>
                            <a:srgbClr val="000000"/>
                          </a:solidFill>
                          <a:effectLst/>
                          <a:latin typeface="Calibri" panose="020F0502020204030204" pitchFamily="34" charset="0"/>
                        </a:rPr>
                        <a:t>A</a:t>
                      </a:r>
                    </a:p>
                  </a:txBody>
                  <a:tcPr marL="9525" marR="9525" marT="9525" marB="0" anchor="b"/>
                </a:tc>
                <a:tc>
                  <a:txBody>
                    <a:bodyPr/>
                    <a:lstStyle/>
                    <a:p>
                      <a:pPr algn="ctr" fontAlgn="b"/>
                      <a:r>
                        <a:rPr lang="en-US" sz="2800" b="0" i="0" u="none" strike="noStrike" dirty="0" smtClean="0">
                          <a:solidFill>
                            <a:srgbClr val="000000"/>
                          </a:solidFill>
                          <a:effectLst/>
                          <a:latin typeface="Calibri" panose="020F0502020204030204" pitchFamily="34" charset="0"/>
                        </a:rPr>
                        <a:t>Learner </a:t>
                      </a:r>
                      <a:r>
                        <a:rPr lang="en-US" sz="2800" b="0" i="0" u="none" strike="noStrike" baseline="0" dirty="0" smtClean="0">
                          <a:solidFill>
                            <a:srgbClr val="000000"/>
                          </a:solidFill>
                          <a:effectLst/>
                          <a:latin typeface="Calibri" panose="020F0502020204030204" pitchFamily="34" charset="0"/>
                        </a:rPr>
                        <a:t>2A Name</a:t>
                      </a:r>
                      <a:endParaRPr lang="en-US" sz="2800" b="0" i="0" u="none" strike="noStrike" dirty="0">
                        <a:solidFill>
                          <a:srgbClr val="000000"/>
                        </a:solidFill>
                        <a:effectLst/>
                        <a:latin typeface="Calibri" panose="020F0502020204030204" pitchFamily="34" charset="0"/>
                      </a:endParaRPr>
                    </a:p>
                  </a:txBody>
                  <a:tcPr marL="9525" marR="9525" marT="9525" marB="0" anchor="b">
                    <a:solidFill>
                      <a:schemeClr val="accent5">
                        <a:lumMod val="40000"/>
                        <a:lumOff val="60000"/>
                      </a:schemeClr>
                    </a:solidFill>
                  </a:tcPr>
                </a:tc>
                <a:tc>
                  <a:txBody>
                    <a:bodyPr/>
                    <a:lstStyle/>
                    <a:p>
                      <a:pPr algn="l" fontAlgn="b"/>
                      <a:r>
                        <a:rPr lang="en-US" sz="2800" b="1" i="1" u="none" strike="noStrike" dirty="0">
                          <a:solidFill>
                            <a:srgbClr val="000000"/>
                          </a:solidFill>
                          <a:effectLst/>
                          <a:latin typeface="Calibri" panose="020F0502020204030204" pitchFamily="34" charset="0"/>
                        </a:rPr>
                        <a:t>A</a:t>
                      </a:r>
                    </a:p>
                  </a:txBody>
                  <a:tcPr marL="9525" marR="9525" marT="9525" marB="0" anchor="b">
                    <a:solidFill>
                      <a:schemeClr val="accent5">
                        <a:lumMod val="40000"/>
                        <a:lumOff val="60000"/>
                      </a:schemeClr>
                    </a:solidFill>
                  </a:tcPr>
                </a:tc>
                <a:tc>
                  <a:txBody>
                    <a:bodyPr/>
                    <a:lstStyle/>
                    <a:p>
                      <a:pPr algn="ctr" fontAlgn="b"/>
                      <a:r>
                        <a:rPr lang="en-US" sz="2800" b="0" i="0" u="none" strike="noStrike" dirty="0" smtClean="0">
                          <a:solidFill>
                            <a:srgbClr val="000000"/>
                          </a:solidFill>
                          <a:effectLst/>
                          <a:latin typeface="Calibri" panose="020F0502020204030204" pitchFamily="34" charset="0"/>
                        </a:rPr>
                        <a:t>Learner </a:t>
                      </a:r>
                      <a:r>
                        <a:rPr lang="en-US" sz="2800" b="0" i="0" u="none" strike="noStrike" baseline="0" dirty="0" smtClean="0">
                          <a:solidFill>
                            <a:srgbClr val="000000"/>
                          </a:solidFill>
                          <a:effectLst/>
                          <a:latin typeface="Calibri" panose="020F0502020204030204" pitchFamily="34" charset="0"/>
                        </a:rPr>
                        <a:t>3A Name</a:t>
                      </a:r>
                      <a:endParaRPr lang="en-US" sz="2800" b="0" i="0" u="none" strike="noStrike" dirty="0">
                        <a:solidFill>
                          <a:srgbClr val="000000"/>
                        </a:solidFill>
                        <a:effectLst/>
                        <a:latin typeface="Calibri" panose="020F0502020204030204" pitchFamily="34" charset="0"/>
                      </a:endParaRPr>
                    </a:p>
                  </a:txBody>
                  <a:tcPr marL="9525" marR="9525" marT="9525" marB="0" anchor="b">
                    <a:solidFill>
                      <a:schemeClr val="accent3">
                        <a:lumMod val="40000"/>
                        <a:lumOff val="60000"/>
                      </a:schemeClr>
                    </a:solidFill>
                  </a:tcPr>
                </a:tc>
                <a:tc>
                  <a:txBody>
                    <a:bodyPr/>
                    <a:lstStyle/>
                    <a:p>
                      <a:pPr algn="l" fontAlgn="b"/>
                      <a:r>
                        <a:rPr lang="en-US" sz="2800" b="1" i="1" u="none" strike="noStrike" dirty="0">
                          <a:solidFill>
                            <a:srgbClr val="000000"/>
                          </a:solidFill>
                          <a:effectLst/>
                          <a:latin typeface="Calibri" panose="020F0502020204030204" pitchFamily="34" charset="0"/>
                        </a:rPr>
                        <a:t>A</a:t>
                      </a:r>
                    </a:p>
                  </a:txBody>
                  <a:tcPr marL="9525" marR="9525" marT="9525" marB="0" anchor="b">
                    <a:solidFill>
                      <a:schemeClr val="accent3">
                        <a:lumMod val="40000"/>
                        <a:lumOff val="60000"/>
                      </a:schemeClr>
                    </a:solidFill>
                  </a:tcPr>
                </a:tc>
                <a:extLst>
                  <a:ext uri="{0D108BD9-81ED-4DB2-BD59-A6C34878D82A}">
                    <a16:rowId xmlns:a16="http://schemas.microsoft.com/office/drawing/2014/main" xmlns="" val="1028143466"/>
                  </a:ext>
                </a:extLst>
              </a:tr>
              <a:tr h="741193">
                <a:tc>
                  <a:txBody>
                    <a:bodyPr/>
                    <a:lstStyle/>
                    <a:p>
                      <a:pPr marL="0" marR="0" indent="0" algn="ctr" defTabSz="457200" rtl="0" eaLnBrk="1" fontAlgn="b" latinLnBrk="0" hangingPunct="1">
                        <a:lnSpc>
                          <a:spcPct val="100000"/>
                        </a:lnSpc>
                        <a:spcBef>
                          <a:spcPts val="0"/>
                        </a:spcBef>
                        <a:spcAft>
                          <a:spcPts val="0"/>
                        </a:spcAft>
                        <a:buClrTx/>
                        <a:buSzTx/>
                        <a:buFontTx/>
                        <a:buNone/>
                        <a:tabLst/>
                        <a:defRPr/>
                      </a:pPr>
                      <a:r>
                        <a:rPr lang="en-US" sz="2800" b="0" i="0" u="none" strike="noStrike" dirty="0" smtClean="0">
                          <a:solidFill>
                            <a:srgbClr val="000000"/>
                          </a:solidFill>
                          <a:effectLst/>
                          <a:latin typeface="Calibri" panose="020F0502020204030204" pitchFamily="34" charset="0"/>
                        </a:rPr>
                        <a:t>Learner 1B </a:t>
                      </a:r>
                      <a:r>
                        <a:rPr lang="en-US" sz="2800" b="0" i="0" u="none" strike="noStrike" baseline="0" dirty="0" smtClean="0">
                          <a:solidFill>
                            <a:srgbClr val="000000"/>
                          </a:solidFill>
                          <a:effectLst/>
                          <a:latin typeface="Calibri" panose="020F0502020204030204" pitchFamily="34" charset="0"/>
                        </a:rPr>
                        <a:t>Name</a:t>
                      </a:r>
                      <a:endParaRPr lang="en-US" sz="2800" b="0" i="0" u="none" strike="noStrike" dirty="0" smtClean="0">
                        <a:solidFill>
                          <a:srgbClr val="000000"/>
                        </a:solidFill>
                        <a:effectLst/>
                        <a:latin typeface="Calibri" panose="020F0502020204030204" pitchFamily="34" charset="0"/>
                      </a:endParaRPr>
                    </a:p>
                  </a:txBody>
                  <a:tcPr marL="9525" marR="9525" marT="9525" marB="0" anchor="b"/>
                </a:tc>
                <a:tc>
                  <a:txBody>
                    <a:bodyPr/>
                    <a:lstStyle/>
                    <a:p>
                      <a:pPr algn="l" fontAlgn="b"/>
                      <a:r>
                        <a:rPr lang="en-US" sz="2800" b="1" i="1" u="none" strike="noStrike" dirty="0">
                          <a:solidFill>
                            <a:srgbClr val="000000"/>
                          </a:solidFill>
                          <a:effectLst/>
                          <a:latin typeface="Calibri" panose="020F0502020204030204" pitchFamily="34" charset="0"/>
                        </a:rPr>
                        <a:t>B</a:t>
                      </a:r>
                    </a:p>
                  </a:txBody>
                  <a:tcPr marL="9525" marR="9525" marT="9525" marB="0" anchor="b"/>
                </a:tc>
                <a:tc>
                  <a:txBody>
                    <a:bodyPr/>
                    <a:lstStyle/>
                    <a:p>
                      <a:pPr marL="0" marR="0" indent="0" algn="ctr" defTabSz="457200" rtl="0" eaLnBrk="1" fontAlgn="b" latinLnBrk="0" hangingPunct="1">
                        <a:lnSpc>
                          <a:spcPct val="100000"/>
                        </a:lnSpc>
                        <a:spcBef>
                          <a:spcPts val="0"/>
                        </a:spcBef>
                        <a:spcAft>
                          <a:spcPts val="0"/>
                        </a:spcAft>
                        <a:buClrTx/>
                        <a:buSzTx/>
                        <a:buFontTx/>
                        <a:buNone/>
                        <a:tabLst/>
                        <a:defRPr/>
                      </a:pPr>
                      <a:r>
                        <a:rPr lang="en-US" sz="2800" b="0" i="0" u="none" strike="noStrike" dirty="0" smtClean="0">
                          <a:solidFill>
                            <a:srgbClr val="000000"/>
                          </a:solidFill>
                          <a:effectLst/>
                          <a:latin typeface="Calibri" panose="020F0502020204030204" pitchFamily="34" charset="0"/>
                        </a:rPr>
                        <a:t>Learner 2B </a:t>
                      </a:r>
                      <a:r>
                        <a:rPr lang="en-US" sz="2800" b="0" i="0" u="none" strike="noStrike" baseline="0" dirty="0" smtClean="0">
                          <a:solidFill>
                            <a:srgbClr val="000000"/>
                          </a:solidFill>
                          <a:effectLst/>
                          <a:latin typeface="Calibri" panose="020F0502020204030204" pitchFamily="34" charset="0"/>
                        </a:rPr>
                        <a:t>Name</a:t>
                      </a:r>
                      <a:endParaRPr lang="en-US" sz="2800" b="0" i="0" u="none" strike="noStrike" dirty="0" smtClean="0">
                        <a:solidFill>
                          <a:srgbClr val="000000"/>
                        </a:solidFill>
                        <a:effectLst/>
                        <a:latin typeface="Calibri" panose="020F0502020204030204" pitchFamily="34" charset="0"/>
                      </a:endParaRPr>
                    </a:p>
                  </a:txBody>
                  <a:tcPr marL="9525" marR="9525" marT="9525" marB="0" anchor="b">
                    <a:solidFill>
                      <a:schemeClr val="accent5">
                        <a:lumMod val="40000"/>
                        <a:lumOff val="60000"/>
                      </a:schemeClr>
                    </a:solidFill>
                  </a:tcPr>
                </a:tc>
                <a:tc>
                  <a:txBody>
                    <a:bodyPr/>
                    <a:lstStyle/>
                    <a:p>
                      <a:pPr algn="l" fontAlgn="b"/>
                      <a:r>
                        <a:rPr lang="en-US" sz="2800" b="1" i="1" u="none" strike="noStrike" dirty="0">
                          <a:solidFill>
                            <a:srgbClr val="000000"/>
                          </a:solidFill>
                          <a:effectLst/>
                          <a:latin typeface="Calibri" panose="020F0502020204030204" pitchFamily="34" charset="0"/>
                        </a:rPr>
                        <a:t>B</a:t>
                      </a:r>
                    </a:p>
                  </a:txBody>
                  <a:tcPr marL="9525" marR="9525" marT="9525" marB="0" anchor="b">
                    <a:solidFill>
                      <a:schemeClr val="accent5">
                        <a:lumMod val="40000"/>
                        <a:lumOff val="60000"/>
                      </a:schemeClr>
                    </a:solidFill>
                  </a:tcPr>
                </a:tc>
                <a:tc>
                  <a:txBody>
                    <a:bodyPr/>
                    <a:lstStyle/>
                    <a:p>
                      <a:pPr marL="0" marR="0" indent="0" algn="ctr" defTabSz="457200" rtl="0" eaLnBrk="1" fontAlgn="b" latinLnBrk="0" hangingPunct="1">
                        <a:lnSpc>
                          <a:spcPct val="100000"/>
                        </a:lnSpc>
                        <a:spcBef>
                          <a:spcPts val="0"/>
                        </a:spcBef>
                        <a:spcAft>
                          <a:spcPts val="0"/>
                        </a:spcAft>
                        <a:buClrTx/>
                        <a:buSzTx/>
                        <a:buFontTx/>
                        <a:buNone/>
                        <a:tabLst/>
                        <a:defRPr/>
                      </a:pPr>
                      <a:r>
                        <a:rPr lang="en-US" sz="2800" b="0" i="0" u="none" strike="noStrike" dirty="0" smtClean="0">
                          <a:solidFill>
                            <a:srgbClr val="000000"/>
                          </a:solidFill>
                          <a:effectLst/>
                          <a:latin typeface="Calibri" panose="020F0502020204030204" pitchFamily="34" charset="0"/>
                        </a:rPr>
                        <a:t>Learner 3B </a:t>
                      </a:r>
                      <a:r>
                        <a:rPr lang="en-US" sz="2800" b="0" i="0" u="none" strike="noStrike" baseline="0" dirty="0" smtClean="0">
                          <a:solidFill>
                            <a:srgbClr val="000000"/>
                          </a:solidFill>
                          <a:effectLst/>
                          <a:latin typeface="Calibri" panose="020F0502020204030204" pitchFamily="34" charset="0"/>
                        </a:rPr>
                        <a:t>Name</a:t>
                      </a:r>
                      <a:endParaRPr lang="en-US" sz="2800" b="0" i="0" u="none" strike="noStrike" dirty="0" smtClean="0">
                        <a:solidFill>
                          <a:srgbClr val="000000"/>
                        </a:solidFill>
                        <a:effectLst/>
                        <a:latin typeface="Calibri" panose="020F0502020204030204" pitchFamily="34" charset="0"/>
                      </a:endParaRPr>
                    </a:p>
                  </a:txBody>
                  <a:tcPr marL="9525" marR="9525" marT="9525" marB="0" anchor="b">
                    <a:solidFill>
                      <a:schemeClr val="accent3">
                        <a:lumMod val="40000"/>
                        <a:lumOff val="60000"/>
                      </a:schemeClr>
                    </a:solidFill>
                  </a:tcPr>
                </a:tc>
                <a:tc>
                  <a:txBody>
                    <a:bodyPr/>
                    <a:lstStyle/>
                    <a:p>
                      <a:pPr algn="l" fontAlgn="b"/>
                      <a:r>
                        <a:rPr lang="en-US" sz="2800" b="1" i="1" u="none" strike="noStrike" dirty="0">
                          <a:solidFill>
                            <a:srgbClr val="000000"/>
                          </a:solidFill>
                          <a:effectLst/>
                          <a:latin typeface="Calibri" panose="020F0502020204030204" pitchFamily="34" charset="0"/>
                        </a:rPr>
                        <a:t>B</a:t>
                      </a:r>
                    </a:p>
                  </a:txBody>
                  <a:tcPr marL="9525" marR="9525" marT="9525" marB="0" anchor="b">
                    <a:solidFill>
                      <a:schemeClr val="accent3">
                        <a:lumMod val="40000"/>
                        <a:lumOff val="60000"/>
                      </a:schemeClr>
                    </a:solidFill>
                  </a:tcPr>
                </a:tc>
                <a:extLst>
                  <a:ext uri="{0D108BD9-81ED-4DB2-BD59-A6C34878D82A}">
                    <a16:rowId xmlns:a16="http://schemas.microsoft.com/office/drawing/2014/main" xmlns="" val="10002"/>
                  </a:ext>
                </a:extLst>
              </a:tr>
              <a:tr h="741193">
                <a:tc>
                  <a:txBody>
                    <a:bodyPr/>
                    <a:lstStyle/>
                    <a:p>
                      <a:pPr marL="0" marR="0" indent="0" algn="ctr" defTabSz="457200" rtl="0" eaLnBrk="1" fontAlgn="b" latinLnBrk="0" hangingPunct="1">
                        <a:lnSpc>
                          <a:spcPct val="100000"/>
                        </a:lnSpc>
                        <a:spcBef>
                          <a:spcPts val="0"/>
                        </a:spcBef>
                        <a:spcAft>
                          <a:spcPts val="0"/>
                        </a:spcAft>
                        <a:buClrTx/>
                        <a:buSzTx/>
                        <a:buFontTx/>
                        <a:buNone/>
                        <a:tabLst/>
                        <a:defRPr/>
                      </a:pPr>
                      <a:r>
                        <a:rPr lang="en-US" sz="2800" b="0" i="0" u="none" strike="noStrike" dirty="0" smtClean="0">
                          <a:solidFill>
                            <a:srgbClr val="000000"/>
                          </a:solidFill>
                          <a:effectLst/>
                          <a:latin typeface="Calibri" panose="020F0502020204030204" pitchFamily="34" charset="0"/>
                        </a:rPr>
                        <a:t>Learner 1C </a:t>
                      </a:r>
                      <a:r>
                        <a:rPr lang="en-US" sz="2800" b="0" i="0" u="none" strike="noStrike" baseline="0" dirty="0" smtClean="0">
                          <a:solidFill>
                            <a:srgbClr val="000000"/>
                          </a:solidFill>
                          <a:effectLst/>
                          <a:latin typeface="Calibri" panose="020F0502020204030204" pitchFamily="34" charset="0"/>
                        </a:rPr>
                        <a:t>Name</a:t>
                      </a:r>
                      <a:endParaRPr lang="en-US" sz="2800" b="0" i="0" u="none" strike="noStrike" dirty="0" smtClean="0">
                        <a:solidFill>
                          <a:srgbClr val="000000"/>
                        </a:solidFill>
                        <a:effectLst/>
                        <a:latin typeface="Calibri" panose="020F0502020204030204" pitchFamily="34" charset="0"/>
                      </a:endParaRPr>
                    </a:p>
                  </a:txBody>
                  <a:tcPr marL="9525" marR="9525" marT="9525" marB="0" anchor="b"/>
                </a:tc>
                <a:tc>
                  <a:txBody>
                    <a:bodyPr/>
                    <a:lstStyle/>
                    <a:p>
                      <a:pPr algn="l" fontAlgn="b"/>
                      <a:r>
                        <a:rPr lang="en-US" sz="2800" b="1" i="1" u="none" strike="noStrike" dirty="0">
                          <a:solidFill>
                            <a:srgbClr val="000000"/>
                          </a:solidFill>
                          <a:effectLst/>
                          <a:latin typeface="Calibri" panose="020F0502020204030204" pitchFamily="34" charset="0"/>
                        </a:rPr>
                        <a:t>C</a:t>
                      </a:r>
                    </a:p>
                  </a:txBody>
                  <a:tcPr marL="9525" marR="9525" marT="9525" marB="0" anchor="b"/>
                </a:tc>
                <a:tc>
                  <a:txBody>
                    <a:bodyPr/>
                    <a:lstStyle/>
                    <a:p>
                      <a:pPr marL="0" marR="0" indent="0" algn="ctr" defTabSz="457200" rtl="0" eaLnBrk="1" fontAlgn="b" latinLnBrk="0" hangingPunct="1">
                        <a:lnSpc>
                          <a:spcPct val="100000"/>
                        </a:lnSpc>
                        <a:spcBef>
                          <a:spcPts val="0"/>
                        </a:spcBef>
                        <a:spcAft>
                          <a:spcPts val="0"/>
                        </a:spcAft>
                        <a:buClrTx/>
                        <a:buSzTx/>
                        <a:buFontTx/>
                        <a:buNone/>
                        <a:tabLst/>
                        <a:defRPr/>
                      </a:pPr>
                      <a:r>
                        <a:rPr lang="en-US" sz="2800" b="0" i="0" u="none" strike="noStrike" dirty="0" smtClean="0">
                          <a:solidFill>
                            <a:srgbClr val="000000"/>
                          </a:solidFill>
                          <a:effectLst/>
                          <a:latin typeface="Calibri" panose="020F0502020204030204" pitchFamily="34" charset="0"/>
                        </a:rPr>
                        <a:t>Learner 2C </a:t>
                      </a:r>
                      <a:r>
                        <a:rPr lang="en-US" sz="2800" b="0" i="0" u="none" strike="noStrike" baseline="0" dirty="0" smtClean="0">
                          <a:solidFill>
                            <a:srgbClr val="000000"/>
                          </a:solidFill>
                          <a:effectLst/>
                          <a:latin typeface="Calibri" panose="020F0502020204030204" pitchFamily="34" charset="0"/>
                        </a:rPr>
                        <a:t>Name</a:t>
                      </a:r>
                      <a:endParaRPr lang="en-US" sz="2800" b="0" i="0" u="none" strike="noStrike" dirty="0" smtClean="0">
                        <a:solidFill>
                          <a:srgbClr val="000000"/>
                        </a:solidFill>
                        <a:effectLst/>
                        <a:latin typeface="Calibri" panose="020F0502020204030204" pitchFamily="34" charset="0"/>
                      </a:endParaRPr>
                    </a:p>
                  </a:txBody>
                  <a:tcPr marL="9525" marR="9525" marT="9525" marB="0" anchor="b">
                    <a:solidFill>
                      <a:schemeClr val="accent5">
                        <a:lumMod val="40000"/>
                        <a:lumOff val="60000"/>
                      </a:schemeClr>
                    </a:solidFill>
                  </a:tcPr>
                </a:tc>
                <a:tc>
                  <a:txBody>
                    <a:bodyPr/>
                    <a:lstStyle/>
                    <a:p>
                      <a:pPr algn="l" fontAlgn="b"/>
                      <a:r>
                        <a:rPr lang="en-US" sz="2800" b="1" i="1" u="none" strike="noStrike" dirty="0">
                          <a:solidFill>
                            <a:srgbClr val="000000"/>
                          </a:solidFill>
                          <a:effectLst/>
                          <a:latin typeface="Calibri" panose="020F0502020204030204" pitchFamily="34" charset="0"/>
                        </a:rPr>
                        <a:t>C</a:t>
                      </a:r>
                    </a:p>
                  </a:txBody>
                  <a:tcPr marL="9525" marR="9525" marT="9525" marB="0" anchor="b">
                    <a:solidFill>
                      <a:schemeClr val="accent5">
                        <a:lumMod val="40000"/>
                        <a:lumOff val="60000"/>
                      </a:schemeClr>
                    </a:solidFill>
                  </a:tcPr>
                </a:tc>
                <a:tc>
                  <a:txBody>
                    <a:bodyPr/>
                    <a:lstStyle/>
                    <a:p>
                      <a:pPr marL="0" marR="0" indent="0" algn="ctr" defTabSz="457200" rtl="0" eaLnBrk="1" fontAlgn="b" latinLnBrk="0" hangingPunct="1">
                        <a:lnSpc>
                          <a:spcPct val="100000"/>
                        </a:lnSpc>
                        <a:spcBef>
                          <a:spcPts val="0"/>
                        </a:spcBef>
                        <a:spcAft>
                          <a:spcPts val="0"/>
                        </a:spcAft>
                        <a:buClrTx/>
                        <a:buSzTx/>
                        <a:buFontTx/>
                        <a:buNone/>
                        <a:tabLst/>
                        <a:defRPr/>
                      </a:pPr>
                      <a:r>
                        <a:rPr lang="en-US" sz="2800" b="0" i="0" u="none" strike="noStrike" dirty="0" smtClean="0">
                          <a:solidFill>
                            <a:srgbClr val="000000"/>
                          </a:solidFill>
                          <a:effectLst/>
                          <a:latin typeface="Calibri" panose="020F0502020204030204" pitchFamily="34" charset="0"/>
                        </a:rPr>
                        <a:t>Learner 3C </a:t>
                      </a:r>
                      <a:r>
                        <a:rPr lang="en-US" sz="2800" b="0" i="0" u="none" strike="noStrike" baseline="0" dirty="0" smtClean="0">
                          <a:solidFill>
                            <a:srgbClr val="000000"/>
                          </a:solidFill>
                          <a:effectLst/>
                          <a:latin typeface="Calibri" panose="020F0502020204030204" pitchFamily="34" charset="0"/>
                        </a:rPr>
                        <a:t>Name</a:t>
                      </a:r>
                      <a:endParaRPr lang="en-US" sz="2800" b="0" i="0" u="none" strike="noStrike" dirty="0" smtClean="0">
                        <a:solidFill>
                          <a:srgbClr val="000000"/>
                        </a:solidFill>
                        <a:effectLst/>
                        <a:latin typeface="Calibri" panose="020F0502020204030204" pitchFamily="34" charset="0"/>
                      </a:endParaRPr>
                    </a:p>
                  </a:txBody>
                  <a:tcPr marL="9525" marR="9525" marT="9525" marB="0" anchor="b">
                    <a:solidFill>
                      <a:schemeClr val="accent3">
                        <a:lumMod val="40000"/>
                        <a:lumOff val="60000"/>
                      </a:schemeClr>
                    </a:solidFill>
                  </a:tcPr>
                </a:tc>
                <a:tc>
                  <a:txBody>
                    <a:bodyPr/>
                    <a:lstStyle/>
                    <a:p>
                      <a:pPr algn="l" fontAlgn="b"/>
                      <a:r>
                        <a:rPr lang="en-US" sz="2800" b="1" i="1" u="none" strike="noStrike" dirty="0">
                          <a:solidFill>
                            <a:srgbClr val="000000"/>
                          </a:solidFill>
                          <a:effectLst/>
                          <a:latin typeface="Calibri" panose="020F0502020204030204" pitchFamily="34" charset="0"/>
                        </a:rPr>
                        <a:t>C</a:t>
                      </a:r>
                    </a:p>
                  </a:txBody>
                  <a:tcPr marL="9525" marR="9525" marT="9525" marB="0" anchor="b">
                    <a:solidFill>
                      <a:schemeClr val="accent3">
                        <a:lumMod val="40000"/>
                        <a:lumOff val="60000"/>
                      </a:schemeClr>
                    </a:solidFill>
                  </a:tcPr>
                </a:tc>
                <a:extLst>
                  <a:ext uri="{0D108BD9-81ED-4DB2-BD59-A6C34878D82A}">
                    <a16:rowId xmlns:a16="http://schemas.microsoft.com/office/drawing/2014/main" xmlns="" val="1392875940"/>
                  </a:ext>
                </a:extLst>
              </a:tr>
              <a:tr h="741193">
                <a:tc>
                  <a:txBody>
                    <a:bodyPr/>
                    <a:lstStyle/>
                    <a:p>
                      <a:pPr marL="0" marR="0" indent="0" algn="ctr" defTabSz="457200" rtl="0" eaLnBrk="1" fontAlgn="b" latinLnBrk="0" hangingPunct="1">
                        <a:lnSpc>
                          <a:spcPct val="100000"/>
                        </a:lnSpc>
                        <a:spcBef>
                          <a:spcPts val="0"/>
                        </a:spcBef>
                        <a:spcAft>
                          <a:spcPts val="0"/>
                        </a:spcAft>
                        <a:buClrTx/>
                        <a:buSzTx/>
                        <a:buFontTx/>
                        <a:buNone/>
                        <a:tabLst/>
                        <a:defRPr/>
                      </a:pPr>
                      <a:r>
                        <a:rPr lang="en-US" sz="2800" b="0" i="0" u="none" strike="noStrike" dirty="0" smtClean="0">
                          <a:solidFill>
                            <a:srgbClr val="000000"/>
                          </a:solidFill>
                          <a:effectLst/>
                          <a:latin typeface="Calibri" panose="020F0502020204030204" pitchFamily="34" charset="0"/>
                        </a:rPr>
                        <a:t>Learner 1D </a:t>
                      </a:r>
                      <a:r>
                        <a:rPr lang="en-US" sz="2800" b="0" i="0" u="none" strike="noStrike" baseline="0" dirty="0" smtClean="0">
                          <a:solidFill>
                            <a:srgbClr val="000000"/>
                          </a:solidFill>
                          <a:effectLst/>
                          <a:latin typeface="Calibri" panose="020F0502020204030204" pitchFamily="34" charset="0"/>
                        </a:rPr>
                        <a:t>Name</a:t>
                      </a:r>
                      <a:endParaRPr lang="en-US" sz="2800" b="0" i="0" u="none" strike="noStrike" dirty="0" smtClean="0">
                        <a:solidFill>
                          <a:srgbClr val="000000"/>
                        </a:solidFill>
                        <a:effectLst/>
                        <a:latin typeface="Calibri" panose="020F0502020204030204" pitchFamily="34" charset="0"/>
                      </a:endParaRPr>
                    </a:p>
                  </a:txBody>
                  <a:tcPr marL="9525" marR="9525" marT="9525" marB="0" anchor="b"/>
                </a:tc>
                <a:tc>
                  <a:txBody>
                    <a:bodyPr/>
                    <a:lstStyle/>
                    <a:p>
                      <a:pPr algn="l" fontAlgn="b"/>
                      <a:r>
                        <a:rPr lang="en-US" sz="2800" b="1" i="1" u="none" strike="noStrike" dirty="0">
                          <a:solidFill>
                            <a:srgbClr val="000000"/>
                          </a:solidFill>
                          <a:effectLst/>
                          <a:latin typeface="Calibri" panose="020F0502020204030204" pitchFamily="34" charset="0"/>
                        </a:rPr>
                        <a:t>D</a:t>
                      </a:r>
                    </a:p>
                  </a:txBody>
                  <a:tcPr marL="9525" marR="9525" marT="9525" marB="0" anchor="b"/>
                </a:tc>
                <a:tc>
                  <a:txBody>
                    <a:bodyPr/>
                    <a:lstStyle/>
                    <a:p>
                      <a:pPr marL="0" marR="0" indent="0" algn="ctr" defTabSz="457200" rtl="0" eaLnBrk="1" fontAlgn="b" latinLnBrk="0" hangingPunct="1">
                        <a:lnSpc>
                          <a:spcPct val="100000"/>
                        </a:lnSpc>
                        <a:spcBef>
                          <a:spcPts val="0"/>
                        </a:spcBef>
                        <a:spcAft>
                          <a:spcPts val="0"/>
                        </a:spcAft>
                        <a:buClrTx/>
                        <a:buSzTx/>
                        <a:buFontTx/>
                        <a:buNone/>
                        <a:tabLst/>
                        <a:defRPr/>
                      </a:pPr>
                      <a:r>
                        <a:rPr lang="en-US" sz="2800" b="0" i="0" u="none" strike="noStrike" dirty="0" smtClean="0">
                          <a:solidFill>
                            <a:srgbClr val="000000"/>
                          </a:solidFill>
                          <a:effectLst/>
                          <a:latin typeface="Calibri" panose="020F0502020204030204" pitchFamily="34" charset="0"/>
                        </a:rPr>
                        <a:t>Learner 2D </a:t>
                      </a:r>
                      <a:r>
                        <a:rPr lang="en-US" sz="2800" b="0" i="0" u="none" strike="noStrike" baseline="0" dirty="0" smtClean="0">
                          <a:solidFill>
                            <a:srgbClr val="000000"/>
                          </a:solidFill>
                          <a:effectLst/>
                          <a:latin typeface="Calibri" panose="020F0502020204030204" pitchFamily="34" charset="0"/>
                        </a:rPr>
                        <a:t>Name</a:t>
                      </a:r>
                      <a:endParaRPr lang="en-US" sz="2800" b="0" i="0" u="none" strike="noStrike" dirty="0" smtClean="0">
                        <a:solidFill>
                          <a:srgbClr val="000000"/>
                        </a:solidFill>
                        <a:effectLst/>
                        <a:latin typeface="Calibri" panose="020F0502020204030204" pitchFamily="34" charset="0"/>
                      </a:endParaRPr>
                    </a:p>
                  </a:txBody>
                  <a:tcPr marL="9525" marR="9525" marT="9525" marB="0" anchor="b">
                    <a:solidFill>
                      <a:schemeClr val="accent5">
                        <a:lumMod val="40000"/>
                        <a:lumOff val="60000"/>
                      </a:schemeClr>
                    </a:solidFill>
                  </a:tcPr>
                </a:tc>
                <a:tc>
                  <a:txBody>
                    <a:bodyPr/>
                    <a:lstStyle/>
                    <a:p>
                      <a:pPr algn="l" fontAlgn="b"/>
                      <a:r>
                        <a:rPr lang="en-US" sz="2800" b="1" i="1" u="none" strike="noStrike" dirty="0">
                          <a:solidFill>
                            <a:srgbClr val="000000"/>
                          </a:solidFill>
                          <a:effectLst/>
                          <a:latin typeface="Calibri" panose="020F0502020204030204" pitchFamily="34" charset="0"/>
                        </a:rPr>
                        <a:t>D</a:t>
                      </a:r>
                    </a:p>
                  </a:txBody>
                  <a:tcPr marL="9525" marR="9525" marT="9525" marB="0" anchor="b">
                    <a:solidFill>
                      <a:schemeClr val="accent5">
                        <a:lumMod val="40000"/>
                        <a:lumOff val="60000"/>
                      </a:schemeClr>
                    </a:solidFill>
                  </a:tcPr>
                </a:tc>
                <a:tc>
                  <a:txBody>
                    <a:bodyPr/>
                    <a:lstStyle/>
                    <a:p>
                      <a:pPr marL="0" marR="0" indent="0" algn="ctr" defTabSz="457200" rtl="0" eaLnBrk="1" fontAlgn="b" latinLnBrk="0" hangingPunct="1">
                        <a:lnSpc>
                          <a:spcPct val="100000"/>
                        </a:lnSpc>
                        <a:spcBef>
                          <a:spcPts val="0"/>
                        </a:spcBef>
                        <a:spcAft>
                          <a:spcPts val="0"/>
                        </a:spcAft>
                        <a:buClrTx/>
                        <a:buSzTx/>
                        <a:buFontTx/>
                        <a:buNone/>
                        <a:tabLst/>
                        <a:defRPr/>
                      </a:pPr>
                      <a:r>
                        <a:rPr lang="en-US" sz="2800" b="0" i="0" u="none" strike="noStrike" dirty="0" smtClean="0">
                          <a:solidFill>
                            <a:srgbClr val="000000"/>
                          </a:solidFill>
                          <a:effectLst/>
                          <a:latin typeface="Calibri" panose="020F0502020204030204" pitchFamily="34" charset="0"/>
                        </a:rPr>
                        <a:t>Learner 3D </a:t>
                      </a:r>
                      <a:r>
                        <a:rPr lang="en-US" sz="2800" b="0" i="0" u="none" strike="noStrike" baseline="0" dirty="0" smtClean="0">
                          <a:solidFill>
                            <a:srgbClr val="000000"/>
                          </a:solidFill>
                          <a:effectLst/>
                          <a:latin typeface="Calibri" panose="020F0502020204030204" pitchFamily="34" charset="0"/>
                        </a:rPr>
                        <a:t>Name</a:t>
                      </a:r>
                      <a:endParaRPr lang="en-US" sz="2800" b="0" i="0" u="none" strike="noStrike" dirty="0" smtClean="0">
                        <a:solidFill>
                          <a:srgbClr val="000000"/>
                        </a:solidFill>
                        <a:effectLst/>
                        <a:latin typeface="Calibri" panose="020F0502020204030204" pitchFamily="34" charset="0"/>
                      </a:endParaRPr>
                    </a:p>
                  </a:txBody>
                  <a:tcPr marL="9525" marR="9525" marT="9525" marB="0" anchor="b">
                    <a:solidFill>
                      <a:schemeClr val="accent3">
                        <a:lumMod val="40000"/>
                        <a:lumOff val="60000"/>
                      </a:schemeClr>
                    </a:solidFill>
                  </a:tcPr>
                </a:tc>
                <a:tc>
                  <a:txBody>
                    <a:bodyPr/>
                    <a:lstStyle/>
                    <a:p>
                      <a:pPr algn="l" fontAlgn="b"/>
                      <a:r>
                        <a:rPr lang="en-US" sz="2800" b="1" i="1" u="none" strike="noStrike" dirty="0">
                          <a:solidFill>
                            <a:srgbClr val="000000"/>
                          </a:solidFill>
                          <a:effectLst/>
                          <a:latin typeface="Calibri" panose="020F0502020204030204" pitchFamily="34" charset="0"/>
                        </a:rPr>
                        <a:t>D</a:t>
                      </a:r>
                    </a:p>
                  </a:txBody>
                  <a:tcPr marL="9525" marR="9525" marT="9525" marB="0" anchor="b">
                    <a:solidFill>
                      <a:schemeClr val="accent3">
                        <a:lumMod val="40000"/>
                        <a:lumOff val="60000"/>
                      </a:schemeClr>
                    </a:solidFill>
                  </a:tcPr>
                </a:tc>
                <a:extLst>
                  <a:ext uri="{0D108BD9-81ED-4DB2-BD59-A6C34878D82A}">
                    <a16:rowId xmlns:a16="http://schemas.microsoft.com/office/drawing/2014/main" xmlns="" val="572075281"/>
                  </a:ext>
                </a:extLst>
              </a:tr>
            </a:tbl>
          </a:graphicData>
        </a:graphic>
      </p:graphicFrame>
      <p:pic>
        <p:nvPicPr>
          <p:cNvPr id="4" name="Content Placeholder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521441" y="6275242"/>
            <a:ext cx="632930" cy="504634"/>
          </a:xfrm>
          <a:prstGeom prst="rect">
            <a:avLst/>
          </a:prstGeom>
          <a:solidFill>
            <a:schemeClr val="bg1"/>
          </a:solidFill>
        </p:spPr>
      </p:pic>
    </p:spTree>
    <p:extLst>
      <p:ext uri="{BB962C8B-B14F-4D97-AF65-F5344CB8AC3E}">
        <p14:creationId xmlns:p14="http://schemas.microsoft.com/office/powerpoint/2010/main" val="3542906621"/>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art 1- Expert Groups (40min)</a:t>
            </a:r>
            <a:endParaRPr lang="en-US" dirty="0"/>
          </a:p>
        </p:txBody>
      </p:sp>
      <p:sp>
        <p:nvSpPr>
          <p:cNvPr id="3" name="Content Placeholder 2"/>
          <p:cNvSpPr>
            <a:spLocks noGrp="1"/>
          </p:cNvSpPr>
          <p:nvPr>
            <p:ph idx="1"/>
          </p:nvPr>
        </p:nvSpPr>
        <p:spPr>
          <a:xfrm>
            <a:off x="561111" y="2603500"/>
            <a:ext cx="5327625" cy="4016756"/>
          </a:xfrm>
        </p:spPr>
        <p:txBody>
          <a:bodyPr>
            <a:normAutofit/>
          </a:bodyPr>
          <a:lstStyle/>
          <a:p>
            <a:r>
              <a:rPr lang="en-US" dirty="0" smtClean="0"/>
              <a:t>Divide into groups A, B, C, D</a:t>
            </a:r>
            <a:br>
              <a:rPr lang="en-US" dirty="0" smtClean="0"/>
            </a:br>
            <a:endParaRPr lang="en-US" dirty="0" smtClean="0"/>
          </a:p>
          <a:p>
            <a:r>
              <a:rPr lang="en-US" dirty="0" smtClean="0"/>
              <a:t>Use the articles provided to complete your expert group worksheet</a:t>
            </a:r>
            <a:r>
              <a:rPr lang="en-US" dirty="0"/>
              <a:t/>
            </a:r>
            <a:br>
              <a:rPr lang="en-US" dirty="0"/>
            </a:br>
            <a:endParaRPr lang="en-US" dirty="0" smtClean="0"/>
          </a:p>
          <a:p>
            <a:r>
              <a:rPr lang="en-US" dirty="0" smtClean="0"/>
              <a:t>Afterwards, you will take your expertise to your home group to solve patient cases</a:t>
            </a:r>
          </a:p>
        </p:txBody>
      </p:sp>
      <p:graphicFrame>
        <p:nvGraphicFramePr>
          <p:cNvPr id="4" name="Table 3"/>
          <p:cNvGraphicFramePr>
            <a:graphicFrameLocks noGrp="1"/>
          </p:cNvGraphicFramePr>
          <p:nvPr>
            <p:extLst>
              <p:ext uri="{D42A27DB-BD31-4B8C-83A1-F6EECF244321}">
                <p14:modId xmlns:p14="http://schemas.microsoft.com/office/powerpoint/2010/main" val="923131879"/>
              </p:ext>
            </p:extLst>
          </p:nvPr>
        </p:nvGraphicFramePr>
        <p:xfrm>
          <a:off x="6455665" y="3016250"/>
          <a:ext cx="5563673" cy="2590800"/>
        </p:xfrm>
        <a:graphic>
          <a:graphicData uri="http://schemas.openxmlformats.org/drawingml/2006/table">
            <a:tbl>
              <a:tblPr firstRow="1" bandRow="1">
                <a:tableStyleId>{22838BEF-8BB2-4498-84A7-C5851F593DF1}</a:tableStyleId>
              </a:tblPr>
              <a:tblGrid>
                <a:gridCol w="522548">
                  <a:extLst>
                    <a:ext uri="{9D8B030D-6E8A-4147-A177-3AD203B41FA5}">
                      <a16:colId xmlns:a16="http://schemas.microsoft.com/office/drawing/2014/main" xmlns="" val="20000"/>
                    </a:ext>
                  </a:extLst>
                </a:gridCol>
                <a:gridCol w="5041125">
                  <a:extLst>
                    <a:ext uri="{9D8B030D-6E8A-4147-A177-3AD203B41FA5}">
                      <a16:colId xmlns:a16="http://schemas.microsoft.com/office/drawing/2014/main" xmlns="" val="20001"/>
                    </a:ext>
                  </a:extLst>
                </a:gridCol>
              </a:tblGrid>
              <a:tr h="370840">
                <a:tc>
                  <a:txBody>
                    <a:bodyPr/>
                    <a:lstStyle/>
                    <a:p>
                      <a:endParaRPr lang="en-US" sz="2800" dirty="0"/>
                    </a:p>
                  </a:txBody>
                  <a:tcPr/>
                </a:tc>
                <a:tc>
                  <a:txBody>
                    <a:bodyPr/>
                    <a:lstStyle/>
                    <a:p>
                      <a:r>
                        <a:rPr lang="en-US" sz="2800" dirty="0"/>
                        <a:t>Topic</a:t>
                      </a:r>
                    </a:p>
                  </a:txBody>
                  <a:tcPr/>
                </a:tc>
                <a:extLst>
                  <a:ext uri="{0D108BD9-81ED-4DB2-BD59-A6C34878D82A}">
                    <a16:rowId xmlns:a16="http://schemas.microsoft.com/office/drawing/2014/main" xmlns="" val="10000"/>
                  </a:ext>
                </a:extLst>
              </a:tr>
              <a:tr h="370840">
                <a:tc>
                  <a:txBody>
                    <a:bodyPr/>
                    <a:lstStyle/>
                    <a:p>
                      <a:pPr algn="ctr"/>
                      <a:r>
                        <a:rPr lang="en-US" sz="2800" b="1" dirty="0"/>
                        <a:t>A</a:t>
                      </a:r>
                    </a:p>
                  </a:txBody>
                  <a:tcPr/>
                </a:tc>
                <a:tc>
                  <a:txBody>
                    <a:bodyPr/>
                    <a:lstStyle/>
                    <a:p>
                      <a:r>
                        <a:rPr lang="en-US" sz="2800" dirty="0" smtClean="0"/>
                        <a:t>Abnormal Uterine Bleeding</a:t>
                      </a:r>
                      <a:endParaRPr lang="en-US" sz="2800" dirty="0"/>
                    </a:p>
                  </a:txBody>
                  <a:tcPr/>
                </a:tc>
                <a:extLst>
                  <a:ext uri="{0D108BD9-81ED-4DB2-BD59-A6C34878D82A}">
                    <a16:rowId xmlns:a16="http://schemas.microsoft.com/office/drawing/2014/main" xmlns="" val="10001"/>
                  </a:ext>
                </a:extLst>
              </a:tr>
              <a:tr h="370840">
                <a:tc>
                  <a:txBody>
                    <a:bodyPr/>
                    <a:lstStyle/>
                    <a:p>
                      <a:pPr algn="ctr"/>
                      <a:r>
                        <a:rPr lang="en-US" sz="2800" b="1" dirty="0"/>
                        <a:t>B</a:t>
                      </a:r>
                    </a:p>
                  </a:txBody>
                  <a:tcPr/>
                </a:tc>
                <a:tc>
                  <a:txBody>
                    <a:bodyPr/>
                    <a:lstStyle/>
                    <a:p>
                      <a:r>
                        <a:rPr lang="en-US" sz="2800" dirty="0" smtClean="0"/>
                        <a:t>Osteoporosis</a:t>
                      </a:r>
                      <a:endParaRPr lang="en-US" sz="2800" dirty="0"/>
                    </a:p>
                  </a:txBody>
                  <a:tcPr/>
                </a:tc>
                <a:extLst>
                  <a:ext uri="{0D108BD9-81ED-4DB2-BD59-A6C34878D82A}">
                    <a16:rowId xmlns:a16="http://schemas.microsoft.com/office/drawing/2014/main" xmlns="" val="10002"/>
                  </a:ext>
                </a:extLst>
              </a:tr>
              <a:tr h="370840">
                <a:tc>
                  <a:txBody>
                    <a:bodyPr/>
                    <a:lstStyle/>
                    <a:p>
                      <a:pPr algn="ctr"/>
                      <a:r>
                        <a:rPr lang="en-US" sz="2800" b="1" dirty="0"/>
                        <a:t>C</a:t>
                      </a:r>
                    </a:p>
                  </a:txBody>
                  <a:tcPr/>
                </a:tc>
                <a:tc>
                  <a:txBody>
                    <a:bodyPr/>
                    <a:lstStyle/>
                    <a:p>
                      <a:r>
                        <a:rPr lang="en-US" sz="2800" dirty="0" smtClean="0"/>
                        <a:t>Menopause</a:t>
                      </a:r>
                      <a:endParaRPr lang="en-US" sz="2800" dirty="0"/>
                    </a:p>
                  </a:txBody>
                  <a:tcPr/>
                </a:tc>
                <a:extLst>
                  <a:ext uri="{0D108BD9-81ED-4DB2-BD59-A6C34878D82A}">
                    <a16:rowId xmlns:a16="http://schemas.microsoft.com/office/drawing/2014/main" xmlns="" val="10003"/>
                  </a:ext>
                </a:extLst>
              </a:tr>
              <a:tr h="370840">
                <a:tc>
                  <a:txBody>
                    <a:bodyPr/>
                    <a:lstStyle/>
                    <a:p>
                      <a:pPr algn="ctr"/>
                      <a:r>
                        <a:rPr lang="en-US" sz="2800" b="1" dirty="0"/>
                        <a:t>D</a:t>
                      </a:r>
                    </a:p>
                  </a:txBody>
                  <a:tcPr/>
                </a:tc>
                <a:tc>
                  <a:txBody>
                    <a:bodyPr/>
                    <a:lstStyle/>
                    <a:p>
                      <a:r>
                        <a:rPr lang="en-US" sz="2800" dirty="0" smtClean="0"/>
                        <a:t>Urinary Incontinence</a:t>
                      </a:r>
                      <a:endParaRPr lang="en-US" sz="2800" dirty="0"/>
                    </a:p>
                  </a:txBody>
                  <a:tcPr/>
                </a:tc>
                <a:extLst>
                  <a:ext uri="{0D108BD9-81ED-4DB2-BD59-A6C34878D82A}">
                    <a16:rowId xmlns:a16="http://schemas.microsoft.com/office/drawing/2014/main" xmlns="" val="10004"/>
                  </a:ext>
                </a:extLst>
              </a:tr>
            </a:tbl>
          </a:graphicData>
        </a:graphic>
      </p:graphicFrame>
      <p:pic>
        <p:nvPicPr>
          <p:cNvPr id="5" name="Content Placeholder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034813" y="5887254"/>
            <a:ext cx="1119558" cy="892621"/>
          </a:xfrm>
          <a:prstGeom prst="rect">
            <a:avLst/>
          </a:prstGeom>
          <a:solidFill>
            <a:schemeClr val="bg1"/>
          </a:solidFill>
        </p:spPr>
      </p:pic>
    </p:spTree>
    <p:extLst>
      <p:ext uri="{BB962C8B-B14F-4D97-AF65-F5344CB8AC3E}">
        <p14:creationId xmlns:p14="http://schemas.microsoft.com/office/powerpoint/2010/main" val="272716835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art 2- Patient Cases (40 min)</a:t>
            </a:r>
            <a:endParaRPr lang="en-US" dirty="0"/>
          </a:p>
        </p:txBody>
      </p:sp>
      <p:sp>
        <p:nvSpPr>
          <p:cNvPr id="3" name="Content Placeholder 2"/>
          <p:cNvSpPr>
            <a:spLocks noGrp="1"/>
          </p:cNvSpPr>
          <p:nvPr>
            <p:ph idx="1"/>
          </p:nvPr>
        </p:nvSpPr>
        <p:spPr>
          <a:xfrm>
            <a:off x="561111" y="2603500"/>
            <a:ext cx="10600875" cy="3416300"/>
          </a:xfrm>
        </p:spPr>
        <p:txBody>
          <a:bodyPr>
            <a:normAutofit/>
          </a:bodyPr>
          <a:lstStyle/>
          <a:p>
            <a:r>
              <a:rPr lang="en-US" dirty="0" smtClean="0"/>
              <a:t>Return to your </a:t>
            </a:r>
            <a:r>
              <a:rPr lang="en-US" b="1" dirty="0" smtClean="0"/>
              <a:t>Home Groups</a:t>
            </a:r>
            <a:r>
              <a:rPr lang="en-US" dirty="0" smtClean="0"/>
              <a:t/>
            </a:r>
            <a:br>
              <a:rPr lang="en-US" dirty="0" smtClean="0"/>
            </a:br>
            <a:endParaRPr lang="en-US" dirty="0" smtClean="0"/>
          </a:p>
          <a:p>
            <a:r>
              <a:rPr lang="en-US" dirty="0" smtClean="0"/>
              <a:t>Each team has at least 1 person of each letter</a:t>
            </a:r>
            <a:br>
              <a:rPr lang="en-US" dirty="0" smtClean="0"/>
            </a:br>
            <a:endParaRPr lang="en-US" dirty="0" smtClean="0"/>
          </a:p>
          <a:p>
            <a:r>
              <a:rPr lang="en-US" dirty="0" smtClean="0"/>
              <a:t>Based off of what you learned in part 1, solve the patient case worksheet</a:t>
            </a:r>
            <a:endParaRPr lang="en-US" dirty="0"/>
          </a:p>
        </p:txBody>
      </p:sp>
      <p:sp>
        <p:nvSpPr>
          <p:cNvPr id="4" name="TextBox 3"/>
          <p:cNvSpPr txBox="1"/>
          <p:nvPr/>
        </p:nvSpPr>
        <p:spPr>
          <a:xfrm>
            <a:off x="8794376" y="3173506"/>
            <a:ext cx="537882" cy="769441"/>
          </a:xfrm>
          <a:prstGeom prst="rect">
            <a:avLst/>
          </a:prstGeom>
          <a:noFill/>
        </p:spPr>
        <p:txBody>
          <a:bodyPr wrap="square" rtlCol="0">
            <a:spAutoFit/>
          </a:bodyPr>
          <a:lstStyle/>
          <a:p>
            <a:r>
              <a:rPr lang="en-US" sz="4400" b="1" dirty="0" smtClean="0">
                <a:solidFill>
                  <a:schemeClr val="bg1"/>
                </a:solidFill>
              </a:rPr>
              <a:t>A</a:t>
            </a:r>
            <a:endParaRPr lang="en-US" b="1" dirty="0">
              <a:solidFill>
                <a:schemeClr val="bg1"/>
              </a:solidFill>
            </a:endParaRPr>
          </a:p>
        </p:txBody>
      </p:sp>
      <p:sp>
        <p:nvSpPr>
          <p:cNvPr id="6" name="TextBox 5"/>
          <p:cNvSpPr txBox="1"/>
          <p:nvPr/>
        </p:nvSpPr>
        <p:spPr>
          <a:xfrm>
            <a:off x="10425774" y="4990626"/>
            <a:ext cx="537882" cy="769441"/>
          </a:xfrm>
          <a:prstGeom prst="rect">
            <a:avLst/>
          </a:prstGeom>
          <a:noFill/>
        </p:spPr>
        <p:txBody>
          <a:bodyPr wrap="square" rtlCol="0">
            <a:spAutoFit/>
          </a:bodyPr>
          <a:lstStyle/>
          <a:p>
            <a:r>
              <a:rPr lang="en-US" sz="4400" b="1" dirty="0" smtClean="0">
                <a:solidFill>
                  <a:schemeClr val="bg1"/>
                </a:solidFill>
              </a:rPr>
              <a:t>D</a:t>
            </a:r>
            <a:endParaRPr lang="en-US" b="1" dirty="0">
              <a:solidFill>
                <a:schemeClr val="bg1"/>
              </a:solidFill>
            </a:endParaRPr>
          </a:p>
        </p:txBody>
      </p:sp>
      <p:sp>
        <p:nvSpPr>
          <p:cNvPr id="7" name="TextBox 6"/>
          <p:cNvSpPr txBox="1"/>
          <p:nvPr/>
        </p:nvSpPr>
        <p:spPr>
          <a:xfrm>
            <a:off x="10493188" y="3503850"/>
            <a:ext cx="537882" cy="769441"/>
          </a:xfrm>
          <a:prstGeom prst="rect">
            <a:avLst/>
          </a:prstGeom>
          <a:noFill/>
        </p:spPr>
        <p:txBody>
          <a:bodyPr wrap="square" rtlCol="0">
            <a:spAutoFit/>
          </a:bodyPr>
          <a:lstStyle/>
          <a:p>
            <a:r>
              <a:rPr lang="en-US" sz="4400" b="1" dirty="0" smtClean="0">
                <a:solidFill>
                  <a:schemeClr val="bg1"/>
                </a:solidFill>
              </a:rPr>
              <a:t>B</a:t>
            </a:r>
            <a:endParaRPr lang="en-US" b="1" dirty="0">
              <a:solidFill>
                <a:schemeClr val="bg1"/>
              </a:solidFill>
            </a:endParaRPr>
          </a:p>
        </p:txBody>
      </p:sp>
      <p:pic>
        <p:nvPicPr>
          <p:cNvPr id="8" name="Content Placeholder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034813" y="5887254"/>
            <a:ext cx="1119558" cy="892621"/>
          </a:xfrm>
          <a:prstGeom prst="rect">
            <a:avLst/>
          </a:prstGeom>
          <a:solidFill>
            <a:schemeClr val="bg1"/>
          </a:solidFill>
        </p:spPr>
      </p:pic>
    </p:spTree>
    <p:extLst>
      <p:ext uri="{BB962C8B-B14F-4D97-AF65-F5344CB8AC3E}">
        <p14:creationId xmlns:p14="http://schemas.microsoft.com/office/powerpoint/2010/main" val="202283140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art 3- Group Debrief (30 min)</a:t>
            </a:r>
            <a:endParaRPr lang="en-US" dirty="0"/>
          </a:p>
        </p:txBody>
      </p:sp>
      <p:sp>
        <p:nvSpPr>
          <p:cNvPr id="3" name="Content Placeholder 2"/>
          <p:cNvSpPr>
            <a:spLocks noGrp="1"/>
          </p:cNvSpPr>
          <p:nvPr>
            <p:ph idx="1"/>
          </p:nvPr>
        </p:nvSpPr>
        <p:spPr>
          <a:xfrm>
            <a:off x="561110" y="3436882"/>
            <a:ext cx="11082593" cy="2582917"/>
          </a:xfrm>
        </p:spPr>
        <p:txBody>
          <a:bodyPr/>
          <a:lstStyle/>
          <a:p>
            <a:pPr marL="0" indent="0" algn="ctr">
              <a:buNone/>
            </a:pPr>
            <a:r>
              <a:rPr lang="en-US" sz="6000" b="1" dirty="0" smtClean="0">
                <a:hlinkClick r:id="rId3"/>
              </a:rPr>
              <a:t>https://kahoot.it</a:t>
            </a:r>
            <a:endParaRPr lang="en-US" sz="6000" b="1" dirty="0" smtClean="0"/>
          </a:p>
          <a:p>
            <a:pPr marL="0" indent="0">
              <a:buNone/>
            </a:pPr>
            <a:endParaRPr lang="en-US" dirty="0"/>
          </a:p>
        </p:txBody>
      </p:sp>
      <p:sp>
        <p:nvSpPr>
          <p:cNvPr id="5" name="Rectangle 4"/>
          <p:cNvSpPr/>
          <p:nvPr/>
        </p:nvSpPr>
        <p:spPr>
          <a:xfrm>
            <a:off x="129938" y="31728"/>
            <a:ext cx="4586512" cy="369332"/>
          </a:xfrm>
          <a:prstGeom prst="rect">
            <a:avLst/>
          </a:prstGeom>
        </p:spPr>
        <p:txBody>
          <a:bodyPr wrap="none">
            <a:spAutoFit/>
          </a:bodyPr>
          <a:lstStyle/>
          <a:p>
            <a:r>
              <a:rPr lang="en-US" dirty="0" smtClean="0"/>
              <a:t>Instructor: </a:t>
            </a:r>
            <a:r>
              <a:rPr lang="en-US" dirty="0" smtClean="0">
                <a:hlinkClick r:id="rId4"/>
              </a:rPr>
              <a:t>https</a:t>
            </a:r>
            <a:r>
              <a:rPr lang="en-US" dirty="0">
                <a:hlinkClick r:id="rId4"/>
              </a:rPr>
              <a:t>://create.kahoot.it/login</a:t>
            </a:r>
            <a:endParaRPr lang="en-US" dirty="0"/>
          </a:p>
        </p:txBody>
      </p:sp>
      <p:pic>
        <p:nvPicPr>
          <p:cNvPr id="6" name="Content Placeholder 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1034813" y="5887254"/>
            <a:ext cx="1119558" cy="892621"/>
          </a:xfrm>
          <a:prstGeom prst="rect">
            <a:avLst/>
          </a:prstGeom>
          <a:solidFill>
            <a:schemeClr val="bg1"/>
          </a:solidFill>
        </p:spPr>
      </p:pic>
    </p:spTree>
    <p:extLst>
      <p:ext uri="{BB962C8B-B14F-4D97-AF65-F5344CB8AC3E}">
        <p14:creationId xmlns:p14="http://schemas.microsoft.com/office/powerpoint/2010/main" val="4081700561"/>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034813" y="5887254"/>
            <a:ext cx="1119558" cy="892621"/>
          </a:xfrm>
          <a:prstGeom prst="rect">
            <a:avLst/>
          </a:prstGeom>
          <a:solidFill>
            <a:schemeClr val="bg1"/>
          </a:solidFill>
        </p:spPr>
      </p:pic>
      <p:sp>
        <p:nvSpPr>
          <p:cNvPr id="2" name="Title 1"/>
          <p:cNvSpPr>
            <a:spLocks noGrp="1"/>
          </p:cNvSpPr>
          <p:nvPr>
            <p:ph type="title"/>
          </p:nvPr>
        </p:nvSpPr>
        <p:spPr/>
        <p:txBody>
          <a:bodyPr/>
          <a:lstStyle/>
          <a:p>
            <a:r>
              <a:rPr lang="en-US" dirty="0" smtClean="0"/>
              <a:t>Start Post-Test</a:t>
            </a:r>
            <a:endParaRPr lang="en-US" dirty="0"/>
          </a:p>
        </p:txBody>
      </p:sp>
    </p:spTree>
    <p:extLst>
      <p:ext uri="{BB962C8B-B14F-4D97-AF65-F5344CB8AC3E}">
        <p14:creationId xmlns:p14="http://schemas.microsoft.com/office/powerpoint/2010/main" val="27494037"/>
      </p:ext>
    </p:extLst>
  </p:cSld>
  <p:clrMapOvr>
    <a:masterClrMapping/>
  </p:clrMapOvr>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Boardroom">
  <a:themeElements>
    <a:clrScheme name="Ion Boardroom">
      <a:dk1>
        <a:sysClr val="windowText" lastClr="000000"/>
      </a:dk1>
      <a:lt1>
        <a:sysClr val="window" lastClr="FFFFFF"/>
      </a:lt1>
      <a:dk2>
        <a:srgbClr val="3B3059"/>
      </a:dk2>
      <a:lt2>
        <a:srgbClr val="EBEBEB"/>
      </a:lt2>
      <a:accent1>
        <a:srgbClr val="B31166"/>
      </a:accent1>
      <a:accent2>
        <a:srgbClr val="E33D6F"/>
      </a:accent2>
      <a:accent3>
        <a:srgbClr val="E45F3C"/>
      </a:accent3>
      <a:accent4>
        <a:srgbClr val="E9943A"/>
      </a:accent4>
      <a:accent5>
        <a:srgbClr val="9B6BF2"/>
      </a:accent5>
      <a:accent6>
        <a:srgbClr val="D53DD0"/>
      </a:accent6>
      <a:hlink>
        <a:srgbClr val="8F8F8F"/>
      </a:hlink>
      <a:folHlink>
        <a:srgbClr val="A5A5A5"/>
      </a:folHlink>
    </a:clrScheme>
    <a:fontScheme name="Ion Boardroom">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Boardroom">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8000"/>
                <a:hueMod val="124000"/>
                <a:satMod val="148000"/>
                <a:lumMod val="124000"/>
              </a:schemeClr>
            </a:gs>
            <a:gs pos="100000">
              <a:schemeClr val="phClr">
                <a:shade val="76000"/>
                <a:hueMod val="89000"/>
                <a:satMod val="164000"/>
                <a:lumMod val="56000"/>
              </a:schemeClr>
            </a:gs>
          </a:gsLst>
          <a:path path="circle">
            <a:fillToRect l="45000" t="65000" r="125000" b="100000"/>
          </a:path>
        </a:gradFill>
        <a:blipFill rotWithShape="1">
          <a:blip xmlns:r="http://schemas.openxmlformats.org/officeDocument/2006/relationships" r:embed="rId1">
            <a:duotone>
              <a:schemeClr val="phClr">
                <a:shade val="69000"/>
                <a:hueMod val="91000"/>
                <a:satMod val="164000"/>
                <a:lumMod val="74000"/>
              </a:schemeClr>
              <a:schemeClr val="phClr">
                <a:hueMod val="124000"/>
                <a:satMod val="140000"/>
                <a:lumMod val="142000"/>
              </a:schemeClr>
            </a:duotone>
          </a:blip>
          <a:stretch/>
        </a:blipFill>
      </a:bgFillStyleLst>
    </a:fmtScheme>
  </a:themeElements>
  <a:objectDefaults/>
  <a:extraClrSchemeLst/>
  <a:extLst>
    <a:ext uri="{05A4C25C-085E-4340-85A3-A5531E510DB2}">
      <thm15:themeFamily xmlns:thm15="http://schemas.microsoft.com/office/thememl/2012/main" name="Ion Boardroom" id="{FC33163D-4339-46B1-8EED-24C834239D99}" vid="{B8502691-933B-45FE-8764-BA278511EF27}"/>
    </a:ext>
  </a:extLst>
</a:theme>
</file>

<file path=ppt/theme/theme2.xml><?xml version="1.0" encoding="utf-8"?>
<a:theme xmlns:a="http://schemas.openxmlformats.org/drawingml/2006/main" name="Stony Brook PowerPoint Template 1">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esentation9" id="{C8F7EB01-FB59-4FAF-A95F-65B6C254F811}" vid="{BFF223BF-B884-4909-92F7-05AE8BD8E300}"/>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on Boardroom</Template>
  <TotalTime>264</TotalTime>
  <Words>792</Words>
  <Application>Microsoft Office PowerPoint</Application>
  <PresentationFormat>Widescreen</PresentationFormat>
  <Paragraphs>143</Paragraphs>
  <Slides>8</Slides>
  <Notes>8</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8</vt:i4>
      </vt:variant>
    </vt:vector>
  </HeadingPairs>
  <TitlesOfParts>
    <vt:vector size="15" baseType="lpstr">
      <vt:lpstr>Arial</vt:lpstr>
      <vt:lpstr>Calibri</vt:lpstr>
      <vt:lpstr>Calibri Light</vt:lpstr>
      <vt:lpstr>Century Gothic</vt:lpstr>
      <vt:lpstr>Wingdings 3</vt:lpstr>
      <vt:lpstr>Ion Boardroom</vt:lpstr>
      <vt:lpstr>Stony Brook PowerPoint Template 1</vt:lpstr>
      <vt:lpstr>Geriatrics Women’s Health for IM Residents</vt:lpstr>
      <vt:lpstr>Workshop Overview</vt:lpstr>
      <vt:lpstr>Start Pre-Test</vt:lpstr>
      <vt:lpstr>Home Groups</vt:lpstr>
      <vt:lpstr>Part 1- Expert Groups (40min)</vt:lpstr>
      <vt:lpstr>Part 2- Patient Cases (40 min)</vt:lpstr>
      <vt:lpstr>Part 3- Group Debrief (30 min)</vt:lpstr>
      <vt:lpstr>Start Post-Test</vt:lpstr>
    </vt:vector>
  </TitlesOfParts>
  <Company>SUNY Stony Brook</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g, Patricia</dc:creator>
  <cp:lastModifiedBy>Ng, Patricia</cp:lastModifiedBy>
  <cp:revision>37</cp:revision>
  <dcterms:created xsi:type="dcterms:W3CDTF">2017-12-28T18:29:08Z</dcterms:created>
  <dcterms:modified xsi:type="dcterms:W3CDTF">2020-04-20T14:56:01Z</dcterms:modified>
</cp:coreProperties>
</file>